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4" r:id="rId2"/>
  </p:sldIdLst>
  <p:sldSz cx="6492875" cy="841216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045">
          <p15:clr>
            <a:srgbClr val="A4A3A4"/>
          </p15:clr>
        </p15:guide>
        <p15:guide id="3" orient="horz" pos="68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43" autoAdjust="0"/>
    <p:restoredTop sz="96081" autoAdjust="0"/>
  </p:normalViewPr>
  <p:slideViewPr>
    <p:cSldViewPr>
      <p:cViewPr varScale="1">
        <p:scale>
          <a:sx n="78" d="100"/>
          <a:sy n="78" d="100"/>
        </p:scale>
        <p:origin x="1122" y="108"/>
      </p:cViewPr>
      <p:guideLst>
        <p:guide pos="2045"/>
        <p:guide orient="horz" pos="68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o" userId="b11a5121-062d-4360-8951-d081ad96d999" providerId="ADAL" clId="{08E3E914-632B-4CE1-915E-2B81B87CD524}"/>
    <pc:docChg chg="delSld">
      <pc:chgData name="Go" userId="b11a5121-062d-4360-8951-d081ad96d999" providerId="ADAL" clId="{08E3E914-632B-4CE1-915E-2B81B87CD524}" dt="2022-10-15T03:33:03.717" v="2" actId="47"/>
      <pc:docMkLst>
        <pc:docMk/>
      </pc:docMkLst>
      <pc:sldChg chg="del">
        <pc:chgData name="Go" userId="b11a5121-062d-4360-8951-d081ad96d999" providerId="ADAL" clId="{08E3E914-632B-4CE1-915E-2B81B87CD524}" dt="2022-10-15T03:33:03.717" v="2" actId="47"/>
        <pc:sldMkLst>
          <pc:docMk/>
          <pc:sldMk cId="4198847848" sldId="289"/>
        </pc:sldMkLst>
      </pc:sldChg>
      <pc:sldChg chg="del">
        <pc:chgData name="Go" userId="b11a5121-062d-4360-8951-d081ad96d999" providerId="ADAL" clId="{08E3E914-632B-4CE1-915E-2B81B87CD524}" dt="2022-10-15T03:33:01.325" v="1" actId="47"/>
        <pc:sldMkLst>
          <pc:docMk/>
          <pc:sldMk cId="765565405" sldId="295"/>
        </pc:sldMkLst>
      </pc:sldChg>
      <pc:sldChg chg="del">
        <pc:chgData name="Go" userId="b11a5121-062d-4360-8951-d081ad96d999" providerId="ADAL" clId="{08E3E914-632B-4CE1-915E-2B81B87CD524}" dt="2022-10-15T03:33:03.717" v="2" actId="47"/>
        <pc:sldMkLst>
          <pc:docMk/>
          <pc:sldMk cId="970619779" sldId="297"/>
        </pc:sldMkLst>
      </pc:sldChg>
      <pc:sldChg chg="del">
        <pc:chgData name="Go" userId="b11a5121-062d-4360-8951-d081ad96d999" providerId="ADAL" clId="{08E3E914-632B-4CE1-915E-2B81B87CD524}" dt="2022-10-15T03:32:59.868" v="0" actId="47"/>
        <pc:sldMkLst>
          <pc:docMk/>
          <pc:sldMk cId="2231304746" sldId="299"/>
        </pc:sldMkLst>
      </pc:sldChg>
      <pc:sldChg chg="del">
        <pc:chgData name="Go" userId="b11a5121-062d-4360-8951-d081ad96d999" providerId="ADAL" clId="{08E3E914-632B-4CE1-915E-2B81B87CD524}" dt="2022-10-15T03:32:59.868" v="0" actId="47"/>
        <pc:sldMkLst>
          <pc:docMk/>
          <pc:sldMk cId="3299870256" sldId="301"/>
        </pc:sldMkLst>
      </pc:sldChg>
      <pc:sldChg chg="del">
        <pc:chgData name="Go" userId="b11a5121-062d-4360-8951-d081ad96d999" providerId="ADAL" clId="{08E3E914-632B-4CE1-915E-2B81B87CD524}" dt="2022-10-15T03:32:59.868" v="0" actId="47"/>
        <pc:sldMkLst>
          <pc:docMk/>
          <pc:sldMk cId="2069005311" sldId="302"/>
        </pc:sldMkLst>
      </pc:sldChg>
      <pc:sldChg chg="del">
        <pc:chgData name="Go" userId="b11a5121-062d-4360-8951-d081ad96d999" providerId="ADAL" clId="{08E3E914-632B-4CE1-915E-2B81B87CD524}" dt="2022-10-15T03:33:03.717" v="2" actId="47"/>
        <pc:sldMkLst>
          <pc:docMk/>
          <pc:sldMk cId="1909606739" sldId="303"/>
        </pc:sldMkLst>
      </pc:sldChg>
    </pc:docChg>
  </pc:docChgLst>
  <pc:docChgLst>
    <pc:chgData name="Go" userId="b11a5121-062d-4360-8951-d081ad96d999" providerId="ADAL" clId="{9F3DCE2B-CD69-4735-8D75-F97BD501C620}"/>
    <pc:docChg chg="undo redo custSel delSld modSld">
      <pc:chgData name="Go" userId="b11a5121-062d-4360-8951-d081ad96d999" providerId="ADAL" clId="{9F3DCE2B-CD69-4735-8D75-F97BD501C620}" dt="2022-10-06T03:01:28.049" v="365" actId="1035"/>
      <pc:docMkLst>
        <pc:docMk/>
      </pc:docMkLst>
      <pc:sldChg chg="addSp delSp modSp mod">
        <pc:chgData name="Go" userId="b11a5121-062d-4360-8951-d081ad96d999" providerId="ADAL" clId="{9F3DCE2B-CD69-4735-8D75-F97BD501C620}" dt="2022-10-06T01:59:05.555" v="40" actId="1035"/>
        <pc:sldMkLst>
          <pc:docMk/>
          <pc:sldMk cId="765565405" sldId="295"/>
        </pc:sldMkLst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5" creationId="{A13A7755-482B-DB79-B7FA-774EDD0CF951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6" creationId="{D51863D8-455B-EC0F-71CB-5FDB543079E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7" creationId="{9AD3C06D-AD2A-06FC-BE68-B49D85C3C27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68" creationId="{0451ED29-33C0-93F8-7A36-FA45EAFD881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0" creationId="{13C8E1A1-5815-DA4D-8E86-1F21026E355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3" creationId="{8BBE0DCD-5716-2704-9454-472A9944543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5" creationId="{3958EEFB-0F3C-661B-D83D-665E60B1FFC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6" creationId="{DFED24C3-182C-8E23-946D-496948D6DAC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7" creationId="{CA3E831C-A33B-43D2-4F89-C1F7CD8DD0F3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8" creationId="{C1D5D536-8CBB-3EDB-A7A2-5D4B65174D4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79" creationId="{7BEEB265-4B51-6C6C-35D4-DDC52F490EC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81" creationId="{3AF757E8-4AE4-91BF-3E89-1C195E53A14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14" creationId="{EF596959-60D3-4521-DE7A-48D803BF3B4D}"/>
          </ac:spMkLst>
        </pc:spChg>
        <pc:spChg chg="mod">
          <ac:chgData name="Go" userId="b11a5121-062d-4360-8951-d081ad96d999" providerId="ADAL" clId="{9F3DCE2B-CD69-4735-8D75-F97BD501C620}" dt="2022-10-06T01:59:00.819" v="39" actId="1035"/>
          <ac:spMkLst>
            <pc:docMk/>
            <pc:sldMk cId="765565405" sldId="295"/>
            <ac:spMk id="216" creationId="{D657EAB7-2F22-372F-9161-BC037AAB4596}"/>
          </ac:spMkLst>
        </pc:spChg>
        <pc:spChg chg="mod">
          <ac:chgData name="Go" userId="b11a5121-062d-4360-8951-d081ad96d999" providerId="ADAL" clId="{9F3DCE2B-CD69-4735-8D75-F97BD501C620}" dt="2022-10-06T01:58:57.487" v="36" actId="1035"/>
          <ac:spMkLst>
            <pc:docMk/>
            <pc:sldMk cId="765565405" sldId="295"/>
            <ac:spMk id="218" creationId="{DEF0CF26-0463-2340-281E-4E244F51EE6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4" creationId="{496BC65B-71E2-B748-5735-2F5B94283B97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7" creationId="{08B8E35D-A3C5-891E-C395-16525445E0F6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29" creationId="{C0E28091-6E1D-3F5D-B88E-B2A6DD29E0F4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31" creationId="{04F20118-ABCF-DE51-B90D-76C4364A5290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49" creationId="{2882A209-37C6-C544-F7FA-06B6F9367A59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0" creationId="{ACD10E03-4C8C-F276-636D-6243D531551C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1" creationId="{1017BC00-01DE-61D9-21A2-3D40BC47FF34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2" creationId="{3B01E9EB-DEFC-7FE9-A5F0-ADD2FCEAECB5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3" creationId="{A1BD4D14-C8EF-62A2-EB85-FE16D10AF276}"/>
          </ac:spMkLst>
        </pc:spChg>
        <pc:spChg chg="mod">
          <ac:chgData name="Go" userId="b11a5121-062d-4360-8951-d081ad96d999" providerId="ADAL" clId="{9F3DCE2B-CD69-4735-8D75-F97BD501C620}" dt="2022-10-06T01:58:06.317" v="16"/>
          <ac:spMkLst>
            <pc:docMk/>
            <pc:sldMk cId="765565405" sldId="295"/>
            <ac:spMk id="254" creationId="{C609FA06-A566-4E80-A9F9-8EEDAD7EA1EE}"/>
          </ac:spMkLst>
        </pc:s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5" creationId="{AD8DB468-048F-B9FC-6CFF-C0488CA069F1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8" creationId="{1AB48F4C-6B99-087F-F438-3FD82BD25946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9" creationId="{7A847D17-1ACF-D55D-13C8-86539824C271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31" creationId="{8176E087-5509-EB8F-312F-9CE869835A67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25" creationId="{EC15710E-7CE9-A2A5-77EF-8A1B923D8D58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58" creationId="{88CF5590-DD0D-0456-695B-C7F320C4D46D}"/>
          </ac:grpSpMkLst>
        </pc:grpChg>
        <pc:grpChg chg="mod">
          <ac:chgData name="Go" userId="b11a5121-062d-4360-8951-d081ad96d999" providerId="ADAL" clId="{9F3DCE2B-CD69-4735-8D75-F97BD501C620}" dt="2022-10-06T01:58:06.317" v="16"/>
          <ac:grpSpMkLst>
            <pc:docMk/>
            <pc:sldMk cId="765565405" sldId="295"/>
            <ac:grpSpMk id="268" creationId="{71E89F71-02F2-647A-FBAF-2276502E671F}"/>
          </ac:grpSpMkLst>
        </pc:grpChg>
        <pc:graphicFrameChg chg="add del mod">
          <ac:chgData name="Go" userId="b11a5121-062d-4360-8951-d081ad96d999" providerId="ADAL" clId="{9F3DCE2B-CD69-4735-8D75-F97BD501C620}" dt="2022-10-06T01:57:36.085" v="8"/>
          <ac:graphicFrameMkLst>
            <pc:docMk/>
            <pc:sldMk cId="765565405" sldId="295"/>
            <ac:graphicFrameMk id="2" creationId="{73622A94-0173-6612-EE8E-82144F55ED2C}"/>
          </ac:graphicFrameMkLst>
        </pc:graphicFrameChg>
        <pc:graphicFrameChg chg="mod">
          <ac:chgData name="Go" userId="b11a5121-062d-4360-8951-d081ad96d999" providerId="ADAL" clId="{9F3DCE2B-CD69-4735-8D75-F97BD501C620}" dt="2022-10-06T01:58:06.317" v="16"/>
          <ac:graphicFrameMkLst>
            <pc:docMk/>
            <pc:sldMk cId="765565405" sldId="295"/>
            <ac:graphicFrameMk id="257" creationId="{93C7C028-D7E1-E394-069E-29D1113A0275}"/>
          </ac:graphicFrameMkLst>
        </pc:graphicFrameChg>
        <pc:picChg chg="add mod modCrop">
          <ac:chgData name="Go" userId="b11a5121-062d-4360-8951-d081ad96d999" providerId="ADAL" clId="{9F3DCE2B-CD69-4735-8D75-F97BD501C620}" dt="2022-10-06T01:59:05.555" v="40" actId="1035"/>
          <ac:picMkLst>
            <pc:docMk/>
            <pc:sldMk cId="765565405" sldId="295"/>
            <ac:picMk id="10" creationId="{A3549F28-64D7-EB92-998C-4E26A68827E2}"/>
          </ac:picMkLst>
        </pc:picChg>
        <pc:picChg chg="del mod">
          <ac:chgData name="Go" userId="b11a5121-062d-4360-8951-d081ad96d999" providerId="ADAL" clId="{9F3DCE2B-CD69-4735-8D75-F97BD501C620}" dt="2022-10-06T01:58:42.303" v="25" actId="478"/>
          <ac:picMkLst>
            <pc:docMk/>
            <pc:sldMk cId="765565405" sldId="295"/>
            <ac:picMk id="262" creationId="{A92ABF3D-C883-625D-933E-47CC786B689E}"/>
          </ac:picMkLst>
        </pc:picChg>
        <pc:picChg chg="del mod">
          <ac:chgData name="Go" userId="b11a5121-062d-4360-8951-d081ad96d999" providerId="ADAL" clId="{9F3DCE2B-CD69-4735-8D75-F97BD501C620}" dt="2022-10-06T01:58:43.479" v="26" actId="478"/>
          <ac:picMkLst>
            <pc:docMk/>
            <pc:sldMk cId="765565405" sldId="295"/>
            <ac:picMk id="263" creationId="{EBAFD2EB-5626-2B49-9723-8A5BAC7693A1}"/>
          </ac:picMkLst>
        </pc:picChg>
        <pc:picChg chg="del mod">
          <ac:chgData name="Go" userId="b11a5121-062d-4360-8951-d081ad96d999" providerId="ADAL" clId="{9F3DCE2B-CD69-4735-8D75-F97BD501C620}" dt="2022-10-06T01:58:44.701" v="27" actId="478"/>
          <ac:picMkLst>
            <pc:docMk/>
            <pc:sldMk cId="765565405" sldId="295"/>
            <ac:picMk id="264" creationId="{8652B5E2-4623-CA66-805E-616B7FA3FF24}"/>
          </ac:picMkLst>
        </pc:picChg>
      </pc:sldChg>
      <pc:sldChg chg="del">
        <pc:chgData name="Go" userId="b11a5121-062d-4360-8951-d081ad96d999" providerId="ADAL" clId="{9F3DCE2B-CD69-4735-8D75-F97BD501C620}" dt="2022-10-06T01:27:14.763" v="0" actId="47"/>
        <pc:sldMkLst>
          <pc:docMk/>
          <pc:sldMk cId="2177906614" sldId="300"/>
        </pc:sldMkLst>
      </pc:sldChg>
      <pc:sldChg chg="addSp delSp modSp mod">
        <pc:chgData name="Go" userId="b11a5121-062d-4360-8951-d081ad96d999" providerId="ADAL" clId="{9F3DCE2B-CD69-4735-8D75-F97BD501C620}" dt="2022-10-06T03:01:28.049" v="365" actId="1035"/>
        <pc:sldMkLst>
          <pc:docMk/>
          <pc:sldMk cId="3299870256" sldId="301"/>
        </pc:sldMkLst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2" creationId="{A7DA65A8-9C18-44D5-8A91-8C50381BEF9D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6" creationId="{2D415CC3-EC50-47BD-9C07-95599E264991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36" creationId="{0ABDE28E-4F18-7EA1-324E-0C46208B542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4" creationId="{089D6C4B-E85D-1CD3-914B-2088CDFD16BB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61" creationId="{5141CB8A-7B8E-6254-DBB4-D32013666423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63" creationId="{C2DEC8A3-11BC-D720-0DA0-92E3857A969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4" creationId="{9F007954-0AAD-3205-735A-B9A54442C770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5" creationId="{515CE48F-1CC6-72F9-4350-E9508E72096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6" creationId="{7448F8AD-C4F0-4AA1-98CB-C813BC9B24D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7" creationId="{B3A138A0-A275-7353-FE03-EC2EFA9DC93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8" creationId="{2CDF2CD0-379D-D6FC-2C99-2932958E9A5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76" creationId="{74E5028F-A99A-AA28-7FDC-A26AA484CD2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4" creationId="{837F1CCF-F169-1CFB-7F9B-402401FD2EE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5" creationId="{ECDDBD90-6215-8E50-4FF9-A25F1931545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6" creationId="{E2524BC4-E63F-BA5E-F6B8-AA15C24401A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7" creationId="{449EA4CF-2036-F01A-EDEE-4CF90C93DED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8" creationId="{BA00C4AC-2A75-732C-667D-BC15171D6C0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89" creationId="{FFF62C9B-5DEA-D3C7-C3CE-99A61B19D56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4" creationId="{F56C1CE8-089D-C261-8DF8-C11DFF669F6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5" creationId="{3248A607-9A53-1219-2078-5B2467583ED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98" creationId="{E58C1058-FD72-2F7B-528C-68026EC1AEB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06" creationId="{C61B6210-8D97-7703-4BFD-05CF3757588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07" creationId="{A8BCDEF0-1932-D050-7EA4-6D4982CCD0B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1" creationId="{6238CB2F-65B3-6DAB-3A9F-573FDC5657A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2" creationId="{E9C1FCEA-6490-E01F-C27D-DC03ED1AF9B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3" creationId="{3A35C103-3B66-069D-BFFA-FEF04477F7F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4" creationId="{81ABC751-DDFA-1FD8-FFF3-CA82D5193F6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6" creationId="{44B7E7F0-E894-2277-9541-01E126F3AC6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7" creationId="{E2AC9109-AE40-1616-97A4-F9388B59D5D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18" creationId="{8BCFE8D6-B1DA-1CE4-64E1-56169C4D7EB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0" creationId="{EDB01C96-6BB2-78ED-E253-EE7A72186D0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2" creationId="{56C5CEE4-9BE2-803A-12E1-E95FE066836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4" creationId="{D0F35713-6707-76B8-B2CA-E131E5AEEC5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6" creationId="{2D35C4E2-2DB7-0322-089D-ADFA59447EA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127" creationId="{8A76B3BE-6305-3092-D6E1-5320853AEDB0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171" creationId="{5103E0C0-A43F-D0E9-26C3-CFD997322F2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15" creationId="{131802D4-FD62-DC83-FE86-405BECC0C5AA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18" creationId="{F3298815-9305-CB10-9853-8B2AF8F8156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4" creationId="{C151D2B4-1E4C-80C5-7FBD-15CFB819C12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6" creationId="{B309F41F-5305-547C-2F54-2F496AA42D6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237" creationId="{89D1BCF2-D4AC-8C3F-17A1-9C25E61AACD4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295" creationId="{7E9BA595-48EE-AD01-7067-1703D560FBA6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03" creationId="{56F6A622-9BDD-3332-828E-C876E4560FE0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09" creationId="{59BF9AEA-DF00-F9B3-5F98-B7501CB2231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0" creationId="{1EF5F240-AEF8-72E9-3C23-CEA138F8550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1" creationId="{B8EF6791-1158-4708-9A41-CD908898F733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2" creationId="{C9089F88-A7E2-5192-3F75-580721F351E0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3" creationId="{94B3687A-97A1-8162-DA02-5A08EB9BA277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4" creationId="{5DAC7207-6117-B06A-89BC-088ABA7B6A05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5" creationId="{5D88F820-8544-2545-70B6-0BDC1A5C5C1E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6" creationId="{AF751193-0DF9-5599-55EE-F3E02CCEAA68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17" creationId="{AF1BA0F4-20EC-226C-B2A1-722E87497F17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1" creationId="{B48E4DE0-D0C2-B224-D68D-CB7F847EFBE1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2" creationId="{0CF15B6C-3EB2-F776-FBC5-FC00A990B539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4" creationId="{460DEB48-76D4-95E0-407D-DDA21DDCBA5F}"/>
          </ac:spMkLst>
        </pc:spChg>
        <pc:spChg chg="mod">
          <ac:chgData name="Go" userId="b11a5121-062d-4360-8951-d081ad96d999" providerId="ADAL" clId="{9F3DCE2B-CD69-4735-8D75-F97BD501C620}" dt="2022-10-06T02:27:09.450" v="144" actId="165"/>
          <ac:spMkLst>
            <pc:docMk/>
            <pc:sldMk cId="3299870256" sldId="301"/>
            <ac:spMk id="345" creationId="{3779F03F-3B36-8DA2-E323-D4E5CF787794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48" creationId="{2A461E41-4216-804B-0458-33A2868184CA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4" creationId="{C806C188-7867-D5B4-150F-4F77934B8ECB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5" creationId="{22380C95-4B15-1A66-81BF-353DE139D1E1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6" creationId="{05DF12E6-6425-A279-8DF6-B401F100E7E4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57" creationId="{EB0679B9-FB9D-D1A9-8665-BD7FA0EB5622}"/>
          </ac:spMkLst>
        </pc:spChg>
        <pc:spChg chg="mod">
          <ac:chgData name="Go" userId="b11a5121-062d-4360-8951-d081ad96d999" providerId="ADAL" clId="{9F3DCE2B-CD69-4735-8D75-F97BD501C620}" dt="2022-10-06T02:25:01.107" v="115" actId="165"/>
          <ac:spMkLst>
            <pc:docMk/>
            <pc:sldMk cId="3299870256" sldId="301"/>
            <ac:spMk id="365" creationId="{836643C2-CA20-7104-1C79-E65775AADB79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66" creationId="{5F7E0991-BECC-20EF-901D-EAB2B04864D8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68" creationId="{40317649-68F2-CA88-178D-C47C5142B84F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81" creationId="{5126D9D2-1907-A43F-5821-94A44A8E930C}"/>
          </ac:spMkLst>
        </pc:spChg>
        <pc:spChg chg="mod topLvl">
          <ac:chgData name="Go" userId="b11a5121-062d-4360-8951-d081ad96d999" providerId="ADAL" clId="{9F3DCE2B-CD69-4735-8D75-F97BD501C620}" dt="2022-10-06T02:41:12.703" v="356" actId="1076"/>
          <ac:spMkLst>
            <pc:docMk/>
            <pc:sldMk cId="3299870256" sldId="301"/>
            <ac:spMk id="383" creationId="{61A85EF3-E6C7-95D6-BA84-F36035F58FA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386" creationId="{A2558EC1-8F79-87E0-9F0A-99507D5576B2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04" creationId="{02ECC1BC-F39A-F87F-9CAA-AAC3D74418F5}"/>
          </ac:spMkLst>
        </pc:spChg>
        <pc:spChg chg="mod topLvl">
          <ac:chgData name="Go" userId="b11a5121-062d-4360-8951-d081ad96d999" providerId="ADAL" clId="{9F3DCE2B-CD69-4735-8D75-F97BD501C620}" dt="2022-10-06T02:40:53.751" v="349" actId="1076"/>
          <ac:spMkLst>
            <pc:docMk/>
            <pc:sldMk cId="3299870256" sldId="301"/>
            <ac:spMk id="405" creationId="{C923D1E9-D5B0-0DF4-CBD0-3D3506D36739}"/>
          </ac:spMkLst>
        </pc:spChg>
        <pc:spChg chg="mod topLvl">
          <ac:chgData name="Go" userId="b11a5121-062d-4360-8951-d081ad96d999" providerId="ADAL" clId="{9F3DCE2B-CD69-4735-8D75-F97BD501C620}" dt="2022-10-06T02:41:01.432" v="354" actId="1037"/>
          <ac:spMkLst>
            <pc:docMk/>
            <pc:sldMk cId="3299870256" sldId="301"/>
            <ac:spMk id="406" creationId="{0803A274-7185-EFF4-5AF0-E12E2D8EFEA3}"/>
          </ac:spMkLst>
        </pc:spChg>
        <pc:spChg chg="mod topLvl">
          <ac:chgData name="Go" userId="b11a5121-062d-4360-8951-d081ad96d999" providerId="ADAL" clId="{9F3DCE2B-CD69-4735-8D75-F97BD501C620}" dt="2022-10-06T02:41:07.288" v="355" actId="1076"/>
          <ac:spMkLst>
            <pc:docMk/>
            <pc:sldMk cId="3299870256" sldId="301"/>
            <ac:spMk id="408" creationId="{AB7599AF-4951-AA93-87B7-6A93798964A9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452" creationId="{2136A444-A366-651A-8DD2-6AF9265DE35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55" creationId="{4DA4660F-ABBE-E1BD-5B04-62B5A75AF21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56" creationId="{86E53E75-99F4-B1E6-B573-52DB085C453C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0" creationId="{5A29D108-29F5-7C8C-D1AF-996AF7E677CC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5" creationId="{ED225DD9-8CCA-9A76-EC30-5DA9B34FB8D4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466" creationId="{FE81A49E-D7DF-8994-E47D-A7017A9CFAE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68" creationId="{E95DC29B-B5FD-B227-3FFC-1E3502018B6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69" creationId="{D5A042FA-7D32-E9B3-3B81-23AD2D95A59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0" creationId="{DD6F5203-AECB-944C-E662-8247BA40D12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1" creationId="{87640FCD-6B71-365A-85C7-2D643B96436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2" creationId="{B8E3CB13-DBD7-FE2B-BF3B-A4EAEC7673D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3" creationId="{02E05548-012B-5367-9DFB-97F6A11A488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4" creationId="{C2F53A96-9F30-3C1A-CB69-52256E765E1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5" creationId="{4744D8DF-930C-3B5B-09F9-A94276C8D9B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6" creationId="{3911E389-1D35-72CE-BC08-5E50583D7DC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7" creationId="{7EEB1084-1002-B0C4-1E1C-D92645DB60E7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8" creationId="{A7F7CE73-E775-3967-291E-40028BF042A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79" creationId="{8EAA0873-B598-5BE3-8342-51E8F6DF1A8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0" creationId="{CC82C95F-5C71-C27D-4206-E11F5EB5B9F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1" creationId="{60BADF61-66FA-FD1F-153D-F3F36D85C5E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2" creationId="{DF1886F2-5957-1B28-30F3-2CD8D284277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3" creationId="{12A17A62-16A9-6466-4779-40330CF1DE0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4" creationId="{9087FF59-69FE-7709-3CE9-A9F5DB483B5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5" creationId="{17E6B6D2-622D-92E6-B57F-FA64CF50E6B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6" creationId="{5D193B9A-953C-1C54-DAEE-2F2FE396431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7" creationId="{38E7CFA7-3C01-32E1-2485-C481865A24F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8" creationId="{72C442C6-B6C5-A390-2AF4-1B5317F3FC0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89" creationId="{58847D3E-458C-7434-18F2-7DEC6FF5708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0" creationId="{DE2EACE1-B1D4-A17C-19F9-AD910B5A439C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1" creationId="{9524A231-081B-5229-0CE3-B73A72EED83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2" creationId="{B326FC93-01BC-D9EE-4496-123A9C9CA7A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493" creationId="{F37444E6-F551-0343-6775-CCD99B22E61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1" creationId="{8C6D8F70-58C2-6378-C678-38A073D3669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2" creationId="{9874BC1F-FB66-C56E-C54A-4A3D12C6C612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03" creationId="{3B8BF806-70E7-E9DB-EEAC-637882EB2953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1" creationId="{11039C50-FDC1-40E3-088C-9894CAB1FB0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3" creationId="{AB451B77-BD36-9D5E-3A42-ADC85C4A274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14" creationId="{27D74B33-A501-EFCF-CFC0-D5FF6947670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1" creationId="{20C542BB-E9AE-126F-C06F-2E3D1E9B051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3" creationId="{F343F3E4-96B9-E3F1-B27B-E6D7CEE54E7E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24" creationId="{0A7AAEA6-6BAB-0BDC-F388-EFCAF18976CA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26" creationId="{7150DCAB-0E6C-B67D-824B-2033EDAB459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2" creationId="{A657FCEA-4FF8-EBB9-EA2E-5DE85F99CD4B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3" creationId="{268130D2-72A5-6320-96B4-4CEC51FC0D9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4" creationId="{190E084B-4D3B-EE22-4F06-58112F5111B9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65" creationId="{3821EC33-988D-5E7A-366D-8526840CF9CB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566" creationId="{F84D33E0-D75B-E5DD-90F3-F58810190783}"/>
          </ac:spMkLst>
        </pc:spChg>
        <pc:spChg chg="add mod">
          <ac:chgData name="Go" userId="b11a5121-062d-4360-8951-d081ad96d999" providerId="ADAL" clId="{9F3DCE2B-CD69-4735-8D75-F97BD501C620}" dt="2022-10-06T02:26:20.422" v="133" actId="164"/>
          <ac:spMkLst>
            <pc:docMk/>
            <pc:sldMk cId="3299870256" sldId="301"/>
            <ac:spMk id="567" creationId="{0674B0C4-69D0-6BA3-FBC1-6938931A39E6}"/>
          </ac:spMkLst>
        </pc:spChg>
        <pc:spChg chg="add mod">
          <ac:chgData name="Go" userId="b11a5121-062d-4360-8951-d081ad96d999" providerId="ADAL" clId="{9F3DCE2B-CD69-4735-8D75-F97BD501C620}" dt="2022-10-06T02:26:51.843" v="140" actId="14100"/>
          <ac:spMkLst>
            <pc:docMk/>
            <pc:sldMk cId="3299870256" sldId="301"/>
            <ac:spMk id="569" creationId="{7FEE8F95-0A39-7126-223C-C6EF2690BC96}"/>
          </ac:spMkLst>
        </pc:spChg>
        <pc:spChg chg="add mod">
          <ac:chgData name="Go" userId="b11a5121-062d-4360-8951-d081ad96d999" providerId="ADAL" clId="{9F3DCE2B-CD69-4735-8D75-F97BD501C620}" dt="2022-10-06T02:27:03.098" v="143" actId="6549"/>
          <ac:spMkLst>
            <pc:docMk/>
            <pc:sldMk cId="3299870256" sldId="301"/>
            <ac:spMk id="570" creationId="{59DE02A7-C0DC-0479-0D80-A0B880F649FC}"/>
          </ac:spMkLst>
        </pc:spChg>
        <pc:spChg chg="add mod">
          <ac:chgData name="Go" userId="b11a5121-062d-4360-8951-d081ad96d999" providerId="ADAL" clId="{9F3DCE2B-CD69-4735-8D75-F97BD501C620}" dt="2022-10-06T02:26:55.376" v="141"/>
          <ac:spMkLst>
            <pc:docMk/>
            <pc:sldMk cId="3299870256" sldId="301"/>
            <ac:spMk id="571" creationId="{B5FECC4F-4C4A-CF55-3697-F1285BD8FDC6}"/>
          </ac:spMkLst>
        </pc:spChg>
        <pc:spChg chg="add mod">
          <ac:chgData name="Go" userId="b11a5121-062d-4360-8951-d081ad96d999" providerId="ADAL" clId="{9F3DCE2B-CD69-4735-8D75-F97BD501C620}" dt="2022-10-06T02:26:46.155" v="138" actId="14100"/>
          <ac:spMkLst>
            <pc:docMk/>
            <pc:sldMk cId="3299870256" sldId="301"/>
            <ac:spMk id="572" creationId="{A0827BB1-6801-B6D2-2367-75A2600B37A0}"/>
          </ac:spMkLst>
        </pc:spChg>
        <pc:spChg chg="mod topLvl">
          <ac:chgData name="Go" userId="b11a5121-062d-4360-8951-d081ad96d999" providerId="ADAL" clId="{9F3DCE2B-CD69-4735-8D75-F97BD501C620}" dt="2022-10-06T02:39:08.977" v="300" actId="164"/>
          <ac:spMkLst>
            <pc:docMk/>
            <pc:sldMk cId="3299870256" sldId="301"/>
            <ac:spMk id="576" creationId="{B3051111-6CD4-B04F-9F5B-F260D6C89BD5}"/>
          </ac:spMkLst>
        </pc:spChg>
        <pc:spChg chg="mod topLvl">
          <ac:chgData name="Go" userId="b11a5121-062d-4360-8951-d081ad96d999" providerId="ADAL" clId="{9F3DCE2B-CD69-4735-8D75-F97BD501C620}" dt="2022-10-06T02:39:08.977" v="300" actId="164"/>
          <ac:spMkLst>
            <pc:docMk/>
            <pc:sldMk cId="3299870256" sldId="301"/>
            <ac:spMk id="577" creationId="{291D8301-F5B4-C87F-E0CE-35783993D7FC}"/>
          </ac:spMkLst>
        </pc:spChg>
        <pc:spChg chg="mod topLvl">
          <ac:chgData name="Go" userId="b11a5121-062d-4360-8951-d081ad96d999" providerId="ADAL" clId="{9F3DCE2B-CD69-4735-8D75-F97BD501C620}" dt="2022-10-06T02:39:12.753" v="301" actId="164"/>
          <ac:spMkLst>
            <pc:docMk/>
            <pc:sldMk cId="3299870256" sldId="301"/>
            <ac:spMk id="578" creationId="{39F090BB-F7CE-9A2D-DB70-190E68C5EB83}"/>
          </ac:spMkLst>
        </pc:spChg>
        <pc:spChg chg="mod topLvl">
          <ac:chgData name="Go" userId="b11a5121-062d-4360-8951-d081ad96d999" providerId="ADAL" clId="{9F3DCE2B-CD69-4735-8D75-F97BD501C620}" dt="2022-10-06T02:39:12.753" v="301" actId="164"/>
          <ac:spMkLst>
            <pc:docMk/>
            <pc:sldMk cId="3299870256" sldId="301"/>
            <ac:spMk id="579" creationId="{0F2B4379-20AA-5B82-9C7E-6CD3C418FAD9}"/>
          </ac:spMkLst>
        </pc:spChg>
        <pc:spChg chg="mod topLvl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80" creationId="{7792413A-1C5F-F801-4015-D5F0C3EBE6AD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586" creationId="{205EBF96-3975-9EBB-82BF-524229ADCA5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0" creationId="{AA06D570-6CA8-78A8-4078-0DCECA1A2914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1" creationId="{DAF03CD4-6585-0520-B5E5-596E496FC8D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2" creationId="{68E2104F-A94A-2856-1246-CD9535F3C81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3" creationId="{73CD0F0F-1DC2-2D06-FBAB-0AD204A2C89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4" creationId="{7AC4DDB0-14D2-7C48-BB54-FD55593DF778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5" creationId="{A38E2007-370C-1F1D-947C-193A8785E42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596" creationId="{D90BAA66-82BF-AB0E-F44E-A36937766776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19" creationId="{449E51EC-10A4-27BD-9A52-B3764E537BCF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1" creationId="{CD1F8E55-9517-768F-F486-09E3E8CD2121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2" creationId="{34E3AA86-8CB3-AEFE-8E81-B5D67BC7EA65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3" creationId="{8C025F04-1C7C-D904-4E2F-58041B5E43FD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4" creationId="{056594E1-727B-F8A1-7873-ACB7CE51EE0A}"/>
          </ac:spMkLst>
        </pc:spChg>
        <pc:spChg chg="mod">
          <ac:chgData name="Go" userId="b11a5121-062d-4360-8951-d081ad96d999" providerId="ADAL" clId="{9F3DCE2B-CD69-4735-8D75-F97BD501C620}" dt="2022-10-06T02:35:20.501" v="220"/>
          <ac:spMkLst>
            <pc:docMk/>
            <pc:sldMk cId="3299870256" sldId="301"/>
            <ac:spMk id="625" creationId="{2DEC7FC4-B77B-41B9-39FB-F34AC4A598DE}"/>
          </ac:spMkLst>
        </pc:spChg>
        <pc:spChg chg="mod">
          <ac:chgData name="Go" userId="b11a5121-062d-4360-8951-d081ad96d999" providerId="ADAL" clId="{9F3DCE2B-CD69-4735-8D75-F97BD501C620}" dt="2022-10-06T03:01:28.049" v="365" actId="1035"/>
          <ac:spMkLst>
            <pc:docMk/>
            <pc:sldMk cId="3299870256" sldId="301"/>
            <ac:spMk id="629" creationId="{F9EE2836-7AC4-31A7-0E13-A86BEF57BE09}"/>
          </ac:spMkLst>
        </pc:s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3" creationId="{3A15472C-E09F-4095-A18E-A09C1E12E157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" creationId="{2D984CF2-E6E5-BE37-045A-A523D153C1F2}"/>
          </ac:grpSpMkLst>
        </pc:grpChg>
        <pc:grpChg chg="mod topLvl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" creationId="{1388BBF7-D2F6-5B7B-E265-EEFCCE94891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9" creationId="{6DD48C8D-2E56-FC23-39A6-9849EF8614D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0" creationId="{22BC352B-0776-C75B-AFCE-B2F4DA4B02D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3" creationId="{1E099AC9-B6D4-462F-43ED-2B932B9309F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4" creationId="{9F868A2D-1438-4051-AF94-B48BE5A5D4A5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5" creationId="{EB21658D-98D4-B8CE-DB71-377C482A4C7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8" creationId="{6AEEC1AF-D955-9805-31DF-521E0F8EECF7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19" creationId="{DCFDA3C9-95DA-84E5-B03B-630323BBD700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20" creationId="{E21F8CEC-E83B-F070-D777-299FA4EAFA32}"/>
          </ac:grpSpMkLst>
        </pc:grpChg>
        <pc:grpChg chg="del">
          <ac:chgData name="Go" userId="b11a5121-062d-4360-8951-d081ad96d999" providerId="ADAL" clId="{9F3DCE2B-CD69-4735-8D75-F97BD501C620}" dt="2022-10-06T02:19:21.711" v="86" actId="478"/>
          <ac:grpSpMkLst>
            <pc:docMk/>
            <pc:sldMk cId="3299870256" sldId="301"/>
            <ac:grpSpMk id="21" creationId="{4C4BFF3F-907D-5187-7CB9-14A7EFEEED2A}"/>
          </ac:grpSpMkLst>
        </pc:grpChg>
        <pc:grpChg chg="del mod topLvl">
          <ac:chgData name="Go" userId="b11a5121-062d-4360-8951-d081ad96d999" providerId="ADAL" clId="{9F3DCE2B-CD69-4735-8D75-F97BD501C620}" dt="2022-10-06T02:25:01.107" v="115" actId="165"/>
          <ac:grpSpMkLst>
            <pc:docMk/>
            <pc:sldMk cId="3299870256" sldId="301"/>
            <ac:grpSpMk id="26" creationId="{0BA1BCA1-5FC4-0C49-C14F-40FB8ED755B9}"/>
          </ac:grpSpMkLst>
        </pc:grpChg>
        <pc:grpChg chg="del mod topLvl">
          <ac:chgData name="Go" userId="b11a5121-062d-4360-8951-d081ad96d999" providerId="ADAL" clId="{9F3DCE2B-CD69-4735-8D75-F97BD501C620}" dt="2022-10-06T02:25:05.203" v="116" actId="478"/>
          <ac:grpSpMkLst>
            <pc:docMk/>
            <pc:sldMk cId="3299870256" sldId="301"/>
            <ac:grpSpMk id="32" creationId="{C5C02679-FE29-E5DC-3B04-0FEEB2230AC0}"/>
          </ac:grpSpMkLst>
        </pc:grpChg>
        <pc:grpChg chg="del mod">
          <ac:chgData name="Go" userId="b11a5121-062d-4360-8951-d081ad96d999" providerId="ADAL" clId="{9F3DCE2B-CD69-4735-8D75-F97BD501C620}" dt="2022-10-06T02:24:54.472" v="114" actId="165"/>
          <ac:grpSpMkLst>
            <pc:docMk/>
            <pc:sldMk cId="3299870256" sldId="301"/>
            <ac:grpSpMk id="33" creationId="{F87A5B70-5377-48A3-675A-7BB159218FC4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35" creationId="{3B5D5338-4068-0B8B-9A3F-750DB95A2FDC}"/>
          </ac:grpSpMkLst>
        </pc:grpChg>
        <pc:grpChg chg="del mod topLvl">
          <ac:chgData name="Go" userId="b11a5121-062d-4360-8951-d081ad96d999" providerId="ADAL" clId="{9F3DCE2B-CD69-4735-8D75-F97BD501C620}" dt="2022-10-06T02:27:09.450" v="144" actId="165"/>
          <ac:grpSpMkLst>
            <pc:docMk/>
            <pc:sldMk cId="3299870256" sldId="301"/>
            <ac:grpSpMk id="37" creationId="{C9AA53E6-8F5E-1970-A858-EA458C600559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2" creationId="{B7ABF30E-0DAA-79EC-3373-2A1384ED35EE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" creationId="{CA2DC73B-0DCA-BD1A-690E-97E31DECD1A1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6" creationId="{D1FC1DCA-D234-F33B-B943-D3EC23252ADD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8" creationId="{9FBB999A-C9A9-63E3-4497-9E82FE676455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9" creationId="{229C6446-E3E8-E694-9D74-5E2F97B0E3BC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0" creationId="{2494B6E0-8512-E611-C1B9-FB4744D3EE4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4" creationId="{E0F5D351-A7F5-BEAB-DA1C-80547F9DD3E0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58" creationId="{50A49278-9C09-11F2-7571-2FABA095C600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9" creationId="{6C9199C7-9E8F-87D8-5B0D-213EBCB0BABD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2" creationId="{C8E36A41-226C-3052-0ADB-0BB617BAD256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29" creationId="{89124929-017B-F717-C116-73761B755524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0" creationId="{2B0E73FB-59F0-E7D2-0310-1FD156327979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1" creationId="{5EA6E0E4-6A72-08B5-0EB1-47721D704954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5" creationId="{A265201B-D5B5-EEB9-D592-E9EF89CB9301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6" creationId="{660071C4-AF1A-F11A-7193-C5071E39C7E7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7" creationId="{6ED48973-95E0-357D-AC36-20D3666319FF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138" creationId="{C1E8B024-5731-5476-C6B6-95AA4CAD3B03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265" creationId="{58D7A5F3-D98F-4285-EE18-1B7425AB048A}"/>
          </ac:grpSpMkLst>
        </pc:grpChg>
        <pc:grpChg chg="del mod topLvl">
          <ac:chgData name="Go" userId="b11a5121-062d-4360-8951-d081ad96d999" providerId="ADAL" clId="{9F3DCE2B-CD69-4735-8D75-F97BD501C620}" dt="2022-10-06T02:27:18.765" v="147" actId="478"/>
          <ac:grpSpMkLst>
            <pc:docMk/>
            <pc:sldMk cId="3299870256" sldId="301"/>
            <ac:grpSpMk id="294" creationId="{16B64ABB-AAB7-D70E-E2F1-5D23EAEE781C}"/>
          </ac:grpSpMkLst>
        </pc:grpChg>
        <pc:grpChg chg="del mod topLvl">
          <ac:chgData name="Go" userId="b11a5121-062d-4360-8951-d081ad96d999" providerId="ADAL" clId="{9F3DCE2B-CD69-4735-8D75-F97BD501C620}" dt="2022-10-06T02:27:12.746" v="146" actId="478"/>
          <ac:grpSpMkLst>
            <pc:docMk/>
            <pc:sldMk cId="3299870256" sldId="301"/>
            <ac:grpSpMk id="340" creationId="{6978A1B5-46A4-5B6A-79C9-71083DA3C80C}"/>
          </ac:grpSpMkLst>
        </pc:grpChg>
        <pc:grpChg chg="del mod topLvl">
          <ac:chgData name="Go" userId="b11a5121-062d-4360-8951-d081ad96d999" providerId="ADAL" clId="{9F3DCE2B-CD69-4735-8D75-F97BD501C620}" dt="2022-10-06T02:25:06.866" v="117" actId="478"/>
          <ac:grpSpMkLst>
            <pc:docMk/>
            <pc:sldMk cId="3299870256" sldId="301"/>
            <ac:grpSpMk id="353" creationId="{FD21445C-3153-DE45-74B6-F1410920582C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3" creationId="{5BAB4F1C-9B77-0EE4-3B0E-C89DF28CDA19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454" creationId="{9A5D5962-E869-7093-4002-36410AA5D696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464" creationId="{17C21720-62CF-2EB6-2C65-7D0429926D99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68" creationId="{706C3840-D8CA-33D8-4500-9CF9E3C9CD63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73" creationId="{FBA6C53D-B473-F3A3-9284-0CA75D11F752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74" creationId="{09B9E57B-C211-879A-4E02-D57C8D7370D5}"/>
          </ac:grpSpMkLst>
        </pc:grpChg>
        <pc:grpChg chg="add del mod">
          <ac:chgData name="Go" userId="b11a5121-062d-4360-8951-d081ad96d999" providerId="ADAL" clId="{9F3DCE2B-CD69-4735-8D75-F97BD501C620}" dt="2022-10-06T02:38:58.369" v="299" actId="165"/>
          <ac:grpSpMkLst>
            <pc:docMk/>
            <pc:sldMk cId="3299870256" sldId="301"/>
            <ac:grpSpMk id="575" creationId="{B920F064-3CFB-215B-A207-B4908F644B6C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81" creationId="{4E21338A-FC59-5D0F-6590-E5BBA4062FCA}"/>
          </ac:grpSpMkLst>
        </pc:grpChg>
        <pc:grpChg chg="add 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582" creationId="{8285CAB0-3863-6BEB-31C1-2CA27C7772CF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09" creationId="{5933C05E-F357-C1AA-C0E5-AB0366B3323F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0" creationId="{9E51DE33-5F23-372E-E897-B37F4B9D38B7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1" creationId="{B5383931-008B-27A4-8551-928741CA87C8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2" creationId="{AA7BD866-A642-E072-CB03-E6EC90E03463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3" creationId="{384C9D67-922B-5FE4-F5BE-2EDEE970B4F6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4" creationId="{2A68A7DF-F9C9-5046-85AB-EC2E5E9C691E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5" creationId="{B51C6E7A-1939-D71C-0980-ADDC1E6F759A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6" creationId="{A235A10B-0046-850D-E367-6FAB78643C13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7" creationId="{479189AC-07BA-8F0E-3FB2-7C45473B6F09}"/>
          </ac:grpSpMkLst>
        </pc:grpChg>
        <pc:grpChg chg="mod">
          <ac:chgData name="Go" userId="b11a5121-062d-4360-8951-d081ad96d999" providerId="ADAL" clId="{9F3DCE2B-CD69-4735-8D75-F97BD501C620}" dt="2022-10-06T02:35:20.501" v="220"/>
          <ac:grpSpMkLst>
            <pc:docMk/>
            <pc:sldMk cId="3299870256" sldId="301"/>
            <ac:grpSpMk id="618" creationId="{E1536666-8D1C-1255-C1E9-4C42CCAEDEF8}"/>
          </ac:grpSpMkLst>
        </pc:grpChg>
        <pc:grpChg chg="mod">
          <ac:chgData name="Go" userId="b11a5121-062d-4360-8951-d081ad96d999" providerId="ADAL" clId="{9F3DCE2B-CD69-4735-8D75-F97BD501C620}" dt="2022-10-06T03:01:28.049" v="365" actId="1035"/>
          <ac:grpSpMkLst>
            <pc:docMk/>
            <pc:sldMk cId="3299870256" sldId="301"/>
            <ac:grpSpMk id="639" creationId="{1DE898C2-E809-2B55-CF57-DE7A01B03F65}"/>
          </ac:grpSpMkLst>
        </pc:grpChg>
        <pc:graphicFrameChg chg="add mod ord">
          <ac:chgData name="Go" userId="b11a5121-062d-4360-8951-d081ad96d999" providerId="ADAL" clId="{9F3DCE2B-CD69-4735-8D75-F97BD501C620}" dt="2022-10-06T03:01:28.049" v="365" actId="1035"/>
          <ac:graphicFrameMkLst>
            <pc:docMk/>
            <pc:sldMk cId="3299870256" sldId="301"/>
            <ac:graphicFrameMk id="2" creationId="{1AD00D3D-FBDC-C399-AE11-A003C5D2BB23}"/>
          </ac:graphicFrameMkLst>
        </pc:graphicFrameChg>
        <pc:graphicFrameChg chg="mod">
          <ac:chgData name="Go" userId="b11a5121-062d-4360-8951-d081ad96d999" providerId="ADAL" clId="{9F3DCE2B-CD69-4735-8D75-F97BD501C620}" dt="2022-10-06T02:35:20.501" v="220"/>
          <ac:graphicFrameMkLst>
            <pc:docMk/>
            <pc:sldMk cId="3299870256" sldId="301"/>
            <ac:graphicFrameMk id="7" creationId="{29619FA3-5320-80AE-05A1-1DFE07FA76AF}"/>
          </ac:graphicFrameMkLst>
        </pc:graphicFrameChg>
        <pc:graphicFrameChg chg="mod">
          <ac:chgData name="Go" userId="b11a5121-062d-4360-8951-d081ad96d999" providerId="ADAL" clId="{9F3DCE2B-CD69-4735-8D75-F97BD501C620}" dt="2022-10-06T03:01:28.049" v="365" actId="1035"/>
          <ac:graphicFrameMkLst>
            <pc:docMk/>
            <pc:sldMk cId="3299870256" sldId="301"/>
            <ac:graphicFrameMk id="39" creationId="{A19956A4-38A4-0919-E076-3ECBAC5CB58A}"/>
          </ac:graphicFrameMkLst>
        </pc:graphicFrameChg>
        <pc:graphicFrameChg chg="del mod topLvl">
          <ac:chgData name="Go" userId="b11a5121-062d-4360-8951-d081ad96d999" providerId="ADAL" clId="{9F3DCE2B-CD69-4735-8D75-F97BD501C620}" dt="2022-10-06T02:25:47.036" v="126" actId="478"/>
          <ac:graphicFrameMkLst>
            <pc:docMk/>
            <pc:sldMk cId="3299870256" sldId="301"/>
            <ac:graphicFrameMk id="214" creationId="{3A7A70EC-40DB-875B-87FC-ADBA3AA62B73}"/>
          </ac:graphicFrameMkLst>
        </pc:graphicFrameChg>
        <pc:picChg chg="del topLvl">
          <ac:chgData name="Go" userId="b11a5121-062d-4360-8951-d081ad96d999" providerId="ADAL" clId="{9F3DCE2B-CD69-4735-8D75-F97BD501C620}" dt="2022-10-06T02:19:21.711" v="86" actId="478"/>
          <ac:picMkLst>
            <pc:docMk/>
            <pc:sldMk cId="3299870256" sldId="301"/>
            <ac:picMk id="267" creationId="{56C78E99-E031-09B9-7725-4188B39EFF2C}"/>
          </ac:picMkLst>
        </pc:picChg>
      </pc:sldChg>
    </pc:docChg>
  </pc:docChgLst>
  <pc:docChgLst>
    <pc:chgData name="Go" userId="b11a5121-062d-4360-8951-d081ad96d999" providerId="ADAL" clId="{52F29124-2773-4FC9-A15B-0DFCA3E9DA52}"/>
    <pc:docChg chg="undo custSel modSld">
      <pc:chgData name="Go" userId="b11a5121-062d-4360-8951-d081ad96d999" providerId="ADAL" clId="{52F29124-2773-4FC9-A15B-0DFCA3E9DA52}" dt="2022-10-13T06:03:31.608" v="99" actId="6549"/>
      <pc:docMkLst>
        <pc:docMk/>
      </pc:docMkLst>
      <pc:sldChg chg="addSp delSp modSp mod">
        <pc:chgData name="Go" userId="b11a5121-062d-4360-8951-d081ad96d999" providerId="ADAL" clId="{52F29124-2773-4FC9-A15B-0DFCA3E9DA52}" dt="2022-10-13T06:03:31.608" v="99" actId="6549"/>
        <pc:sldMkLst>
          <pc:docMk/>
          <pc:sldMk cId="4198847848" sldId="289"/>
        </pc:sldMkLst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6" creationId="{1371575E-03FE-EE70-76FF-FA71A80DCB10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2" creationId="{862C96C3-B678-4FDB-79C7-BD9FF90DBB5B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4" creationId="{46907438-93BD-1BB7-73D0-42587FA78A56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15" creationId="{330CE62C-3F93-475E-1991-04687F7380DF}"/>
          </ac:spMkLst>
        </pc:spChg>
        <pc:spChg chg="mod">
          <ac:chgData name="Go" userId="b11a5121-062d-4360-8951-d081ad96d999" providerId="ADAL" clId="{52F29124-2773-4FC9-A15B-0DFCA3E9DA52}" dt="2022-10-13T06:03:13.558" v="89"/>
          <ac:spMkLst>
            <pc:docMk/>
            <pc:sldMk cId="4198847848" sldId="289"/>
            <ac:spMk id="19" creationId="{7D68F769-E8DD-44CF-A4E5-1312488851B5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0" creationId="{1E5638A1-D88D-1784-8C3B-1B8361927869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2" creationId="{36E91FB9-4892-1F8E-353E-FF9EB925FD47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3" creationId="{8F56171D-F7BE-E561-DC43-A9B6735F84A4}"/>
          </ac:spMkLst>
        </pc:spChg>
        <pc:spChg chg="mod topLvl">
          <ac:chgData name="Go" userId="b11a5121-062d-4360-8951-d081ad96d999" providerId="ADAL" clId="{52F29124-2773-4FC9-A15B-0DFCA3E9DA52}" dt="2022-10-13T05:59:26.328" v="49" actId="165"/>
          <ac:spMkLst>
            <pc:docMk/>
            <pc:sldMk cId="4198847848" sldId="289"/>
            <ac:spMk id="25" creationId="{68F4F58B-8832-9843-D9CE-23AFF4B8F241}"/>
          </ac:spMkLst>
        </pc:spChg>
        <pc:spChg chg="del mod topLvl">
          <ac:chgData name="Go" userId="b11a5121-062d-4360-8951-d081ad96d999" providerId="ADAL" clId="{52F29124-2773-4FC9-A15B-0DFCA3E9DA52}" dt="2022-10-13T06:02:23.728" v="69" actId="478"/>
          <ac:spMkLst>
            <pc:docMk/>
            <pc:sldMk cId="4198847848" sldId="289"/>
            <ac:spMk id="26" creationId="{C7291577-3B2B-CF92-110E-2F3C3AF1C20E}"/>
          </ac:spMkLst>
        </pc:spChg>
        <pc:spChg chg="mod topLvl">
          <ac:chgData name="Go" userId="b11a5121-062d-4360-8951-d081ad96d999" providerId="ADAL" clId="{52F29124-2773-4FC9-A15B-0DFCA3E9DA52}" dt="2022-10-13T06:02:18.358" v="68" actId="164"/>
          <ac:spMkLst>
            <pc:docMk/>
            <pc:sldMk cId="4198847848" sldId="289"/>
            <ac:spMk id="29" creationId="{0859BD14-4FA4-0795-E0EB-5AAE01B9CCD5}"/>
          </ac:spMkLst>
        </pc:spChg>
        <pc:spChg chg="mod">
          <ac:chgData name="Go" userId="b11a5121-062d-4360-8951-d081ad96d999" providerId="ADAL" clId="{52F29124-2773-4FC9-A15B-0DFCA3E9DA52}" dt="2022-10-13T06:02:43.058" v="77" actId="14100"/>
          <ac:spMkLst>
            <pc:docMk/>
            <pc:sldMk cId="4198847848" sldId="289"/>
            <ac:spMk id="30" creationId="{FC148F42-5523-6278-2C5F-3B069D4677E0}"/>
          </ac:spMkLst>
        </pc:spChg>
        <pc:spChg chg="mod">
          <ac:chgData name="Go" userId="b11a5121-062d-4360-8951-d081ad96d999" providerId="ADAL" clId="{52F29124-2773-4FC9-A15B-0DFCA3E9DA52}" dt="2022-10-13T06:02:40.849" v="76" actId="14100"/>
          <ac:spMkLst>
            <pc:docMk/>
            <pc:sldMk cId="4198847848" sldId="289"/>
            <ac:spMk id="31" creationId="{4B0C0D4E-C485-800D-136E-3B5190E9C0AF}"/>
          </ac:spMkLst>
        </pc:spChg>
        <pc:spChg chg="mod">
          <ac:chgData name="Go" userId="b11a5121-062d-4360-8951-d081ad96d999" providerId="ADAL" clId="{52F29124-2773-4FC9-A15B-0DFCA3E9DA52}" dt="2022-10-13T06:02:02.488" v="65" actId="165"/>
          <ac:spMkLst>
            <pc:docMk/>
            <pc:sldMk cId="4198847848" sldId="289"/>
            <ac:spMk id="33" creationId="{2C118948-231F-1F9D-09C3-4B4F5BA9B6A0}"/>
          </ac:spMkLst>
        </pc:spChg>
        <pc:spChg chg="mod">
          <ac:chgData name="Go" userId="b11a5121-062d-4360-8951-d081ad96d999" providerId="ADAL" clId="{52F29124-2773-4FC9-A15B-0DFCA3E9DA52}" dt="2022-10-13T06:02:28.228" v="70" actId="14100"/>
          <ac:spMkLst>
            <pc:docMk/>
            <pc:sldMk cId="4198847848" sldId="289"/>
            <ac:spMk id="34" creationId="{830A266A-048F-1F68-B3E0-F65F808C7741}"/>
          </ac:spMkLst>
        </pc:spChg>
        <pc:spChg chg="mod">
          <ac:chgData name="Go" userId="b11a5121-062d-4360-8951-d081ad96d999" providerId="ADAL" clId="{52F29124-2773-4FC9-A15B-0DFCA3E9DA52}" dt="2022-10-13T06:02:29.898" v="71" actId="14100"/>
          <ac:spMkLst>
            <pc:docMk/>
            <pc:sldMk cId="4198847848" sldId="289"/>
            <ac:spMk id="35" creationId="{5400C05B-D17B-E886-3BA9-7F75EDADED5E}"/>
          </ac:spMkLst>
        </pc:spChg>
        <pc:spChg chg="mod">
          <ac:chgData name="Go" userId="b11a5121-062d-4360-8951-d081ad96d999" providerId="ADAL" clId="{52F29124-2773-4FC9-A15B-0DFCA3E9DA52}" dt="2022-10-13T06:02:02.488" v="65" actId="165"/>
          <ac:spMkLst>
            <pc:docMk/>
            <pc:sldMk cId="4198847848" sldId="289"/>
            <ac:spMk id="36" creationId="{7FF9410D-73F7-EB65-E0FF-E2112266A595}"/>
          </ac:spMkLst>
        </pc:spChg>
        <pc:spChg chg="add del mod">
          <ac:chgData name="Go" userId="b11a5121-062d-4360-8951-d081ad96d999" providerId="ADAL" clId="{52F29124-2773-4FC9-A15B-0DFCA3E9DA52}" dt="2022-10-13T06:01:32.518" v="56"/>
          <ac:spMkLst>
            <pc:docMk/>
            <pc:sldMk cId="4198847848" sldId="289"/>
            <ac:spMk id="37" creationId="{E1C7FEAE-40E1-AD62-FABA-24EF613FC5BB}"/>
          </ac:spMkLst>
        </pc:spChg>
        <pc:spChg chg="mod">
          <ac:chgData name="Go" userId="b11a5121-062d-4360-8951-d081ad96d999" providerId="ADAL" clId="{52F29124-2773-4FC9-A15B-0DFCA3E9DA52}" dt="2022-10-13T06:03:03.298" v="84" actId="20577"/>
          <ac:spMkLst>
            <pc:docMk/>
            <pc:sldMk cId="4198847848" sldId="289"/>
            <ac:spMk id="56" creationId="{591B5E2C-071D-1FA3-516C-A23252F4EAE0}"/>
          </ac:spMkLst>
        </pc:spChg>
        <pc:spChg chg="add mod">
          <ac:chgData name="Go" userId="b11a5121-062d-4360-8951-d081ad96d999" providerId="ADAL" clId="{52F29124-2773-4FC9-A15B-0DFCA3E9DA52}" dt="2022-10-13T06:03:31.608" v="99" actId="6549"/>
          <ac:spMkLst>
            <pc:docMk/>
            <pc:sldMk cId="4198847848" sldId="289"/>
            <ac:spMk id="59" creationId="{638D4131-CD65-E2A2-5377-7594633FFA79}"/>
          </ac:spMkLst>
        </pc:spChg>
        <pc:spChg chg="mod">
          <ac:chgData name="Go" userId="b11a5121-062d-4360-8951-d081ad96d999" providerId="ADAL" clId="{52F29124-2773-4FC9-A15B-0DFCA3E9DA52}" dt="2022-10-13T06:03:16.368" v="94"/>
          <ac:spMkLst>
            <pc:docMk/>
            <pc:sldMk cId="4198847848" sldId="289"/>
            <ac:spMk id="69" creationId="{ECFCF99C-38AB-4DC4-A277-DFC8A3B1ECDF}"/>
          </ac:spMkLst>
        </pc:spChg>
        <pc:spChg chg="ord">
          <ac:chgData name="Go" userId="b11a5121-062d-4360-8951-d081ad96d999" providerId="ADAL" clId="{52F29124-2773-4FC9-A15B-0DFCA3E9DA52}" dt="2022-10-13T06:01:39.228" v="57" actId="167"/>
          <ac:spMkLst>
            <pc:docMk/>
            <pc:sldMk cId="4198847848" sldId="289"/>
            <ac:spMk id="74" creationId="{EA64EB29-ADCA-73ED-7718-2E8F06FCEFA9}"/>
          </ac:spMkLst>
        </pc:spChg>
        <pc:grpChg chg="mod">
          <ac:chgData name="Go" userId="b11a5121-062d-4360-8951-d081ad96d999" providerId="ADAL" clId="{52F29124-2773-4FC9-A15B-0DFCA3E9DA52}" dt="2022-10-13T05:48:39.978" v="43" actId="1038"/>
          <ac:grpSpMkLst>
            <pc:docMk/>
            <pc:sldMk cId="4198847848" sldId="289"/>
            <ac:grpSpMk id="2" creationId="{B2FD1FFB-4E78-0C3D-A641-8046DE08B520}"/>
          </ac:grpSpMkLst>
        </pc:grpChg>
        <pc:grpChg chg="add del mod">
          <ac:chgData name="Go" userId="b11a5121-062d-4360-8951-d081ad96d999" providerId="ADAL" clId="{52F29124-2773-4FC9-A15B-0DFCA3E9DA52}" dt="2022-10-13T05:59:26.328" v="49" actId="165"/>
          <ac:grpSpMkLst>
            <pc:docMk/>
            <pc:sldMk cId="4198847848" sldId="289"/>
            <ac:grpSpMk id="3" creationId="{9FCC5441-2205-C08C-6D50-7D141B324DC7}"/>
          </ac:grpSpMkLst>
        </pc:grpChg>
        <pc:grpChg chg="del mod topLvl">
          <ac:chgData name="Go" userId="b11a5121-062d-4360-8951-d081ad96d999" providerId="ADAL" clId="{52F29124-2773-4FC9-A15B-0DFCA3E9DA52}" dt="2022-10-13T06:02:02.488" v="65" actId="165"/>
          <ac:grpSpMkLst>
            <pc:docMk/>
            <pc:sldMk cId="4198847848" sldId="289"/>
            <ac:grpSpMk id="8" creationId="{24E21BA2-1B5B-917F-B506-20D2BE47DF70}"/>
          </ac:grpSpMkLst>
        </pc:grpChg>
        <pc:grpChg chg="mod topLvl">
          <ac:chgData name="Go" userId="b11a5121-062d-4360-8951-d081ad96d999" providerId="ADAL" clId="{52F29124-2773-4FC9-A15B-0DFCA3E9DA52}" dt="2022-10-13T06:02:02.488" v="65" actId="165"/>
          <ac:grpSpMkLst>
            <pc:docMk/>
            <pc:sldMk cId="4198847848" sldId="289"/>
            <ac:grpSpMk id="27" creationId="{075889E4-E48A-F0E3-C5D2-CEC000F97771}"/>
          </ac:grpSpMkLst>
        </pc:grpChg>
        <pc:grpChg chg="mod topLvl">
          <ac:chgData name="Go" userId="b11a5121-062d-4360-8951-d081ad96d999" providerId="ADAL" clId="{52F29124-2773-4FC9-A15B-0DFCA3E9DA52}" dt="2022-10-13T06:02:33.718" v="73" actId="14100"/>
          <ac:grpSpMkLst>
            <pc:docMk/>
            <pc:sldMk cId="4198847848" sldId="289"/>
            <ac:grpSpMk id="28" creationId="{B2BC3338-3EEF-6A44-68D8-885DD23C1818}"/>
          </ac:grpSpMkLst>
        </pc:grpChg>
        <pc:grpChg chg="add mod">
          <ac:chgData name="Go" userId="b11a5121-062d-4360-8951-d081ad96d999" providerId="ADAL" clId="{52F29124-2773-4FC9-A15B-0DFCA3E9DA52}" dt="2022-10-13T06:02:58.198" v="80" actId="554"/>
          <ac:grpSpMkLst>
            <pc:docMk/>
            <pc:sldMk cId="4198847848" sldId="289"/>
            <ac:grpSpMk id="45" creationId="{2DFEA9BC-4E4D-469F-F722-637BB01AF58C}"/>
          </ac:grpSpMkLst>
        </pc:grpChg>
        <pc:grpChg chg="add mod">
          <ac:chgData name="Go" userId="b11a5121-062d-4360-8951-d081ad96d999" providerId="ADAL" clId="{52F29124-2773-4FC9-A15B-0DFCA3E9DA52}" dt="2022-10-13T06:02:58.198" v="80" actId="554"/>
          <ac:grpSpMkLst>
            <pc:docMk/>
            <pc:sldMk cId="4198847848" sldId="289"/>
            <ac:grpSpMk id="55" creationId="{26809872-AEDA-55C9-D4EF-8B78CEE05A9F}"/>
          </ac:grpSpMkLst>
        </pc:grp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4" creationId="{C61A9ACD-A35E-CABF-DC0F-DFC3FE911A68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5" creationId="{D529FFCD-96DD-2085-D658-05BE8822553F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7" creationId="{570C03D4-9885-1DE9-A161-07890068A4F9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0" creationId="{47239B5B-AE66-30F7-4FE8-F032BB78F5AE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3" creationId="{6384335C-79AE-8172-D5DF-7529DDE9B744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6" creationId="{4A4092D2-96F2-FA8F-E9AB-2569B80AAA70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17" creationId="{C2F012C9-F323-36DA-07F4-CEA68E0FBAF6}"/>
          </ac:picMkLst>
        </pc:picChg>
        <pc:picChg chg="mod topLvl">
          <ac:chgData name="Go" userId="b11a5121-062d-4360-8951-d081ad96d999" providerId="ADAL" clId="{52F29124-2773-4FC9-A15B-0DFCA3E9DA52}" dt="2022-10-13T05:59:26.328" v="49" actId="165"/>
          <ac:picMkLst>
            <pc:docMk/>
            <pc:sldMk cId="4198847848" sldId="289"/>
            <ac:picMk id="24" creationId="{7158A9C9-E5E3-F9F3-6597-D9E12877E31C}"/>
          </ac:picMkLst>
        </pc:picChg>
        <pc:cxnChg chg="add mod">
          <ac:chgData name="Go" userId="b11a5121-062d-4360-8951-d081ad96d999" providerId="ADAL" clId="{52F29124-2773-4FC9-A15B-0DFCA3E9DA52}" dt="2022-10-13T06:02:18.358" v="68" actId="164"/>
          <ac:cxnSpMkLst>
            <pc:docMk/>
            <pc:sldMk cId="4198847848" sldId="289"/>
            <ac:cxnSpMk id="38" creationId="{5BD417B4-8375-6009-ED5A-2BFA8E28E7E7}"/>
          </ac:cxnSpMkLst>
        </pc:cxnChg>
        <pc:cxnChg chg="mod">
          <ac:chgData name="Go" userId="b11a5121-062d-4360-8951-d081ad96d999" providerId="ADAL" clId="{52F29124-2773-4FC9-A15B-0DFCA3E9DA52}" dt="2022-10-13T06:02:49.548" v="78"/>
          <ac:cxnSpMkLst>
            <pc:docMk/>
            <pc:sldMk cId="4198847848" sldId="289"/>
            <ac:cxnSpMk id="58" creationId="{1E81D1DD-D381-72F3-3ABE-D9D10DA53938}"/>
          </ac:cxnSpMkLst>
        </pc:cxnChg>
      </pc:sldChg>
      <pc:sldChg chg="modSp mod">
        <pc:chgData name="Go" userId="b11a5121-062d-4360-8951-d081ad96d999" providerId="ADAL" clId="{52F29124-2773-4FC9-A15B-0DFCA3E9DA52}" dt="2022-10-13T05:48:18.939" v="12" actId="1038"/>
        <pc:sldMkLst>
          <pc:docMk/>
          <pc:sldMk cId="2231304746" sldId="299"/>
        </pc:sldMkLst>
        <pc:spChg chg="mod">
          <ac:chgData name="Go" userId="b11a5121-062d-4360-8951-d081ad96d999" providerId="ADAL" clId="{52F29124-2773-4FC9-A15B-0DFCA3E9DA52}" dt="2022-10-13T05:48:18.939" v="12" actId="1038"/>
          <ac:spMkLst>
            <pc:docMk/>
            <pc:sldMk cId="2231304746" sldId="299"/>
            <ac:spMk id="26" creationId="{B24D405F-2229-B7DC-EC12-925F30D0A658}"/>
          </ac:spMkLst>
        </pc:spChg>
        <pc:spChg chg="mod">
          <ac:chgData name="Go" userId="b11a5121-062d-4360-8951-d081ad96d999" providerId="ADAL" clId="{52F29124-2773-4FC9-A15B-0DFCA3E9DA52}" dt="2022-10-13T05:48:18.939" v="12" actId="1038"/>
          <ac:spMkLst>
            <pc:docMk/>
            <pc:sldMk cId="2231304746" sldId="299"/>
            <ac:spMk id="27" creationId="{B42E50CF-C6BD-ED37-FE05-0B55412D9AD3}"/>
          </ac:spMkLst>
        </pc:spChg>
        <pc:grpChg chg="mod">
          <ac:chgData name="Go" userId="b11a5121-062d-4360-8951-d081ad96d999" providerId="ADAL" clId="{52F29124-2773-4FC9-A15B-0DFCA3E9DA52}" dt="2022-10-13T05:48:18.939" v="12" actId="1038"/>
          <ac:grpSpMkLst>
            <pc:docMk/>
            <pc:sldMk cId="2231304746" sldId="299"/>
            <ac:grpSpMk id="4" creationId="{27BA6C3D-7A59-89EB-3682-D8BCAA78894E}"/>
          </ac:grpSpMkLst>
        </pc:grpChg>
      </pc:sldChg>
    </pc:docChg>
  </pc:docChgLst>
  <pc:docChgLst>
    <pc:chgData name="Go" userId="b11a5121-062d-4360-8951-d081ad96d999" providerId="ADAL" clId="{A37B11FE-7E2B-4B71-9282-AB38B86228CA}"/>
    <pc:docChg chg="undo redo custSel addSld modSld sldOrd">
      <pc:chgData name="Go" userId="b11a5121-062d-4360-8951-d081ad96d999" providerId="ADAL" clId="{A37B11FE-7E2B-4B71-9282-AB38B86228CA}" dt="2022-10-15T01:48:08.111" v="1521" actId="555"/>
      <pc:docMkLst>
        <pc:docMk/>
      </pc:docMkLst>
      <pc:sldChg chg="modSp mod">
        <pc:chgData name="Go" userId="b11a5121-062d-4360-8951-d081ad96d999" providerId="ADAL" clId="{A37B11FE-7E2B-4B71-9282-AB38B86228CA}" dt="2022-10-15T01:46:26.953" v="1491" actId="20577"/>
        <pc:sldMkLst>
          <pc:docMk/>
          <pc:sldMk cId="1094954127" sldId="284"/>
        </pc:sldMkLst>
        <pc:spChg chg="mod">
          <ac:chgData name="Go" userId="b11a5121-062d-4360-8951-d081ad96d999" providerId="ADAL" clId="{A37B11FE-7E2B-4B71-9282-AB38B86228CA}" dt="2022-10-15T01:46:12.230" v="1482" actId="20577"/>
          <ac:spMkLst>
            <pc:docMk/>
            <pc:sldMk cId="1094954127" sldId="284"/>
            <ac:spMk id="347" creationId="{7E39A75D-38B4-D5AD-98A4-4AE965473059}"/>
          </ac:spMkLst>
        </pc:spChg>
        <pc:spChg chg="mod">
          <ac:chgData name="Go" userId="b11a5121-062d-4360-8951-d081ad96d999" providerId="ADAL" clId="{A37B11FE-7E2B-4B71-9282-AB38B86228CA}" dt="2022-10-15T01:46:17.881" v="1485" actId="20577"/>
          <ac:spMkLst>
            <pc:docMk/>
            <pc:sldMk cId="1094954127" sldId="284"/>
            <ac:spMk id="359" creationId="{C8E420D2-28A1-5437-B38E-6D212B142507}"/>
          </ac:spMkLst>
        </pc:spChg>
        <pc:spChg chg="mod">
          <ac:chgData name="Go" userId="b11a5121-062d-4360-8951-d081ad96d999" providerId="ADAL" clId="{A37B11FE-7E2B-4B71-9282-AB38B86228CA}" dt="2022-10-15T01:46:23.467" v="1488" actId="20577"/>
          <ac:spMkLst>
            <pc:docMk/>
            <pc:sldMk cId="1094954127" sldId="284"/>
            <ac:spMk id="371" creationId="{38316EC8-82FB-7105-7E65-4D366D5DC41F}"/>
          </ac:spMkLst>
        </pc:spChg>
        <pc:spChg chg="mod">
          <ac:chgData name="Go" userId="b11a5121-062d-4360-8951-d081ad96d999" providerId="ADAL" clId="{A37B11FE-7E2B-4B71-9282-AB38B86228CA}" dt="2022-10-15T01:46:26.953" v="1491" actId="20577"/>
          <ac:spMkLst>
            <pc:docMk/>
            <pc:sldMk cId="1094954127" sldId="284"/>
            <ac:spMk id="455" creationId="{1B83A5B9-24D0-604A-B889-D87FC290C02C}"/>
          </ac:spMkLst>
        </pc:spChg>
      </pc:sldChg>
      <pc:sldChg chg="delSp modSp mod">
        <pc:chgData name="Go" userId="b11a5121-062d-4360-8951-d081ad96d999" providerId="ADAL" clId="{A37B11FE-7E2B-4B71-9282-AB38B86228CA}" dt="2022-10-15T01:48:08.111" v="1521" actId="555"/>
        <pc:sldMkLst>
          <pc:docMk/>
          <pc:sldMk cId="4198847848" sldId="289"/>
        </pc:sldMkLst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6" creationId="{1371575E-03FE-EE70-76FF-FA71A80DCB10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2" creationId="{862C96C3-B678-4FDB-79C7-BD9FF90DBB5B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4" creationId="{46907438-93BD-1BB7-73D0-42587FA78A56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15" creationId="{330CE62C-3F93-475E-1991-04687F7380DF}"/>
          </ac:spMkLst>
        </pc:spChg>
        <pc:spChg chg="mod">
          <ac:chgData name="Go" userId="b11a5121-062d-4360-8951-d081ad96d999" providerId="ADAL" clId="{A37B11FE-7E2B-4B71-9282-AB38B86228CA}" dt="2022-10-13T20:38:46.290" v="1118" actId="20577"/>
          <ac:spMkLst>
            <pc:docMk/>
            <pc:sldMk cId="4198847848" sldId="289"/>
            <ac:spMk id="19" creationId="{7D68F769-E8DD-44CF-A4E5-1312488851B5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0" creationId="{1E5638A1-D88D-1784-8C3B-1B8361927869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2" creationId="{36E91FB9-4892-1F8E-353E-FF9EB925FD47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3" creationId="{8F56171D-F7BE-E561-DC43-A9B6735F84A4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25" creationId="{68F4F58B-8832-9843-D9CE-23AFF4B8F241}"/>
          </ac:spMkLst>
        </pc:spChg>
        <pc:spChg chg="mod">
          <ac:chgData name="Go" userId="b11a5121-062d-4360-8951-d081ad96d999" providerId="ADAL" clId="{A37B11FE-7E2B-4B71-9282-AB38B86228CA}" dt="2022-10-13T20:38:31.029" v="1085" actId="20577"/>
          <ac:spMkLst>
            <pc:docMk/>
            <pc:sldMk cId="4198847848" sldId="289"/>
            <ac:spMk id="44" creationId="{4EBA0680-77E2-2ABD-9B13-E3E33B2FEBA0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52" creationId="{9870C4CC-D847-B4A6-B69D-EA5358FC56E3}"/>
          </ac:spMkLst>
        </pc:spChg>
        <pc:spChg chg="del">
          <ac:chgData name="Go" userId="b11a5121-062d-4360-8951-d081ad96d999" providerId="ADAL" clId="{A37B11FE-7E2B-4B71-9282-AB38B86228CA}" dt="2022-10-13T20:38:35.630" v="1086" actId="478"/>
          <ac:spMkLst>
            <pc:docMk/>
            <pc:sldMk cId="4198847848" sldId="289"/>
            <ac:spMk id="59" creationId="{638D4131-CD65-E2A2-5377-7594633FFA79}"/>
          </ac:spMkLst>
        </pc:spChg>
        <pc:spChg chg="mod">
          <ac:chgData name="Go" userId="b11a5121-062d-4360-8951-d081ad96d999" providerId="ADAL" clId="{A37B11FE-7E2B-4B71-9282-AB38B86228CA}" dt="2022-10-13T20:38:48.726" v="1120" actId="20577"/>
          <ac:spMkLst>
            <pc:docMk/>
            <pc:sldMk cId="4198847848" sldId="289"/>
            <ac:spMk id="69" creationId="{ECFCF99C-38AB-4DC4-A277-DFC8A3B1ECDF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77" creationId="{33C1C1D7-4480-E59E-7619-2126CC1A36FF}"/>
          </ac:spMkLst>
        </pc:spChg>
        <pc:spChg chg="mod">
          <ac:chgData name="Go" userId="b11a5121-062d-4360-8951-d081ad96d999" providerId="ADAL" clId="{A37B11FE-7E2B-4B71-9282-AB38B86228CA}" dt="2022-10-15T01:48:08.111" v="1521" actId="555"/>
          <ac:spMkLst>
            <pc:docMk/>
            <pc:sldMk cId="4198847848" sldId="289"/>
            <ac:spMk id="79" creationId="{E0309F23-C5EE-0A6E-0543-BF3AE2E1E50B}"/>
          </ac:spMkLst>
        </pc:spChg>
        <pc:grpChg chg="mod">
          <ac:chgData name="Go" userId="b11a5121-062d-4360-8951-d081ad96d999" providerId="ADAL" clId="{A37B11FE-7E2B-4B71-9282-AB38B86228CA}" dt="2022-10-13T20:38:42.614" v="1116" actId="1037"/>
          <ac:grpSpMkLst>
            <pc:docMk/>
            <pc:sldMk cId="4198847848" sldId="289"/>
            <ac:grpSpMk id="2" creationId="{B2FD1FFB-4E78-0C3D-A641-8046DE08B520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27" creationId="{075889E4-E48A-F0E3-C5D2-CEC000F97771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28" creationId="{B2BC3338-3EEF-6A44-68D8-885DD23C1818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45" creationId="{2DFEA9BC-4E4D-469F-F722-637BB01AF58C}"/>
          </ac:grpSpMkLst>
        </pc:grpChg>
        <pc:grpChg chg="del">
          <ac:chgData name="Go" userId="b11a5121-062d-4360-8951-d081ad96d999" providerId="ADAL" clId="{A37B11FE-7E2B-4B71-9282-AB38B86228CA}" dt="2022-10-13T20:38:35.630" v="1086" actId="478"/>
          <ac:grpSpMkLst>
            <pc:docMk/>
            <pc:sldMk cId="4198847848" sldId="289"/>
            <ac:grpSpMk id="55" creationId="{26809872-AEDA-55C9-D4EF-8B78CEE05A9F}"/>
          </ac:grpSpMkLst>
        </pc:grp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4" creationId="{C61A9ACD-A35E-CABF-DC0F-DFC3FE911A68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5" creationId="{D529FFCD-96DD-2085-D658-05BE8822553F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7" creationId="{570C03D4-9885-1DE9-A161-07890068A4F9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0" creationId="{47239B5B-AE66-30F7-4FE8-F032BB78F5AE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3" creationId="{6384335C-79AE-8172-D5DF-7529DDE9B744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6" creationId="{4A4092D2-96F2-FA8F-E9AB-2569B80AAA70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17" creationId="{C2F012C9-F323-36DA-07F4-CEA68E0FBAF6}"/>
          </ac:picMkLst>
        </pc:picChg>
        <pc:picChg chg="del">
          <ac:chgData name="Go" userId="b11a5121-062d-4360-8951-d081ad96d999" providerId="ADAL" clId="{A37B11FE-7E2B-4B71-9282-AB38B86228CA}" dt="2022-10-13T20:38:35.630" v="1086" actId="478"/>
          <ac:picMkLst>
            <pc:docMk/>
            <pc:sldMk cId="4198847848" sldId="289"/>
            <ac:picMk id="24" creationId="{7158A9C9-E5E3-F9F3-6597-D9E12877E31C}"/>
          </ac:picMkLst>
        </pc:picChg>
      </pc:sldChg>
      <pc:sldChg chg="addSp delSp modSp mod">
        <pc:chgData name="Go" userId="b11a5121-062d-4360-8951-d081ad96d999" providerId="ADAL" clId="{A37B11FE-7E2B-4B71-9282-AB38B86228CA}" dt="2022-10-14T01:53:43.823" v="1347" actId="478"/>
        <pc:sldMkLst>
          <pc:docMk/>
          <pc:sldMk cId="765565405" sldId="295"/>
        </pc:sldMkLst>
        <pc:spChg chg="add del mod">
          <ac:chgData name="Go" userId="b11a5121-062d-4360-8951-d081ad96d999" providerId="ADAL" clId="{A37B11FE-7E2B-4B71-9282-AB38B86228CA}" dt="2022-10-13T20:39:51.738" v="1124" actId="478"/>
          <ac:spMkLst>
            <pc:docMk/>
            <pc:sldMk cId="765565405" sldId="295"/>
            <ac:spMk id="2" creationId="{7288BBF4-1537-B43B-BB42-DA412F0CAAEB}"/>
          </ac:spMkLst>
        </pc:spChg>
        <pc:spChg chg="del">
          <ac:chgData name="Go" userId="b11a5121-062d-4360-8951-d081ad96d999" providerId="ADAL" clId="{A37B11FE-7E2B-4B71-9282-AB38B86228CA}" dt="2022-10-13T20:39:37.685" v="1122" actId="478"/>
          <ac:spMkLst>
            <pc:docMk/>
            <pc:sldMk cId="765565405" sldId="295"/>
            <ac:spMk id="6" creationId="{47B992C5-C82F-9A33-E06F-0CF2A4077CC8}"/>
          </ac:spMkLst>
        </pc:spChg>
        <pc:spChg chg="del">
          <ac:chgData name="Go" userId="b11a5121-062d-4360-8951-d081ad96d999" providerId="ADAL" clId="{A37B11FE-7E2B-4B71-9282-AB38B86228CA}" dt="2022-10-13T20:40:53.102" v="1133" actId="478"/>
          <ac:spMkLst>
            <pc:docMk/>
            <pc:sldMk cId="765565405" sldId="295"/>
            <ac:spMk id="32" creationId="{01000DD1-93DA-1423-F7E5-5A48E9CC7F42}"/>
          </ac:spMkLst>
        </pc:spChg>
        <pc:spChg chg="add mod">
          <ac:chgData name="Go" userId="b11a5121-062d-4360-8951-d081ad96d999" providerId="ADAL" clId="{A37B11FE-7E2B-4B71-9282-AB38B86228CA}" dt="2022-10-13T20:42:07.095" v="1155" actId="1036"/>
          <ac:spMkLst>
            <pc:docMk/>
            <pc:sldMk cId="765565405" sldId="295"/>
            <ac:spMk id="36" creationId="{F245A393-AA8C-8E50-A7C0-9BBDD069179F}"/>
          </ac:spMkLst>
        </pc:spChg>
        <pc:spChg chg="add mod">
          <ac:chgData name="Go" userId="b11a5121-062d-4360-8951-d081ad96d999" providerId="ADAL" clId="{A37B11FE-7E2B-4B71-9282-AB38B86228CA}" dt="2022-10-13T20:41:15.141" v="1141" actId="1076"/>
          <ac:spMkLst>
            <pc:docMk/>
            <pc:sldMk cId="765565405" sldId="295"/>
            <ac:spMk id="37" creationId="{660F6457-F508-AE06-1A3B-E3DBC117B738}"/>
          </ac:spMkLst>
        </pc:spChg>
        <pc:picChg chg="add del mod">
          <ac:chgData name="Go" userId="b11a5121-062d-4360-8951-d081ad96d999" providerId="ADAL" clId="{A37B11FE-7E2B-4B71-9282-AB38B86228CA}" dt="2022-10-14T01:53:43.823" v="1347" actId="478"/>
          <ac:picMkLst>
            <pc:docMk/>
            <pc:sldMk cId="765565405" sldId="295"/>
            <ac:picMk id="40" creationId="{5DDE6FC3-ECFB-5D45-AE89-4D8A04E171F8}"/>
          </ac:picMkLst>
        </pc:picChg>
        <pc:cxnChg chg="add del mod">
          <ac:chgData name="Go" userId="b11a5121-062d-4360-8951-d081ad96d999" providerId="ADAL" clId="{A37B11FE-7E2B-4B71-9282-AB38B86228CA}" dt="2022-10-13T20:40:54.620" v="1134" actId="478"/>
          <ac:cxnSpMkLst>
            <pc:docMk/>
            <pc:sldMk cId="765565405" sldId="295"/>
            <ac:cxnSpMk id="35" creationId="{D3EAD5EB-A2A1-BD4B-748C-6AD789159238}"/>
          </ac:cxnSpMkLst>
        </pc:cxnChg>
      </pc:sldChg>
      <pc:sldChg chg="modSp mod">
        <pc:chgData name="Go" userId="b11a5121-062d-4360-8951-d081ad96d999" providerId="ADAL" clId="{A37B11FE-7E2B-4B71-9282-AB38B86228CA}" dt="2022-10-15T01:47:01.280" v="1505" actId="20577"/>
        <pc:sldMkLst>
          <pc:docMk/>
          <pc:sldMk cId="970619779" sldId="297"/>
        </pc:sldMkLst>
        <pc:spChg chg="mod">
          <ac:chgData name="Go" userId="b11a5121-062d-4360-8951-d081ad96d999" providerId="ADAL" clId="{A37B11FE-7E2B-4B71-9282-AB38B86228CA}" dt="2022-10-15T01:46:40.900" v="1494" actId="20577"/>
          <ac:spMkLst>
            <pc:docMk/>
            <pc:sldMk cId="970619779" sldId="297"/>
            <ac:spMk id="1113" creationId="{39F2BCD9-900F-01E9-1717-5DA5F4D4C967}"/>
          </ac:spMkLst>
        </pc:spChg>
        <pc:spChg chg="mod">
          <ac:chgData name="Go" userId="b11a5121-062d-4360-8951-d081ad96d999" providerId="ADAL" clId="{A37B11FE-7E2B-4B71-9282-AB38B86228CA}" dt="2022-10-15T01:46:56.153" v="1502" actId="13926"/>
          <ac:spMkLst>
            <pc:docMk/>
            <pc:sldMk cId="970619779" sldId="297"/>
            <ac:spMk id="1185" creationId="{D9F5002C-825F-FC50-D3F7-F7E1E66A74B0}"/>
          </ac:spMkLst>
        </pc:spChg>
        <pc:spChg chg="mod">
          <ac:chgData name="Go" userId="b11a5121-062d-4360-8951-d081ad96d999" providerId="ADAL" clId="{A37B11FE-7E2B-4B71-9282-AB38B86228CA}" dt="2022-10-15T01:47:01.280" v="1505" actId="20577"/>
          <ac:spMkLst>
            <pc:docMk/>
            <pc:sldMk cId="970619779" sldId="297"/>
            <ac:spMk id="1221" creationId="{596C9DE2-9098-44CD-FA87-981A8ED98497}"/>
          </ac:spMkLst>
        </pc:spChg>
      </pc:sldChg>
      <pc:sldChg chg="addSp delSp modSp mod">
        <pc:chgData name="Go" userId="b11a5121-062d-4360-8951-d081ad96d999" providerId="ADAL" clId="{A37B11FE-7E2B-4B71-9282-AB38B86228CA}" dt="2022-10-15T01:45:25.502" v="1479" actId="20577"/>
        <pc:sldMkLst>
          <pc:docMk/>
          <pc:sldMk cId="3299870256" sldId="301"/>
        </pc:sldMkLst>
        <pc:spChg chg="mod">
          <ac:chgData name="Go" userId="b11a5121-062d-4360-8951-d081ad96d999" providerId="ADAL" clId="{A37B11FE-7E2B-4B71-9282-AB38B86228CA}" dt="2022-10-14T00:57:19.778" v="1193" actId="554"/>
          <ac:spMkLst>
            <pc:docMk/>
            <pc:sldMk cId="3299870256" sldId="301"/>
            <ac:spMk id="12" creationId="{A7DA65A8-9C18-44D5-8A91-8C50381BEF9D}"/>
          </ac:spMkLst>
        </pc:spChg>
        <pc:spChg chg="mod">
          <ac:chgData name="Go" userId="b11a5121-062d-4360-8951-d081ad96d999" providerId="ADAL" clId="{A37B11FE-7E2B-4B71-9282-AB38B86228CA}" dt="2022-10-13T20:32:44.234" v="1046" actId="1035"/>
          <ac:spMkLst>
            <pc:docMk/>
            <pc:sldMk cId="3299870256" sldId="301"/>
            <ac:spMk id="16" creationId="{2D415CC3-EC50-47BD-9C07-95599E264991}"/>
          </ac:spMkLst>
        </pc:spChg>
        <pc:spChg chg="add del mod">
          <ac:chgData name="Go" userId="b11a5121-062d-4360-8951-d081ad96d999" providerId="ADAL" clId="{A37B11FE-7E2B-4B71-9282-AB38B86228CA}" dt="2022-10-14T05:28:21.614" v="1473" actId="478"/>
          <ac:spMkLst>
            <pc:docMk/>
            <pc:sldMk cId="3299870256" sldId="301"/>
            <ac:spMk id="21" creationId="{0BCBD50A-D2DE-9423-2FCD-6A2AF9DA2E79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24" creationId="{DE2A6ADC-279B-EB8D-4D1B-8A1449932BC7}"/>
          </ac:spMkLst>
        </pc:spChg>
        <pc:spChg chg="mod topLvl">
          <ac:chgData name="Go" userId="b11a5121-062d-4360-8951-d081ad96d999" providerId="ADAL" clId="{A37B11FE-7E2B-4B71-9282-AB38B86228CA}" dt="2022-10-14T01:36:07.890" v="1310" actId="164"/>
          <ac:spMkLst>
            <pc:docMk/>
            <pc:sldMk cId="3299870256" sldId="301"/>
            <ac:spMk id="37" creationId="{873ABBA6-F404-2931-A177-FA14A024DAE1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4" creationId="{089D6C4B-E85D-1CD3-914B-2088CDFD16BB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63" creationId="{C2DEC8A3-11BC-D720-0DA0-92E3857A96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4" creationId="{9F007954-0AAD-3205-735A-B9A54442C77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5" creationId="{515CE48F-1CC6-72F9-4350-E9508E72096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6" creationId="{7448F8AD-C4F0-4AA1-98CB-C813BC9B24D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7" creationId="{B3A138A0-A275-7353-FE03-EC2EFA9DC93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8" creationId="{2CDF2CD0-379D-D6FC-2C99-2932958E9A5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76" creationId="{74E5028F-A99A-AA28-7FDC-A26AA484CD2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4" creationId="{837F1CCF-F169-1CFB-7F9B-402401FD2EE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5" creationId="{ECDDBD90-6215-8E50-4FF9-A25F1931545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6" creationId="{E2524BC4-E63F-BA5E-F6B8-AA15C24401A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7" creationId="{449EA4CF-2036-F01A-EDEE-4CF90C93DED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8" creationId="{BA00C4AC-2A75-732C-667D-BC15171D6C0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89" creationId="{FFF62C9B-5DEA-D3C7-C3CE-99A61B19D567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4" creationId="{F56C1CE8-089D-C261-8DF8-C11DFF669F6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5" creationId="{3248A607-9A53-1219-2078-5B2467583ED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98" creationId="{E58C1058-FD72-2F7B-528C-68026EC1AEB2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99" creationId="{C89A6AE9-D9E0-46E2-ACDE-19A7EC908815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100" creationId="{F6DAD6F7-1072-4389-B036-7467DC7F1C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06" creationId="{C61B6210-8D97-7703-4BFD-05CF3757588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07" creationId="{A8BCDEF0-1932-D050-7EA4-6D4982CCD0B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1" creationId="{6238CB2F-65B3-6DAB-3A9F-573FDC5657A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2" creationId="{E9C1FCEA-6490-E01F-C27D-DC03ED1AF9B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3" creationId="{3A35C103-3B66-069D-BFFA-FEF04477F7F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4" creationId="{81ABC751-DDFA-1FD8-FFF3-CA82D5193F6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6" creationId="{44B7E7F0-E894-2277-9541-01E126F3AC6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7" creationId="{E2AC9109-AE40-1616-97A4-F9388B59D5D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18" creationId="{8BCFE8D6-B1DA-1CE4-64E1-56169C4D7EB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0" creationId="{EDB01C96-6BB2-78ED-E253-EE7A72186D0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2" creationId="{56C5CEE4-9BE2-803A-12E1-E95FE066836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4" creationId="{D0F35713-6707-76B8-B2CA-E131E5AEEC5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6" creationId="{2D35C4E2-2DB7-0322-089D-ADFA59447EA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127" creationId="{8A76B3BE-6305-3092-D6E1-5320853AEDB0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2" creationId="{F68DB3C2-4564-74AC-DFC6-43FCC3D3E48B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3" creationId="{AF8279E9-D98F-4C66-2611-E40CEBB01977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134" creationId="{062BBD42-984D-069F-1412-A08C27DAFD2C}"/>
          </ac:spMkLst>
        </pc:spChg>
        <pc:spChg chg="add mod topLvl">
          <ac:chgData name="Go" userId="b11a5121-062d-4360-8951-d081ad96d999" providerId="ADAL" clId="{A37B11FE-7E2B-4B71-9282-AB38B86228CA}" dt="2022-10-14T00:59:52.956" v="1242" actId="554"/>
          <ac:spMkLst>
            <pc:docMk/>
            <pc:sldMk cId="3299870256" sldId="301"/>
            <ac:spMk id="147" creationId="{F8F1AE5A-A214-4AA6-B7F8-28DC4C5193D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1" creationId="{410B34D5-B21B-1370-706A-E83FD2C998DC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2" creationId="{5CA570F2-FD9E-C7C0-BED4-4844B823FFD2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3" creationId="{C8331F8C-B2BF-090A-B61A-EA551E60FF4C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4" creationId="{32C6731D-4C97-B09A-895D-9591540B3CA3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5" creationId="{72FAA0B2-0F23-A665-57A5-DD5AF0F7FDB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6" creationId="{D37F5891-CB3D-0432-66EB-7AACF067DA6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57" creationId="{C5C9552E-F78D-0C3F-9E24-A306C70AD2A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64" creationId="{797590FF-41DB-2D3E-7727-D12E05DA075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65" creationId="{7DAC27D9-CD5C-0A1E-6661-5E581B5CE15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0" creationId="{AD58643F-7E35-7DF6-0A9E-666FB89DA40A}"/>
          </ac:spMkLst>
        </pc:spChg>
        <pc:spChg chg="mod topLvl">
          <ac:chgData name="Go" userId="b11a5121-062d-4360-8951-d081ad96d999" providerId="ADAL" clId="{A37B11FE-7E2B-4B71-9282-AB38B86228CA}" dt="2022-10-13T20:32:44.234" v="1046" actId="1035"/>
          <ac:spMkLst>
            <pc:docMk/>
            <pc:sldMk cId="3299870256" sldId="301"/>
            <ac:spMk id="171" creationId="{5103E0C0-A43F-D0E9-26C3-CFD997322F2E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3" creationId="{B1D845A5-3098-D846-9A7C-1E92E624AA05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6" creationId="{30116284-ABB0-05C0-8ECF-05A13F661117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7" creationId="{B04C50BB-6C20-23E9-2C3D-67C921011979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79" creationId="{223152C6-6F3E-4B9C-1FAB-6FE3606B51DA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1" creationId="{050F6027-1DFF-7CE2-01D4-531DFC658F25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3" creationId="{A8ABD308-10EB-1461-E88B-37AA7F48C2C0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5" creationId="{DC094AB9-5000-D2A7-51BE-B2B71B1F027B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7" creationId="{FC66F015-C44C-65B9-1C1F-9266CA083B48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89" creationId="{9F8BD057-798E-C352-0523-F8ED43AB17C1}"/>
          </ac:spMkLst>
        </pc:spChg>
        <pc:spChg chg="mod">
          <ac:chgData name="Go" userId="b11a5121-062d-4360-8951-d081ad96d999" providerId="ADAL" clId="{A37B11FE-7E2B-4B71-9282-AB38B86228CA}" dt="2022-10-13T19:27:29.859" v="258"/>
          <ac:spMkLst>
            <pc:docMk/>
            <pc:sldMk cId="3299870256" sldId="301"/>
            <ac:spMk id="191" creationId="{F3A5E892-050B-70EB-D2CC-62D5FBF30FD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4" creationId="{EE94773D-5D9B-1C40-E368-03AF1BD63AFF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6" creationId="{C42C49A1-C07F-4823-E569-91B91B755B49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7" creationId="{1103D0D3-6D6E-40A8-68C4-264398024C3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8" creationId="{F9EA1132-45A4-2108-6B16-3A0E24232315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199" creationId="{B08E2F55-95F2-B43E-00B2-0C0A0F36AA80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0" creationId="{76EDAA07-94BC-156E-0580-C09DA35F5359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1" creationId="{8740DBA2-4FF4-6B96-159C-2DC0BD0D939F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2" creationId="{E29DD96A-7BA8-0D91-4F6A-96AC9EDC3781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4" creationId="{9CD771A1-8D0D-352A-8060-AD4928AB94D8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6" creationId="{D0FC6218-5698-90CE-F787-8BBA6078919D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08" creationId="{2A7499D1-1E3B-A887-1963-B1383A8CF875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0" creationId="{86EC0BC4-A1E4-CD4A-0F01-A44D291FF2E0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2" creationId="{CEBEB22F-93EF-38BE-DFF4-CC4920E68616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4" creationId="{91A9AE94-577E-8E33-C932-431481F040F2}"/>
          </ac:spMkLst>
        </pc:spChg>
        <pc:spChg chg="mod">
          <ac:chgData name="Go" userId="b11a5121-062d-4360-8951-d081ad96d999" providerId="ADAL" clId="{A37B11FE-7E2B-4B71-9282-AB38B86228CA}" dt="2022-10-13T19:37:49.807" v="278" actId="20577"/>
          <ac:spMkLst>
            <pc:docMk/>
            <pc:sldMk cId="3299870256" sldId="301"/>
            <ac:spMk id="215" creationId="{131802D4-FD62-DC83-FE86-405BECC0C5AA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16" creationId="{6EE8B2C0-C171-F025-FF38-79271C556B5F}"/>
          </ac:spMkLst>
        </pc:spChg>
        <pc:spChg chg="mod topLvl">
          <ac:chgData name="Go" userId="b11a5121-062d-4360-8951-d081ad96d999" providerId="ADAL" clId="{A37B11FE-7E2B-4B71-9282-AB38B86228CA}" dt="2022-10-14T04:48:12.717" v="1469" actId="20577"/>
          <ac:spMkLst>
            <pc:docMk/>
            <pc:sldMk cId="3299870256" sldId="301"/>
            <ac:spMk id="218" creationId="{F3298815-9305-CB10-9853-8B2AF8F8156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19" creationId="{6D8CA97D-F558-BC5F-31A4-DE0F2829044B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0" creationId="{889F0B7B-5A9E-19BE-28A5-B1EBE2A39EC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1" creationId="{13522CE3-C41C-10C4-F76C-DF37342B9C48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2" creationId="{24D16945-1AFD-F22D-7D89-AB65CCE4FB41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23" creationId="{64BB2A03-9676-EC4E-4315-26C55CFBA8F6}"/>
          </ac:spMkLst>
        </pc:spChg>
        <pc:spChg chg="mod topLvl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26" creationId="{7EFDD885-E759-5633-16AB-83EBABFD10FA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28" creationId="{EEB83C73-C9F0-F538-9D71-F91A136029BA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1" creationId="{E20DBB86-5321-43D4-CB59-5868ACA36A90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2" creationId="{F80AF707-F9C5-DFF3-4775-E6E60AC6BCA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4" creationId="{C151D2B4-1E4C-80C5-7FBD-15CFB819C126}"/>
          </ac:spMkLst>
        </pc:spChg>
        <pc:spChg chg="mod">
          <ac:chgData name="Go" userId="b11a5121-062d-4360-8951-d081ad96d999" providerId="ADAL" clId="{A37B11FE-7E2B-4B71-9282-AB38B86228CA}" dt="2022-10-14T02:29:52.315" v="1456" actId="165"/>
          <ac:spMkLst>
            <pc:docMk/>
            <pc:sldMk cId="3299870256" sldId="301"/>
            <ac:spMk id="235" creationId="{E5E79CFE-CF5A-258B-9604-679C5D9AA6A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6" creationId="{B309F41F-5305-547C-2F54-2F496AA42D6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37" creationId="{89D1BCF2-D4AC-8C3F-17A1-9C25E61AACD4}"/>
          </ac:spMkLst>
        </pc:spChg>
        <pc:spChg chg="add mod topLvl">
          <ac:chgData name="Go" userId="b11a5121-062d-4360-8951-d081ad96d999" providerId="ADAL" clId="{A37B11FE-7E2B-4B71-9282-AB38B86228CA}" dt="2022-10-14T02:29:48.593" v="1455" actId="165"/>
          <ac:spMkLst>
            <pc:docMk/>
            <pc:sldMk cId="3299870256" sldId="301"/>
            <ac:spMk id="239" creationId="{55468863-7BBD-8A76-7C95-BCDCE8D1690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2" creationId="{38A457A0-6299-A36D-F9B4-45B52B2DE62B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3" creationId="{EE0326AC-C714-2619-B53B-3301BC65247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5" creationId="{BC9EF48A-F0A0-2C75-14C4-D4F63F70D2BD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7" creationId="{EDD17BF4-DD9A-E43E-C91C-936DA3F1C642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49" creationId="{5B97B126-3602-DBBE-E080-38451E40E469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1" creationId="{324AE1E1-B787-38F6-A0CC-407494CA79A5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3" creationId="{DFE31705-E4C4-DEF6-9035-25B45B8B5F37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5" creationId="{9A070BDD-A588-B11F-531A-59BBB3CEDF13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257" creationId="{AB60716B-3E83-4CBF-FBED-16441BEF075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68" creationId="{914F3C87-7FCA-419B-1E93-14D6129C080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69" creationId="{8B257F69-AB3F-5C08-4EB2-6F4244C62D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0" creationId="{DE906DF3-C9AF-1C9B-E116-A6DCDB379890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1" creationId="{0912BD74-E735-9597-BEF9-74C9A57A78A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272" creationId="{4E4E8A32-917C-289D-6F00-1AB3E3E5E713}"/>
          </ac:spMkLst>
        </pc:spChg>
        <pc:spChg chg="mod topLvl">
          <ac:chgData name="Go" userId="b11a5121-062d-4360-8951-d081ad96d999" providerId="ADAL" clId="{A37B11FE-7E2B-4B71-9282-AB38B86228CA}" dt="2022-10-14T04:48:15.954" v="1470" actId="20577"/>
          <ac:spMkLst>
            <pc:docMk/>
            <pc:sldMk cId="3299870256" sldId="301"/>
            <ac:spMk id="273" creationId="{C210E4EB-3C52-AF8D-4A79-5A61361B4082}"/>
          </ac:spMkLst>
        </pc:spChg>
        <pc:spChg chg="mod topLvl">
          <ac:chgData name="Go" userId="b11a5121-062d-4360-8951-d081ad96d999" providerId="ADAL" clId="{A37B11FE-7E2B-4B71-9282-AB38B86228CA}" dt="2022-10-13T19:59:05.306" v="496" actId="164"/>
          <ac:spMkLst>
            <pc:docMk/>
            <pc:sldMk cId="3299870256" sldId="301"/>
            <ac:spMk id="281" creationId="{1369908A-0A01-7976-2954-B5D6EF43679B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3" creationId="{E3F5427E-0639-BBD4-6023-720F1BD74CB1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5" creationId="{4D89257F-ADA3-4D9F-69B3-BE376248B923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7" creationId="{C96BEBA5-198A-60C9-97E3-3D213A1DE43E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89" creationId="{9EF922F4-6E43-7047-6E71-A344DF1A1463}"/>
          </ac:spMkLst>
        </pc:spChg>
        <pc:spChg chg="mod">
          <ac:chgData name="Go" userId="b11a5121-062d-4360-8951-d081ad96d999" providerId="ADAL" clId="{A37B11FE-7E2B-4B71-9282-AB38B86228CA}" dt="2022-10-13T19:58:04.305" v="483" actId="165"/>
          <ac:spMkLst>
            <pc:docMk/>
            <pc:sldMk cId="3299870256" sldId="301"/>
            <ac:spMk id="291" creationId="{3E1A0532-51CA-BA86-754F-0B6DB8FB50F5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294" creationId="{677421E6-57E3-4798-6373-C17F5D175D9A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295" creationId="{7E9BA595-48EE-AD01-7067-1703D560FBA6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3" creationId="{7DD169BB-39E6-03F8-84E4-00C88278E47A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5" creationId="{8F842E5A-061E-FBF8-D81A-961C95AE4D98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7" creationId="{1CFD66BD-464B-F4F9-CB0F-827B3F7EAADC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09" creationId="{418769DE-D879-63BB-AE3A-950845F6CDA3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11" creationId="{B5AF5CE1-DAE3-6A69-94E6-9CCBDDB7A4C6}"/>
          </ac:spMkLst>
        </pc:spChg>
        <pc:spChg chg="mod">
          <ac:chgData name="Go" userId="b11a5121-062d-4360-8951-d081ad96d999" providerId="ADAL" clId="{A37B11FE-7E2B-4B71-9282-AB38B86228CA}" dt="2022-10-13T20:09:45.203" v="626"/>
          <ac:spMkLst>
            <pc:docMk/>
            <pc:sldMk cId="3299870256" sldId="301"/>
            <ac:spMk id="313" creationId="{D1329BDE-346B-4B3C-A2FF-2DDE44C2227B}"/>
          </ac:spMkLst>
        </pc:spChg>
        <pc:spChg chg="del mod topLvl">
          <ac:chgData name="Go" userId="b11a5121-062d-4360-8951-d081ad96d999" providerId="ADAL" clId="{A37B11FE-7E2B-4B71-9282-AB38B86228CA}" dt="2022-10-13T20:15:28.643" v="716" actId="478"/>
          <ac:spMkLst>
            <pc:docMk/>
            <pc:sldMk cId="3299870256" sldId="301"/>
            <ac:spMk id="321" creationId="{7933A066-F9C5-BA68-6D9B-EA66E4D763E3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3" creationId="{56EAB5A6-DA9A-1633-90AF-5C2407E9ACBF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5" creationId="{76F53C94-1C4B-8B2B-3722-4828FDC374B6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7" creationId="{E1A00A2D-5FC7-1B94-AFB9-0F7EA0B0965C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29" creationId="{1B6D271F-8BC9-BF59-3720-402DCE293261}"/>
          </ac:spMkLst>
        </pc:spChg>
        <pc:spChg chg="mod">
          <ac:chgData name="Go" userId="b11a5121-062d-4360-8951-d081ad96d999" providerId="ADAL" clId="{A37B11FE-7E2B-4B71-9282-AB38B86228CA}" dt="2022-10-13T20:09:58.048" v="631" actId="165"/>
          <ac:spMkLst>
            <pc:docMk/>
            <pc:sldMk cId="3299870256" sldId="301"/>
            <ac:spMk id="333" creationId="{995AB39E-D048-F3F8-8DC9-3FB4AAE5D86E}"/>
          </ac:spMkLst>
        </pc:spChg>
        <pc:spChg chg="add del mod topLvl">
          <ac:chgData name="Go" userId="b11a5121-062d-4360-8951-d081ad96d999" providerId="ADAL" clId="{A37B11FE-7E2B-4B71-9282-AB38B86228CA}" dt="2022-10-13T20:37:11.999" v="1065" actId="478"/>
          <ac:spMkLst>
            <pc:docMk/>
            <pc:sldMk cId="3299870256" sldId="301"/>
            <ac:spMk id="338" creationId="{F61388DE-78D6-A063-F8E2-2E1EB0C288EB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2" creationId="{5B182495-D05C-96FA-90A6-B181E5093098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3" creationId="{88163E27-4BD9-6721-43BC-FC14157C7427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4" creationId="{3F91C208-2C69-E38B-1897-E6CDBB5D543A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45" creationId="{22FD6676-1D73-9E66-4253-E581101CE7EF}"/>
          </ac:spMkLst>
        </pc:spChg>
        <pc:spChg chg="mod topLvl">
          <ac:chgData name="Go" userId="b11a5121-062d-4360-8951-d081ad96d999" providerId="ADAL" clId="{A37B11FE-7E2B-4B71-9282-AB38B86228CA}" dt="2022-10-14T00:58:30.819" v="1209" actId="1036"/>
          <ac:spMkLst>
            <pc:docMk/>
            <pc:sldMk cId="3299870256" sldId="301"/>
            <ac:spMk id="347" creationId="{8C2F235E-BE56-B400-BDA7-5C1A101B84CD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48" creationId="{2A461E41-4216-804B-0458-33A2868184CA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3" creationId="{1F4CA620-E81E-2F50-4DA7-C796E90AC79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4" creationId="{67A08CF0-2928-977E-98A5-CFDF5FC048E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5" creationId="{3B8B14B8-A98A-D94A-537F-D4BA1BD9C84E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6" creationId="{21CA8342-E53C-1399-DB93-98E1343B97D4}"/>
          </ac:spMkLst>
        </pc:spChg>
        <pc:spChg chg="mod topLvl">
          <ac:chgData name="Go" userId="b11a5121-062d-4360-8951-d081ad96d999" providerId="ADAL" clId="{A37B11FE-7E2B-4B71-9282-AB38B86228CA}" dt="2022-10-13T20:27:28.335" v="982" actId="164"/>
          <ac:spMkLst>
            <pc:docMk/>
            <pc:sldMk cId="3299870256" sldId="301"/>
            <ac:spMk id="357" creationId="{18AC1B22-6F97-05EE-AAF5-FE7524CC6C7F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58" creationId="{ABDBAC41-3AA4-B8E0-2AEA-507E1DAD2F9B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59" creationId="{55D50987-4EE4-E058-8699-52B43934212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0" creationId="{361DFD0E-6289-4549-33CE-BA74C4A458BC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1" creationId="{7F295788-CB92-F4DB-5157-B691C112E0DA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2" creationId="{B6FE5AD6-2AEF-DDC3-74C7-91BBEA0D846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3" creationId="{0D339847-D246-EAF2-4A13-5EFEDD0EC755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4" creationId="{A43BB9FD-A784-657A-B34B-0E0533415E32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5" creationId="{03D66B09-C79D-3129-8189-FF4AE8E228E1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66" creationId="{5F7E0991-BECC-20EF-901D-EAB2B04864D8}"/>
          </ac:spMkLst>
        </pc:spChg>
        <pc:spChg chg="mod">
          <ac:chgData name="Go" userId="b11a5121-062d-4360-8951-d081ad96d999" providerId="ADAL" clId="{A37B11FE-7E2B-4B71-9282-AB38B86228CA}" dt="2022-10-14T00:59:37.722" v="1239" actId="165"/>
          <ac:spMkLst>
            <pc:docMk/>
            <pc:sldMk cId="3299870256" sldId="301"/>
            <ac:spMk id="367" creationId="{1CE6BBD2-914A-B05C-14F0-406EAAD341E0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368" creationId="{40317649-68F2-CA88-178D-C47C5142B84F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69" creationId="{6A0B3758-47AE-CAB8-B244-037548C315ED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0" creationId="{58300AB8-C197-A261-49FD-C1C855DC6A89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1" creationId="{B8CC8457-3C8D-BCAA-998C-4CDCF8725E12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2" creationId="{6B92EA03-FA8A-9F99-5D6F-95A7565A2029}"/>
          </ac:spMkLst>
        </pc:spChg>
        <pc:spChg chg="mod">
          <ac:chgData name="Go" userId="b11a5121-062d-4360-8951-d081ad96d999" providerId="ADAL" clId="{A37B11FE-7E2B-4B71-9282-AB38B86228CA}" dt="2022-10-13T20:24:09.931" v="865" actId="165"/>
          <ac:spMkLst>
            <pc:docMk/>
            <pc:sldMk cId="3299870256" sldId="301"/>
            <ac:spMk id="373" creationId="{2789CC9A-BB73-C89F-238A-C7A0AACD5F48}"/>
          </ac:spMkLst>
        </pc:spChg>
        <pc:spChg chg="add mod">
          <ac:chgData name="Go" userId="b11a5121-062d-4360-8951-d081ad96d999" providerId="ADAL" clId="{A37B11FE-7E2B-4B71-9282-AB38B86228CA}" dt="2022-10-14T01:00:36.842" v="1249" actId="1076"/>
          <ac:spMkLst>
            <pc:docMk/>
            <pc:sldMk cId="3299870256" sldId="301"/>
            <ac:spMk id="375" creationId="{D8E59C99-FE38-C093-2603-38F0FAF81006}"/>
          </ac:spMkLst>
        </pc:spChg>
        <pc:spChg chg="add del mod">
          <ac:chgData name="Go" userId="b11a5121-062d-4360-8951-d081ad96d999" providerId="ADAL" clId="{A37B11FE-7E2B-4B71-9282-AB38B86228CA}" dt="2022-10-14T01:33:53.139" v="1290" actId="478"/>
          <ac:spMkLst>
            <pc:docMk/>
            <pc:sldMk cId="3299870256" sldId="301"/>
            <ac:spMk id="376" creationId="{B2628F72-15A4-CC7F-80F0-4C978868CE08}"/>
          </ac:spMkLst>
        </pc:spChg>
        <pc:spChg chg="add del mod">
          <ac:chgData name="Go" userId="b11a5121-062d-4360-8951-d081ad96d999" providerId="ADAL" clId="{A37B11FE-7E2B-4B71-9282-AB38B86228CA}" dt="2022-10-14T02:29:24.684" v="1453" actId="478"/>
          <ac:spMkLst>
            <pc:docMk/>
            <pc:sldMk cId="3299870256" sldId="301"/>
            <ac:spMk id="377" creationId="{5B62DD5F-9DED-CCE0-B537-41C43ABF0433}"/>
          </ac:spMkLst>
        </pc:spChg>
        <pc:spChg chg="mod">
          <ac:chgData name="Go" userId="b11a5121-062d-4360-8951-d081ad96d999" providerId="ADAL" clId="{A37B11FE-7E2B-4B71-9282-AB38B86228CA}" dt="2022-10-13T20:28:51.124" v="1025" actId="1076"/>
          <ac:spMkLst>
            <pc:docMk/>
            <pc:sldMk cId="3299870256" sldId="301"/>
            <ac:spMk id="381" creationId="{5126D9D2-1907-A43F-5821-94A44A8E930C}"/>
          </ac:spMkLst>
        </pc:spChg>
        <pc:spChg chg="mod topLvl">
          <ac:chgData name="Go" userId="b11a5121-062d-4360-8951-d081ad96d999" providerId="ADAL" clId="{A37B11FE-7E2B-4B71-9282-AB38B86228CA}" dt="2022-10-14T04:48:18.557" v="1471" actId="20577"/>
          <ac:spMkLst>
            <pc:docMk/>
            <pc:sldMk cId="3299870256" sldId="301"/>
            <ac:spMk id="386" creationId="{A2558EC1-8F79-87E0-9F0A-99507D5576B2}"/>
          </ac:spMkLst>
        </pc:spChg>
        <pc:spChg chg="add del mod">
          <ac:chgData name="Go" userId="b11a5121-062d-4360-8951-d081ad96d999" providerId="ADAL" clId="{A37B11FE-7E2B-4B71-9282-AB38B86228CA}" dt="2022-10-14T01:35:57.189" v="1304" actId="478"/>
          <ac:spMkLst>
            <pc:docMk/>
            <pc:sldMk cId="3299870256" sldId="301"/>
            <ac:spMk id="387" creationId="{5B255E18-82A7-5851-9AFC-6200480DA9F3}"/>
          </ac:spMkLst>
        </pc:spChg>
        <pc:spChg chg="add mod topLvl">
          <ac:chgData name="Go" userId="b11a5121-062d-4360-8951-d081ad96d999" providerId="ADAL" clId="{A37B11FE-7E2B-4B71-9282-AB38B86228CA}" dt="2022-10-14T01:45:09.381" v="1323" actId="553"/>
          <ac:spMkLst>
            <pc:docMk/>
            <pc:sldMk cId="3299870256" sldId="301"/>
            <ac:spMk id="388" creationId="{0C1977C0-E865-A02A-3AE8-62B202FA0D49}"/>
          </ac:spMkLst>
        </pc:spChg>
        <pc:spChg chg="add del mod">
          <ac:chgData name="Go" userId="b11a5121-062d-4360-8951-d081ad96d999" providerId="ADAL" clId="{A37B11FE-7E2B-4B71-9282-AB38B86228CA}" dt="2022-10-14T05:28:19.845" v="1472" actId="478"/>
          <ac:spMkLst>
            <pc:docMk/>
            <pc:sldMk cId="3299870256" sldId="301"/>
            <ac:spMk id="400" creationId="{11176BA0-D140-7221-C5F0-E0D29AAF7CD4}"/>
          </ac:spMkLst>
        </pc:spChg>
        <pc:spChg chg="add mod">
          <ac:chgData name="Go" userId="b11a5121-062d-4360-8951-d081ad96d999" providerId="ADAL" clId="{A37B11FE-7E2B-4B71-9282-AB38B86228CA}" dt="2022-10-14T02:31:02.987" v="1466" actId="1076"/>
          <ac:spMkLst>
            <pc:docMk/>
            <pc:sldMk cId="3299870256" sldId="301"/>
            <ac:spMk id="401" creationId="{6D03CB62-9395-58D3-20AA-37BEE1BE1AEE}"/>
          </ac:spMkLst>
        </pc:spChg>
        <pc:spChg chg="mod">
          <ac:chgData name="Go" userId="b11a5121-062d-4360-8951-d081ad96d999" providerId="ADAL" clId="{A37B11FE-7E2B-4B71-9282-AB38B86228CA}" dt="2022-10-13T19:42:29.526" v="330" actId="164"/>
          <ac:spMkLst>
            <pc:docMk/>
            <pc:sldMk cId="3299870256" sldId="301"/>
            <ac:spMk id="404" creationId="{02ECC1BC-F39A-F87F-9CAA-AAC3D74418F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55" creationId="{4DA4660F-ABBE-E1BD-5B04-62B5A75AF21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56" creationId="{86E53E75-99F4-B1E6-B573-52DB085C453C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0" creationId="{5A29D108-29F5-7C8C-D1AF-996AF7E677CC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5" creationId="{ED225DD9-8CCA-9A76-EC30-5DA9B34FB8D4}"/>
          </ac:spMkLst>
        </pc:spChg>
        <pc:spChg chg="mod">
          <ac:chgData name="Go" userId="b11a5121-062d-4360-8951-d081ad96d999" providerId="ADAL" clId="{A37B11FE-7E2B-4B71-9282-AB38B86228CA}" dt="2022-10-13T19:37:44.577" v="276" actId="164"/>
          <ac:spMkLst>
            <pc:docMk/>
            <pc:sldMk cId="3299870256" sldId="301"/>
            <ac:spMk id="466" creationId="{FE81A49E-D7DF-8994-E47D-A7017A9CFAE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68" creationId="{E95DC29B-B5FD-B227-3FFC-1E3502018B6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69" creationId="{D5A042FA-7D32-E9B3-3B81-23AD2D95A59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0" creationId="{DD6F5203-AECB-944C-E662-8247BA40D12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1" creationId="{87640FCD-6B71-365A-85C7-2D643B96436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2" creationId="{B8E3CB13-DBD7-FE2B-BF3B-A4EAEC7673D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3" creationId="{02E05548-012B-5367-9DFB-97F6A11A488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4" creationId="{C2F53A96-9F30-3C1A-CB69-52256E765E1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5" creationId="{4744D8DF-930C-3B5B-09F9-A94276C8D9B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6" creationId="{3911E389-1D35-72CE-BC08-5E50583D7DC3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7" creationId="{7EEB1084-1002-B0C4-1E1C-D92645DB60E7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8" creationId="{A7F7CE73-E775-3967-291E-40028BF042A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79" creationId="{8EAA0873-B598-5BE3-8342-51E8F6DF1A8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0" creationId="{CC82C95F-5C71-C27D-4206-E11F5EB5B9F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1" creationId="{60BADF61-66FA-FD1F-153D-F3F36D85C5E3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2" creationId="{DF1886F2-5957-1B28-30F3-2CD8D284277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3" creationId="{12A17A62-16A9-6466-4779-40330CF1DE0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4" creationId="{9087FF59-69FE-7709-3CE9-A9F5DB483B5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5" creationId="{17E6B6D2-622D-92E6-B57F-FA64CF50E6B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6" creationId="{5D193B9A-953C-1C54-DAEE-2F2FE396431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7" creationId="{38E7CFA7-3C01-32E1-2485-C481865A24F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8" creationId="{72C442C6-B6C5-A390-2AF4-1B5317F3FC0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89" creationId="{58847D3E-458C-7434-18F2-7DEC6FF5708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0" creationId="{DE2EACE1-B1D4-A17C-19F9-AD910B5A439C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1" creationId="{9524A231-081B-5229-0CE3-B73A72EED83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2" creationId="{B326FC93-01BC-D9EE-4496-123A9C9CA7A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493" creationId="{F37444E6-F551-0343-6775-CCD99B22E615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499" creationId="{3E85AFA4-C5F7-DF52-BB9E-66D505EBD6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1" creationId="{8C6D8F70-58C2-6378-C678-38A073D3669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2" creationId="{9874BC1F-FB66-C56E-C54A-4A3D12C6C612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03" creationId="{3B8BF806-70E7-E9DB-EEAC-637882EB2953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504" creationId="{4A085E4F-99C9-9469-54B8-25B756BA807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1" creationId="{11039C50-FDC1-40E3-088C-9894CAB1FB0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3" creationId="{AB451B77-BD36-9D5E-3A42-ADC85C4A274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14" creationId="{27D74B33-A501-EFCF-CFC0-D5FF6947670D}"/>
          </ac:spMkLst>
        </pc:spChg>
        <pc:spChg chg="mod">
          <ac:chgData name="Go" userId="b11a5121-062d-4360-8951-d081ad96d999" providerId="ADAL" clId="{A37B11FE-7E2B-4B71-9282-AB38B86228CA}" dt="2022-10-13T20:17:25.731" v="732" actId="165"/>
          <ac:spMkLst>
            <pc:docMk/>
            <pc:sldMk cId="3299870256" sldId="301"/>
            <ac:spMk id="520" creationId="{98230770-BA50-4A07-C329-6CF4E9E4E9F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1" creationId="{20C542BB-E9AE-126F-C06F-2E3D1E9B051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3" creationId="{F343F3E4-96B9-E3F1-B27B-E6D7CEE54E7E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24" creationId="{0A7AAEA6-6BAB-0BDC-F388-EFCAF18976CA}"/>
          </ac:spMkLst>
        </pc:spChg>
        <pc:spChg chg="mod">
          <ac:chgData name="Go" userId="b11a5121-062d-4360-8951-d081ad96d999" providerId="ADAL" clId="{A37B11FE-7E2B-4B71-9282-AB38B86228CA}" dt="2022-10-13T20:13:18.935" v="662" actId="1076"/>
          <ac:spMkLst>
            <pc:docMk/>
            <pc:sldMk cId="3299870256" sldId="301"/>
            <ac:spMk id="526" creationId="{7150DCAB-0E6C-B67D-824B-2033EDAB459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2" creationId="{A657FCEA-4FF8-EBB9-EA2E-5DE85F99CD4B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3" creationId="{268130D2-72A5-6320-96B4-4CEC51FC0D9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4" creationId="{190E084B-4D3B-EE22-4F06-58112F5111B9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65" creationId="{3821EC33-988D-5E7A-366D-8526840CF9CB}"/>
          </ac:spMkLst>
        </pc:spChg>
        <pc:spChg chg="mod">
          <ac:chgData name="Go" userId="b11a5121-062d-4360-8951-d081ad96d999" providerId="ADAL" clId="{A37B11FE-7E2B-4B71-9282-AB38B86228CA}" dt="2022-10-13T19:39:15.377" v="292" actId="164"/>
          <ac:spMkLst>
            <pc:docMk/>
            <pc:sldMk cId="3299870256" sldId="301"/>
            <ac:spMk id="580" creationId="{7792413A-1C5F-F801-4015-D5F0C3EBE6AD}"/>
          </ac:spMkLst>
        </pc:spChg>
        <pc:spChg chg="mod topLvl">
          <ac:chgData name="Go" userId="b11a5121-062d-4360-8951-d081ad96d999" providerId="ADAL" clId="{A37B11FE-7E2B-4B71-9282-AB38B86228CA}" dt="2022-10-14T01:36:06.800" v="1309" actId="164"/>
          <ac:spMkLst>
            <pc:docMk/>
            <pc:sldMk cId="3299870256" sldId="301"/>
            <ac:spMk id="585" creationId="{E23D58ED-5C8D-3D42-D41C-1749190240B7}"/>
          </ac:spMkLst>
        </pc:spChg>
        <pc:spChg chg="mod">
          <ac:chgData name="Go" userId="b11a5121-062d-4360-8951-d081ad96d999" providerId="ADAL" clId="{A37B11FE-7E2B-4B71-9282-AB38B86228CA}" dt="2022-10-13T20:12:06.081" v="648" actId="1035"/>
          <ac:spMkLst>
            <pc:docMk/>
            <pc:sldMk cId="3299870256" sldId="301"/>
            <ac:spMk id="586" creationId="{205EBF96-3975-9EBB-82BF-524229ADCA56}"/>
          </ac:spMkLst>
        </pc:spChg>
        <pc:spChg chg="mod topLvl">
          <ac:chgData name="Go" userId="b11a5121-062d-4360-8951-d081ad96d999" providerId="ADAL" clId="{A37B11FE-7E2B-4B71-9282-AB38B86228CA}" dt="2022-10-14T01:36:21.436" v="1316" actId="164"/>
          <ac:spMkLst>
            <pc:docMk/>
            <pc:sldMk cId="3299870256" sldId="301"/>
            <ac:spMk id="588" creationId="{A32DF1B7-4FEE-A5A9-0149-91E988297B36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0" creationId="{AA06D570-6CA8-78A8-4078-0DCECA1A2914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1" creationId="{DAF03CD4-6585-0520-B5E5-596E496FC8D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2" creationId="{68E2104F-A94A-2856-1246-CD9535F3C81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3" creationId="{73CD0F0F-1DC2-2D06-FBAB-0AD204A2C89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4" creationId="{7AC4DDB0-14D2-7C48-BB54-FD55593DF778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5" creationId="{A38E2007-370C-1F1D-947C-193A8785E42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596" creationId="{D90BAA66-82BF-AB0E-F44E-A36937766776}"/>
          </ac:spMkLst>
        </pc:spChg>
        <pc:spChg chg="mod topLvl">
          <ac:chgData name="Go" userId="b11a5121-062d-4360-8951-d081ad96d999" providerId="ADAL" clId="{A37B11FE-7E2B-4B71-9282-AB38B86228CA}" dt="2022-10-14T01:45:09.381" v="1323" actId="553"/>
          <ac:spMkLst>
            <pc:docMk/>
            <pc:sldMk cId="3299870256" sldId="301"/>
            <ac:spMk id="597" creationId="{E6292181-C7C6-4CF8-A805-A931E21A76A1}"/>
          </ac:spMkLst>
        </pc:spChg>
        <pc:spChg chg="del mod topLvl">
          <ac:chgData name="Go" userId="b11a5121-062d-4360-8951-d081ad96d999" providerId="ADAL" clId="{A37B11FE-7E2B-4B71-9282-AB38B86228CA}" dt="2022-10-13T20:44:50.671" v="1174" actId="478"/>
          <ac:spMkLst>
            <pc:docMk/>
            <pc:sldMk cId="3299870256" sldId="301"/>
            <ac:spMk id="599" creationId="{E3E9E340-698C-4C41-C51F-F9688B6E4A7B}"/>
          </ac:spMkLst>
        </pc:spChg>
        <pc:spChg chg="mod topLvl">
          <ac:chgData name="Go" userId="b11a5121-062d-4360-8951-d081ad96d999" providerId="ADAL" clId="{A37B11FE-7E2B-4B71-9282-AB38B86228CA}" dt="2022-10-14T01:36:20.178" v="1315" actId="164"/>
          <ac:spMkLst>
            <pc:docMk/>
            <pc:sldMk cId="3299870256" sldId="301"/>
            <ac:spMk id="600" creationId="{25A313C0-ED4F-B2AC-AA3D-FC9850323AB4}"/>
          </ac:spMkLst>
        </pc:spChg>
        <pc:spChg chg="mod topLvl">
          <ac:chgData name="Go" userId="b11a5121-062d-4360-8951-d081ad96d999" providerId="ADAL" clId="{A37B11FE-7E2B-4B71-9282-AB38B86228CA}" dt="2022-10-14T01:36:05.499" v="1308" actId="164"/>
          <ac:spMkLst>
            <pc:docMk/>
            <pc:sldMk cId="3299870256" sldId="301"/>
            <ac:spMk id="601" creationId="{A697E26C-8009-3F24-4E68-358C8DEF8C11}"/>
          </ac:spMkLst>
        </pc:spChg>
        <pc:spChg chg="mod topLvl">
          <ac:chgData name="Go" userId="b11a5121-062d-4360-8951-d081ad96d999" providerId="ADAL" clId="{A37B11FE-7E2B-4B71-9282-AB38B86228CA}" dt="2022-10-14T01:36:14.970" v="1314" actId="164"/>
          <ac:spMkLst>
            <pc:docMk/>
            <pc:sldMk cId="3299870256" sldId="301"/>
            <ac:spMk id="603" creationId="{020F0874-AAB1-362B-9A95-E64C15A3E8FA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04" creationId="{7A9BDA8B-9DBA-9769-D99B-EFE7737C9653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07" creationId="{722E467E-3687-BA7D-239B-1BF6CF2A196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19" creationId="{449E51EC-10A4-27BD-9A52-B3764E537BCF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1" creationId="{CD1F8E55-9517-768F-F486-09E3E8CD2121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2" creationId="{34E3AA86-8CB3-AEFE-8E81-B5D67BC7EA65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3" creationId="{8C025F04-1C7C-D904-4E2F-58041B5E43FD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4" creationId="{056594E1-727B-F8A1-7873-ACB7CE51EE0A}"/>
          </ac:spMkLst>
        </pc:spChg>
        <pc:spChg chg="mod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5" creationId="{2DEC7FC4-B77B-41B9-39FB-F34AC4A598DE}"/>
          </ac:spMkLst>
        </pc:spChg>
        <pc:spChg chg="mod topLvl">
          <ac:chgData name="Go" userId="b11a5121-062d-4360-8951-d081ad96d999" providerId="ADAL" clId="{A37B11FE-7E2B-4B71-9282-AB38B86228CA}" dt="2022-10-15T01:45:25.502" v="1479" actId="20577"/>
          <ac:spMkLst>
            <pc:docMk/>
            <pc:sldMk cId="3299870256" sldId="301"/>
            <ac:spMk id="627" creationId="{BB631823-0DC3-5C1A-041D-A50258A2A6BF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28" creationId="{31E8D49C-35CD-EDF2-DC82-42A21F575D80}"/>
          </ac:spMkLst>
        </pc:spChg>
        <pc:spChg chg="mod topLvl">
          <ac:chgData name="Go" userId="b11a5121-062d-4360-8951-d081ad96d999" providerId="ADAL" clId="{A37B11FE-7E2B-4B71-9282-AB38B86228CA}" dt="2022-10-14T00:57:07.779" v="1192" actId="165"/>
          <ac:spMkLst>
            <pc:docMk/>
            <pc:sldMk cId="3299870256" sldId="301"/>
            <ac:spMk id="629" creationId="{F9EE2836-7AC4-31A7-0E13-A86BEF57BE09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30" creationId="{F103AB24-EC14-CA9C-C4C8-EE62809B3B01}"/>
          </ac:spMkLst>
        </pc:spChg>
        <pc:spChg chg="mod topLvl">
          <ac:chgData name="Go" userId="b11a5121-062d-4360-8951-d081ad96d999" providerId="ADAL" clId="{A37B11FE-7E2B-4B71-9282-AB38B86228CA}" dt="2022-10-14T01:34:22.952" v="1296" actId="165"/>
          <ac:spMkLst>
            <pc:docMk/>
            <pc:sldMk cId="3299870256" sldId="301"/>
            <ac:spMk id="631" creationId="{2D9A61C5-B110-F215-6EE2-F5FA5C51E266}"/>
          </ac:spMkLst>
        </pc:spChg>
        <pc:spChg chg="mod topLvl">
          <ac:chgData name="Go" userId="b11a5121-062d-4360-8951-d081ad96d999" providerId="ADAL" clId="{A37B11FE-7E2B-4B71-9282-AB38B86228CA}" dt="2022-10-15T01:45:21.181" v="1476" actId="20577"/>
          <ac:spMkLst>
            <pc:docMk/>
            <pc:sldMk cId="3299870256" sldId="301"/>
            <ac:spMk id="633" creationId="{54DFD1DA-06A8-DAA2-E105-226D1953D5D8}"/>
          </ac:spMkLst>
        </pc:spChg>
        <pc:grpChg chg="mod topLvl">
          <ac:chgData name="Go" userId="b11a5121-062d-4360-8951-d081ad96d999" providerId="ADAL" clId="{A37B11FE-7E2B-4B71-9282-AB38B86228CA}" dt="2022-10-14T00:58:14.953" v="1205" actId="1037"/>
          <ac:grpSpMkLst>
            <pc:docMk/>
            <pc:sldMk cId="3299870256" sldId="301"/>
            <ac:grpSpMk id="3" creationId="{3A15472C-E09F-4095-A18E-A09C1E12E157}"/>
          </ac:grpSpMkLst>
        </pc:grpChg>
        <pc:grpChg chg="mod">
          <ac:chgData name="Go" userId="b11a5121-062d-4360-8951-d081ad96d999" providerId="ADAL" clId="{A37B11FE-7E2B-4B71-9282-AB38B86228CA}" dt="2022-10-14T00:58:02.932" v="1200" actId="553"/>
          <ac:grpSpMkLst>
            <pc:docMk/>
            <pc:sldMk cId="3299870256" sldId="301"/>
            <ac:grpSpMk id="4" creationId="{2D984CF2-E6E5-BE37-045A-A523D153C1F2}"/>
          </ac:grpSpMkLst>
        </pc:grpChg>
        <pc:grpChg chg="mod topLvl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5" creationId="{1388BBF7-D2F6-5B7B-E265-EEFCCE94891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6" creationId="{EFB1E376-C984-27E2-D7BA-ECC00BD555CB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8" creationId="{88008BFA-7955-448B-7576-35EA5B302522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9" creationId="{6DD48C8D-2E56-FC23-39A6-9849EF8614D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0" creationId="{22BC352B-0776-C75B-AFCE-B2F4DA4B02D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3" creationId="{1E099AC9-B6D4-462F-43ED-2B932B9309F3}"/>
          </ac:grpSpMkLst>
        </pc:grpChg>
        <pc:grpChg chg="mod">
          <ac:chgData name="Go" userId="b11a5121-062d-4360-8951-d081ad96d999" providerId="ADAL" clId="{A37B11FE-7E2B-4B71-9282-AB38B86228CA}" dt="2022-10-14T00:58:02.932" v="1200" actId="553"/>
          <ac:grpSpMkLst>
            <pc:docMk/>
            <pc:sldMk cId="3299870256" sldId="301"/>
            <ac:grpSpMk id="14" creationId="{9F868A2D-1438-4051-AF94-B48BE5A5D4A5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5" creationId="{EB21658D-98D4-B8CE-DB71-377C482A4C7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17" creationId="{93C19B69-5A22-1796-D34A-E0CFBF4D2942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8" creationId="{6AEEC1AF-D955-9805-31DF-521E0F8EECF7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19" creationId="{DCFDA3C9-95DA-84E5-B03B-630323BBD700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20" creationId="{E21F8CEC-E83B-F070-D777-299FA4EAFA32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2" creationId="{263E61ED-5421-DE06-B82D-EE1732F3DA77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3" creationId="{65B76B05-D1BD-E06F-2690-D36B4A3C1298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5" creationId="{08034CE4-3BE0-82C9-E197-E68BA40F9FFB}"/>
          </ac:grpSpMkLst>
        </pc:grpChg>
        <pc:grpChg chg="add del mod">
          <ac:chgData name="Go" userId="b11a5121-062d-4360-8951-d081ad96d999" providerId="ADAL" clId="{A37B11FE-7E2B-4B71-9282-AB38B86228CA}" dt="2022-10-13T19:25:12.606" v="201" actId="165"/>
          <ac:grpSpMkLst>
            <pc:docMk/>
            <pc:sldMk cId="3299870256" sldId="301"/>
            <ac:grpSpMk id="26" creationId="{3A610986-9E30-7E86-865F-33685AA918A1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7" creationId="{9722C1A9-94D4-550D-27FD-D9A371E8B1B3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28" creationId="{4C3A9C18-AA41-2261-76B8-6A3AF44FBB04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9" creationId="{A7DDF06A-382C-6CD8-C3E3-BE0952D0724E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0" creationId="{DE657C15-C591-D2D6-7331-C3DA2583BEC7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1" creationId="{1B170842-CD20-41D8-BECA-DB0F71589DFC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34" creationId="{5CBAE8C0-4B65-AE6B-5DF5-74957DC4BC0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35" creationId="{3B5D5338-4068-0B8B-9A3F-750DB95A2FDC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0" creationId="{DA83DE12-C34C-C77E-7C63-AF20E33CF15F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1" creationId="{5A65F7AC-5AE9-8CE2-C5A0-43547C8A0C9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2" creationId="{B7ABF30E-0DAA-79EC-3373-2A1384ED35EE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" creationId="{CA2DC73B-0DCA-BD1A-690E-97E31DECD1A1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6" creationId="{D1FC1DCA-D234-F33B-B943-D3EC23252ADD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8" creationId="{9FBB999A-C9A9-63E3-4497-9E82FE676455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9" creationId="{229C6446-E3E8-E694-9D74-5E2F97B0E3BC}"/>
          </ac:grpSpMkLst>
        </pc:grpChg>
        <pc:grpChg chg="mod">
          <ac:chgData name="Go" userId="b11a5121-062d-4360-8951-d081ad96d999" providerId="ADAL" clId="{A37B11FE-7E2B-4B71-9282-AB38B86228CA}" dt="2022-10-13T19:37:57.744" v="281" actId="164"/>
          <ac:grpSpMkLst>
            <pc:docMk/>
            <pc:sldMk cId="3299870256" sldId="301"/>
            <ac:grpSpMk id="50" creationId="{2494B6E0-8512-E611-C1B9-FB4744D3EE43}"/>
          </ac:grpSpMkLst>
        </pc:grpChg>
        <pc:grpChg chg="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52" creationId="{48E7B0E3-D283-8BA1-1AFA-8DE42C102D2F}"/>
          </ac:grpSpMkLst>
        </pc:grpChg>
        <pc:grpChg chg="mod topLvl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54" creationId="{E0F5D351-A7F5-BEAB-DA1C-80547F9DD3E0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58" creationId="{50A49278-9C09-11F2-7571-2FABA095C600}"/>
          </ac:grpSpMkLst>
        </pc:grpChg>
        <pc:grpChg chg="mod">
          <ac:chgData name="Go" userId="b11a5121-062d-4360-8951-d081ad96d999" providerId="ADAL" clId="{A37B11FE-7E2B-4B71-9282-AB38B86228CA}" dt="2022-10-13T19:42:29.526" v="330" actId="164"/>
          <ac:grpSpMkLst>
            <pc:docMk/>
            <pc:sldMk cId="3299870256" sldId="301"/>
            <ac:grpSpMk id="59" creationId="{6C9199C7-9E8F-87D8-5B0D-213EBCB0BABD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2" creationId="{C8E36A41-226C-3052-0ADB-0BB617BAD25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29" creationId="{89124929-017B-F717-C116-73761B755524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0" creationId="{2B0E73FB-59F0-E7D2-0310-1FD156327979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1" creationId="{5EA6E0E4-6A72-08B5-0EB1-47721D704954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5" creationId="{A265201B-D5B5-EEB9-D592-E9EF89CB9301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6" creationId="{660071C4-AF1A-F11A-7193-C5071E39C7E7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7" creationId="{6ED48973-95E0-357D-AC36-20D3666319FF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138" creationId="{C1E8B024-5731-5476-C6B6-95AA4CAD3B03}"/>
          </ac:grpSpMkLst>
        </pc:grpChg>
        <pc:grpChg chg="add del mod">
          <ac:chgData name="Go" userId="b11a5121-062d-4360-8951-d081ad96d999" providerId="ADAL" clId="{A37B11FE-7E2B-4B71-9282-AB38B86228CA}" dt="2022-10-14T00:59:40.964" v="1240" actId="165"/>
          <ac:grpSpMkLst>
            <pc:docMk/>
            <pc:sldMk cId="3299870256" sldId="301"/>
            <ac:grpSpMk id="148" creationId="{DA943FAE-201F-B1F7-CF56-BE6899E04EDE}"/>
          </ac:grpSpMkLst>
        </pc:grpChg>
        <pc:grpChg chg="add del mod">
          <ac:chgData name="Go" userId="b11a5121-062d-4360-8951-d081ad96d999" providerId="ADAL" clId="{A37B11FE-7E2B-4B71-9282-AB38B86228CA}" dt="2022-10-13T19:29:13.781" v="260" actId="478"/>
          <ac:grpSpMkLst>
            <pc:docMk/>
            <pc:sldMk cId="3299870256" sldId="301"/>
            <ac:grpSpMk id="149" creationId="{D3A98D2F-2446-214B-B826-9BB044E14D15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0" creationId="{05F86C2F-640D-E1D5-36EB-E6E50B8C3F91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8" creationId="{20C4011F-06A5-AD21-717D-E7DCFB5938BD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59" creationId="{888587E8-F72F-7AE3-6E49-39A5F6F39D88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0" creationId="{2503A332-E3D4-87E9-47D4-A2C1195791C6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1" creationId="{81FB3C0B-C61C-C430-93FB-1E80A877F9F6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2" creationId="{BACCF2D1-C048-E0F7-D0DD-15E11C95356C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3" creationId="{4A37BA4A-52DE-625C-3261-8EE61324ED0F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6" creationId="{AF619EF9-F673-DAA6-00F8-12297E94F047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7" creationId="{D0DA96D6-88AB-3185-11D5-A333C067C9B4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8" creationId="{03B504D3-9D18-15FC-01FA-6B74980B0B97}"/>
          </ac:grpSpMkLst>
        </pc:grpChg>
        <pc:grpChg chg="mod">
          <ac:chgData name="Go" userId="b11a5121-062d-4360-8951-d081ad96d999" providerId="ADAL" clId="{A37B11FE-7E2B-4B71-9282-AB38B86228CA}" dt="2022-10-13T19:27:29.859" v="258"/>
          <ac:grpSpMkLst>
            <pc:docMk/>
            <pc:sldMk cId="3299870256" sldId="301"/>
            <ac:grpSpMk id="169" creationId="{7A29E34A-835F-0AE1-F6A4-8483D9010DE9}"/>
          </ac:grpSpMkLst>
        </pc:grpChg>
        <pc:grpChg chg="add del 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193" creationId="{89CCBB04-7A77-C318-6C19-2E834C00AD68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03" creationId="{CA055B1A-29F7-78DE-2EA1-2873F4ABC67E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17" creationId="{00040F81-2DC4-3E38-9036-FC1F1F38BE7F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24" creationId="{71E7D225-FA66-432D-8FC6-B6242D429D47}"/>
          </ac:grpSpMkLst>
        </pc:grpChg>
        <pc:grpChg chg="mod topLvl">
          <ac:chgData name="Go" userId="b11a5121-062d-4360-8951-d081ad96d999" providerId="ADAL" clId="{A37B11FE-7E2B-4B71-9282-AB38B86228CA}" dt="2022-10-14T02:29:52.315" v="1456" actId="165"/>
          <ac:grpSpMkLst>
            <pc:docMk/>
            <pc:sldMk cId="3299870256" sldId="301"/>
            <ac:grpSpMk id="225" creationId="{BD3B101C-4210-8AF9-1348-81B31A70C4A5}"/>
          </ac:grpSpMkLst>
        </pc:grpChg>
        <pc:grpChg chg="add del mod">
          <ac:chgData name="Go" userId="b11a5121-062d-4360-8951-d081ad96d999" providerId="ADAL" clId="{A37B11FE-7E2B-4B71-9282-AB38B86228CA}" dt="2022-10-14T02:29:48.593" v="1455" actId="165"/>
          <ac:grpSpMkLst>
            <pc:docMk/>
            <pc:sldMk cId="3299870256" sldId="301"/>
            <ac:grpSpMk id="240" creationId="{BED4C65C-1302-ADDD-5052-6C97109E5888}"/>
          </ac:grpSpMkLst>
        </pc:grpChg>
        <pc:grpChg chg="add del mod">
          <ac:chgData name="Go" userId="b11a5121-062d-4360-8951-d081ad96d999" providerId="ADAL" clId="{A37B11FE-7E2B-4B71-9282-AB38B86228CA}" dt="2022-10-13T20:37:40.069" v="1073" actId="21"/>
          <ac:grpSpMkLst>
            <pc:docMk/>
            <pc:sldMk cId="3299870256" sldId="301"/>
            <ac:grpSpMk id="259" creationId="{06052E30-B50E-1C14-3C48-1E6384204462}"/>
          </ac:grpSpMkLst>
        </pc:grpChg>
        <pc:grpChg chg="add del mod">
          <ac:chgData name="Go" userId="b11a5121-062d-4360-8951-d081ad96d999" providerId="ADAL" clId="{A37B11FE-7E2B-4B71-9282-AB38B86228CA}" dt="2022-10-13T20:37:40.069" v="1073" actId="21"/>
          <ac:grpSpMkLst>
            <pc:docMk/>
            <pc:sldMk cId="3299870256" sldId="301"/>
            <ac:grpSpMk id="260" creationId="{DB986CF1-E1A6-C8BC-4A2D-B9BF80A0EBDC}"/>
          </ac:grpSpMkLst>
        </pc:grpChg>
        <pc:grpChg chg="add del 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261" creationId="{BD2AFFE4-E983-4043-6794-C32D45ACD43C}"/>
          </ac:grpSpMkLst>
        </pc:grpChg>
        <pc:grpChg chg="add del mod">
          <ac:chgData name="Go" userId="b11a5121-062d-4360-8951-d081ad96d999" providerId="ADAL" clId="{A37B11FE-7E2B-4B71-9282-AB38B86228CA}" dt="2022-10-14T00:59:37.722" v="1239" actId="165"/>
          <ac:grpSpMkLst>
            <pc:docMk/>
            <pc:sldMk cId="3299870256" sldId="301"/>
            <ac:grpSpMk id="262" creationId="{61B0BC72-812D-A231-D96A-F6087C5E3EE6}"/>
          </ac:grpSpMkLst>
        </pc:grpChg>
        <pc:grpChg chg="add del mod">
          <ac:chgData name="Go" userId="b11a5121-062d-4360-8951-d081ad96d999" providerId="ADAL" clId="{A37B11FE-7E2B-4B71-9282-AB38B86228CA}" dt="2022-10-14T01:01:34.453" v="1259" actId="478"/>
          <ac:grpSpMkLst>
            <pc:docMk/>
            <pc:sldMk cId="3299870256" sldId="301"/>
            <ac:grpSpMk id="263" creationId="{B0AC73BE-6F55-4723-14F2-ADCD102BA898}"/>
          </ac:grpSpMkLst>
        </pc:grpChg>
        <pc:grpChg chg="add del mod">
          <ac:chgData name="Go" userId="b11a5121-062d-4360-8951-d081ad96d999" providerId="ADAL" clId="{A37B11FE-7E2B-4B71-9282-AB38B86228CA}" dt="2022-10-14T01:01:29.443" v="1258" actId="478"/>
          <ac:grpSpMkLst>
            <pc:docMk/>
            <pc:sldMk cId="3299870256" sldId="301"/>
            <ac:grpSpMk id="264" creationId="{68282E87-717A-8666-E037-BFEC9228F9BE}"/>
          </ac:grpSpMkLst>
        </pc:grpChg>
        <pc:grpChg chg="mod topLvl">
          <ac:chgData name="Go" userId="b11a5121-062d-4360-8951-d081ad96d999" providerId="ADAL" clId="{A37B11FE-7E2B-4B71-9282-AB38B86228CA}" dt="2022-10-14T00:57:24.470" v="1194" actId="1038"/>
          <ac:grpSpMkLst>
            <pc:docMk/>
            <pc:sldMk cId="3299870256" sldId="301"/>
            <ac:grpSpMk id="265" creationId="{58D7A5F3-D98F-4285-EE18-1B7425AB048A}"/>
          </ac:grpSpMkLst>
        </pc:grpChg>
        <pc:grpChg chg="add del 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266" creationId="{FDD02D53-F9C4-E829-3548-2F53BFBEF7F5}"/>
          </ac:grpSpMkLst>
        </pc:grpChg>
        <pc:grpChg chg="add del mod">
          <ac:chgData name="Go" userId="b11a5121-062d-4360-8951-d081ad96d999" providerId="ADAL" clId="{A37B11FE-7E2B-4B71-9282-AB38B86228CA}" dt="2022-10-13T19:57:57.841" v="482" actId="165"/>
          <ac:grpSpMkLst>
            <pc:docMk/>
            <pc:sldMk cId="3299870256" sldId="301"/>
            <ac:grpSpMk id="267" creationId="{D4E4A787-B943-BF86-3346-2D6278942CFC}"/>
          </ac:grpSpMkLst>
        </pc:grpChg>
        <pc:grpChg chg="del mod topLvl">
          <ac:chgData name="Go" userId="b11a5121-062d-4360-8951-d081ad96d999" providerId="ADAL" clId="{A37B11FE-7E2B-4B71-9282-AB38B86228CA}" dt="2022-10-13T19:58:04.305" v="483" actId="165"/>
          <ac:grpSpMkLst>
            <pc:docMk/>
            <pc:sldMk cId="3299870256" sldId="301"/>
            <ac:grpSpMk id="274" creationId="{875AD099-F79F-5547-17A1-3CB1F0DE0D7D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5" creationId="{2158226A-2A85-E602-9A30-79BEBEA3D320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6" creationId="{114847D3-18A6-759B-AE6B-087468152E16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7" creationId="{11523D18-64A6-16B0-416E-2EAD11284048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8" creationId="{AB8DEA19-BAE1-4C09-BCA8-37C2A07CE1ED}"/>
          </ac:grpSpMkLst>
        </pc:grpChg>
        <pc:grpChg chg="mod topLvl">
          <ac:chgData name="Go" userId="b11a5121-062d-4360-8951-d081ad96d999" providerId="ADAL" clId="{A37B11FE-7E2B-4B71-9282-AB38B86228CA}" dt="2022-10-13T19:59:05.306" v="496" actId="164"/>
          <ac:grpSpMkLst>
            <pc:docMk/>
            <pc:sldMk cId="3299870256" sldId="301"/>
            <ac:grpSpMk id="279" creationId="{280A69EF-3FA3-42BF-A3BF-970EC68C35C7}"/>
          </ac:grpSpMkLst>
        </pc:grpChg>
        <pc:grpChg chg="add del mod">
          <ac:chgData name="Go" userId="b11a5121-062d-4360-8951-d081ad96d999" providerId="ADAL" clId="{A37B11FE-7E2B-4B71-9282-AB38B86228CA}" dt="2022-10-14T01:01:29.443" v="1258" actId="478"/>
          <ac:grpSpMkLst>
            <pc:docMk/>
            <pc:sldMk cId="3299870256" sldId="301"/>
            <ac:grpSpMk id="292" creationId="{A8D94023-2F40-FAB7-4B38-1E6FEAAB6C72}"/>
          </ac:grpSpMkLst>
        </pc:grpChg>
        <pc:grpChg chg="add del mod">
          <ac:chgData name="Go" userId="b11a5121-062d-4360-8951-d081ad96d999" providerId="ADAL" clId="{A37B11FE-7E2B-4B71-9282-AB38B86228CA}" dt="2022-10-13T20:09:47.735" v="627"/>
          <ac:grpSpMkLst>
            <pc:docMk/>
            <pc:sldMk cId="3299870256" sldId="301"/>
            <ac:grpSpMk id="293" creationId="{B1964AB4-0E69-E994-4026-A46804A76D72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6" creationId="{FC6F99FC-79C9-2209-7971-392B413549E2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7" creationId="{B0D4C18E-3363-8B56-22FE-A41267AA89FC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8" creationId="{1BB8B353-3D71-2B26-8968-183486501540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299" creationId="{52A52DF8-7456-73AB-62E4-82D75F8C0E88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300" creationId="{A5F6D758-F059-6A13-B942-EB95B8D109E7}"/>
          </ac:grpSpMkLst>
        </pc:grpChg>
        <pc:grpChg chg="mod">
          <ac:chgData name="Go" userId="b11a5121-062d-4360-8951-d081ad96d999" providerId="ADAL" clId="{A37B11FE-7E2B-4B71-9282-AB38B86228CA}" dt="2022-10-13T20:09:45.203" v="626"/>
          <ac:grpSpMkLst>
            <pc:docMk/>
            <pc:sldMk cId="3299870256" sldId="301"/>
            <ac:grpSpMk id="301" creationId="{FC5468B3-7BDA-852D-9EB3-4C3821F961B5}"/>
          </ac:grpSpMkLst>
        </pc:grpChg>
        <pc:grpChg chg="add del mod">
          <ac:chgData name="Go" userId="b11a5121-062d-4360-8951-d081ad96d999" providerId="ADAL" clId="{A37B11FE-7E2B-4B71-9282-AB38B86228CA}" dt="2022-10-13T20:09:58.048" v="631" actId="165"/>
          <ac:grpSpMkLst>
            <pc:docMk/>
            <pc:sldMk cId="3299870256" sldId="301"/>
            <ac:grpSpMk id="314" creationId="{898D394D-672C-000D-342D-400772054CE8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5" creationId="{9DF2153F-54CF-41D9-92CA-304D9C0F4E19}"/>
          </ac:grpSpMkLst>
        </pc:grpChg>
        <pc:grpChg chg="mod topLvl">
          <ac:chgData name="Go" userId="b11a5121-062d-4360-8951-d081ad96d999" providerId="ADAL" clId="{A37B11FE-7E2B-4B71-9282-AB38B86228CA}" dt="2022-10-13T20:11:40.162" v="640" actId="164"/>
          <ac:grpSpMkLst>
            <pc:docMk/>
            <pc:sldMk cId="3299870256" sldId="301"/>
            <ac:grpSpMk id="316" creationId="{58532A4C-F9CD-9019-825E-0C65A6314E0C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7" creationId="{F03F37D9-D1DC-8D1E-1E1F-0E4F3AD1A154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8" creationId="{3A39B59E-48B3-8BE2-1987-B615FF746E62}"/>
          </ac:grpSpMkLst>
        </pc:grpChg>
        <pc:grpChg chg="mod topLvl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19" creationId="{6E199C07-D00E-0C25-D136-995E9A39EAF9}"/>
          </ac:grpSpMkLst>
        </pc:grpChg>
        <pc:grpChg chg="add mod">
          <ac:chgData name="Go" userId="b11a5121-062d-4360-8951-d081ad96d999" providerId="ADAL" clId="{A37B11FE-7E2B-4B71-9282-AB38B86228CA}" dt="2022-10-13T20:11:51.449" v="642" actId="164"/>
          <ac:grpSpMkLst>
            <pc:docMk/>
            <pc:sldMk cId="3299870256" sldId="301"/>
            <ac:grpSpMk id="336" creationId="{DCE78AD3-C711-3E16-3E7F-D857F61DDA9B}"/>
          </ac:grpSpMkLst>
        </pc:grpChg>
        <pc:grpChg chg="add mod topLvl">
          <ac:chgData name="Go" userId="b11a5121-062d-4360-8951-d081ad96d999" providerId="ADAL" clId="{A37B11FE-7E2B-4B71-9282-AB38B86228CA}" dt="2022-10-14T01:00:33.659" v="1248" actId="1076"/>
          <ac:grpSpMkLst>
            <pc:docMk/>
            <pc:sldMk cId="3299870256" sldId="301"/>
            <ac:grpSpMk id="337" creationId="{A592923E-902B-1B0D-72C1-7CA0B9A4BB1C}"/>
          </ac:grpSpMkLst>
        </pc:grpChg>
        <pc:grpChg chg="add del mod">
          <ac:chgData name="Go" userId="b11a5121-062d-4360-8951-d081ad96d999" providerId="ADAL" clId="{A37B11FE-7E2B-4B71-9282-AB38B86228CA}" dt="2022-10-13T20:37:11.999" v="1065" actId="478"/>
          <ac:grpSpMkLst>
            <pc:docMk/>
            <pc:sldMk cId="3299870256" sldId="301"/>
            <ac:grpSpMk id="339" creationId="{6676A960-59B6-7C0B-035C-8F4BE41BEDAA}"/>
          </ac:grpSpMkLst>
        </pc:grpChg>
        <pc:grpChg chg="add del mod">
          <ac:chgData name="Go" userId="b11a5121-062d-4360-8951-d081ad96d999" providerId="ADAL" clId="{A37B11FE-7E2B-4B71-9282-AB38B86228CA}" dt="2022-10-13T20:24:09.931" v="865" actId="165"/>
          <ac:grpSpMkLst>
            <pc:docMk/>
            <pc:sldMk cId="3299870256" sldId="301"/>
            <ac:grpSpMk id="340" creationId="{671D36F8-D555-942C-3E5D-AAA35E59A0A4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46" creationId="{E3EC0F57-23A8-8FFB-0A67-17581C852908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49" creationId="{2BA48B4E-73AD-40F9-7176-5EDE0323FA4B}"/>
          </ac:grpSpMkLst>
        </pc:grpChg>
        <pc:grpChg chg="mod topLvl">
          <ac:chgData name="Go" userId="b11a5121-062d-4360-8951-d081ad96d999" providerId="ADAL" clId="{A37B11FE-7E2B-4B71-9282-AB38B86228CA}" dt="2022-10-13T20:27:28.335" v="982" actId="164"/>
          <ac:grpSpMkLst>
            <pc:docMk/>
            <pc:sldMk cId="3299870256" sldId="301"/>
            <ac:grpSpMk id="350" creationId="{B1B0CBD4-0FAD-2780-2395-1FB3557AB250}"/>
          </ac:grpSpMkLst>
        </pc:grpChg>
        <pc:grpChg chg="del mod topLvl">
          <ac:chgData name="Go" userId="b11a5121-062d-4360-8951-d081ad96d999" providerId="ADAL" clId="{A37B11FE-7E2B-4B71-9282-AB38B86228CA}" dt="2022-10-13T20:27:13.878" v="979" actId="165"/>
          <ac:grpSpMkLst>
            <pc:docMk/>
            <pc:sldMk cId="3299870256" sldId="301"/>
            <ac:grpSpMk id="351" creationId="{47D789D8-FE9C-BF73-69A9-D6B8EA12AA0E}"/>
          </ac:grpSpMkLst>
        </pc:grpChg>
        <pc:grpChg chg="del mod topLvl">
          <ac:chgData name="Go" userId="b11a5121-062d-4360-8951-d081ad96d999" providerId="ADAL" clId="{A37B11FE-7E2B-4B71-9282-AB38B86228CA}" dt="2022-10-13T20:27:13.878" v="979" actId="165"/>
          <ac:grpSpMkLst>
            <pc:docMk/>
            <pc:sldMk cId="3299870256" sldId="301"/>
            <ac:grpSpMk id="352" creationId="{C52075DA-F236-C5A1-FFCF-53173DA2EF5D}"/>
          </ac:grpSpMkLst>
        </pc:grpChg>
        <pc:grpChg chg="add mod">
          <ac:chgData name="Go" userId="b11a5121-062d-4360-8951-d081ad96d999" providerId="ADAL" clId="{A37B11FE-7E2B-4B71-9282-AB38B86228CA}" dt="2022-10-14T00:58:24.463" v="1206" actId="1036"/>
          <ac:grpSpMkLst>
            <pc:docMk/>
            <pc:sldMk cId="3299870256" sldId="301"/>
            <ac:grpSpMk id="374" creationId="{AAF6BCB0-A71D-E66D-E543-E248480A65DC}"/>
          </ac:grpSpMkLst>
        </pc:grpChg>
        <pc:grpChg chg="add del mod">
          <ac:chgData name="Go" userId="b11a5121-062d-4360-8951-d081ad96d999" providerId="ADAL" clId="{A37B11FE-7E2B-4B71-9282-AB38B86228CA}" dt="2022-10-14T01:34:22.952" v="1296" actId="165"/>
          <ac:grpSpMkLst>
            <pc:docMk/>
            <pc:sldMk cId="3299870256" sldId="301"/>
            <ac:grpSpMk id="378" creationId="{5FFF24B6-C87F-CBE8-3E41-3B9ED19D81C8}"/>
          </ac:grpSpMkLst>
        </pc:grpChg>
        <pc:grpChg chg="add del mod">
          <ac:chgData name="Go" userId="b11a5121-062d-4360-8951-d081ad96d999" providerId="ADAL" clId="{A37B11FE-7E2B-4B71-9282-AB38B86228CA}" dt="2022-10-14T01:44:41.667" v="1318" actId="165"/>
          <ac:grpSpMkLst>
            <pc:docMk/>
            <pc:sldMk cId="3299870256" sldId="301"/>
            <ac:grpSpMk id="389" creationId="{25FC274A-B6D8-289C-446E-766DA1432518}"/>
          </ac:grpSpMkLst>
        </pc:grpChg>
        <pc:grpChg chg="add mod">
          <ac:chgData name="Go" userId="b11a5121-062d-4360-8951-d081ad96d999" providerId="ADAL" clId="{A37B11FE-7E2B-4B71-9282-AB38B86228CA}" dt="2022-10-14T01:36:05.499" v="1308" actId="164"/>
          <ac:grpSpMkLst>
            <pc:docMk/>
            <pc:sldMk cId="3299870256" sldId="301"/>
            <ac:grpSpMk id="390" creationId="{88B4357D-F221-0FB8-5451-F494353BCF01}"/>
          </ac:grpSpMkLst>
        </pc:grpChg>
        <pc:grpChg chg="add mod">
          <ac:chgData name="Go" userId="b11a5121-062d-4360-8951-d081ad96d999" providerId="ADAL" clId="{A37B11FE-7E2B-4B71-9282-AB38B86228CA}" dt="2022-10-14T01:36:06.800" v="1309" actId="164"/>
          <ac:grpSpMkLst>
            <pc:docMk/>
            <pc:sldMk cId="3299870256" sldId="301"/>
            <ac:grpSpMk id="391" creationId="{56F5E0E1-433B-E0CD-9B1A-609B3A9E497D}"/>
          </ac:grpSpMkLst>
        </pc:grpChg>
        <pc:grpChg chg="add mod">
          <ac:chgData name="Go" userId="b11a5121-062d-4360-8951-d081ad96d999" providerId="ADAL" clId="{A37B11FE-7E2B-4B71-9282-AB38B86228CA}" dt="2022-10-14T01:36:07.890" v="1310" actId="164"/>
          <ac:grpSpMkLst>
            <pc:docMk/>
            <pc:sldMk cId="3299870256" sldId="301"/>
            <ac:grpSpMk id="392" creationId="{F3D96FC1-C2D2-7B17-73F0-75EA30515C07}"/>
          </ac:grpSpMkLst>
        </pc:grpChg>
        <pc:grpChg chg="add del mod">
          <ac:chgData name="Go" userId="b11a5121-062d-4360-8951-d081ad96d999" providerId="ADAL" clId="{A37B11FE-7E2B-4B71-9282-AB38B86228CA}" dt="2022-10-14T01:44:41.667" v="1318" actId="165"/>
          <ac:grpSpMkLst>
            <pc:docMk/>
            <pc:sldMk cId="3299870256" sldId="301"/>
            <ac:grpSpMk id="393" creationId="{BB0A7282-2B13-93EF-0556-B0F550101E56}"/>
          </ac:grpSpMkLst>
        </pc:grpChg>
        <pc:grpChg chg="add mod">
          <ac:chgData name="Go" userId="b11a5121-062d-4360-8951-d081ad96d999" providerId="ADAL" clId="{A37B11FE-7E2B-4B71-9282-AB38B86228CA}" dt="2022-10-14T01:36:14.970" v="1314" actId="164"/>
          <ac:grpSpMkLst>
            <pc:docMk/>
            <pc:sldMk cId="3299870256" sldId="301"/>
            <ac:grpSpMk id="394" creationId="{ACAC60D1-21EC-ACB0-DEDE-C686500DE9BE}"/>
          </ac:grpSpMkLst>
        </pc:grpChg>
        <pc:grpChg chg="add mod">
          <ac:chgData name="Go" userId="b11a5121-062d-4360-8951-d081ad96d999" providerId="ADAL" clId="{A37B11FE-7E2B-4B71-9282-AB38B86228CA}" dt="2022-10-14T01:36:14.970" v="1314" actId="164"/>
          <ac:grpSpMkLst>
            <pc:docMk/>
            <pc:sldMk cId="3299870256" sldId="301"/>
            <ac:grpSpMk id="395" creationId="{1D1AE8C7-A0B7-49C4-EA03-8B8AC06968C1}"/>
          </ac:grpSpMkLst>
        </pc:grpChg>
        <pc:grpChg chg="add mod">
          <ac:chgData name="Go" userId="b11a5121-062d-4360-8951-d081ad96d999" providerId="ADAL" clId="{A37B11FE-7E2B-4B71-9282-AB38B86228CA}" dt="2022-10-14T01:36:20.178" v="1315" actId="164"/>
          <ac:grpSpMkLst>
            <pc:docMk/>
            <pc:sldMk cId="3299870256" sldId="301"/>
            <ac:grpSpMk id="396" creationId="{DB5C0BBC-03F2-39E0-1842-A4556752C54E}"/>
          </ac:grpSpMkLst>
        </pc:grpChg>
        <pc:grpChg chg="add mod">
          <ac:chgData name="Go" userId="b11a5121-062d-4360-8951-d081ad96d999" providerId="ADAL" clId="{A37B11FE-7E2B-4B71-9282-AB38B86228CA}" dt="2022-10-14T01:36:21.436" v="1316" actId="164"/>
          <ac:grpSpMkLst>
            <pc:docMk/>
            <pc:sldMk cId="3299870256" sldId="301"/>
            <ac:grpSpMk id="397" creationId="{B646B08F-FD34-C549-D704-3078D9996104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3" creationId="{5BAB4F1C-9B77-0EE4-3B0E-C89DF28CDA19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454" creationId="{9A5D5962-E869-7093-4002-36410AA5D696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464" creationId="{17C21720-62CF-2EB6-2C65-7D0429926D99}"/>
          </ac:grpSpMkLst>
        </pc:grpChg>
        <pc:grpChg chg="mod">
          <ac:chgData name="Go" userId="b11a5121-062d-4360-8951-d081ad96d999" providerId="ADAL" clId="{A37B11FE-7E2B-4B71-9282-AB38B86228CA}" dt="2022-10-13T20:17:25.731" v="732" actId="165"/>
          <ac:grpSpMkLst>
            <pc:docMk/>
            <pc:sldMk cId="3299870256" sldId="301"/>
            <ac:grpSpMk id="494" creationId="{5541D77E-146B-9CA5-ABC1-585250266CB6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68" creationId="{706C3840-D8CA-33D8-4500-9CF9E3C9CD63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73" creationId="{FBA6C53D-B473-F3A3-9284-0CA75D11F752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74" creationId="{09B9E57B-C211-879A-4E02-D57C8D7370D5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81" creationId="{4E21338A-FC59-5D0F-6590-E5BBA4062FCA}"/>
          </ac:grpSpMkLst>
        </pc:grpChg>
        <pc:grpChg chg="mod">
          <ac:chgData name="Go" userId="b11a5121-062d-4360-8951-d081ad96d999" providerId="ADAL" clId="{A37B11FE-7E2B-4B71-9282-AB38B86228CA}" dt="2022-10-13T19:39:15.377" v="292" actId="164"/>
          <ac:grpSpMkLst>
            <pc:docMk/>
            <pc:sldMk cId="3299870256" sldId="301"/>
            <ac:grpSpMk id="582" creationId="{8285CAB0-3863-6BEB-31C1-2CA27C7772CF}"/>
          </ac:grpSpMkLst>
        </pc:grpChg>
        <pc:grpChg chg="del mod topLvl">
          <ac:chgData name="Go" userId="b11a5121-062d-4360-8951-d081ad96d999" providerId="ADAL" clId="{A37B11FE-7E2B-4B71-9282-AB38B86228CA}" dt="2022-10-13T19:25:23.053" v="204" actId="165"/>
          <ac:grpSpMkLst>
            <pc:docMk/>
            <pc:sldMk cId="3299870256" sldId="301"/>
            <ac:grpSpMk id="583" creationId="{C172713A-54D7-22D0-035B-9E05CBD66C13}"/>
          </ac:grpSpMkLst>
        </pc:grpChg>
        <pc:grpChg chg="del mod topLvl">
          <ac:chgData name="Go" userId="b11a5121-062d-4360-8951-d081ad96d999" providerId="ADAL" clId="{A37B11FE-7E2B-4B71-9282-AB38B86228CA}" dt="2022-10-13T19:25:34.478" v="211" actId="165"/>
          <ac:grpSpMkLst>
            <pc:docMk/>
            <pc:sldMk cId="3299870256" sldId="301"/>
            <ac:grpSpMk id="605" creationId="{A1356258-CE95-6898-7C17-5897EA0D9115}"/>
          </ac:grpSpMkLst>
        </pc:grpChg>
        <pc:grpChg chg="del mod topLvl">
          <ac:chgData name="Go" userId="b11a5121-062d-4360-8951-d081ad96d999" providerId="ADAL" clId="{A37B11FE-7E2B-4B71-9282-AB38B86228CA}" dt="2022-10-13T19:25:34.478" v="211" actId="165"/>
          <ac:grpSpMkLst>
            <pc:docMk/>
            <pc:sldMk cId="3299870256" sldId="301"/>
            <ac:grpSpMk id="606" creationId="{20C45F35-C86C-5E72-B540-C0B86CD2C27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09" creationId="{5933C05E-F357-C1AA-C0E5-AB0366B3323F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0" creationId="{9E51DE33-5F23-372E-E897-B37F4B9D38B7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1" creationId="{B5383931-008B-27A4-8551-928741CA87C8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2" creationId="{AA7BD866-A642-E072-CB03-E6EC90E03463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3" creationId="{384C9D67-922B-5FE4-F5BE-2EDEE970B4F6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4" creationId="{2A68A7DF-F9C9-5046-85AB-EC2E5E9C691E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5" creationId="{B51C6E7A-1939-D71C-0980-ADDC1E6F759A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6" creationId="{A235A10B-0046-850D-E367-6FAB78643C13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7" creationId="{479189AC-07BA-8F0E-3FB2-7C45473B6F09}"/>
          </ac:grpSpMkLst>
        </pc:grpChg>
        <pc:grpChg chg="mod">
          <ac:chgData name="Go" userId="b11a5121-062d-4360-8951-d081ad96d999" providerId="ADAL" clId="{A37B11FE-7E2B-4B71-9282-AB38B86228CA}" dt="2022-10-14T00:57:07.779" v="1192" actId="165"/>
          <ac:grpSpMkLst>
            <pc:docMk/>
            <pc:sldMk cId="3299870256" sldId="301"/>
            <ac:grpSpMk id="618" creationId="{E1536666-8D1C-1255-C1E9-4C42CCAEDEF8}"/>
          </ac:grpSpMkLst>
        </pc:grpChg>
        <pc:grpChg chg="mod">
          <ac:chgData name="Go" userId="b11a5121-062d-4360-8951-d081ad96d999" providerId="ADAL" clId="{A37B11FE-7E2B-4B71-9282-AB38B86228CA}" dt="2022-10-13T19:37:44.577" v="276" actId="164"/>
          <ac:grpSpMkLst>
            <pc:docMk/>
            <pc:sldMk cId="3299870256" sldId="301"/>
            <ac:grpSpMk id="639" creationId="{1DE898C2-E809-2B55-CF57-DE7A01B03F65}"/>
          </ac:grpSpMkLst>
        </pc:grpChg>
        <pc:graphicFrameChg chg="mod">
          <ac:chgData name="Go" userId="b11a5121-062d-4360-8951-d081ad96d999" providerId="ADAL" clId="{A37B11FE-7E2B-4B71-9282-AB38B86228CA}" dt="2022-10-13T19:39:15.377" v="292" actId="164"/>
          <ac:graphicFrameMkLst>
            <pc:docMk/>
            <pc:sldMk cId="3299870256" sldId="301"/>
            <ac:graphicFrameMk id="2" creationId="{1AD00D3D-FBDC-C399-AE11-A003C5D2BB23}"/>
          </ac:graphicFrameMkLst>
        </pc:graphicFrameChg>
        <pc:graphicFrameChg chg="mod">
          <ac:chgData name="Go" userId="b11a5121-062d-4360-8951-d081ad96d999" providerId="ADAL" clId="{A37B11FE-7E2B-4B71-9282-AB38B86228CA}" dt="2022-10-14T00:57:07.779" v="1192" actId="165"/>
          <ac:graphicFrameMkLst>
            <pc:docMk/>
            <pc:sldMk cId="3299870256" sldId="301"/>
            <ac:graphicFrameMk id="7" creationId="{29619FA3-5320-80AE-05A1-1DFE07FA76AF}"/>
          </ac:graphicFrameMkLst>
        </pc:graphicFrameChg>
        <pc:graphicFrameChg chg="mod">
          <ac:chgData name="Go" userId="b11a5121-062d-4360-8951-d081ad96d999" providerId="ADAL" clId="{A37B11FE-7E2B-4B71-9282-AB38B86228CA}" dt="2022-10-13T19:37:44.577" v="276" actId="164"/>
          <ac:graphicFrameMkLst>
            <pc:docMk/>
            <pc:sldMk cId="3299870256" sldId="301"/>
            <ac:graphicFrameMk id="39" creationId="{A19956A4-38A4-0919-E076-3ECBAC5CB58A}"/>
          </ac:graphicFrameMkLst>
        </pc:graphicFrameChg>
        <pc:graphicFrameChg chg="mod topLvl">
          <ac:chgData name="Go" userId="b11a5121-062d-4360-8951-d081ad96d999" providerId="ADAL" clId="{A37B11FE-7E2B-4B71-9282-AB38B86228CA}" dt="2022-10-13T20:27:28.335" v="982" actId="164"/>
          <ac:graphicFrameMkLst>
            <pc:docMk/>
            <pc:sldMk cId="3299870256" sldId="301"/>
            <ac:graphicFrameMk id="341" creationId="{D64BF4A6-E3DC-8AAE-CAC2-318CE7EFEC5C}"/>
          </ac:graphicFrameMkLst>
        </pc:graphicFrameChg>
        <pc:picChg chg="mod topLvl">
          <ac:chgData name="Go" userId="b11a5121-062d-4360-8951-d081ad96d999" providerId="ADAL" clId="{A37B11FE-7E2B-4B71-9282-AB38B86228CA}" dt="2022-10-14T01:36:14.970" v="1314" actId="164"/>
          <ac:picMkLst>
            <pc:docMk/>
            <pc:sldMk cId="3299870256" sldId="301"/>
            <ac:picMk id="32" creationId="{2175B2CF-25CD-A072-BE64-BA372B9244D8}"/>
          </ac:picMkLst>
        </pc:picChg>
        <pc:picChg chg="mod topLvl">
          <ac:chgData name="Go" userId="b11a5121-062d-4360-8951-d081ad96d999" providerId="ADAL" clId="{A37B11FE-7E2B-4B71-9282-AB38B86228CA}" dt="2022-10-14T01:36:20.178" v="1315" actId="164"/>
          <ac:picMkLst>
            <pc:docMk/>
            <pc:sldMk cId="3299870256" sldId="301"/>
            <ac:picMk id="33" creationId="{86A53033-86F9-389C-04D5-9CD2C9AD01C7}"/>
          </ac:picMkLst>
        </pc:picChg>
        <pc:picChg chg="mod modCrop">
          <ac:chgData name="Go" userId="b11a5121-062d-4360-8951-d081ad96d999" providerId="ADAL" clId="{A37B11FE-7E2B-4B71-9282-AB38B86228CA}" dt="2022-10-13T20:31:51.861" v="1028" actId="732"/>
          <ac:picMkLst>
            <pc:docMk/>
            <pc:sldMk cId="3299870256" sldId="301"/>
            <ac:picMk id="57" creationId="{E1D85ABA-4B6A-4782-B82E-435A15947D01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1" creationId="{A560FC92-4919-4B14-889D-8C2914B72130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2" creationId="{9740845C-8279-4BED-92E8-8A0979FDFD33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3" creationId="{AE457A15-1519-464E-A3CE-71E3E325892C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7" creationId="{B94AD668-0A32-446F-BE51-E1497543E9EE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8" creationId="{A5F75C6C-B398-4E7A-812C-C7FBBC62310F}"/>
          </ac:picMkLst>
        </pc:picChg>
        <pc:picChg chg="mod">
          <ac:chgData name="Go" userId="b11a5121-062d-4360-8951-d081ad96d999" providerId="ADAL" clId="{A37B11FE-7E2B-4B71-9282-AB38B86228CA}" dt="2022-10-13T20:17:25.731" v="732" actId="165"/>
          <ac:picMkLst>
            <pc:docMk/>
            <pc:sldMk cId="3299870256" sldId="301"/>
            <ac:picMk id="79" creationId="{75A60953-8AA9-4F02-B89B-EF8574966FFF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72" creationId="{FE95AE74-DC2E-9C0A-30F0-56061665B389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0" creationId="{599237E0-A6BA-B535-F78D-0455DD124D02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2" creationId="{E18B8620-6E4C-5622-6580-0071CB265FF6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4" creationId="{F9AD6C7D-96E2-2720-C7FF-986551E1E6EA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6" creationId="{37539F2F-9ABF-6C7B-B760-5A27B78D95CC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88" creationId="{FD7407D0-35C7-7024-0B01-1C8BD7630444}"/>
          </ac:picMkLst>
        </pc:picChg>
        <pc:picChg chg="mod">
          <ac:chgData name="Go" userId="b11a5121-062d-4360-8951-d081ad96d999" providerId="ADAL" clId="{A37B11FE-7E2B-4B71-9282-AB38B86228CA}" dt="2022-10-13T19:27:29.859" v="258"/>
          <ac:picMkLst>
            <pc:docMk/>
            <pc:sldMk cId="3299870256" sldId="301"/>
            <ac:picMk id="192" creationId="{F8D28C29-6038-2007-FEAB-6EE40969F86D}"/>
          </ac:picMkLst>
        </pc:picChg>
        <pc:picChg chg="mod topLvl">
          <ac:chgData name="Go" userId="b11a5121-062d-4360-8951-d081ad96d999" providerId="ADAL" clId="{A37B11FE-7E2B-4B71-9282-AB38B86228CA}" dt="2022-10-14T02:30:26.872" v="1461" actId="14100"/>
          <ac:picMkLst>
            <pc:docMk/>
            <pc:sldMk cId="3299870256" sldId="301"/>
            <ac:picMk id="195" creationId="{786CCD50-E8F9-E81C-0AAB-7EF8B6F3918F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05" creationId="{8E4A55A6-943E-0E63-1E18-354FD95B363A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07" creationId="{DEB24383-22A9-2F3E-6C00-9C29A0BCD65F}"/>
          </ac:picMkLst>
        </pc:picChg>
        <pc:picChg chg="mod topLvl">
          <ac:chgData name="Go" userId="b11a5121-062d-4360-8951-d081ad96d999" providerId="ADAL" clId="{A37B11FE-7E2B-4B71-9282-AB38B86228CA}" dt="2022-10-14T02:30:31.387" v="1462" actId="14100"/>
          <ac:picMkLst>
            <pc:docMk/>
            <pc:sldMk cId="3299870256" sldId="301"/>
            <ac:picMk id="209" creationId="{10C6B6B0-2782-E2D0-9480-48DD6CA69FB6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11" creationId="{3D276DC3-F7EE-8569-6F10-9547D39EEA9A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13" creationId="{8A301B36-7C95-FC89-871D-2FC646B973C1}"/>
          </ac:picMkLst>
        </pc:picChg>
        <pc:picChg chg="mod topLvl">
          <ac:chgData name="Go" userId="b11a5121-062d-4360-8951-d081ad96d999" providerId="ADAL" clId="{A37B11FE-7E2B-4B71-9282-AB38B86228CA}" dt="2022-10-14T02:30:38.718" v="1463" actId="14100"/>
          <ac:picMkLst>
            <pc:docMk/>
            <pc:sldMk cId="3299870256" sldId="301"/>
            <ac:picMk id="227" creationId="{66CB2C0A-997F-312D-14F9-BB43C1C08538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1" creationId="{6225382C-CEA2-8A07-48CD-77F6215A93A1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4" creationId="{D28A80E1-93DF-7A66-672F-928AF1D25836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6" creationId="{36F5ED06-1E8C-AE34-A972-C9583CAC8862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48" creationId="{7D80C03B-9C9D-84CF-DC28-048A337FAFC3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0" creationId="{587F0235-90D0-252A-5423-E5932CB64E65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2" creationId="{A5809071-133E-E097-D812-5A37CE8B3451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4" creationId="{CFE60308-241A-5B01-3D08-548074367263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6" creationId="{AFCE8761-4598-82BE-E608-94FFCDAFE026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258" creationId="{FA1EF86B-68DA-C21E-D921-80FF67C57DD5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2" creationId="{87F1EA15-F692-1978-7957-6C6030F0498E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4" creationId="{1D4D6272-457D-FE94-E6ED-36CDD0772A4A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6" creationId="{9C796707-8624-499A-3CD4-02B4748A8439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88" creationId="{C2DEF756-D200-98E0-7B7E-8C3F707BD047}"/>
          </ac:picMkLst>
        </pc:picChg>
        <pc:picChg chg="mod">
          <ac:chgData name="Go" userId="b11a5121-062d-4360-8951-d081ad96d999" providerId="ADAL" clId="{A37B11FE-7E2B-4B71-9282-AB38B86228CA}" dt="2022-10-13T19:58:04.305" v="483" actId="165"/>
          <ac:picMkLst>
            <pc:docMk/>
            <pc:sldMk cId="3299870256" sldId="301"/>
            <ac:picMk id="290" creationId="{30D2A285-EC12-EDAC-1CB7-BF966DCA26A2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4" creationId="{A5C76721-20CE-E278-3628-37B247E667C8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6" creationId="{DD9A4FDD-EAC9-697D-851C-564C4ECEF525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08" creationId="{4C2DB0C2-9CBE-8800-69E1-C9546D4CACA2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10" creationId="{C0752B75-EC16-5B4F-C37B-1BB57DAF4526}"/>
          </ac:picMkLst>
        </pc:picChg>
        <pc:picChg chg="mod">
          <ac:chgData name="Go" userId="b11a5121-062d-4360-8951-d081ad96d999" providerId="ADAL" clId="{A37B11FE-7E2B-4B71-9282-AB38B86228CA}" dt="2022-10-13T20:09:45.203" v="626"/>
          <ac:picMkLst>
            <pc:docMk/>
            <pc:sldMk cId="3299870256" sldId="301"/>
            <ac:picMk id="312" creationId="{2C0B7C10-41CD-6AF9-3FEF-6B44B3CCA843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2" creationId="{64E61B9D-ABF2-DE7F-925C-92920B46FACF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4" creationId="{4FDEBCD0-7D59-A5F4-FAD9-BA6DE364DDD8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6" creationId="{CA49994B-E184-710F-F726-327CBE43296C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28" creationId="{C814B21F-8DC9-978F-83D8-F85C32A134A7}"/>
          </ac:picMkLst>
        </pc:picChg>
        <pc:picChg chg="mod">
          <ac:chgData name="Go" userId="b11a5121-062d-4360-8951-d081ad96d999" providerId="ADAL" clId="{A37B11FE-7E2B-4B71-9282-AB38B86228CA}" dt="2022-10-13T20:09:58.048" v="631" actId="165"/>
          <ac:picMkLst>
            <pc:docMk/>
            <pc:sldMk cId="3299870256" sldId="301"/>
            <ac:picMk id="330" creationId="{50AD55B5-1E68-D51D-B42E-75DC66E83D02}"/>
          </ac:picMkLst>
        </pc:picChg>
        <pc:picChg chg="mod">
          <ac:chgData name="Go" userId="b11a5121-062d-4360-8951-d081ad96d999" providerId="ADAL" clId="{A37B11FE-7E2B-4B71-9282-AB38B86228CA}" dt="2022-10-14T00:59:37.722" v="1239" actId="165"/>
          <ac:picMkLst>
            <pc:docMk/>
            <pc:sldMk cId="3299870256" sldId="301"/>
            <ac:picMk id="379" creationId="{D4146D48-93B6-2FF3-81E7-9C112A4B30F0}"/>
          </ac:picMkLst>
        </pc:picChg>
        <pc:picChg chg="add mod topLvl modCrop">
          <ac:chgData name="Go" userId="b11a5121-062d-4360-8951-d081ad96d999" providerId="ADAL" clId="{A37B11FE-7E2B-4B71-9282-AB38B86228CA}" dt="2022-10-14T01:44:56.252" v="1320" actId="14100"/>
          <ac:picMkLst>
            <pc:docMk/>
            <pc:sldMk cId="3299870256" sldId="301"/>
            <ac:picMk id="380" creationId="{52F0F89B-193D-9C05-F8CD-D3CE67ED10CC}"/>
          </ac:picMkLst>
        </pc:picChg>
        <pc:picChg chg="add del mod">
          <ac:chgData name="Go" userId="b11a5121-062d-4360-8951-d081ad96d999" providerId="ADAL" clId="{A37B11FE-7E2B-4B71-9282-AB38B86228CA}" dt="2022-10-14T01:32:09.215" v="1267" actId="478"/>
          <ac:picMkLst>
            <pc:docMk/>
            <pc:sldMk cId="3299870256" sldId="301"/>
            <ac:picMk id="384" creationId="{8F844B30-6FC6-CCC8-550D-FBE282D07090}"/>
          </ac:picMkLst>
        </pc:picChg>
        <pc:picChg chg="add del mod">
          <ac:chgData name="Go" userId="b11a5121-062d-4360-8951-d081ad96d999" providerId="ADAL" clId="{A37B11FE-7E2B-4B71-9282-AB38B86228CA}" dt="2022-10-14T01:33:20.994" v="1286" actId="478"/>
          <ac:picMkLst>
            <pc:docMk/>
            <pc:sldMk cId="3299870256" sldId="301"/>
            <ac:picMk id="385" creationId="{F44476F1-1B01-3154-6B83-BFD8E9F47CD8}"/>
          </ac:picMkLst>
        </pc:picChg>
        <pc:picChg chg="add mod modCrop">
          <ac:chgData name="Go" userId="b11a5121-062d-4360-8951-d081ad96d999" providerId="ADAL" clId="{A37B11FE-7E2B-4B71-9282-AB38B86228CA}" dt="2022-10-14T02:30:45.589" v="1464" actId="1076"/>
          <ac:picMkLst>
            <pc:docMk/>
            <pc:sldMk cId="3299870256" sldId="301"/>
            <ac:picMk id="399" creationId="{F9E2993B-1F21-94E2-522E-705FFE1F3AC0}"/>
          </ac:picMkLst>
        </pc:picChg>
        <pc:picChg chg="mod topLvl">
          <ac:chgData name="Go" userId="b11a5121-062d-4360-8951-d081ad96d999" providerId="ADAL" clId="{A37B11FE-7E2B-4B71-9282-AB38B86228CA}" dt="2022-10-14T01:36:07.890" v="1310" actId="164"/>
          <ac:picMkLst>
            <pc:docMk/>
            <pc:sldMk cId="3299870256" sldId="301"/>
            <ac:picMk id="575" creationId="{6BEBEA05-1D4B-5D31-DB0F-1C7C69F0773F}"/>
          </ac:picMkLst>
        </pc:picChg>
        <pc:picChg chg="mod topLvl">
          <ac:chgData name="Go" userId="b11a5121-062d-4360-8951-d081ad96d999" providerId="ADAL" clId="{A37B11FE-7E2B-4B71-9282-AB38B86228CA}" dt="2022-10-14T01:36:06.800" v="1309" actId="164"/>
          <ac:picMkLst>
            <pc:docMk/>
            <pc:sldMk cId="3299870256" sldId="301"/>
            <ac:picMk id="584" creationId="{65E099EC-DF37-0FB7-4855-75B080ABBDCC}"/>
          </ac:picMkLst>
        </pc:picChg>
        <pc:picChg chg="mod topLvl modCrop">
          <ac:chgData name="Go" userId="b11a5121-062d-4360-8951-d081ad96d999" providerId="ADAL" clId="{A37B11FE-7E2B-4B71-9282-AB38B86228CA}" dt="2022-10-14T01:36:21.436" v="1316" actId="164"/>
          <ac:picMkLst>
            <pc:docMk/>
            <pc:sldMk cId="3299870256" sldId="301"/>
            <ac:picMk id="587" creationId="{7D6F430A-1C5C-3112-B7CF-1E2590BBA0CB}"/>
          </ac:picMkLst>
        </pc:picChg>
        <pc:picChg chg="del mod topLvl">
          <ac:chgData name="Go" userId="b11a5121-062d-4360-8951-d081ad96d999" providerId="ADAL" clId="{A37B11FE-7E2B-4B71-9282-AB38B86228CA}" dt="2022-10-13T20:44:49.183" v="1173" actId="478"/>
          <ac:picMkLst>
            <pc:docMk/>
            <pc:sldMk cId="3299870256" sldId="301"/>
            <ac:picMk id="589" creationId="{2ABF06E6-EEAE-48EA-B11A-625F8C9B6298}"/>
          </ac:picMkLst>
        </pc:picChg>
        <pc:picChg chg="mod ord topLvl">
          <ac:chgData name="Go" userId="b11a5121-062d-4360-8951-d081ad96d999" providerId="ADAL" clId="{A37B11FE-7E2B-4B71-9282-AB38B86228CA}" dt="2022-10-14T01:44:51.858" v="1319" actId="553"/>
          <ac:picMkLst>
            <pc:docMk/>
            <pc:sldMk cId="3299870256" sldId="301"/>
            <ac:picMk id="598" creationId="{CEED833A-E64F-B880-BB0C-53F165B34A39}"/>
          </ac:picMkLst>
        </pc:picChg>
        <pc:picChg chg="mod topLvl">
          <ac:chgData name="Go" userId="b11a5121-062d-4360-8951-d081ad96d999" providerId="ADAL" clId="{A37B11FE-7E2B-4B71-9282-AB38B86228CA}" dt="2022-10-14T01:36:05.499" v="1308" actId="164"/>
          <ac:picMkLst>
            <pc:docMk/>
            <pc:sldMk cId="3299870256" sldId="301"/>
            <ac:picMk id="602" creationId="{9D32713A-E1E1-E4ED-0C5F-FDD66A6BC6DF}"/>
          </ac:picMkLst>
        </pc:pic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74" creationId="{DCDE6181-4EE4-4CE9-B87D-C2F223928381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75" creationId="{0B4D26CA-7184-4164-A7A0-395716A8AF0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0" creationId="{38A7C430-3563-4774-A34C-6F184920A4E0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1" creationId="{24ED3403-A14E-478B-B263-3A63A5EBF90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2" creationId="{FF7C67B4-2C73-4E59-8E93-1234143CAE77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83" creationId="{981C2F62-03F3-4054-A706-F5CF44248249}"/>
          </ac:cxnSpMkLst>
        </pc:cxnChg>
        <pc:cxnChg chg="mod topLvl">
          <ac:chgData name="Go" userId="b11a5121-062d-4360-8951-d081ad96d999" providerId="ADAL" clId="{A37B11FE-7E2B-4B71-9282-AB38B86228CA}" dt="2022-10-14T01:34:22.952" v="1296" actId="165"/>
          <ac:cxnSpMkLst>
            <pc:docMk/>
            <pc:sldMk cId="3299870256" sldId="301"/>
            <ac:cxnSpMk id="146" creationId="{E5A01E2F-D923-7B8A-4376-3E5510F5BDFB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4" creationId="{7B096F60-44C9-25BE-9B07-BA1E416D8E0F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5" creationId="{E1108CE8-330C-441F-3887-76B03A1F171A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78" creationId="{350D44BE-6AAA-F538-1181-644E2C63FC39}"/>
          </ac:cxnSpMkLst>
        </pc:cxnChg>
        <pc:cxnChg chg="mod">
          <ac:chgData name="Go" userId="b11a5121-062d-4360-8951-d081ad96d999" providerId="ADAL" clId="{A37B11FE-7E2B-4B71-9282-AB38B86228CA}" dt="2022-10-13T19:27:29.859" v="258"/>
          <ac:cxnSpMkLst>
            <pc:docMk/>
            <pc:sldMk cId="3299870256" sldId="301"/>
            <ac:cxnSpMk id="190" creationId="{6E185FA5-7462-299C-A473-2C31C4A61910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29" creationId="{3AFDC835-E16C-64C7-E36F-6D452494FB8A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0" creationId="{0B05E7E3-BC15-0A5C-DFA2-1FC65FB7D022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3" creationId="{8074A64F-CF67-37F1-DFDA-55A586A11E2F}"/>
          </ac:cxnSpMkLst>
        </pc:cxnChg>
        <pc:cxnChg chg="mod">
          <ac:chgData name="Go" userId="b11a5121-062d-4360-8951-d081ad96d999" providerId="ADAL" clId="{A37B11FE-7E2B-4B71-9282-AB38B86228CA}" dt="2022-10-14T02:29:52.315" v="1456" actId="165"/>
          <ac:cxnSpMkLst>
            <pc:docMk/>
            <pc:sldMk cId="3299870256" sldId="301"/>
            <ac:cxnSpMk id="238" creationId="{BF540BCA-E2DD-B7DC-1BE2-7963F369D77A}"/>
          </ac:cxnSpMkLst>
        </pc:cxnChg>
        <pc:cxnChg chg="mod topLvl">
          <ac:chgData name="Go" userId="b11a5121-062d-4360-8951-d081ad96d999" providerId="ADAL" clId="{A37B11FE-7E2B-4B71-9282-AB38B86228CA}" dt="2022-10-13T19:59:05.306" v="496" actId="164"/>
          <ac:cxnSpMkLst>
            <pc:docMk/>
            <pc:sldMk cId="3299870256" sldId="301"/>
            <ac:cxnSpMk id="280" creationId="{71483C28-169B-5E49-FB08-F99A8867EA06}"/>
          </ac:cxnSpMkLst>
        </pc:cxnChg>
        <pc:cxnChg chg="mod">
          <ac:chgData name="Go" userId="b11a5121-062d-4360-8951-d081ad96d999" providerId="ADAL" clId="{A37B11FE-7E2B-4B71-9282-AB38B86228CA}" dt="2022-10-13T20:09:45.203" v="626"/>
          <ac:cxnSpMkLst>
            <pc:docMk/>
            <pc:sldMk cId="3299870256" sldId="301"/>
            <ac:cxnSpMk id="302" creationId="{71E0DB69-8833-F8B1-EA78-2DD037215BB5}"/>
          </ac:cxnSpMkLst>
        </pc:cxnChg>
        <pc:cxnChg chg="mod topLvl">
          <ac:chgData name="Go" userId="b11a5121-062d-4360-8951-d081ad96d999" providerId="ADAL" clId="{A37B11FE-7E2B-4B71-9282-AB38B86228CA}" dt="2022-10-13T20:11:40.162" v="640" actId="164"/>
          <ac:cxnSpMkLst>
            <pc:docMk/>
            <pc:sldMk cId="3299870256" sldId="301"/>
            <ac:cxnSpMk id="320" creationId="{6B53738C-27BF-CB34-A15A-246E1FE637F0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1" creationId="{B69216E1-6575-1489-2D44-322046CBC33E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2" creationId="{9DF3C598-777D-BD61-9BD4-03BEBD85A8E2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4" creationId="{AA9A303D-7650-CB52-AC81-F0A6C13F7B6D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335" creationId="{9669EB3B-99E7-D90C-92BE-9B049A8DB7AA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5" creationId="{77F25675-7B55-4E09-01E1-94D6922AF568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6" creationId="{BEA321F4-F52F-6980-814F-CE03E2BD8E99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7" creationId="{7BADAB79-F454-2B66-6A91-7858FEAB433C}"/>
          </ac:cxnSpMkLst>
        </pc:cxnChg>
        <pc:cxnChg chg="mod">
          <ac:chgData name="Go" userId="b11a5121-062d-4360-8951-d081ad96d999" providerId="ADAL" clId="{A37B11FE-7E2B-4B71-9282-AB38B86228CA}" dt="2022-10-13T20:17:25.731" v="732" actId="165"/>
          <ac:cxnSpMkLst>
            <pc:docMk/>
            <pc:sldMk cId="3299870256" sldId="301"/>
            <ac:cxnSpMk id="498" creationId="{6D1A51C3-C35B-30B8-E518-25E26BC7DB78}"/>
          </ac:cxnSpMkLst>
        </pc:cxnChg>
        <pc:cxnChg chg="mod topLvl">
          <ac:chgData name="Go" userId="b11a5121-062d-4360-8951-d081ad96d999" providerId="ADAL" clId="{A37B11FE-7E2B-4B71-9282-AB38B86228CA}" dt="2022-10-14T01:34:22.952" v="1296" actId="165"/>
          <ac:cxnSpMkLst>
            <pc:docMk/>
            <pc:sldMk cId="3299870256" sldId="301"/>
            <ac:cxnSpMk id="632" creationId="{9CF49B4E-790A-93D5-9972-4C45B0E7B7D5}"/>
          </ac:cxnSpMkLst>
        </pc:cxnChg>
      </pc:sldChg>
      <pc:sldChg chg="addSp delSp modSp new mod">
        <pc:chgData name="Go" userId="b11a5121-062d-4360-8951-d081ad96d999" providerId="ADAL" clId="{A37B11FE-7E2B-4B71-9282-AB38B86228CA}" dt="2022-10-14T02:00:56.036" v="1429" actId="164"/>
        <pc:sldMkLst>
          <pc:docMk/>
          <pc:sldMk cId="2069005311" sldId="302"/>
        </pc:sldMkLst>
        <pc:spChg chg="del">
          <ac:chgData name="Go" userId="b11a5121-062d-4360-8951-d081ad96d999" providerId="ADAL" clId="{A37B11FE-7E2B-4B71-9282-AB38B86228CA}" dt="2022-10-14T01:00:46.363" v="1251" actId="478"/>
          <ac:spMkLst>
            <pc:docMk/>
            <pc:sldMk cId="2069005311" sldId="302"/>
            <ac:spMk id="2" creationId="{F5B0F420-CC21-AA5A-9C72-9B1A9F298217}"/>
          </ac:spMkLst>
        </pc:spChg>
        <pc:spChg chg="del">
          <ac:chgData name="Go" userId="b11a5121-062d-4360-8951-d081ad96d999" providerId="ADAL" clId="{A37B11FE-7E2B-4B71-9282-AB38B86228CA}" dt="2022-10-14T01:00:43.390" v="1250" actId="478"/>
          <ac:spMkLst>
            <pc:docMk/>
            <pc:sldMk cId="2069005311" sldId="302"/>
            <ac:spMk id="3" creationId="{6F6B9B75-AA43-B4DE-F78A-7A92AB44B191}"/>
          </ac:spMkLst>
        </pc:spChg>
        <pc:spChg chg="mod topLvl">
          <ac:chgData name="Go" userId="b11a5121-062d-4360-8951-d081ad96d999" providerId="ADAL" clId="{A37B11FE-7E2B-4B71-9282-AB38B86228CA}" dt="2022-10-14T02:00:56.036" v="1429" actId="164"/>
          <ac:spMkLst>
            <pc:docMk/>
            <pc:sldMk cId="2069005311" sldId="302"/>
            <ac:spMk id="6" creationId="{7201332A-CE8F-EA78-8E01-D352071260EA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8" creationId="{6E80E716-1388-DECF-371E-1E392B8503AB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13" creationId="{BC5672E3-3BA2-B802-B7F1-90B4FB27945A}"/>
          </ac:spMkLst>
        </pc:spChg>
        <pc:spChg chg="mod">
          <ac:chgData name="Go" userId="b11a5121-062d-4360-8951-d081ad96d999" providerId="ADAL" clId="{A37B11FE-7E2B-4B71-9282-AB38B86228CA}" dt="2022-10-14T02:00:42.402" v="1423" actId="165"/>
          <ac:spMkLst>
            <pc:docMk/>
            <pc:sldMk cId="2069005311" sldId="302"/>
            <ac:spMk id="14" creationId="{C2994E3F-B475-77BB-DBB3-2C19C32EA91C}"/>
          </ac:spMkLst>
        </pc:spChg>
        <pc:spChg chg="mod topLvl">
          <ac:chgData name="Go" userId="b11a5121-062d-4360-8951-d081ad96d999" providerId="ADAL" clId="{A37B11FE-7E2B-4B71-9282-AB38B86228CA}" dt="2022-10-14T02:00:56.036" v="1429" actId="164"/>
          <ac:spMkLst>
            <pc:docMk/>
            <pc:sldMk cId="2069005311" sldId="302"/>
            <ac:spMk id="16" creationId="{962959EC-F6B9-E811-2B9D-A1CB077C647C}"/>
          </ac:spMkLst>
        </pc:spChg>
        <pc:spChg chg="mod topLvl">
          <ac:chgData name="Go" userId="b11a5121-062d-4360-8951-d081ad96d999" providerId="ADAL" clId="{A37B11FE-7E2B-4B71-9282-AB38B86228CA}" dt="2022-10-14T02:00:14.628" v="1412" actId="164"/>
          <ac:spMkLst>
            <pc:docMk/>
            <pc:sldMk cId="2069005311" sldId="302"/>
            <ac:spMk id="19" creationId="{85CDD789-3BE1-362E-4568-93BA3716E071}"/>
          </ac:spMkLst>
        </pc:spChg>
        <pc:spChg chg="mod topLvl">
          <ac:chgData name="Go" userId="b11a5121-062d-4360-8951-d081ad96d999" providerId="ADAL" clId="{A37B11FE-7E2B-4B71-9282-AB38B86228CA}" dt="2022-10-14T01:57:27.303" v="1356" actId="164"/>
          <ac:spMkLst>
            <pc:docMk/>
            <pc:sldMk cId="2069005311" sldId="302"/>
            <ac:spMk id="21" creationId="{3A3DFD42-FE4F-DC52-19DB-CA29A22880F9}"/>
          </ac:spMkLst>
        </pc:spChg>
        <pc:spChg chg="mod topLvl">
          <ac:chgData name="Go" userId="b11a5121-062d-4360-8951-d081ad96d999" providerId="ADAL" clId="{A37B11FE-7E2B-4B71-9282-AB38B86228CA}" dt="2022-10-14T01:57:27.303" v="1356" actId="164"/>
          <ac:spMkLst>
            <pc:docMk/>
            <pc:sldMk cId="2069005311" sldId="302"/>
            <ac:spMk id="22" creationId="{3257A8D9-033C-AED0-D1F9-500BCDFA786C}"/>
          </ac:spMkLst>
        </pc:spChg>
        <pc:spChg chg="mod topLvl">
          <ac:chgData name="Go" userId="b11a5121-062d-4360-8951-d081ad96d999" providerId="ADAL" clId="{A37B11FE-7E2B-4B71-9282-AB38B86228CA}" dt="2022-10-14T01:57:48.729" v="1367" actId="164"/>
          <ac:spMkLst>
            <pc:docMk/>
            <pc:sldMk cId="2069005311" sldId="302"/>
            <ac:spMk id="25" creationId="{5ADBB3AB-5C13-C5BE-B1A0-5A1EEF2BEFD4}"/>
          </ac:spMkLst>
        </pc:spChg>
        <pc:spChg chg="mod topLvl">
          <ac:chgData name="Go" userId="b11a5121-062d-4360-8951-d081ad96d999" providerId="ADAL" clId="{A37B11FE-7E2B-4B71-9282-AB38B86228CA}" dt="2022-10-14T01:57:48.729" v="1367" actId="164"/>
          <ac:spMkLst>
            <pc:docMk/>
            <pc:sldMk cId="2069005311" sldId="302"/>
            <ac:spMk id="26" creationId="{D96734F8-7CF1-631D-EEA1-981B62643BD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5" creationId="{990E21BF-643A-FE04-7F24-DBEDF1AA0CE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6" creationId="{D085FA2B-7379-A06A-D3A7-BA7A4A01617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7" creationId="{E30FEDBC-F209-55FC-778A-62D805167E0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8" creationId="{DF0470C2-60E4-D51E-8465-F38B205F6C6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39" creationId="{CD906AC6-3905-2824-E358-1E4D36142C1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0" creationId="{85BE65DA-0172-A046-B3A3-B5CEC8D5DCD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2" creationId="{A1D8E731-A41D-E180-AB69-9ECC77E2C6B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3" creationId="{3486CAEF-F6AF-E62D-FFF8-E1C327F3EDB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4" creationId="{5D30EA5C-AD57-474C-A22F-F5AF1758EE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5" creationId="{66471B26-CE17-0F2D-086B-5F2111ABB1D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6" creationId="{AD3955E4-6EF6-C950-CE16-996185F2FC3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7" creationId="{450AC69B-3CA4-9D10-5236-5D79AC52A68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8" creationId="{489B0A1C-2B10-01EB-C7FD-C6C68F719DE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49" creationId="{D335B55C-D172-A17B-786C-B9C1A79C0D0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1" creationId="{D01F265F-7FA6-B3B7-6E4D-9237581EB86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2" creationId="{3D6D1C42-0510-CE8D-BFEE-A6D06F835B9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3" creationId="{C6034425-8B38-65C5-5B72-1F10F325EB1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4" creationId="{D6752323-53E9-C894-1419-64E4EC9FEE4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5" creationId="{A4A883A5-A35F-773E-A346-59F2C8B30ABA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6" creationId="{8329FDA3-6515-FE52-68A5-41EBF455CF5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8" creationId="{54B3961D-901F-D9B1-7E5A-0AA991923ED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59" creationId="{3E7F6FE1-7A7E-AFD2-DB0D-35A8FD4C0C3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0" creationId="{CC878395-538B-7D90-96CD-B5E8243335B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1" creationId="{DA072248-5DB0-BBB1-8D19-CEEE979BB3B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2" creationId="{2F00770D-E276-E49E-6F6C-C0247F738D7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3" creationId="{CA763550-89D3-AC2A-1F98-69B3C8BCAE6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5" creationId="{754CD4D9-DFD0-437F-D36F-4B5B6A667D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6" creationId="{D1C4BD5B-3085-977D-B1B4-7D1FA6FE0D9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7" creationId="{6DA05AB2-AD48-C63B-A9E2-68AB67ED941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8" creationId="{9359E7F3-2980-0BE4-CDE5-FAFBBCC4959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69" creationId="{D02B7B17-A300-614A-7083-C43DFC94761F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0" creationId="{6B37E447-A62F-8A61-370E-08D171850B5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2" creationId="{3CD7D238-4606-A32D-0119-56C3E96DB184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3" creationId="{AEAF8A22-51E8-FBA0-7F25-B82302684AD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4" creationId="{7A30CEC7-F23A-624F-C204-CB2684297EC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5" creationId="{E36C9280-06B0-7BAE-2C23-C45EFE46E9E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6" creationId="{67F8F2EF-DBB8-BADE-B4B4-EF285298B0B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7" creationId="{F786F93A-241C-4B79-A49E-B81760D2DDDC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79" creationId="{695B351B-56E7-9F0B-544D-666A38F4D1E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0" creationId="{563B0552-675D-47C2-509A-69C4FD63559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1" creationId="{B39F3217-B036-CCE3-65EC-EF2A32AC2A1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2" creationId="{1094859F-7BA8-FBAE-0D20-F39ED965238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3" creationId="{3796D51C-34A9-D375-3315-911CF8BEB65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4" creationId="{2C4D0FCE-D400-0B8F-3920-EBD2F4A1712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5" creationId="{2E8E5CB3-C8BC-CE4B-ABD9-1E17BAED0FD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6" creationId="{45721C41-34FA-8890-9B55-630B95D43CAD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7" creationId="{E6821FDF-FE3E-B109-B7AD-5AD5FA59522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8" creationId="{B83E925D-4F73-D5EC-CBBE-04D5905384C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89" creationId="{CC84A8AC-7B60-0300-BE57-74415D4793F2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0" creationId="{DEF632F5-1469-EA83-BA38-34A37EE2955F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2" creationId="{8657E0E6-9449-8149-1174-5F1A80907103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3" creationId="{771D689C-E772-D6A0-8875-56A5EDBAA52A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4" creationId="{157D474E-1990-92AB-766A-01677A3BB2C7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5" creationId="{6F963894-C4E9-BDBE-42F7-B092E5CCF301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6" creationId="{4510D476-D187-4342-750F-0E613A0D5B90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7" creationId="{BDDE968E-775E-67FF-1FBD-DFF9D69308E9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8" creationId="{247E4D9D-7EB0-25B0-806A-E6774F4A0C1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99" creationId="{589927D1-050A-E38B-438F-9BD492E33635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0" creationId="{535C0306-F684-C4C3-07BA-1257E02DA866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1" creationId="{B9274B0D-A7C2-9865-A478-C37C5D04CC5E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2" creationId="{343C84E6-E602-12B9-C9F4-E16819C0F5B8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3" creationId="{FCB4D65B-6EFB-AEFD-6951-23765D5265BB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6" creationId="{1437D720-A9F5-08B9-E445-301CB5A5809D}"/>
          </ac:spMkLst>
        </pc:spChg>
        <pc:spChg chg="mod">
          <ac:chgData name="Go" userId="b11a5121-062d-4360-8951-d081ad96d999" providerId="ADAL" clId="{A37B11FE-7E2B-4B71-9282-AB38B86228CA}" dt="2022-10-14T01:54:53.790" v="1350" actId="165"/>
          <ac:spMkLst>
            <pc:docMk/>
            <pc:sldMk cId="2069005311" sldId="302"/>
            <ac:spMk id="108" creationId="{4DF76A7C-4BF2-9F69-EFDA-789588C9BB1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14" creationId="{4FA7B592-DC9E-6A8B-BFDF-D378238ADE6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16" creationId="{30E7A49A-DFB1-0E00-A6D6-0BFB7B883B0C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18" creationId="{B41C5022-BF0F-0D95-3304-07B520EADA78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0" creationId="{E262D6C8-1DD9-CBEA-EB09-51B4CD7C705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1" creationId="{E7A7D6E1-C9E1-0D34-BAA1-9395985EE62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2" creationId="{46FBC6D1-03DF-8AF3-28F1-9D7FF671AD8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3" creationId="{B5098512-E7FA-7D63-0092-517CCFA9D2B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4" creationId="{0821E1FA-4FD1-C4B9-DF91-DFD34EA6E71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25" creationId="{4B5B55CA-62E4-EDB3-CFF4-81C4E29C728C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26" creationId="{CF2A0B3F-4EC3-3A0B-F6C9-19237171F97D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27" creationId="{80475976-F4A4-6322-AFBA-DE5CFC5D0767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0" creationId="{EE0FB00B-48D6-68A9-2954-80AE065AE68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1" creationId="{7E122340-3C67-713D-7BFF-A56EAA119FB8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2" creationId="{B28F7F8D-10F4-54CF-CA11-4E53A4D2078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3" creationId="{CBCCE842-5339-4946-FF45-B19E588DE36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4" creationId="{56299C0F-3983-3E2B-619A-DB927529364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5" creationId="{8B22EE08-C08E-C88A-4A69-E39506A390E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7" creationId="{B19613A5-CC54-74F7-302E-CBC0BD1373F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8" creationId="{859B2DB3-399D-9460-D440-BF52F0A9A76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39" creationId="{DA50130C-B28A-1C20-606E-B7CA547E447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0" creationId="{24ADBB4F-4607-9821-0D3A-92816655EBE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1" creationId="{2A91B6C1-FA2A-8E6E-A9CB-C7F6BBA80F50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42" creationId="{B4CDD664-F9D3-9035-66DB-449EA6919B4E}"/>
          </ac:spMkLst>
        </pc:spChg>
        <pc:spChg chg="add del mod">
          <ac:chgData name="Go" userId="b11a5121-062d-4360-8951-d081ad96d999" providerId="ADAL" clId="{A37B11FE-7E2B-4B71-9282-AB38B86228CA}" dt="2022-10-14T02:00:31.124" v="1419" actId="478"/>
          <ac:spMkLst>
            <pc:docMk/>
            <pc:sldMk cId="2069005311" sldId="302"/>
            <ac:spMk id="143" creationId="{1B376F4B-8B0C-4DEB-C6A3-14E3ECD7729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6" creationId="{912F7C55-E987-09F1-BAF9-36EF5130E98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7" creationId="{55D9929E-0AAC-B682-84B3-C58E9431DA1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8" creationId="{F120EE07-D48B-EA4D-077C-2D70280AAD4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49" creationId="{33B352AA-3AD7-BEC6-0E28-6BAD300488B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0" creationId="{2AF75B7B-135C-1119-62FC-30D67A90975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1" creationId="{657A2EC8-689B-8520-1323-C61C120B727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2" creationId="{3B6E4C18-7944-96BE-E7A6-9CBC6D8FB9C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5" creationId="{7023C2A0-744D-C8A8-D64F-B76D8A57A7B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6" creationId="{5029A15A-7712-DB1E-2ADD-2F4F089063B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7" creationId="{7E6907D6-BE47-8954-7DA4-428CE8A9BD5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8" creationId="{7178E0A6-7898-EF17-F27C-5CCC0CE46D7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59" creationId="{DD46448E-E289-D2F2-A21F-76AA38B61DD7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0" creationId="{0D216BA3-AFA3-02A8-D15B-1FD5698E4F8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3" creationId="{56B14904-4730-1337-B317-DB93EEECAD0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4" creationId="{50B3BBFC-1FF5-026C-914B-439EDDB55D6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5" creationId="{75E826F8-7110-7734-47B1-386FE54D4B8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6" creationId="{57C8B1EE-8DBC-D792-1BD6-6A830446FE34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7" creationId="{3B3283CC-4FEB-57D8-BC0E-F3E2DF1B95D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68" creationId="{221FE9DC-1A0B-2833-D190-E97D6284C776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1" creationId="{073232C0-2BA2-23E7-060A-A0CC73585A8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2" creationId="{D7C1B412-33BD-1377-DFE2-5E1CDA17B12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3" creationId="{8622AD26-67FD-53E4-6230-960A1C526C5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4" creationId="{78AEF689-D798-61B4-6A93-27EBF5FD062C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5" creationId="{0E763800-7189-9A3E-9C7B-178AD446B8C3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6" creationId="{9366B754-B59E-7137-11B5-8F9A431CE0D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79" creationId="{D2A01D62-EAE0-8278-FCB3-3CB4EE9B9AF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0" creationId="{18947320-E5FB-26D2-6AFA-C4A41C34CAD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1" creationId="{009CBB73-663D-6433-C04E-5331179488D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2" creationId="{9FF40825-3CD6-E345-64C7-D4292F45128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3" creationId="{6B6A32A5-E6F3-B267-DE3C-1F5C7AB721D5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4" creationId="{618CD8A1-2D46-7F9E-B650-F172B6CBC5BA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7" creationId="{40243990-F929-8991-4A00-AB38535DDF29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8" creationId="{27F888B5-289A-ACD8-28BD-875AB20D2F2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89" creationId="{11AFBFE8-2AEF-3D21-6418-FFEC890FADB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0" creationId="{F1C971F6-A71C-14A5-1A8C-DC33E9E828AB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1" creationId="{98FB049C-8B13-28C7-B2D2-3BF8E5196893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2" creationId="{FCCAE40E-9AB7-D86A-6A5F-34083FCE96EF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3" creationId="{6BE0124E-12A2-9B52-D357-BE6C1ED3A94D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4" creationId="{B1621662-1A7C-76D7-01D6-0913EA3F6601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7" creationId="{8C254A4F-7533-A5F9-5666-ABE4C1798E50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8" creationId="{FE3A19C0-0477-B81F-137B-E87280379E1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199" creationId="{523C51D0-C8A5-625E-59FD-C3BD23968F9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0" creationId="{3519AF80-15AF-3A6E-13F6-58A45AD46962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1" creationId="{B7570C76-ECE1-8AF6-E835-BB491EB7D7CE}"/>
          </ac:spMkLst>
        </pc:spChg>
        <pc:spChg chg="mod">
          <ac:chgData name="Go" userId="b11a5121-062d-4360-8951-d081ad96d999" providerId="ADAL" clId="{A37B11FE-7E2B-4B71-9282-AB38B86228CA}" dt="2022-10-14T01:54:57.578" v="1351"/>
          <ac:spMkLst>
            <pc:docMk/>
            <pc:sldMk cId="2069005311" sldId="302"/>
            <ac:spMk id="202" creationId="{AF94A8A6-0493-9F07-082F-0CBBB01310A5}"/>
          </ac:spMkLst>
        </pc:spChg>
        <pc:grpChg chg="add del mod">
          <ac:chgData name="Go" userId="b11a5121-062d-4360-8951-d081ad96d999" providerId="ADAL" clId="{A37B11FE-7E2B-4B71-9282-AB38B86228CA}" dt="2022-10-14T02:00:42.402" v="1423" actId="165"/>
          <ac:grpSpMkLst>
            <pc:docMk/>
            <pc:sldMk cId="2069005311" sldId="302"/>
            <ac:grpSpMk id="4" creationId="{C3849621-DD9F-0DB9-5825-2507AAFE7B5D}"/>
          </ac:grpSpMkLst>
        </pc:grpChg>
        <pc:grpChg chg="mod topLvl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5" creationId="{0EC23BB4-87EB-1AD7-BA76-3269B16E747F}"/>
          </ac:grpSpMkLst>
        </pc:grpChg>
        <pc:grpChg chg="mod">
          <ac:chgData name="Go" userId="b11a5121-062d-4360-8951-d081ad96d999" providerId="ADAL" clId="{A37B11FE-7E2B-4B71-9282-AB38B86228CA}" dt="2022-10-14T02:00:42.402" v="1423" actId="165"/>
          <ac:grpSpMkLst>
            <pc:docMk/>
            <pc:sldMk cId="2069005311" sldId="302"/>
            <ac:grpSpMk id="7" creationId="{67B8ECF3-A538-66E8-630B-03C836938949}"/>
          </ac:grpSpMkLst>
        </pc:grpChg>
        <pc:grpChg chg="add del 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5" creationId="{7AEE8FC5-55C4-F5B1-63AB-CCE15B0FF694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18" creationId="{AF41BC5C-DA99-EFB9-8A21-81E15F68E70B}"/>
          </ac:grpSpMkLst>
        </pc:grpChg>
        <pc:grpChg chg="mod topLvl">
          <ac:chgData name="Go" userId="b11a5121-062d-4360-8951-d081ad96d999" providerId="ADAL" clId="{A37B11FE-7E2B-4B71-9282-AB38B86228CA}" dt="2022-10-14T01:57:27.303" v="1356" actId="164"/>
          <ac:grpSpMkLst>
            <pc:docMk/>
            <pc:sldMk cId="2069005311" sldId="302"/>
            <ac:grpSpMk id="20" creationId="{8F6E9110-7CDD-27C6-B975-00903B1ADEFE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3" creationId="{FCB647DD-AF09-F9BD-BDA8-CB3C91BFFD45}"/>
          </ac:grpSpMkLst>
        </pc:grpChg>
        <pc:grpChg chg="mod topLvl">
          <ac:chgData name="Go" userId="b11a5121-062d-4360-8951-d081ad96d999" providerId="ADAL" clId="{A37B11FE-7E2B-4B71-9282-AB38B86228CA}" dt="2022-10-14T01:57:48.729" v="1367" actId="164"/>
          <ac:grpSpMkLst>
            <pc:docMk/>
            <pc:sldMk cId="2069005311" sldId="302"/>
            <ac:grpSpMk id="24" creationId="{A213AD11-B9D4-BAB6-6E36-CD4F6A539C4F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7" creationId="{EDC85F66-A07E-088A-90C6-6900DCC67206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8" creationId="{417E5F6C-8E0D-FF8D-2808-899F3170F1DE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9" creationId="{F1255727-C642-9DE2-60CB-C19030A5C721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0" creationId="{278DD3FC-FB74-194D-F710-A51F619A067D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1" creationId="{4EEF8E52-F6C0-408B-4485-1531AC633B68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2" creationId="{85E9B832-6CD4-D44D-66C6-84A23CF5AE9C}"/>
          </ac:grpSpMkLst>
        </pc:grpChg>
        <pc:grpChg chg="mod topLvl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33" creationId="{B9D88745-0902-F72C-A7AE-C656A8EC3A81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34" creationId="{7EF258CF-409D-98B0-97EC-A615C184C8CB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41" creationId="{9761E88E-A145-EEB2-48F9-8164E52551D0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50" creationId="{1C28B119-F2D4-72EB-BE0C-74B6FB0D4450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57" creationId="{ED3FFD80-C963-A86F-0769-5D33DE543839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64" creationId="{20DF0136-A542-DF51-303E-A959FBEE4A01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71" creationId="{6E6F0B05-BAF0-E896-A86F-83DE1E68EC0B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78" creationId="{DF1F77A6-AAA3-5F16-1DDD-FC2C592268C9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91" creationId="{7BDB70FA-6C97-55D8-7653-4C5C762C4165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04" creationId="{D0527D6C-87BC-97CD-B5EC-AC8475FA6D7F}"/>
          </ac:grpSpMkLst>
        </pc:grpChg>
        <pc:grpChg chg="mod">
          <ac:chgData name="Go" userId="b11a5121-062d-4360-8951-d081ad96d999" providerId="ADAL" clId="{A37B11FE-7E2B-4B71-9282-AB38B86228CA}" dt="2022-10-14T01:54:53.790" v="1350" actId="165"/>
          <ac:grpSpMkLst>
            <pc:docMk/>
            <pc:sldMk cId="2069005311" sldId="302"/>
            <ac:grpSpMk id="105" creationId="{6DF74160-508F-DE47-AC28-BBDFE42CFC86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11" creationId="{F81B2595-D2C7-0A8C-8552-B24F1B115B47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12" creationId="{6AA53046-45BB-BCA9-15AE-EA0CD4A2B560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13" creationId="{6FFF429B-8A6C-086D-EAD6-D2A2791CD877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19" creationId="{612A3924-990A-8BF2-BE9B-973DE32EF8D6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28" creationId="{FC312000-D161-DA87-4459-DE20FBB61403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29" creationId="{73DBCFCA-69D7-9649-D63D-ABCB774A42F5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36" creationId="{96E51CB4-047C-B979-CA7B-DC083C4AF75A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44" creationId="{55D84FE4-4F29-2C39-8725-A9FE38B09155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45" creationId="{82699D60-E13F-83B9-2447-35793F5A6FFC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53" creationId="{A7CCE16A-5D32-86E3-9784-6B7EE2303126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54" creationId="{341B43BC-D7D9-5F13-208E-2AA53E059157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61" creationId="{4C3C5DFD-809A-3481-1924-A934C9897448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62" creationId="{11D8DF77-424B-C1C6-9839-A23B5DAC35C0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69" creationId="{F4A8060A-870A-19E5-0352-9660E4DFE2C6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70" creationId="{130A6559-6EB2-DBB8-2749-24C753F1F51C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77" creationId="{3A24F3D6-5245-C241-9FCB-2755DBA4592D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78" creationId="{AE9CBF8C-0F00-49E2-E2E8-D017B8088DFB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85" creationId="{BCBBADD2-863B-600A-129D-B7B746E85F37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86" creationId="{3A8A2F8A-F114-B539-528B-32E2C15A4E71}"/>
          </ac:grpSpMkLst>
        </pc:grpChg>
        <pc:grpChg chg="add del mod">
          <ac:chgData name="Go" userId="b11a5121-062d-4360-8951-d081ad96d999" providerId="ADAL" clId="{A37B11FE-7E2B-4B71-9282-AB38B86228CA}" dt="2022-10-14T02:00:31.124" v="1419" actId="478"/>
          <ac:grpSpMkLst>
            <pc:docMk/>
            <pc:sldMk cId="2069005311" sldId="302"/>
            <ac:grpSpMk id="195" creationId="{DC346F9D-77BB-CA20-D95E-FF116420FEB5}"/>
          </ac:grpSpMkLst>
        </pc:grpChg>
        <pc:grpChg chg="mod">
          <ac:chgData name="Go" userId="b11a5121-062d-4360-8951-d081ad96d999" providerId="ADAL" clId="{A37B11FE-7E2B-4B71-9282-AB38B86228CA}" dt="2022-10-14T01:54:57.578" v="1351"/>
          <ac:grpSpMkLst>
            <pc:docMk/>
            <pc:sldMk cId="2069005311" sldId="302"/>
            <ac:grpSpMk id="196" creationId="{3E5D6C8C-61CC-5750-35DE-2C11D3AD8CFA}"/>
          </ac:grpSpMkLst>
        </pc:grpChg>
        <pc:grpChg chg="add mod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03" creationId="{AFCD7569-C5C4-93D2-6BD0-BA8EF33FDC28}"/>
          </ac:grpSpMkLst>
        </pc:grpChg>
        <pc:grpChg chg="add mod">
          <ac:chgData name="Go" userId="b11a5121-062d-4360-8951-d081ad96d999" providerId="ADAL" clId="{A37B11FE-7E2B-4B71-9282-AB38B86228CA}" dt="2022-10-14T02:00:14.628" v="1412" actId="164"/>
          <ac:grpSpMkLst>
            <pc:docMk/>
            <pc:sldMk cId="2069005311" sldId="302"/>
            <ac:grpSpMk id="204" creationId="{4B5E5729-03DE-3FEF-8B47-D7D87BC7B5ED}"/>
          </ac:grpSpMkLst>
        </pc:grpChg>
        <pc:grpChg chg="add mod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205" creationId="{6206298C-51E2-0754-767A-59D1994CECE4}"/>
          </ac:grpSpMkLst>
        </pc:grpChg>
        <pc:grpChg chg="add mod">
          <ac:chgData name="Go" userId="b11a5121-062d-4360-8951-d081ad96d999" providerId="ADAL" clId="{A37B11FE-7E2B-4B71-9282-AB38B86228CA}" dt="2022-10-14T02:00:56.036" v="1429" actId="164"/>
          <ac:grpSpMkLst>
            <pc:docMk/>
            <pc:sldMk cId="2069005311" sldId="302"/>
            <ac:grpSpMk id="206" creationId="{808F4ADD-1290-A296-D5A7-6A3A95FB60BD}"/>
          </ac:grpSpMkLst>
        </pc:grpChg>
        <pc:graphicFrameChg chg="mod topLvl">
          <ac:chgData name="Go" userId="b11a5121-062d-4360-8951-d081ad96d999" providerId="ADAL" clId="{A37B11FE-7E2B-4B71-9282-AB38B86228CA}" dt="2022-10-14T02:00:14.628" v="1412" actId="164"/>
          <ac:graphicFrameMkLst>
            <pc:docMk/>
            <pc:sldMk cId="2069005311" sldId="302"/>
            <ac:graphicFrameMk id="17" creationId="{BB7F2A5C-42B8-54BA-B27C-AEC1D83E16F1}"/>
          </ac:graphicFrameMkLst>
        </pc:graphicFrameChg>
        <pc:graphicFrameChg chg="add del mod">
          <ac:chgData name="Go" userId="b11a5121-062d-4360-8951-d081ad96d999" providerId="ADAL" clId="{A37B11FE-7E2B-4B71-9282-AB38B86228CA}" dt="2022-10-14T02:00:28.341" v="1418" actId="478"/>
          <ac:graphicFrameMkLst>
            <pc:docMk/>
            <pc:sldMk cId="2069005311" sldId="302"/>
            <ac:graphicFrameMk id="110" creationId="{0F721F0E-B92A-84E7-000F-5019C3A93A01}"/>
          </ac:graphicFrameMkLst>
        </pc:graphicFrameChg>
        <pc:picChg chg="mod">
          <ac:chgData name="Go" userId="b11a5121-062d-4360-8951-d081ad96d999" providerId="ADAL" clId="{A37B11FE-7E2B-4B71-9282-AB38B86228CA}" dt="2022-10-14T02:00:42.402" v="1423" actId="165"/>
          <ac:picMkLst>
            <pc:docMk/>
            <pc:sldMk cId="2069005311" sldId="302"/>
            <ac:picMk id="9" creationId="{22DFC33F-2FDB-A6EC-9D74-D956F1D3C8A4}"/>
          </ac:picMkLst>
        </pc:picChg>
        <pc:picChg chg="mod">
          <ac:chgData name="Go" userId="b11a5121-062d-4360-8951-d081ad96d999" providerId="ADAL" clId="{A37B11FE-7E2B-4B71-9282-AB38B86228CA}" dt="2022-10-14T02:00:42.402" v="1423" actId="165"/>
          <ac:picMkLst>
            <pc:docMk/>
            <pc:sldMk cId="2069005311" sldId="302"/>
            <ac:picMk id="11" creationId="{AB2EEDC1-E87B-7A6A-6355-8C52B4B045BB}"/>
          </ac:picMkLst>
        </pc:picChg>
        <pc:picChg chg="mod">
          <ac:chgData name="Go" userId="b11a5121-062d-4360-8951-d081ad96d999" providerId="ADAL" clId="{A37B11FE-7E2B-4B71-9282-AB38B86228CA}" dt="2022-10-14T01:54:53.790" v="1350" actId="165"/>
          <ac:picMkLst>
            <pc:docMk/>
            <pc:sldMk cId="2069005311" sldId="302"/>
            <ac:picMk id="107" creationId="{962758D2-FE5B-66E4-6B4E-ED1CBD8BD1D2}"/>
          </ac:picMkLst>
        </pc:picChg>
        <pc:picChg chg="mod">
          <ac:chgData name="Go" userId="b11a5121-062d-4360-8951-d081ad96d999" providerId="ADAL" clId="{A37B11FE-7E2B-4B71-9282-AB38B86228CA}" dt="2022-10-14T01:54:53.790" v="1350" actId="165"/>
          <ac:picMkLst>
            <pc:docMk/>
            <pc:sldMk cId="2069005311" sldId="302"/>
            <ac:picMk id="109" creationId="{CEF6DDD1-7EB7-B8ED-90D8-535831AA95FC}"/>
          </ac:picMkLst>
        </pc:picChg>
        <pc:picChg chg="mod">
          <ac:chgData name="Go" userId="b11a5121-062d-4360-8951-d081ad96d999" providerId="ADAL" clId="{A37B11FE-7E2B-4B71-9282-AB38B86228CA}" dt="2022-10-14T01:54:57.578" v="1351"/>
          <ac:picMkLst>
            <pc:docMk/>
            <pc:sldMk cId="2069005311" sldId="302"/>
            <ac:picMk id="115" creationId="{341854E8-53F7-0362-A7A9-1A8B79CC8B34}"/>
          </ac:picMkLst>
        </pc:picChg>
        <pc:picChg chg="mod">
          <ac:chgData name="Go" userId="b11a5121-062d-4360-8951-d081ad96d999" providerId="ADAL" clId="{A37B11FE-7E2B-4B71-9282-AB38B86228CA}" dt="2022-10-14T01:54:57.578" v="1351"/>
          <ac:picMkLst>
            <pc:docMk/>
            <pc:sldMk cId="2069005311" sldId="302"/>
            <ac:picMk id="117" creationId="{4DE979B2-73B5-43B8-6F8D-9F1D04723FC7}"/>
          </ac:picMkLst>
        </pc:picChg>
        <pc:cxnChg chg="mod">
          <ac:chgData name="Go" userId="b11a5121-062d-4360-8951-d081ad96d999" providerId="ADAL" clId="{A37B11FE-7E2B-4B71-9282-AB38B86228CA}" dt="2022-10-14T02:00:42.402" v="1423" actId="165"/>
          <ac:cxnSpMkLst>
            <pc:docMk/>
            <pc:sldMk cId="2069005311" sldId="302"/>
            <ac:cxnSpMk id="10" creationId="{B55FE84F-E429-1A1A-6E65-62BCD8CCD83E}"/>
          </ac:cxnSpMkLst>
        </pc:cxnChg>
        <pc:cxnChg chg="mod">
          <ac:chgData name="Go" userId="b11a5121-062d-4360-8951-d081ad96d999" providerId="ADAL" clId="{A37B11FE-7E2B-4B71-9282-AB38B86228CA}" dt="2022-10-14T02:00:42.402" v="1423" actId="165"/>
          <ac:cxnSpMkLst>
            <pc:docMk/>
            <pc:sldMk cId="2069005311" sldId="302"/>
            <ac:cxnSpMk id="12" creationId="{8066251B-B99C-AE74-6E40-D4549950E730}"/>
          </ac:cxnSpMkLst>
        </pc:cxnChg>
      </pc:sldChg>
      <pc:sldChg chg="addSp delSp modSp add mod ord">
        <pc:chgData name="Go" userId="b11a5121-062d-4360-8951-d081ad96d999" providerId="ADAL" clId="{A37B11FE-7E2B-4B71-9282-AB38B86228CA}" dt="2022-10-15T01:47:19.882" v="1511" actId="20577"/>
        <pc:sldMkLst>
          <pc:docMk/>
          <pc:sldMk cId="1909606739" sldId="303"/>
        </pc:sldMkLst>
        <pc:spChg chg="add mod">
          <ac:chgData name="Go" userId="b11a5121-062d-4360-8951-d081ad96d999" providerId="ADAL" clId="{A37B11FE-7E2B-4B71-9282-AB38B86228CA}" dt="2022-10-14T01:53:19.704" v="1343" actId="1076"/>
          <ac:spMkLst>
            <pc:docMk/>
            <pc:sldMk cId="1909606739" sldId="303"/>
            <ac:spMk id="8" creationId="{35991093-AFCF-2F1A-6BD6-85DAEAF37A4A}"/>
          </ac:spMkLst>
        </pc:spChg>
        <pc:spChg chg="mod">
          <ac:chgData name="Go" userId="b11a5121-062d-4360-8951-d081ad96d999" providerId="ADAL" clId="{A37B11FE-7E2B-4B71-9282-AB38B86228CA}" dt="2022-10-14T01:53:15.884" v="1342" actId="553"/>
          <ac:spMkLst>
            <pc:docMk/>
            <pc:sldMk cId="1909606739" sldId="303"/>
            <ac:spMk id="20" creationId="{1E5638A1-D88D-1784-8C3B-1B8361927869}"/>
          </ac:spMkLst>
        </pc:spChg>
        <pc:spChg chg="mod">
          <ac:chgData name="Go" userId="b11a5121-062d-4360-8951-d081ad96d999" providerId="ADAL" clId="{A37B11FE-7E2B-4B71-9282-AB38B86228CA}" dt="2022-10-15T01:47:19.882" v="1511" actId="20577"/>
          <ac:spMkLst>
            <pc:docMk/>
            <pc:sldMk cId="1909606739" sldId="303"/>
            <ac:spMk id="33" creationId="{2C118948-231F-1F9D-09C3-4B4F5BA9B6A0}"/>
          </ac:spMkLst>
        </pc:spChg>
        <pc:spChg chg="mod">
          <ac:chgData name="Go" userId="b11a5121-062d-4360-8951-d081ad96d999" providerId="ADAL" clId="{A37B11FE-7E2B-4B71-9282-AB38B86228CA}" dt="2022-10-15T01:47:17.279" v="1508" actId="20577"/>
          <ac:spMkLst>
            <pc:docMk/>
            <pc:sldMk cId="1909606739" sldId="303"/>
            <ac:spMk id="36" creationId="{7FF9410D-73F7-EB65-E0FF-E2112266A595}"/>
          </ac:spMkLst>
        </pc:spChg>
        <pc:spChg chg="mod">
          <ac:chgData name="Go" userId="b11a5121-062d-4360-8951-d081ad96d999" providerId="ADAL" clId="{A37B11FE-7E2B-4B71-9282-AB38B86228CA}" dt="2022-10-13T20:38:27.550" v="1083" actId="20577"/>
          <ac:spMkLst>
            <pc:docMk/>
            <pc:sldMk cId="1909606739" sldId="303"/>
            <ac:spMk id="44" creationId="{4EBA0680-77E2-2ABD-9B13-E3E33B2FEBA0}"/>
          </ac:spMkLst>
        </pc:spChg>
        <pc:spChg chg="del">
          <ac:chgData name="Go" userId="b11a5121-062d-4360-8951-d081ad96d999" providerId="ADAL" clId="{A37B11FE-7E2B-4B71-9282-AB38B86228CA}" dt="2022-10-14T01:45:54.813" v="1325" actId="478"/>
          <ac:spMkLst>
            <pc:docMk/>
            <pc:sldMk cId="1909606739" sldId="303"/>
            <ac:spMk id="59" creationId="{638D4131-CD65-E2A2-5377-7594633FFA79}"/>
          </ac:spMkLst>
        </pc:spChg>
        <pc:grpChg chg="del">
          <ac:chgData name="Go" userId="b11a5121-062d-4360-8951-d081ad96d999" providerId="ADAL" clId="{A37B11FE-7E2B-4B71-9282-AB38B86228CA}" dt="2022-10-13T20:38:22.428" v="1079" actId="478"/>
          <ac:grpSpMkLst>
            <pc:docMk/>
            <pc:sldMk cId="1909606739" sldId="303"/>
            <ac:grpSpMk id="2" creationId="{B2FD1FFB-4E78-0C3D-A641-8046DE08B520}"/>
          </ac:grpSpMkLst>
        </pc:grpChg>
        <pc:picChg chg="add mod modCrop">
          <ac:chgData name="Go" userId="b11a5121-062d-4360-8951-d081ad96d999" providerId="ADAL" clId="{A37B11FE-7E2B-4B71-9282-AB38B86228CA}" dt="2022-10-14T01:52:48.015" v="1338" actId="1076"/>
          <ac:picMkLst>
            <pc:docMk/>
            <pc:sldMk cId="1909606739" sldId="303"/>
            <ac:picMk id="3" creationId="{A16858AB-8E93-7BAF-8E79-AE98E8A5C72A}"/>
          </ac:picMkLst>
        </pc:picChg>
        <pc:picChg chg="mod">
          <ac:chgData name="Go" userId="b11a5121-062d-4360-8951-d081ad96d999" providerId="ADAL" clId="{A37B11FE-7E2B-4B71-9282-AB38B86228CA}" dt="2022-10-13T20:39:14.173" v="1121"/>
          <ac:picMkLst>
            <pc:docMk/>
            <pc:sldMk cId="1909606739" sldId="303"/>
            <ac:picMk id="13" creationId="{6384335C-79AE-8172-D5DF-7529DDE9B744}"/>
          </ac:picMkLst>
        </pc:picChg>
        <pc:picChg chg="mod">
          <ac:chgData name="Go" userId="b11a5121-062d-4360-8951-d081ad96d999" providerId="ADAL" clId="{A37B11FE-7E2B-4B71-9282-AB38B86228CA}" dt="2022-10-14T01:52:43.067" v="1337" actId="552"/>
          <ac:picMkLst>
            <pc:docMk/>
            <pc:sldMk cId="1909606739" sldId="303"/>
            <ac:picMk id="17" creationId="{C2F012C9-F323-36DA-07F4-CEA68E0FBAF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0DD7FB43-A9C4-4FF1-B87C-61A7EFB972BB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68538" y="720725"/>
            <a:ext cx="277812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AD29BE89-A6B3-40AF-AC57-A963D4802BE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55697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2613223"/>
            <a:ext cx="5518944" cy="18031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3931" y="4766892"/>
            <a:ext cx="4545013" cy="214977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07334" y="336877"/>
            <a:ext cx="1460897" cy="71776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4644" y="336877"/>
            <a:ext cx="4274476" cy="71776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2892" y="5405594"/>
            <a:ext cx="5518944" cy="1670749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2892" y="3565434"/>
            <a:ext cx="5518944" cy="184016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4644" y="1962839"/>
            <a:ext cx="2867686" cy="55516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00545" y="1962839"/>
            <a:ext cx="2867686" cy="555163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644" y="1883001"/>
            <a:ext cx="2868814" cy="78474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4644" y="2667746"/>
            <a:ext cx="2868814" cy="484673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98291" y="1883001"/>
            <a:ext cx="2869941" cy="78474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98291" y="2667746"/>
            <a:ext cx="2869941" cy="484673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4644" y="334929"/>
            <a:ext cx="2136111" cy="142539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38534" y="334929"/>
            <a:ext cx="3629697" cy="717954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4644" y="1760323"/>
            <a:ext cx="2136111" cy="575415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72649" y="5888514"/>
            <a:ext cx="3895725" cy="69517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72649" y="751642"/>
            <a:ext cx="3895725" cy="5047298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72649" y="6583687"/>
            <a:ext cx="3895725" cy="98726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4644" y="336877"/>
            <a:ext cx="5843588" cy="140202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644" y="1962839"/>
            <a:ext cx="5843588" cy="55516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4644" y="7796829"/>
            <a:ext cx="1515004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592D2A-DFEB-487D-A069-FA11464F9913}" type="datetimeFigureOut">
              <a:rPr lang="en-US" smtClean="0"/>
              <a:pPr/>
              <a:t>10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18399" y="7796829"/>
            <a:ext cx="2056077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53227" y="7796829"/>
            <a:ext cx="1515004" cy="4478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E76527-B382-4BC5-B5F3-03F6560333E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emf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47">
            <a:extLst>
              <a:ext uri="{FF2B5EF4-FFF2-40B4-BE49-F238E27FC236}">
                <a16:creationId xmlns:a16="http://schemas.microsoft.com/office/drawing/2014/main" id="{964E9181-5AEC-4451-8F42-C6AA3B8CFD45}"/>
              </a:ext>
            </a:extLst>
          </p:cNvPr>
          <p:cNvSpPr txBox="1"/>
          <p:nvPr/>
        </p:nvSpPr>
        <p:spPr>
          <a:xfrm>
            <a:off x="31176" y="0"/>
            <a:ext cx="26875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itchFamily="34" charset="0"/>
              </a:rPr>
              <a:t>Figure S4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2F166BF-9AF1-5845-6276-0BFD1EF3A552}"/>
              </a:ext>
            </a:extLst>
          </p:cNvPr>
          <p:cNvGrpSpPr/>
          <p:nvPr/>
        </p:nvGrpSpPr>
        <p:grpSpPr>
          <a:xfrm>
            <a:off x="-27941" y="291453"/>
            <a:ext cx="6498149" cy="3147906"/>
            <a:chOff x="-27941" y="2000664"/>
            <a:chExt cx="6498149" cy="3147906"/>
          </a:xfrm>
        </p:grpSpPr>
        <p:cxnSp>
          <p:nvCxnSpPr>
            <p:cNvPr id="392" name="Straight Connector 391">
              <a:extLst>
                <a:ext uri="{FF2B5EF4-FFF2-40B4-BE49-F238E27FC236}">
                  <a16:creationId xmlns:a16="http://schemas.microsoft.com/office/drawing/2014/main" id="{01F877EB-85A3-A781-6375-8A293F4708D0}"/>
                </a:ext>
              </a:extLst>
            </p:cNvPr>
            <p:cNvCxnSpPr>
              <a:cxnSpLocks/>
            </p:cNvCxnSpPr>
            <p:nvPr/>
          </p:nvCxnSpPr>
          <p:spPr>
            <a:xfrm>
              <a:off x="427037" y="2590931"/>
              <a:ext cx="1276626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3" name="Straight Connector 392">
              <a:extLst>
                <a:ext uri="{FF2B5EF4-FFF2-40B4-BE49-F238E27FC236}">
                  <a16:creationId xmlns:a16="http://schemas.microsoft.com/office/drawing/2014/main" id="{0DF15784-282F-177D-03CE-47A5D79DCD5A}"/>
                </a:ext>
              </a:extLst>
            </p:cNvPr>
            <p:cNvCxnSpPr>
              <a:cxnSpLocks/>
            </p:cNvCxnSpPr>
            <p:nvPr/>
          </p:nvCxnSpPr>
          <p:spPr>
            <a:xfrm>
              <a:off x="427037" y="3251203"/>
              <a:ext cx="1276626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4" name="Straight Connector 393">
              <a:extLst>
                <a:ext uri="{FF2B5EF4-FFF2-40B4-BE49-F238E27FC236}">
                  <a16:creationId xmlns:a16="http://schemas.microsoft.com/office/drawing/2014/main" id="{FFD111BE-D26C-2CFB-D713-46548462AA17}"/>
                </a:ext>
              </a:extLst>
            </p:cNvPr>
            <p:cNvCxnSpPr>
              <a:cxnSpLocks/>
            </p:cNvCxnSpPr>
            <p:nvPr/>
          </p:nvCxnSpPr>
          <p:spPr>
            <a:xfrm>
              <a:off x="1957660" y="3251203"/>
              <a:ext cx="1276626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5" name="Straight Connector 394">
              <a:extLst>
                <a:ext uri="{FF2B5EF4-FFF2-40B4-BE49-F238E27FC236}">
                  <a16:creationId xmlns:a16="http://schemas.microsoft.com/office/drawing/2014/main" id="{1A560D6E-8BC2-FB52-4FC9-66FE5D676E54}"/>
                </a:ext>
              </a:extLst>
            </p:cNvPr>
            <p:cNvCxnSpPr>
              <a:cxnSpLocks/>
            </p:cNvCxnSpPr>
            <p:nvPr/>
          </p:nvCxnSpPr>
          <p:spPr>
            <a:xfrm>
              <a:off x="3487737" y="3251203"/>
              <a:ext cx="1276626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8" name="Straight Connector 397">
              <a:extLst>
                <a:ext uri="{FF2B5EF4-FFF2-40B4-BE49-F238E27FC236}">
                  <a16:creationId xmlns:a16="http://schemas.microsoft.com/office/drawing/2014/main" id="{ACF50679-0F9B-EFB6-D04E-9E5A7843DBD1}"/>
                </a:ext>
              </a:extLst>
            </p:cNvPr>
            <p:cNvCxnSpPr>
              <a:cxnSpLocks/>
            </p:cNvCxnSpPr>
            <p:nvPr/>
          </p:nvCxnSpPr>
          <p:spPr>
            <a:xfrm>
              <a:off x="1957660" y="2620793"/>
              <a:ext cx="1276626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9" name="Straight Connector 408">
              <a:extLst>
                <a:ext uri="{FF2B5EF4-FFF2-40B4-BE49-F238E27FC236}">
                  <a16:creationId xmlns:a16="http://schemas.microsoft.com/office/drawing/2014/main" id="{99B7D5DD-7D05-F26D-8584-4E0EF9A684B5}"/>
                </a:ext>
              </a:extLst>
            </p:cNvPr>
            <p:cNvCxnSpPr>
              <a:cxnSpLocks/>
            </p:cNvCxnSpPr>
            <p:nvPr/>
          </p:nvCxnSpPr>
          <p:spPr>
            <a:xfrm>
              <a:off x="427037" y="4045762"/>
              <a:ext cx="1276626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0" name="Straight Connector 409">
              <a:extLst>
                <a:ext uri="{FF2B5EF4-FFF2-40B4-BE49-F238E27FC236}">
                  <a16:creationId xmlns:a16="http://schemas.microsoft.com/office/drawing/2014/main" id="{A1EEDE1D-02C3-B41D-7E97-D78E778B1CC9}"/>
                </a:ext>
              </a:extLst>
            </p:cNvPr>
            <p:cNvCxnSpPr>
              <a:cxnSpLocks/>
            </p:cNvCxnSpPr>
            <p:nvPr/>
          </p:nvCxnSpPr>
          <p:spPr>
            <a:xfrm>
              <a:off x="1957660" y="4323112"/>
              <a:ext cx="1276626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1" name="Straight Connector 410">
              <a:extLst>
                <a:ext uri="{FF2B5EF4-FFF2-40B4-BE49-F238E27FC236}">
                  <a16:creationId xmlns:a16="http://schemas.microsoft.com/office/drawing/2014/main" id="{4AAA2AE6-5DF5-F765-BE08-8A65484C775B}"/>
                </a:ext>
              </a:extLst>
            </p:cNvPr>
            <p:cNvCxnSpPr>
              <a:cxnSpLocks/>
            </p:cNvCxnSpPr>
            <p:nvPr/>
          </p:nvCxnSpPr>
          <p:spPr>
            <a:xfrm>
              <a:off x="3487737" y="4176191"/>
              <a:ext cx="1276626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2" name="Straight Connector 411">
              <a:extLst>
                <a:ext uri="{FF2B5EF4-FFF2-40B4-BE49-F238E27FC236}">
                  <a16:creationId xmlns:a16="http://schemas.microsoft.com/office/drawing/2014/main" id="{CE6F9196-4623-D11E-A768-80D2B89930E8}"/>
                </a:ext>
              </a:extLst>
            </p:cNvPr>
            <p:cNvCxnSpPr>
              <a:cxnSpLocks/>
            </p:cNvCxnSpPr>
            <p:nvPr/>
          </p:nvCxnSpPr>
          <p:spPr>
            <a:xfrm>
              <a:off x="3487737" y="2661368"/>
              <a:ext cx="1276626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3" name="Straight Connector 412">
              <a:extLst>
                <a:ext uri="{FF2B5EF4-FFF2-40B4-BE49-F238E27FC236}">
                  <a16:creationId xmlns:a16="http://schemas.microsoft.com/office/drawing/2014/main" id="{C913BA25-1EB4-328B-FAC4-DC6D698E2E82}"/>
                </a:ext>
              </a:extLst>
            </p:cNvPr>
            <p:cNvCxnSpPr>
              <a:cxnSpLocks/>
            </p:cNvCxnSpPr>
            <p:nvPr/>
          </p:nvCxnSpPr>
          <p:spPr>
            <a:xfrm>
              <a:off x="5021602" y="3479006"/>
              <a:ext cx="1276626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6" name="Straight Connector 475">
              <a:extLst>
                <a:ext uri="{FF2B5EF4-FFF2-40B4-BE49-F238E27FC236}">
                  <a16:creationId xmlns:a16="http://schemas.microsoft.com/office/drawing/2014/main" id="{67637367-D075-8518-9660-9A609476C2CB}"/>
                </a:ext>
              </a:extLst>
            </p:cNvPr>
            <p:cNvCxnSpPr>
              <a:cxnSpLocks/>
            </p:cNvCxnSpPr>
            <p:nvPr/>
          </p:nvCxnSpPr>
          <p:spPr>
            <a:xfrm>
              <a:off x="5021602" y="4273822"/>
              <a:ext cx="1276626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7" name="Straight Connector 476">
              <a:extLst>
                <a:ext uri="{FF2B5EF4-FFF2-40B4-BE49-F238E27FC236}">
                  <a16:creationId xmlns:a16="http://schemas.microsoft.com/office/drawing/2014/main" id="{ECF49CA2-870E-19D1-8A27-AD420434B998}"/>
                </a:ext>
              </a:extLst>
            </p:cNvPr>
            <p:cNvCxnSpPr>
              <a:cxnSpLocks/>
            </p:cNvCxnSpPr>
            <p:nvPr/>
          </p:nvCxnSpPr>
          <p:spPr>
            <a:xfrm>
              <a:off x="5021602" y="2586831"/>
              <a:ext cx="1276626" cy="0"/>
            </a:xfrm>
            <a:prstGeom prst="line">
              <a:avLst/>
            </a:prstGeom>
            <a:ln w="9525">
              <a:solidFill>
                <a:schemeClr val="bg1">
                  <a:lumMod val="65000"/>
                </a:schemeClr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84">
              <a:extLst>
                <a:ext uri="{FF2B5EF4-FFF2-40B4-BE49-F238E27FC236}">
                  <a16:creationId xmlns:a16="http://schemas.microsoft.com/office/drawing/2014/main" id="{F7AA566C-4241-D460-B302-3473A4239C72}"/>
                </a:ext>
              </a:extLst>
            </p:cNvPr>
            <p:cNvSpPr txBox="1"/>
            <p:nvPr/>
          </p:nvSpPr>
          <p:spPr>
            <a:xfrm>
              <a:off x="-27941" y="2016272"/>
              <a:ext cx="2901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latin typeface="Arial" pitchFamily="34" charset="0"/>
                  <a:cs typeface="Arial" pitchFamily="34" charset="0"/>
                </a:rPr>
                <a:t>A</a:t>
              </a: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54746834-EBC4-2D86-9579-A168FA679DE1}"/>
                </a:ext>
              </a:extLst>
            </p:cNvPr>
            <p:cNvGrpSpPr/>
            <p:nvPr/>
          </p:nvGrpSpPr>
          <p:grpSpPr>
            <a:xfrm>
              <a:off x="803992" y="3639528"/>
              <a:ext cx="5126829" cy="246221"/>
              <a:chOff x="791734" y="6672509"/>
              <a:chExt cx="5126829" cy="246221"/>
            </a:xfrm>
          </p:grpSpPr>
          <p:sp>
            <p:nvSpPr>
              <p:cNvPr id="462" name="テキスト ボックス 250">
                <a:extLst>
                  <a:ext uri="{FF2B5EF4-FFF2-40B4-BE49-F238E27FC236}">
                    <a16:creationId xmlns:a16="http://schemas.microsoft.com/office/drawing/2014/main" id="{0686D0A5-BCAD-C4E3-2940-65154E409B87}"/>
                  </a:ext>
                </a:extLst>
              </p:cNvPr>
              <p:cNvSpPr txBox="1"/>
              <p:nvPr/>
            </p:nvSpPr>
            <p:spPr>
              <a:xfrm>
                <a:off x="791734" y="6672509"/>
                <a:ext cx="5405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MRP2</a:t>
                </a:r>
              </a:p>
            </p:txBody>
          </p:sp>
          <p:sp>
            <p:nvSpPr>
              <p:cNvPr id="442" name="テキスト ボックス 250">
                <a:extLst>
                  <a:ext uri="{FF2B5EF4-FFF2-40B4-BE49-F238E27FC236}">
                    <a16:creationId xmlns:a16="http://schemas.microsoft.com/office/drawing/2014/main" id="{87093CCF-6846-5F2A-4448-C76FC126F65D}"/>
                  </a:ext>
                </a:extLst>
              </p:cNvPr>
              <p:cNvSpPr txBox="1"/>
              <p:nvPr/>
            </p:nvSpPr>
            <p:spPr>
              <a:xfrm>
                <a:off x="3891744" y="6672509"/>
                <a:ext cx="45557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OTC</a:t>
                </a:r>
              </a:p>
            </p:txBody>
          </p:sp>
          <p:sp>
            <p:nvSpPr>
              <p:cNvPr id="416" name="テキスト ボックス 250">
                <a:extLst>
                  <a:ext uri="{FF2B5EF4-FFF2-40B4-BE49-F238E27FC236}">
                    <a16:creationId xmlns:a16="http://schemas.microsoft.com/office/drawing/2014/main" id="{184704AF-A28B-4958-D0F5-5EFC49D4BDAB}"/>
                  </a:ext>
                </a:extLst>
              </p:cNvPr>
              <p:cNvSpPr txBox="1"/>
              <p:nvPr/>
            </p:nvSpPr>
            <p:spPr>
              <a:xfrm>
                <a:off x="2324507" y="6672509"/>
                <a:ext cx="5325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BSEP</a:t>
                </a:r>
              </a:p>
            </p:txBody>
          </p:sp>
          <p:sp>
            <p:nvSpPr>
              <p:cNvPr id="235" name="テキスト ボックス 250">
                <a:extLst>
                  <a:ext uri="{FF2B5EF4-FFF2-40B4-BE49-F238E27FC236}">
                    <a16:creationId xmlns:a16="http://schemas.microsoft.com/office/drawing/2014/main" id="{910DCC9A-39B3-2AD6-9D83-17443ACE0EC8}"/>
                  </a:ext>
                </a:extLst>
              </p:cNvPr>
              <p:cNvSpPr txBox="1"/>
              <p:nvPr/>
            </p:nvSpPr>
            <p:spPr>
              <a:xfrm>
                <a:off x="5378029" y="6672509"/>
                <a:ext cx="5405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ARG1</a:t>
                </a: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CA0393CC-CF1F-F0F7-49E8-2715F7C57F43}"/>
                </a:ext>
              </a:extLst>
            </p:cNvPr>
            <p:cNvGrpSpPr/>
            <p:nvPr/>
          </p:nvGrpSpPr>
          <p:grpSpPr>
            <a:xfrm>
              <a:off x="767925" y="2839384"/>
              <a:ext cx="5237435" cy="246221"/>
              <a:chOff x="755667" y="5882481"/>
              <a:chExt cx="5237435" cy="246221"/>
            </a:xfrm>
          </p:grpSpPr>
          <p:sp>
            <p:nvSpPr>
              <p:cNvPr id="486" name="テキスト ボックス 250">
                <a:extLst>
                  <a:ext uri="{FF2B5EF4-FFF2-40B4-BE49-F238E27FC236}">
                    <a16:creationId xmlns:a16="http://schemas.microsoft.com/office/drawing/2014/main" id="{3B867B01-5EB5-230A-7914-9D1763CFF2EF}"/>
                  </a:ext>
                </a:extLst>
              </p:cNvPr>
              <p:cNvSpPr txBox="1"/>
              <p:nvPr/>
            </p:nvSpPr>
            <p:spPr>
              <a:xfrm>
                <a:off x="2288270" y="5882481"/>
                <a:ext cx="604992" cy="2185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CYP3A4</a:t>
                </a:r>
              </a:p>
            </p:txBody>
          </p:sp>
          <p:sp>
            <p:nvSpPr>
              <p:cNvPr id="441" name="テキスト ボックス 250">
                <a:extLst>
                  <a:ext uri="{FF2B5EF4-FFF2-40B4-BE49-F238E27FC236}">
                    <a16:creationId xmlns:a16="http://schemas.microsoft.com/office/drawing/2014/main" id="{555442A0-7416-56AF-DA88-861F892B8BAE}"/>
                  </a:ext>
                </a:extLst>
              </p:cNvPr>
              <p:cNvSpPr txBox="1"/>
              <p:nvPr/>
            </p:nvSpPr>
            <p:spPr>
              <a:xfrm>
                <a:off x="755667" y="5882481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ALDH2</a:t>
                </a:r>
              </a:p>
            </p:txBody>
          </p:sp>
          <p:sp>
            <p:nvSpPr>
              <p:cNvPr id="396" name="テキスト ボックス 250">
                <a:extLst>
                  <a:ext uri="{FF2B5EF4-FFF2-40B4-BE49-F238E27FC236}">
                    <a16:creationId xmlns:a16="http://schemas.microsoft.com/office/drawing/2014/main" id="{48DC9610-F25A-D447-0C41-9DA7910031C8}"/>
                  </a:ext>
                </a:extLst>
              </p:cNvPr>
              <p:cNvSpPr txBox="1"/>
              <p:nvPr/>
            </p:nvSpPr>
            <p:spPr>
              <a:xfrm>
                <a:off x="3782740" y="5882481"/>
                <a:ext cx="67358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CYP2E1</a:t>
                </a:r>
              </a:p>
            </p:txBody>
          </p:sp>
          <p:sp>
            <p:nvSpPr>
              <p:cNvPr id="243" name="テキスト ボックス 250">
                <a:extLst>
                  <a:ext uri="{FF2B5EF4-FFF2-40B4-BE49-F238E27FC236}">
                    <a16:creationId xmlns:a16="http://schemas.microsoft.com/office/drawing/2014/main" id="{E6B340DD-4DC1-F605-EFE0-296225DC14DE}"/>
                  </a:ext>
                </a:extLst>
              </p:cNvPr>
              <p:cNvSpPr txBox="1"/>
              <p:nvPr/>
            </p:nvSpPr>
            <p:spPr>
              <a:xfrm>
                <a:off x="5303490" y="5882481"/>
                <a:ext cx="68961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UGT1A1</a:t>
                </a:r>
              </a:p>
            </p:txBody>
          </p:sp>
        </p:grpSp>
        <p:graphicFrame>
          <p:nvGraphicFramePr>
            <p:cNvPr id="390" name="オブジェクト 389">
              <a:extLst>
                <a:ext uri="{FF2B5EF4-FFF2-40B4-BE49-F238E27FC236}">
                  <a16:creationId xmlns:a16="http://schemas.microsoft.com/office/drawing/2014/main" id="{684D526C-EED1-5523-60ED-D25EE820D30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50779581"/>
                </p:ext>
              </p:extLst>
            </p:nvPr>
          </p:nvGraphicFramePr>
          <p:xfrm>
            <a:off x="236096" y="2000664"/>
            <a:ext cx="6234112" cy="2597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2" imgW="6883920" imgH="2871360" progId="Prism5.Document">
                    <p:embed/>
                  </p:oleObj>
                </mc:Choice>
                <mc:Fallback>
                  <p:oleObj name="Prism 5" r:id="rId2" imgW="6883920" imgH="2871360" progId="Prism5.Document">
                    <p:embed/>
                    <p:pic>
                      <p:nvPicPr>
                        <p:cNvPr id="390" name="オブジェクト 389">
                          <a:extLst>
                            <a:ext uri="{FF2B5EF4-FFF2-40B4-BE49-F238E27FC236}">
                              <a16:creationId xmlns:a16="http://schemas.microsoft.com/office/drawing/2014/main" id="{684D526C-EED1-5523-60ED-D25EE820D30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36096" y="2000664"/>
                          <a:ext cx="6234112" cy="2597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89" name="テキスト ボックス 388">
              <a:extLst>
                <a:ext uri="{FF2B5EF4-FFF2-40B4-BE49-F238E27FC236}">
                  <a16:creationId xmlns:a16="http://schemas.microsoft.com/office/drawing/2014/main" id="{8BEC789B-BE0E-F73B-56DF-C13F66A5597F}"/>
                </a:ext>
              </a:extLst>
            </p:cNvPr>
            <p:cNvSpPr txBox="1"/>
            <p:nvPr/>
          </p:nvSpPr>
          <p:spPr>
            <a:xfrm rot="16200000">
              <a:off x="-577875" y="3366496"/>
              <a:ext cx="140561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itchFamily="34" charset="0"/>
                  <a:cs typeface="Arial" pitchFamily="34" charset="0"/>
                </a:rPr>
                <a:t>Fold index</a:t>
              </a:r>
            </a:p>
          </p:txBody>
        </p:sp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E9E4198E-25EA-4719-EC59-9B20FCA93A69}"/>
                </a:ext>
              </a:extLst>
            </p:cNvPr>
            <p:cNvGrpSpPr/>
            <p:nvPr/>
          </p:nvGrpSpPr>
          <p:grpSpPr>
            <a:xfrm>
              <a:off x="2403475" y="3494624"/>
              <a:ext cx="287748" cy="92333"/>
              <a:chOff x="7410745" y="4983105"/>
              <a:chExt cx="287748" cy="92333"/>
            </a:xfrm>
          </p:grpSpPr>
          <p:sp>
            <p:nvSpPr>
              <p:cNvPr id="226" name="TextBox 51">
                <a:extLst>
                  <a:ext uri="{FF2B5EF4-FFF2-40B4-BE49-F238E27FC236}">
                    <a16:creationId xmlns:a16="http://schemas.microsoft.com/office/drawing/2014/main" id="{20628486-9818-7946-2107-BA9876792B70}"/>
                  </a:ext>
                </a:extLst>
              </p:cNvPr>
              <p:cNvSpPr txBox="1"/>
              <p:nvPr/>
            </p:nvSpPr>
            <p:spPr>
              <a:xfrm>
                <a:off x="7410745" y="4983105"/>
                <a:ext cx="173444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D</a:t>
                </a:r>
              </a:p>
            </p:txBody>
          </p:sp>
          <p:sp>
            <p:nvSpPr>
              <p:cNvPr id="227" name="TextBox 51">
                <a:extLst>
                  <a:ext uri="{FF2B5EF4-FFF2-40B4-BE49-F238E27FC236}">
                    <a16:creationId xmlns:a16="http://schemas.microsoft.com/office/drawing/2014/main" id="{C61AEA8C-53B2-4E18-3733-DF7705DD6019}"/>
                  </a:ext>
                </a:extLst>
              </p:cNvPr>
              <p:cNvSpPr txBox="1"/>
              <p:nvPr/>
            </p:nvSpPr>
            <p:spPr>
              <a:xfrm>
                <a:off x="7525049" y="4983105"/>
                <a:ext cx="173444" cy="9233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D</a:t>
                </a:r>
              </a:p>
            </p:txBody>
          </p:sp>
        </p:grpSp>
        <p:grpSp>
          <p:nvGrpSpPr>
            <p:cNvPr id="483" name="グループ化 45">
              <a:extLst>
                <a:ext uri="{FF2B5EF4-FFF2-40B4-BE49-F238E27FC236}">
                  <a16:creationId xmlns:a16="http://schemas.microsoft.com/office/drawing/2014/main" id="{85CA184F-6175-65EB-CD3A-868B34EFE0B2}"/>
                </a:ext>
              </a:extLst>
            </p:cNvPr>
            <p:cNvGrpSpPr/>
            <p:nvPr/>
          </p:nvGrpSpPr>
          <p:grpSpPr>
            <a:xfrm>
              <a:off x="101372" y="2225873"/>
              <a:ext cx="299622" cy="631470"/>
              <a:chOff x="7095004" y="4070624"/>
              <a:chExt cx="258553" cy="711431"/>
            </a:xfrm>
          </p:grpSpPr>
          <p:sp>
            <p:nvSpPr>
              <p:cNvPr id="499" name="TextBox 51">
                <a:extLst>
                  <a:ext uri="{FF2B5EF4-FFF2-40B4-BE49-F238E27FC236}">
                    <a16:creationId xmlns:a16="http://schemas.microsoft.com/office/drawing/2014/main" id="{52286834-2BDE-D2D3-7BFD-2B12C1BBD1C2}"/>
                  </a:ext>
                </a:extLst>
              </p:cNvPr>
              <p:cNvSpPr txBox="1"/>
              <p:nvPr/>
            </p:nvSpPr>
            <p:spPr>
              <a:xfrm>
                <a:off x="7159391" y="4191794"/>
                <a:ext cx="194166" cy="14181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</p:txBody>
          </p:sp>
          <p:sp>
            <p:nvSpPr>
              <p:cNvPr id="500" name="TextBox 61">
                <a:extLst>
                  <a:ext uri="{FF2B5EF4-FFF2-40B4-BE49-F238E27FC236}">
                    <a16:creationId xmlns:a16="http://schemas.microsoft.com/office/drawing/2014/main" id="{E99C8515-4BD3-5C41-7FE0-D0B431C67A07}"/>
                  </a:ext>
                </a:extLst>
              </p:cNvPr>
              <p:cNvSpPr txBox="1"/>
              <p:nvPr/>
            </p:nvSpPr>
            <p:spPr>
              <a:xfrm>
                <a:off x="7107335" y="4300887"/>
                <a:ext cx="246222" cy="14181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1" name="TextBox 51">
                <a:extLst>
                  <a:ext uri="{FF2B5EF4-FFF2-40B4-BE49-F238E27FC236}">
                    <a16:creationId xmlns:a16="http://schemas.microsoft.com/office/drawing/2014/main" id="{1915CD5B-1A76-7A4C-6704-331545B73F8B}"/>
                  </a:ext>
                </a:extLst>
              </p:cNvPr>
              <p:cNvSpPr txBox="1"/>
              <p:nvPr/>
            </p:nvSpPr>
            <p:spPr>
              <a:xfrm>
                <a:off x="7095004" y="4519074"/>
                <a:ext cx="258553" cy="14181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2" name="TextBox 51">
                <a:extLst>
                  <a:ext uri="{FF2B5EF4-FFF2-40B4-BE49-F238E27FC236}">
                    <a16:creationId xmlns:a16="http://schemas.microsoft.com/office/drawing/2014/main" id="{B0C5DA5F-F932-2C6B-4D9C-DC770654E01C}"/>
                  </a:ext>
                </a:extLst>
              </p:cNvPr>
              <p:cNvSpPr txBox="1"/>
              <p:nvPr/>
            </p:nvSpPr>
            <p:spPr>
              <a:xfrm>
                <a:off x="7107339" y="4628167"/>
                <a:ext cx="24621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3" name="TextBox 61">
                <a:extLst>
                  <a:ext uri="{FF2B5EF4-FFF2-40B4-BE49-F238E27FC236}">
                    <a16:creationId xmlns:a16="http://schemas.microsoft.com/office/drawing/2014/main" id="{3B978706-B0AC-E546-46CF-9615068EB06E}"/>
                  </a:ext>
                </a:extLst>
              </p:cNvPr>
              <p:cNvSpPr txBox="1"/>
              <p:nvPr/>
            </p:nvSpPr>
            <p:spPr>
              <a:xfrm>
                <a:off x="7107335" y="4409981"/>
                <a:ext cx="246222" cy="14181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04" name="TextBox 51">
                <a:extLst>
                  <a:ext uri="{FF2B5EF4-FFF2-40B4-BE49-F238E27FC236}">
                    <a16:creationId xmlns:a16="http://schemas.microsoft.com/office/drawing/2014/main" id="{0EAA4518-756C-350B-E139-FA9ABDE7C389}"/>
                  </a:ext>
                </a:extLst>
              </p:cNvPr>
              <p:cNvSpPr txBox="1"/>
              <p:nvPr/>
            </p:nvSpPr>
            <p:spPr>
              <a:xfrm>
                <a:off x="7159391" y="4070624"/>
                <a:ext cx="194166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</a:p>
            </p:txBody>
          </p:sp>
        </p:grpSp>
        <p:grpSp>
          <p:nvGrpSpPr>
            <p:cNvPr id="484" name="グループ化 422">
              <a:extLst>
                <a:ext uri="{FF2B5EF4-FFF2-40B4-BE49-F238E27FC236}">
                  <a16:creationId xmlns:a16="http://schemas.microsoft.com/office/drawing/2014/main" id="{F7D2F74B-0D91-A0F1-664F-DBA97D37A62A}"/>
                </a:ext>
              </a:extLst>
            </p:cNvPr>
            <p:cNvGrpSpPr/>
            <p:nvPr/>
          </p:nvGrpSpPr>
          <p:grpSpPr>
            <a:xfrm>
              <a:off x="1640320" y="3016579"/>
              <a:ext cx="285332" cy="631756"/>
              <a:chOff x="7107335" y="4060466"/>
              <a:chExt cx="246222" cy="711752"/>
            </a:xfrm>
          </p:grpSpPr>
          <p:sp>
            <p:nvSpPr>
              <p:cNvPr id="495" name="TextBox 51">
                <a:extLst>
                  <a:ext uri="{FF2B5EF4-FFF2-40B4-BE49-F238E27FC236}">
                    <a16:creationId xmlns:a16="http://schemas.microsoft.com/office/drawing/2014/main" id="{B07FF7A7-F540-4055-6388-E049280114AA}"/>
                  </a:ext>
                </a:extLst>
              </p:cNvPr>
              <p:cNvSpPr txBox="1"/>
              <p:nvPr/>
            </p:nvSpPr>
            <p:spPr>
              <a:xfrm>
                <a:off x="7159391" y="4246420"/>
                <a:ext cx="194166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496" name="TextBox 51">
                <a:extLst>
                  <a:ext uri="{FF2B5EF4-FFF2-40B4-BE49-F238E27FC236}">
                    <a16:creationId xmlns:a16="http://schemas.microsoft.com/office/drawing/2014/main" id="{FF00AE95-42F6-990C-DAB3-88636C213DFE}"/>
                  </a:ext>
                </a:extLst>
              </p:cNvPr>
              <p:cNvSpPr txBox="1"/>
              <p:nvPr/>
            </p:nvSpPr>
            <p:spPr>
              <a:xfrm>
                <a:off x="7107339" y="4618331"/>
                <a:ext cx="246218" cy="153887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7" name="TextBox 61">
                <a:extLst>
                  <a:ext uri="{FF2B5EF4-FFF2-40B4-BE49-F238E27FC236}">
                    <a16:creationId xmlns:a16="http://schemas.microsoft.com/office/drawing/2014/main" id="{04339411-5AD4-951D-8616-146E4A329D55}"/>
                  </a:ext>
                </a:extLst>
              </p:cNvPr>
              <p:cNvSpPr txBox="1"/>
              <p:nvPr/>
            </p:nvSpPr>
            <p:spPr>
              <a:xfrm>
                <a:off x="7107335" y="4432375"/>
                <a:ext cx="246222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8" name="TextBox 51">
                <a:extLst>
                  <a:ext uri="{FF2B5EF4-FFF2-40B4-BE49-F238E27FC236}">
                    <a16:creationId xmlns:a16="http://schemas.microsoft.com/office/drawing/2014/main" id="{446C4C5A-AA7C-46D2-2128-737BB242C0D4}"/>
                  </a:ext>
                </a:extLst>
              </p:cNvPr>
              <p:cNvSpPr txBox="1"/>
              <p:nvPr/>
            </p:nvSpPr>
            <p:spPr>
              <a:xfrm>
                <a:off x="7159391" y="4060466"/>
                <a:ext cx="194166" cy="153887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</p:grpSp>
        <p:grpSp>
          <p:nvGrpSpPr>
            <p:cNvPr id="465" name="グループ化 453">
              <a:extLst>
                <a:ext uri="{FF2B5EF4-FFF2-40B4-BE49-F238E27FC236}">
                  <a16:creationId xmlns:a16="http://schemas.microsoft.com/office/drawing/2014/main" id="{176B47A6-2805-CD93-D992-53315B5AE792}"/>
                </a:ext>
              </a:extLst>
            </p:cNvPr>
            <p:cNvGrpSpPr/>
            <p:nvPr/>
          </p:nvGrpSpPr>
          <p:grpSpPr>
            <a:xfrm>
              <a:off x="3164978" y="2225873"/>
              <a:ext cx="285332" cy="634097"/>
              <a:chOff x="5289729" y="271712"/>
              <a:chExt cx="246222" cy="714388"/>
            </a:xfrm>
          </p:grpSpPr>
          <p:sp>
            <p:nvSpPr>
              <p:cNvPr id="471" name="TextBox 51">
                <a:extLst>
                  <a:ext uri="{FF2B5EF4-FFF2-40B4-BE49-F238E27FC236}">
                    <a16:creationId xmlns:a16="http://schemas.microsoft.com/office/drawing/2014/main" id="{BB68D46E-EC44-B9D0-ED22-A7AB5F4A61AE}"/>
                  </a:ext>
                </a:extLst>
              </p:cNvPr>
              <p:cNvSpPr txBox="1"/>
              <p:nvPr/>
            </p:nvSpPr>
            <p:spPr>
              <a:xfrm>
                <a:off x="5341785" y="551962"/>
                <a:ext cx="194166" cy="17337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</p:txBody>
          </p:sp>
          <p:sp>
            <p:nvSpPr>
              <p:cNvPr id="472" name="TextBox 51">
                <a:extLst>
                  <a:ext uri="{FF2B5EF4-FFF2-40B4-BE49-F238E27FC236}">
                    <a16:creationId xmlns:a16="http://schemas.microsoft.com/office/drawing/2014/main" id="{434CFDC4-174B-373C-CAD9-A9287BB0F48A}"/>
                  </a:ext>
                </a:extLst>
              </p:cNvPr>
              <p:cNvSpPr txBox="1"/>
              <p:nvPr/>
            </p:nvSpPr>
            <p:spPr>
              <a:xfrm>
                <a:off x="5289733" y="832212"/>
                <a:ext cx="24621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3" name="TextBox 61">
                <a:extLst>
                  <a:ext uri="{FF2B5EF4-FFF2-40B4-BE49-F238E27FC236}">
                    <a16:creationId xmlns:a16="http://schemas.microsoft.com/office/drawing/2014/main" id="{62FAED34-570B-120B-965F-A06BC7A8D536}"/>
                  </a:ext>
                </a:extLst>
              </p:cNvPr>
              <p:cNvSpPr txBox="1"/>
              <p:nvPr/>
            </p:nvSpPr>
            <p:spPr>
              <a:xfrm>
                <a:off x="5289729" y="692086"/>
                <a:ext cx="246222" cy="17337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4" name="TextBox 51">
                <a:extLst>
                  <a:ext uri="{FF2B5EF4-FFF2-40B4-BE49-F238E27FC236}">
                    <a16:creationId xmlns:a16="http://schemas.microsoft.com/office/drawing/2014/main" id="{DA1290E0-D54A-B249-1725-43C12B61D834}"/>
                  </a:ext>
                </a:extLst>
              </p:cNvPr>
              <p:cNvSpPr txBox="1"/>
              <p:nvPr/>
            </p:nvSpPr>
            <p:spPr>
              <a:xfrm>
                <a:off x="5341785" y="411837"/>
                <a:ext cx="194166" cy="17337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</a:p>
            </p:txBody>
          </p:sp>
          <p:sp>
            <p:nvSpPr>
              <p:cNvPr id="475" name="TextBox 51">
                <a:extLst>
                  <a:ext uri="{FF2B5EF4-FFF2-40B4-BE49-F238E27FC236}">
                    <a16:creationId xmlns:a16="http://schemas.microsoft.com/office/drawing/2014/main" id="{06CD5140-11AD-162F-7247-F6C1568A422F}"/>
                  </a:ext>
                </a:extLst>
              </p:cNvPr>
              <p:cNvSpPr txBox="1"/>
              <p:nvPr/>
            </p:nvSpPr>
            <p:spPr>
              <a:xfrm>
                <a:off x="5341785" y="271712"/>
                <a:ext cx="194166" cy="17337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</a:p>
            </p:txBody>
          </p:sp>
        </p:grpSp>
        <p:grpSp>
          <p:nvGrpSpPr>
            <p:cNvPr id="466" name="グループ化 422">
              <a:extLst>
                <a:ext uri="{FF2B5EF4-FFF2-40B4-BE49-F238E27FC236}">
                  <a16:creationId xmlns:a16="http://schemas.microsoft.com/office/drawing/2014/main" id="{76B80A95-479C-E34C-E72A-CE31451319FA}"/>
                </a:ext>
              </a:extLst>
            </p:cNvPr>
            <p:cNvGrpSpPr/>
            <p:nvPr/>
          </p:nvGrpSpPr>
          <p:grpSpPr>
            <a:xfrm>
              <a:off x="115662" y="3800987"/>
              <a:ext cx="285332" cy="631756"/>
              <a:chOff x="7107335" y="4060466"/>
              <a:chExt cx="246222" cy="711752"/>
            </a:xfrm>
          </p:grpSpPr>
          <p:sp>
            <p:nvSpPr>
              <p:cNvPr id="467" name="TextBox 51">
                <a:extLst>
                  <a:ext uri="{FF2B5EF4-FFF2-40B4-BE49-F238E27FC236}">
                    <a16:creationId xmlns:a16="http://schemas.microsoft.com/office/drawing/2014/main" id="{36A361F4-3719-D9D1-8F6B-888BC86798EA}"/>
                  </a:ext>
                </a:extLst>
              </p:cNvPr>
              <p:cNvSpPr txBox="1"/>
              <p:nvPr/>
            </p:nvSpPr>
            <p:spPr>
              <a:xfrm>
                <a:off x="7159391" y="4246420"/>
                <a:ext cx="194166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468" name="TextBox 51">
                <a:extLst>
                  <a:ext uri="{FF2B5EF4-FFF2-40B4-BE49-F238E27FC236}">
                    <a16:creationId xmlns:a16="http://schemas.microsoft.com/office/drawing/2014/main" id="{F20826FA-7CFD-5BEF-52D8-48E9A4ED8C7A}"/>
                  </a:ext>
                </a:extLst>
              </p:cNvPr>
              <p:cNvSpPr txBox="1"/>
              <p:nvPr/>
            </p:nvSpPr>
            <p:spPr>
              <a:xfrm>
                <a:off x="7107339" y="4618331"/>
                <a:ext cx="246218" cy="153887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9" name="TextBox 61">
                <a:extLst>
                  <a:ext uri="{FF2B5EF4-FFF2-40B4-BE49-F238E27FC236}">
                    <a16:creationId xmlns:a16="http://schemas.microsoft.com/office/drawing/2014/main" id="{19A765BA-E9F8-97B8-8208-758146083245}"/>
                  </a:ext>
                </a:extLst>
              </p:cNvPr>
              <p:cNvSpPr txBox="1"/>
              <p:nvPr/>
            </p:nvSpPr>
            <p:spPr>
              <a:xfrm>
                <a:off x="7107335" y="4432375"/>
                <a:ext cx="246222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0" name="TextBox 51">
                <a:extLst>
                  <a:ext uri="{FF2B5EF4-FFF2-40B4-BE49-F238E27FC236}">
                    <a16:creationId xmlns:a16="http://schemas.microsoft.com/office/drawing/2014/main" id="{51E0BAAC-8F6D-F343-17AF-CCFF3DE68CF5}"/>
                  </a:ext>
                </a:extLst>
              </p:cNvPr>
              <p:cNvSpPr txBox="1"/>
              <p:nvPr/>
            </p:nvSpPr>
            <p:spPr>
              <a:xfrm>
                <a:off x="7159391" y="4060466"/>
                <a:ext cx="194166" cy="153887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</p:grpSp>
        <p:grpSp>
          <p:nvGrpSpPr>
            <p:cNvPr id="443" name="グループ化 432">
              <a:extLst>
                <a:ext uri="{FF2B5EF4-FFF2-40B4-BE49-F238E27FC236}">
                  <a16:creationId xmlns:a16="http://schemas.microsoft.com/office/drawing/2014/main" id="{16C33406-ACAB-9D53-F678-32222006BACE}"/>
                </a:ext>
              </a:extLst>
            </p:cNvPr>
            <p:cNvGrpSpPr/>
            <p:nvPr/>
          </p:nvGrpSpPr>
          <p:grpSpPr>
            <a:xfrm>
              <a:off x="3150688" y="3800987"/>
              <a:ext cx="299622" cy="644048"/>
              <a:chOff x="7095004" y="4068789"/>
              <a:chExt cx="258553" cy="725600"/>
            </a:xfrm>
          </p:grpSpPr>
          <p:sp>
            <p:nvSpPr>
              <p:cNvPr id="449" name="TextBox 51">
                <a:extLst>
                  <a:ext uri="{FF2B5EF4-FFF2-40B4-BE49-F238E27FC236}">
                    <a16:creationId xmlns:a16="http://schemas.microsoft.com/office/drawing/2014/main" id="{C185C546-DC40-A9D8-3FBD-E6D39AE945D9}"/>
                  </a:ext>
                </a:extLst>
              </p:cNvPr>
              <p:cNvSpPr txBox="1"/>
              <p:nvPr/>
            </p:nvSpPr>
            <p:spPr>
              <a:xfrm>
                <a:off x="7159391" y="4179233"/>
                <a:ext cx="194166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0" name="TextBox 61">
                <a:extLst>
                  <a:ext uri="{FF2B5EF4-FFF2-40B4-BE49-F238E27FC236}">
                    <a16:creationId xmlns:a16="http://schemas.microsoft.com/office/drawing/2014/main" id="{DA2EC243-AE61-BEB1-9B73-0B6FD5037FE9}"/>
                  </a:ext>
                </a:extLst>
              </p:cNvPr>
              <p:cNvSpPr txBox="1"/>
              <p:nvPr/>
            </p:nvSpPr>
            <p:spPr>
              <a:xfrm>
                <a:off x="7107335" y="4289678"/>
                <a:ext cx="246222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1" name="TextBox 51">
                <a:extLst>
                  <a:ext uri="{FF2B5EF4-FFF2-40B4-BE49-F238E27FC236}">
                    <a16:creationId xmlns:a16="http://schemas.microsoft.com/office/drawing/2014/main" id="{15D13747-EBC4-A6C2-582A-55BE534A5CE3}"/>
                  </a:ext>
                </a:extLst>
              </p:cNvPr>
              <p:cNvSpPr txBox="1"/>
              <p:nvPr/>
            </p:nvSpPr>
            <p:spPr>
              <a:xfrm>
                <a:off x="7095004" y="4510569"/>
                <a:ext cx="258553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2" name="TextBox 51">
                <a:extLst>
                  <a:ext uri="{FF2B5EF4-FFF2-40B4-BE49-F238E27FC236}">
                    <a16:creationId xmlns:a16="http://schemas.microsoft.com/office/drawing/2014/main" id="{E5F3076A-4877-A9C3-1F41-39CFA915C988}"/>
                  </a:ext>
                </a:extLst>
              </p:cNvPr>
              <p:cNvSpPr txBox="1"/>
              <p:nvPr/>
            </p:nvSpPr>
            <p:spPr>
              <a:xfrm>
                <a:off x="7107339" y="4621016"/>
                <a:ext cx="246218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3" name="TextBox 61">
                <a:extLst>
                  <a:ext uri="{FF2B5EF4-FFF2-40B4-BE49-F238E27FC236}">
                    <a16:creationId xmlns:a16="http://schemas.microsoft.com/office/drawing/2014/main" id="{F24F556D-03F8-7448-673F-EDE877985544}"/>
                  </a:ext>
                </a:extLst>
              </p:cNvPr>
              <p:cNvSpPr txBox="1"/>
              <p:nvPr/>
            </p:nvSpPr>
            <p:spPr>
              <a:xfrm>
                <a:off x="7107335" y="4400124"/>
                <a:ext cx="246222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4" name="TextBox 51">
                <a:extLst>
                  <a:ext uri="{FF2B5EF4-FFF2-40B4-BE49-F238E27FC236}">
                    <a16:creationId xmlns:a16="http://schemas.microsoft.com/office/drawing/2014/main" id="{84A3B7C4-DDDF-6A3B-2185-297DBDD45E05}"/>
                  </a:ext>
                </a:extLst>
              </p:cNvPr>
              <p:cNvSpPr txBox="1"/>
              <p:nvPr/>
            </p:nvSpPr>
            <p:spPr>
              <a:xfrm>
                <a:off x="7159391" y="4068789"/>
                <a:ext cx="194166" cy="17337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44" name="グループ化 422">
              <a:extLst>
                <a:ext uri="{FF2B5EF4-FFF2-40B4-BE49-F238E27FC236}">
                  <a16:creationId xmlns:a16="http://schemas.microsoft.com/office/drawing/2014/main" id="{6527D5B7-ADA5-FA4A-04DC-4352B6C301E3}"/>
                </a:ext>
              </a:extLst>
            </p:cNvPr>
            <p:cNvGrpSpPr/>
            <p:nvPr/>
          </p:nvGrpSpPr>
          <p:grpSpPr>
            <a:xfrm>
              <a:off x="115662" y="3016579"/>
              <a:ext cx="285332" cy="631756"/>
              <a:chOff x="7107335" y="4060466"/>
              <a:chExt cx="246222" cy="711752"/>
            </a:xfrm>
          </p:grpSpPr>
          <p:sp>
            <p:nvSpPr>
              <p:cNvPr id="445" name="TextBox 51">
                <a:extLst>
                  <a:ext uri="{FF2B5EF4-FFF2-40B4-BE49-F238E27FC236}">
                    <a16:creationId xmlns:a16="http://schemas.microsoft.com/office/drawing/2014/main" id="{213F4D51-CF11-69DE-77D3-C35519C418A9}"/>
                  </a:ext>
                </a:extLst>
              </p:cNvPr>
              <p:cNvSpPr txBox="1"/>
              <p:nvPr/>
            </p:nvSpPr>
            <p:spPr>
              <a:xfrm>
                <a:off x="7159391" y="4246420"/>
                <a:ext cx="194166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446" name="TextBox 51">
                <a:extLst>
                  <a:ext uri="{FF2B5EF4-FFF2-40B4-BE49-F238E27FC236}">
                    <a16:creationId xmlns:a16="http://schemas.microsoft.com/office/drawing/2014/main" id="{1C33E454-6AC1-3C7B-07A2-9F258BA6E7D6}"/>
                  </a:ext>
                </a:extLst>
              </p:cNvPr>
              <p:cNvSpPr txBox="1"/>
              <p:nvPr/>
            </p:nvSpPr>
            <p:spPr>
              <a:xfrm>
                <a:off x="7107339" y="4618331"/>
                <a:ext cx="246218" cy="153887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7" name="TextBox 61">
                <a:extLst>
                  <a:ext uri="{FF2B5EF4-FFF2-40B4-BE49-F238E27FC236}">
                    <a16:creationId xmlns:a16="http://schemas.microsoft.com/office/drawing/2014/main" id="{618F96EF-488B-CE33-FABD-BCEE2617043E}"/>
                  </a:ext>
                </a:extLst>
              </p:cNvPr>
              <p:cNvSpPr txBox="1"/>
              <p:nvPr/>
            </p:nvSpPr>
            <p:spPr>
              <a:xfrm>
                <a:off x="7107335" y="4432375"/>
                <a:ext cx="246222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8" name="TextBox 51">
                <a:extLst>
                  <a:ext uri="{FF2B5EF4-FFF2-40B4-BE49-F238E27FC236}">
                    <a16:creationId xmlns:a16="http://schemas.microsoft.com/office/drawing/2014/main" id="{310B5631-9029-CB65-C0AF-8888D8E1ED62}"/>
                  </a:ext>
                </a:extLst>
              </p:cNvPr>
              <p:cNvSpPr txBox="1"/>
              <p:nvPr/>
            </p:nvSpPr>
            <p:spPr>
              <a:xfrm>
                <a:off x="7159391" y="4060466"/>
                <a:ext cx="194166" cy="153887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</p:grpSp>
        <p:grpSp>
          <p:nvGrpSpPr>
            <p:cNvPr id="419" name="グループ化 432">
              <a:extLst>
                <a:ext uri="{FF2B5EF4-FFF2-40B4-BE49-F238E27FC236}">
                  <a16:creationId xmlns:a16="http://schemas.microsoft.com/office/drawing/2014/main" id="{7962B3B3-55E3-E999-485F-BE2E86BE4977}"/>
                </a:ext>
              </a:extLst>
            </p:cNvPr>
            <p:cNvGrpSpPr/>
            <p:nvPr/>
          </p:nvGrpSpPr>
          <p:grpSpPr>
            <a:xfrm>
              <a:off x="1626030" y="3800987"/>
              <a:ext cx="299622" cy="644048"/>
              <a:chOff x="7095004" y="4068789"/>
              <a:chExt cx="258553" cy="725600"/>
            </a:xfrm>
          </p:grpSpPr>
          <p:sp>
            <p:nvSpPr>
              <p:cNvPr id="427" name="TextBox 51">
                <a:extLst>
                  <a:ext uri="{FF2B5EF4-FFF2-40B4-BE49-F238E27FC236}">
                    <a16:creationId xmlns:a16="http://schemas.microsoft.com/office/drawing/2014/main" id="{C9C33853-B2B9-7BCF-380E-46812373F034}"/>
                  </a:ext>
                </a:extLst>
              </p:cNvPr>
              <p:cNvSpPr txBox="1"/>
              <p:nvPr/>
            </p:nvSpPr>
            <p:spPr>
              <a:xfrm>
                <a:off x="7159391" y="4179233"/>
                <a:ext cx="194166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  <p:sp>
            <p:nvSpPr>
              <p:cNvPr id="428" name="TextBox 61">
                <a:extLst>
                  <a:ext uri="{FF2B5EF4-FFF2-40B4-BE49-F238E27FC236}">
                    <a16:creationId xmlns:a16="http://schemas.microsoft.com/office/drawing/2014/main" id="{86E01873-91B7-1446-7AF1-BA76131A2C47}"/>
                  </a:ext>
                </a:extLst>
              </p:cNvPr>
              <p:cNvSpPr txBox="1"/>
              <p:nvPr/>
            </p:nvSpPr>
            <p:spPr>
              <a:xfrm>
                <a:off x="7107335" y="4289678"/>
                <a:ext cx="246222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9" name="TextBox 51">
                <a:extLst>
                  <a:ext uri="{FF2B5EF4-FFF2-40B4-BE49-F238E27FC236}">
                    <a16:creationId xmlns:a16="http://schemas.microsoft.com/office/drawing/2014/main" id="{C0EF4CBA-52E8-540A-65DB-1B7C545031A1}"/>
                  </a:ext>
                </a:extLst>
              </p:cNvPr>
              <p:cNvSpPr txBox="1"/>
              <p:nvPr/>
            </p:nvSpPr>
            <p:spPr>
              <a:xfrm>
                <a:off x="7095004" y="4510569"/>
                <a:ext cx="258553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0" name="TextBox 51">
                <a:extLst>
                  <a:ext uri="{FF2B5EF4-FFF2-40B4-BE49-F238E27FC236}">
                    <a16:creationId xmlns:a16="http://schemas.microsoft.com/office/drawing/2014/main" id="{35D1D2FE-985A-6FA1-E9D4-9AD2DB31CB8C}"/>
                  </a:ext>
                </a:extLst>
              </p:cNvPr>
              <p:cNvSpPr txBox="1"/>
              <p:nvPr/>
            </p:nvSpPr>
            <p:spPr>
              <a:xfrm>
                <a:off x="7107339" y="4621016"/>
                <a:ext cx="246218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1" name="TextBox 61">
                <a:extLst>
                  <a:ext uri="{FF2B5EF4-FFF2-40B4-BE49-F238E27FC236}">
                    <a16:creationId xmlns:a16="http://schemas.microsoft.com/office/drawing/2014/main" id="{D8E6FAC4-C896-18EE-B1C1-328AEDD73D46}"/>
                  </a:ext>
                </a:extLst>
              </p:cNvPr>
              <p:cNvSpPr txBox="1"/>
              <p:nvPr/>
            </p:nvSpPr>
            <p:spPr>
              <a:xfrm>
                <a:off x="7107335" y="4400124"/>
                <a:ext cx="246222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2" name="TextBox 51">
                <a:extLst>
                  <a:ext uri="{FF2B5EF4-FFF2-40B4-BE49-F238E27FC236}">
                    <a16:creationId xmlns:a16="http://schemas.microsoft.com/office/drawing/2014/main" id="{840AA576-55A8-CABF-B2EA-D6D020C0D478}"/>
                  </a:ext>
                </a:extLst>
              </p:cNvPr>
              <p:cNvSpPr txBox="1"/>
              <p:nvPr/>
            </p:nvSpPr>
            <p:spPr>
              <a:xfrm>
                <a:off x="7159391" y="4068789"/>
                <a:ext cx="194166" cy="17337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</p:grpSp>
        <p:grpSp>
          <p:nvGrpSpPr>
            <p:cNvPr id="420" name="グループ化 432">
              <a:extLst>
                <a:ext uri="{FF2B5EF4-FFF2-40B4-BE49-F238E27FC236}">
                  <a16:creationId xmlns:a16="http://schemas.microsoft.com/office/drawing/2014/main" id="{DA821E0D-F3F8-9E3A-0732-24F03ECE2BE2}"/>
                </a:ext>
              </a:extLst>
            </p:cNvPr>
            <p:cNvGrpSpPr/>
            <p:nvPr/>
          </p:nvGrpSpPr>
          <p:grpSpPr>
            <a:xfrm>
              <a:off x="4689636" y="2225873"/>
              <a:ext cx="299622" cy="644048"/>
              <a:chOff x="7095004" y="4068789"/>
              <a:chExt cx="258553" cy="725600"/>
            </a:xfrm>
          </p:grpSpPr>
          <p:sp>
            <p:nvSpPr>
              <p:cNvPr id="421" name="TextBox 51">
                <a:extLst>
                  <a:ext uri="{FF2B5EF4-FFF2-40B4-BE49-F238E27FC236}">
                    <a16:creationId xmlns:a16="http://schemas.microsoft.com/office/drawing/2014/main" id="{7FB924B4-7F7C-8FC0-A8DC-CDE8CBA1F2FD}"/>
                  </a:ext>
                </a:extLst>
              </p:cNvPr>
              <p:cNvSpPr txBox="1"/>
              <p:nvPr/>
            </p:nvSpPr>
            <p:spPr>
              <a:xfrm>
                <a:off x="7159391" y="4179233"/>
                <a:ext cx="194166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2" name="TextBox 61">
                <a:extLst>
                  <a:ext uri="{FF2B5EF4-FFF2-40B4-BE49-F238E27FC236}">
                    <a16:creationId xmlns:a16="http://schemas.microsoft.com/office/drawing/2014/main" id="{C9681989-3853-4796-4012-B44626C98E80}"/>
                  </a:ext>
                </a:extLst>
              </p:cNvPr>
              <p:cNvSpPr txBox="1"/>
              <p:nvPr/>
            </p:nvSpPr>
            <p:spPr>
              <a:xfrm>
                <a:off x="7107335" y="4289678"/>
                <a:ext cx="246222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3" name="TextBox 51">
                <a:extLst>
                  <a:ext uri="{FF2B5EF4-FFF2-40B4-BE49-F238E27FC236}">
                    <a16:creationId xmlns:a16="http://schemas.microsoft.com/office/drawing/2014/main" id="{E8263CB1-AE94-4E55-D073-284025482F29}"/>
                  </a:ext>
                </a:extLst>
              </p:cNvPr>
              <p:cNvSpPr txBox="1"/>
              <p:nvPr/>
            </p:nvSpPr>
            <p:spPr>
              <a:xfrm>
                <a:off x="7095004" y="4510569"/>
                <a:ext cx="258553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4" name="TextBox 51">
                <a:extLst>
                  <a:ext uri="{FF2B5EF4-FFF2-40B4-BE49-F238E27FC236}">
                    <a16:creationId xmlns:a16="http://schemas.microsoft.com/office/drawing/2014/main" id="{641159E7-10B4-CD1B-6115-58B27D6D698A}"/>
                  </a:ext>
                </a:extLst>
              </p:cNvPr>
              <p:cNvSpPr txBox="1"/>
              <p:nvPr/>
            </p:nvSpPr>
            <p:spPr>
              <a:xfrm>
                <a:off x="7107339" y="4621016"/>
                <a:ext cx="246218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5" name="TextBox 61">
                <a:extLst>
                  <a:ext uri="{FF2B5EF4-FFF2-40B4-BE49-F238E27FC236}">
                    <a16:creationId xmlns:a16="http://schemas.microsoft.com/office/drawing/2014/main" id="{001B6A12-D6DA-7853-37A0-B4B62AB7148A}"/>
                  </a:ext>
                </a:extLst>
              </p:cNvPr>
              <p:cNvSpPr txBox="1"/>
              <p:nvPr/>
            </p:nvSpPr>
            <p:spPr>
              <a:xfrm>
                <a:off x="7107335" y="4400124"/>
                <a:ext cx="246222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6" name="TextBox 51">
                <a:extLst>
                  <a:ext uri="{FF2B5EF4-FFF2-40B4-BE49-F238E27FC236}">
                    <a16:creationId xmlns:a16="http://schemas.microsoft.com/office/drawing/2014/main" id="{B0197B81-334A-FC00-1F29-1AF11E3DBB53}"/>
                  </a:ext>
                </a:extLst>
              </p:cNvPr>
              <p:cNvSpPr txBox="1"/>
              <p:nvPr/>
            </p:nvSpPr>
            <p:spPr>
              <a:xfrm>
                <a:off x="7159391" y="4068789"/>
                <a:ext cx="194166" cy="17337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988CCFBF-3863-1A5D-5D0A-BD3EF3A9B9C6}"/>
                </a:ext>
              </a:extLst>
            </p:cNvPr>
            <p:cNvGrpSpPr/>
            <p:nvPr/>
          </p:nvGrpSpPr>
          <p:grpSpPr>
            <a:xfrm>
              <a:off x="874919" y="2039240"/>
              <a:ext cx="5099183" cy="246221"/>
              <a:chOff x="862661" y="4980781"/>
              <a:chExt cx="5099183" cy="246221"/>
            </a:xfrm>
          </p:grpSpPr>
          <p:sp>
            <p:nvSpPr>
              <p:cNvPr id="485" name="テキスト ボックス 250">
                <a:extLst>
                  <a:ext uri="{FF2B5EF4-FFF2-40B4-BE49-F238E27FC236}">
                    <a16:creationId xmlns:a16="http://schemas.microsoft.com/office/drawing/2014/main" id="{368253D8-895F-3E00-E1AF-A0D95983BF1C}"/>
                  </a:ext>
                </a:extLst>
              </p:cNvPr>
              <p:cNvSpPr txBox="1"/>
              <p:nvPr/>
            </p:nvSpPr>
            <p:spPr>
              <a:xfrm>
                <a:off x="862661" y="4980781"/>
                <a:ext cx="398680" cy="2185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ALB</a:t>
                </a:r>
              </a:p>
            </p:txBody>
          </p:sp>
          <p:sp>
            <p:nvSpPr>
              <p:cNvPr id="464" name="テキスト ボックス 250">
                <a:extLst>
                  <a:ext uri="{FF2B5EF4-FFF2-40B4-BE49-F238E27FC236}">
                    <a16:creationId xmlns:a16="http://schemas.microsoft.com/office/drawing/2014/main" id="{7EEC2754-76F7-F3AA-4DC5-7554F59C5C6B}"/>
                  </a:ext>
                </a:extLst>
              </p:cNvPr>
              <p:cNvSpPr txBox="1"/>
              <p:nvPr/>
            </p:nvSpPr>
            <p:spPr>
              <a:xfrm>
                <a:off x="3852470" y="4980781"/>
                <a:ext cx="53412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CDH1</a:t>
                </a:r>
              </a:p>
            </p:txBody>
          </p:sp>
          <p:sp>
            <p:nvSpPr>
              <p:cNvPr id="418" name="テキスト ボックス 250">
                <a:extLst>
                  <a:ext uri="{FF2B5EF4-FFF2-40B4-BE49-F238E27FC236}">
                    <a16:creationId xmlns:a16="http://schemas.microsoft.com/office/drawing/2014/main" id="{FAFA9B52-5A8D-0038-FD8D-1733E5C361E7}"/>
                  </a:ext>
                </a:extLst>
              </p:cNvPr>
              <p:cNvSpPr txBox="1"/>
              <p:nvPr/>
            </p:nvSpPr>
            <p:spPr>
              <a:xfrm>
                <a:off x="5334748" y="4980781"/>
                <a:ext cx="6270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ADH1B</a:t>
                </a:r>
              </a:p>
            </p:txBody>
          </p:sp>
          <p:sp>
            <p:nvSpPr>
              <p:cNvPr id="397" name="テキスト ボックス 250">
                <a:extLst>
                  <a:ext uri="{FF2B5EF4-FFF2-40B4-BE49-F238E27FC236}">
                    <a16:creationId xmlns:a16="http://schemas.microsoft.com/office/drawing/2014/main" id="{53A0CCEE-5550-F101-ADBB-33D8FCC574EE}"/>
                  </a:ext>
                </a:extLst>
              </p:cNvPr>
              <p:cNvSpPr txBox="1"/>
              <p:nvPr/>
            </p:nvSpPr>
            <p:spPr>
              <a:xfrm>
                <a:off x="2284432" y="4980781"/>
                <a:ext cx="61266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>
                    <a:latin typeface="Arial" pitchFamily="34" charset="0"/>
                    <a:cs typeface="Arial" pitchFamily="34" charset="0"/>
                  </a:rPr>
                  <a:t>HNF4A</a:t>
                </a:r>
              </a:p>
            </p:txBody>
          </p:sp>
        </p:grpSp>
        <p:grpSp>
          <p:nvGrpSpPr>
            <p:cNvPr id="399" name="グループ化 422">
              <a:extLst>
                <a:ext uri="{FF2B5EF4-FFF2-40B4-BE49-F238E27FC236}">
                  <a16:creationId xmlns:a16="http://schemas.microsoft.com/office/drawing/2014/main" id="{149A64B0-3017-BAC2-205D-32FDE4AF9B6C}"/>
                </a:ext>
              </a:extLst>
            </p:cNvPr>
            <p:cNvGrpSpPr/>
            <p:nvPr/>
          </p:nvGrpSpPr>
          <p:grpSpPr>
            <a:xfrm>
              <a:off x="3164978" y="3016579"/>
              <a:ext cx="285332" cy="631756"/>
              <a:chOff x="7107335" y="4060466"/>
              <a:chExt cx="246222" cy="711752"/>
            </a:xfrm>
          </p:grpSpPr>
          <p:sp>
            <p:nvSpPr>
              <p:cNvPr id="405" name="TextBox 51">
                <a:extLst>
                  <a:ext uri="{FF2B5EF4-FFF2-40B4-BE49-F238E27FC236}">
                    <a16:creationId xmlns:a16="http://schemas.microsoft.com/office/drawing/2014/main" id="{B7B5F7F8-257E-E517-CED1-0E749D54EDB1}"/>
                  </a:ext>
                </a:extLst>
              </p:cNvPr>
              <p:cNvSpPr txBox="1"/>
              <p:nvPr/>
            </p:nvSpPr>
            <p:spPr>
              <a:xfrm>
                <a:off x="7159391" y="4246420"/>
                <a:ext cx="194166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406" name="TextBox 51">
                <a:extLst>
                  <a:ext uri="{FF2B5EF4-FFF2-40B4-BE49-F238E27FC236}">
                    <a16:creationId xmlns:a16="http://schemas.microsoft.com/office/drawing/2014/main" id="{7EDFD839-AD1D-4734-318C-8A71A8D35A51}"/>
                  </a:ext>
                </a:extLst>
              </p:cNvPr>
              <p:cNvSpPr txBox="1"/>
              <p:nvPr/>
            </p:nvSpPr>
            <p:spPr>
              <a:xfrm>
                <a:off x="7107339" y="4618331"/>
                <a:ext cx="246218" cy="153887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7" name="TextBox 61">
                <a:extLst>
                  <a:ext uri="{FF2B5EF4-FFF2-40B4-BE49-F238E27FC236}">
                    <a16:creationId xmlns:a16="http://schemas.microsoft.com/office/drawing/2014/main" id="{E213118A-DDD2-6EF1-149C-30D589D67811}"/>
                  </a:ext>
                </a:extLst>
              </p:cNvPr>
              <p:cNvSpPr txBox="1"/>
              <p:nvPr/>
            </p:nvSpPr>
            <p:spPr>
              <a:xfrm>
                <a:off x="7107335" y="4432375"/>
                <a:ext cx="246222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5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8" name="TextBox 51">
                <a:extLst>
                  <a:ext uri="{FF2B5EF4-FFF2-40B4-BE49-F238E27FC236}">
                    <a16:creationId xmlns:a16="http://schemas.microsoft.com/office/drawing/2014/main" id="{B8335259-1A2C-BD79-E22F-D850E6580E84}"/>
                  </a:ext>
                </a:extLst>
              </p:cNvPr>
              <p:cNvSpPr txBox="1"/>
              <p:nvPr/>
            </p:nvSpPr>
            <p:spPr>
              <a:xfrm>
                <a:off x="7159391" y="4060466"/>
                <a:ext cx="194166" cy="153887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</p:grpSp>
        <p:grpSp>
          <p:nvGrpSpPr>
            <p:cNvPr id="400" name="グループ化 422">
              <a:extLst>
                <a:ext uri="{FF2B5EF4-FFF2-40B4-BE49-F238E27FC236}">
                  <a16:creationId xmlns:a16="http://schemas.microsoft.com/office/drawing/2014/main" id="{C68647EF-2E58-95A8-D625-09A684ADABF0}"/>
                </a:ext>
              </a:extLst>
            </p:cNvPr>
            <p:cNvGrpSpPr/>
            <p:nvPr/>
          </p:nvGrpSpPr>
          <p:grpSpPr>
            <a:xfrm>
              <a:off x="1640320" y="2225873"/>
              <a:ext cx="285332" cy="631756"/>
              <a:chOff x="7107335" y="4060466"/>
              <a:chExt cx="246222" cy="711752"/>
            </a:xfrm>
          </p:grpSpPr>
          <p:sp>
            <p:nvSpPr>
              <p:cNvPr id="401" name="TextBox 51">
                <a:extLst>
                  <a:ext uri="{FF2B5EF4-FFF2-40B4-BE49-F238E27FC236}">
                    <a16:creationId xmlns:a16="http://schemas.microsoft.com/office/drawing/2014/main" id="{5617ACB9-13F8-F138-3964-2E43797642C2}"/>
                  </a:ext>
                </a:extLst>
              </p:cNvPr>
              <p:cNvSpPr txBox="1"/>
              <p:nvPr/>
            </p:nvSpPr>
            <p:spPr>
              <a:xfrm>
                <a:off x="7159391" y="4246420"/>
                <a:ext cx="194166" cy="17337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</p:txBody>
          </p:sp>
          <p:sp>
            <p:nvSpPr>
              <p:cNvPr id="402" name="TextBox 51">
                <a:extLst>
                  <a:ext uri="{FF2B5EF4-FFF2-40B4-BE49-F238E27FC236}">
                    <a16:creationId xmlns:a16="http://schemas.microsoft.com/office/drawing/2014/main" id="{160478C1-EFF2-68E7-4231-1A76ABFDD7DC}"/>
                  </a:ext>
                </a:extLst>
              </p:cNvPr>
              <p:cNvSpPr txBox="1"/>
              <p:nvPr/>
            </p:nvSpPr>
            <p:spPr>
              <a:xfrm>
                <a:off x="7107339" y="4618331"/>
                <a:ext cx="246218" cy="153887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3" name="TextBox 61">
                <a:extLst>
                  <a:ext uri="{FF2B5EF4-FFF2-40B4-BE49-F238E27FC236}">
                    <a16:creationId xmlns:a16="http://schemas.microsoft.com/office/drawing/2014/main" id="{5F01F072-14FA-BD00-0FE5-AE94B924B52D}"/>
                  </a:ext>
                </a:extLst>
              </p:cNvPr>
              <p:cNvSpPr txBox="1"/>
              <p:nvPr/>
            </p:nvSpPr>
            <p:spPr>
              <a:xfrm>
                <a:off x="7107335" y="4432375"/>
                <a:ext cx="246222" cy="17337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4" name="TextBox 51">
                <a:extLst>
                  <a:ext uri="{FF2B5EF4-FFF2-40B4-BE49-F238E27FC236}">
                    <a16:creationId xmlns:a16="http://schemas.microsoft.com/office/drawing/2014/main" id="{B89918B2-B335-F30C-EE07-CE30E6702994}"/>
                  </a:ext>
                </a:extLst>
              </p:cNvPr>
              <p:cNvSpPr txBox="1"/>
              <p:nvPr/>
            </p:nvSpPr>
            <p:spPr>
              <a:xfrm>
                <a:off x="7159391" y="4060466"/>
                <a:ext cx="194166" cy="173374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</a:p>
            </p:txBody>
          </p:sp>
        </p:grp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211C0199-67CA-981F-673E-8EBACC4FD66F}"/>
                </a:ext>
              </a:extLst>
            </p:cNvPr>
            <p:cNvGrpSpPr/>
            <p:nvPr/>
          </p:nvGrpSpPr>
          <p:grpSpPr>
            <a:xfrm>
              <a:off x="5013562" y="4420737"/>
              <a:ext cx="1293985" cy="727833"/>
              <a:chOff x="5001304" y="7434189"/>
              <a:chExt cx="1293985" cy="727833"/>
            </a:xfrm>
          </p:grpSpPr>
          <p:sp>
            <p:nvSpPr>
              <p:cNvPr id="455" name="TextBox 51">
                <a:extLst>
                  <a:ext uri="{FF2B5EF4-FFF2-40B4-BE49-F238E27FC236}">
                    <a16:creationId xmlns:a16="http://schemas.microsoft.com/office/drawing/2014/main" id="{1B83A5B9-24D0-604A-B889-D87FC290C02C}"/>
                  </a:ext>
                </a:extLst>
              </p:cNvPr>
              <p:cNvSpPr txBox="1"/>
              <p:nvPr/>
            </p:nvSpPr>
            <p:spPr>
              <a:xfrm rot="16200000">
                <a:off x="4760930" y="7674563"/>
                <a:ext cx="634635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  <a:endParaRPr lang="en-US" sz="1000" b="1" dirty="0"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6" name="TextBox 61">
                <a:extLst>
                  <a:ext uri="{FF2B5EF4-FFF2-40B4-BE49-F238E27FC236}">
                    <a16:creationId xmlns:a16="http://schemas.microsoft.com/office/drawing/2014/main" id="{E26CDE71-8C76-51D4-684D-E0DE8CA91A1D}"/>
                  </a:ext>
                </a:extLst>
              </p:cNvPr>
              <p:cNvSpPr txBox="1"/>
              <p:nvPr/>
            </p:nvSpPr>
            <p:spPr>
              <a:xfrm rot="16200000">
                <a:off x="4969437" y="7580066"/>
                <a:ext cx="445642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SO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7" name="TextBox 51">
                <a:extLst>
                  <a:ext uri="{FF2B5EF4-FFF2-40B4-BE49-F238E27FC236}">
                    <a16:creationId xmlns:a16="http://schemas.microsoft.com/office/drawing/2014/main" id="{D7A88D38-1C55-6B86-DB98-0290DCDD950B}"/>
                  </a:ext>
                </a:extLst>
              </p:cNvPr>
              <p:cNvSpPr txBox="1"/>
              <p:nvPr/>
            </p:nvSpPr>
            <p:spPr>
              <a:xfrm rot="16200000">
                <a:off x="5091999" y="7571514"/>
                <a:ext cx="42853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S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8" name="TextBox 51">
                <a:extLst>
                  <a:ext uri="{FF2B5EF4-FFF2-40B4-BE49-F238E27FC236}">
                    <a16:creationId xmlns:a16="http://schemas.microsoft.com/office/drawing/2014/main" id="{534B57F9-EDE4-47FA-A45B-E6F625833895}"/>
                  </a:ext>
                </a:extLst>
              </p:cNvPr>
              <p:cNvSpPr txBox="1"/>
              <p:nvPr/>
            </p:nvSpPr>
            <p:spPr>
              <a:xfrm rot="16200000">
                <a:off x="5181072" y="7596451"/>
                <a:ext cx="47841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SO2</a:t>
                </a:r>
              </a:p>
            </p:txBody>
          </p:sp>
          <p:sp>
            <p:nvSpPr>
              <p:cNvPr id="459" name="TextBox 51">
                <a:extLst>
                  <a:ext uri="{FF2B5EF4-FFF2-40B4-BE49-F238E27FC236}">
                    <a16:creationId xmlns:a16="http://schemas.microsoft.com/office/drawing/2014/main" id="{A13E5B30-E6F7-2D80-CB3D-0EFD03EA0AF5}"/>
                  </a:ext>
                </a:extLst>
              </p:cNvPr>
              <p:cNvSpPr txBox="1"/>
              <p:nvPr/>
            </p:nvSpPr>
            <p:spPr>
              <a:xfrm rot="16200000">
                <a:off x="5314959" y="7576574"/>
                <a:ext cx="43865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F</a:t>
                </a:r>
              </a:p>
            </p:txBody>
          </p:sp>
          <p:sp>
            <p:nvSpPr>
              <p:cNvPr id="460" name="TextBox 51">
                <a:extLst>
                  <a:ext uri="{FF2B5EF4-FFF2-40B4-BE49-F238E27FC236}">
                    <a16:creationId xmlns:a16="http://schemas.microsoft.com/office/drawing/2014/main" id="{F6E344FB-87FB-E344-BD9F-BEB2C73B6BE8}"/>
                  </a:ext>
                </a:extLst>
              </p:cNvPr>
              <p:cNvSpPr txBox="1"/>
              <p:nvPr/>
            </p:nvSpPr>
            <p:spPr>
              <a:xfrm rot="16200000">
                <a:off x="5409092" y="7596451"/>
                <a:ext cx="47841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A</a:t>
                </a:r>
              </a:p>
            </p:txBody>
          </p:sp>
          <p:sp>
            <p:nvSpPr>
              <p:cNvPr id="461" name="TextBox 51">
                <a:extLst>
                  <a:ext uri="{FF2B5EF4-FFF2-40B4-BE49-F238E27FC236}">
                    <a16:creationId xmlns:a16="http://schemas.microsoft.com/office/drawing/2014/main" id="{3765A234-1A9B-10FE-5978-7E60422C0C54}"/>
                  </a:ext>
                </a:extLst>
              </p:cNvPr>
              <p:cNvSpPr txBox="1"/>
              <p:nvPr/>
            </p:nvSpPr>
            <p:spPr>
              <a:xfrm rot="16200000">
                <a:off x="5542979" y="7576574"/>
                <a:ext cx="43865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BA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" name="TextBox 51">
                <a:extLst>
                  <a:ext uri="{FF2B5EF4-FFF2-40B4-BE49-F238E27FC236}">
                    <a16:creationId xmlns:a16="http://schemas.microsoft.com/office/drawing/2014/main" id="{458CE805-9E44-4DC9-ED13-55A53CA4B23E}"/>
                  </a:ext>
                </a:extLst>
              </p:cNvPr>
              <p:cNvSpPr txBox="1"/>
              <p:nvPr/>
            </p:nvSpPr>
            <p:spPr>
              <a:xfrm rot="16200000">
                <a:off x="5637112" y="7596451"/>
                <a:ext cx="47841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AC</a:t>
                </a:r>
              </a:p>
            </p:txBody>
          </p:sp>
          <p:sp>
            <p:nvSpPr>
              <p:cNvPr id="252" name="TextBox 51">
                <a:extLst>
                  <a:ext uri="{FF2B5EF4-FFF2-40B4-BE49-F238E27FC236}">
                    <a16:creationId xmlns:a16="http://schemas.microsoft.com/office/drawing/2014/main" id="{7A710710-8784-D568-6794-ACDA45619472}"/>
                  </a:ext>
                </a:extLst>
              </p:cNvPr>
              <p:cNvSpPr txBox="1"/>
              <p:nvPr/>
            </p:nvSpPr>
            <p:spPr>
              <a:xfrm rot="16200000">
                <a:off x="5668051" y="7679522"/>
                <a:ext cx="64455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itamin C</a:t>
                </a:r>
              </a:p>
            </p:txBody>
          </p:sp>
          <p:sp>
            <p:nvSpPr>
              <p:cNvPr id="253" name="TextBox 51">
                <a:extLst>
                  <a:ext uri="{FF2B5EF4-FFF2-40B4-BE49-F238E27FC236}">
                    <a16:creationId xmlns:a16="http://schemas.microsoft.com/office/drawing/2014/main" id="{1BB677EA-5129-A1CE-695E-629F9212BC78}"/>
                  </a:ext>
                </a:extLst>
              </p:cNvPr>
              <p:cNvSpPr txBox="1"/>
              <p:nvPr/>
            </p:nvSpPr>
            <p:spPr>
              <a:xfrm rot="16200000">
                <a:off x="5786062" y="7675521"/>
                <a:ext cx="63655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itamin E</a:t>
                </a:r>
              </a:p>
            </p:txBody>
          </p:sp>
          <p:sp>
            <p:nvSpPr>
              <p:cNvPr id="254" name="TextBox 51">
                <a:extLst>
                  <a:ext uri="{FF2B5EF4-FFF2-40B4-BE49-F238E27FC236}">
                    <a16:creationId xmlns:a16="http://schemas.microsoft.com/office/drawing/2014/main" id="{78A2B736-6DF4-6F00-68F3-C29B38A8A180}"/>
                  </a:ext>
                </a:extLst>
              </p:cNvPr>
              <p:cNvSpPr txBox="1"/>
              <p:nvPr/>
            </p:nvSpPr>
            <p:spPr>
              <a:xfrm rot="16200000">
                <a:off x="5854428" y="7721162"/>
                <a:ext cx="727833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pplement</a:t>
                </a:r>
              </a:p>
            </p:txBody>
          </p:sp>
        </p:grpSp>
        <p:grpSp>
          <p:nvGrpSpPr>
            <p:cNvPr id="325" name="グループ化 432">
              <a:extLst>
                <a:ext uri="{FF2B5EF4-FFF2-40B4-BE49-F238E27FC236}">
                  <a16:creationId xmlns:a16="http://schemas.microsoft.com/office/drawing/2014/main" id="{54F7F9CA-C176-A8A8-C3E5-4739A8A1A457}"/>
                </a:ext>
              </a:extLst>
            </p:cNvPr>
            <p:cNvGrpSpPr/>
            <p:nvPr/>
          </p:nvGrpSpPr>
          <p:grpSpPr>
            <a:xfrm>
              <a:off x="4689636" y="3016579"/>
              <a:ext cx="299622" cy="644048"/>
              <a:chOff x="7095004" y="4068789"/>
              <a:chExt cx="258553" cy="725600"/>
            </a:xfrm>
          </p:grpSpPr>
          <p:sp>
            <p:nvSpPr>
              <p:cNvPr id="326" name="TextBox 51">
                <a:extLst>
                  <a:ext uri="{FF2B5EF4-FFF2-40B4-BE49-F238E27FC236}">
                    <a16:creationId xmlns:a16="http://schemas.microsoft.com/office/drawing/2014/main" id="{97C3ED67-3D23-D264-B941-E5EE88F9C9A8}"/>
                  </a:ext>
                </a:extLst>
              </p:cNvPr>
              <p:cNvSpPr txBox="1"/>
              <p:nvPr/>
            </p:nvSpPr>
            <p:spPr>
              <a:xfrm>
                <a:off x="7159391" y="4179233"/>
                <a:ext cx="194166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</a:p>
            </p:txBody>
          </p:sp>
          <p:sp>
            <p:nvSpPr>
              <p:cNvPr id="327" name="TextBox 61">
                <a:extLst>
                  <a:ext uri="{FF2B5EF4-FFF2-40B4-BE49-F238E27FC236}">
                    <a16:creationId xmlns:a16="http://schemas.microsoft.com/office/drawing/2014/main" id="{24A4E1ED-823E-16B7-2AFB-7FE508D88A3B}"/>
                  </a:ext>
                </a:extLst>
              </p:cNvPr>
              <p:cNvSpPr txBox="1"/>
              <p:nvPr/>
            </p:nvSpPr>
            <p:spPr>
              <a:xfrm>
                <a:off x="7107335" y="4289678"/>
                <a:ext cx="246222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" name="TextBox 51">
                <a:extLst>
                  <a:ext uri="{FF2B5EF4-FFF2-40B4-BE49-F238E27FC236}">
                    <a16:creationId xmlns:a16="http://schemas.microsoft.com/office/drawing/2014/main" id="{1D8AB0F0-B393-C791-C856-DCA342E1F38D}"/>
                  </a:ext>
                </a:extLst>
              </p:cNvPr>
              <p:cNvSpPr txBox="1"/>
              <p:nvPr/>
            </p:nvSpPr>
            <p:spPr>
              <a:xfrm>
                <a:off x="7095004" y="4510569"/>
                <a:ext cx="258553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9" name="TextBox 51">
                <a:extLst>
                  <a:ext uri="{FF2B5EF4-FFF2-40B4-BE49-F238E27FC236}">
                    <a16:creationId xmlns:a16="http://schemas.microsoft.com/office/drawing/2014/main" id="{CD96F178-C098-523D-024A-086279ED78AA}"/>
                  </a:ext>
                </a:extLst>
              </p:cNvPr>
              <p:cNvSpPr txBox="1"/>
              <p:nvPr/>
            </p:nvSpPr>
            <p:spPr>
              <a:xfrm>
                <a:off x="7107339" y="4621016"/>
                <a:ext cx="246218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0" name="TextBox 61">
                <a:extLst>
                  <a:ext uri="{FF2B5EF4-FFF2-40B4-BE49-F238E27FC236}">
                    <a16:creationId xmlns:a16="http://schemas.microsoft.com/office/drawing/2014/main" id="{F2DF42A5-E48C-2A80-0BA1-A5797D963303}"/>
                  </a:ext>
                </a:extLst>
              </p:cNvPr>
              <p:cNvSpPr txBox="1"/>
              <p:nvPr/>
            </p:nvSpPr>
            <p:spPr>
              <a:xfrm>
                <a:off x="7107335" y="4400124"/>
                <a:ext cx="246222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0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1" name="TextBox 51">
                <a:extLst>
                  <a:ext uri="{FF2B5EF4-FFF2-40B4-BE49-F238E27FC236}">
                    <a16:creationId xmlns:a16="http://schemas.microsoft.com/office/drawing/2014/main" id="{D73F8713-AEA7-F2EE-B158-9FCFADA41A44}"/>
                  </a:ext>
                </a:extLst>
              </p:cNvPr>
              <p:cNvSpPr txBox="1"/>
              <p:nvPr/>
            </p:nvSpPr>
            <p:spPr>
              <a:xfrm>
                <a:off x="7159391" y="4068789"/>
                <a:ext cx="194166" cy="17337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</a:p>
            </p:txBody>
          </p:sp>
        </p:grpSp>
        <p:grpSp>
          <p:nvGrpSpPr>
            <p:cNvPr id="339" name="グループ化 432">
              <a:extLst>
                <a:ext uri="{FF2B5EF4-FFF2-40B4-BE49-F238E27FC236}">
                  <a16:creationId xmlns:a16="http://schemas.microsoft.com/office/drawing/2014/main" id="{AE4BED16-C7E0-DF45-7092-A2ED2F13C3D7}"/>
                </a:ext>
              </a:extLst>
            </p:cNvPr>
            <p:cNvGrpSpPr/>
            <p:nvPr/>
          </p:nvGrpSpPr>
          <p:grpSpPr>
            <a:xfrm>
              <a:off x="4689636" y="3800987"/>
              <a:ext cx="299622" cy="644048"/>
              <a:chOff x="7095004" y="4068789"/>
              <a:chExt cx="258553" cy="725600"/>
            </a:xfrm>
          </p:grpSpPr>
          <p:sp>
            <p:nvSpPr>
              <p:cNvPr id="340" name="TextBox 51">
                <a:extLst>
                  <a:ext uri="{FF2B5EF4-FFF2-40B4-BE49-F238E27FC236}">
                    <a16:creationId xmlns:a16="http://schemas.microsoft.com/office/drawing/2014/main" id="{BD3AF584-22AB-805B-8AC3-CD89FB02B21B}"/>
                  </a:ext>
                </a:extLst>
              </p:cNvPr>
              <p:cNvSpPr txBox="1"/>
              <p:nvPr/>
            </p:nvSpPr>
            <p:spPr>
              <a:xfrm>
                <a:off x="7159391" y="4179233"/>
                <a:ext cx="194166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</a:p>
            </p:txBody>
          </p:sp>
          <p:sp>
            <p:nvSpPr>
              <p:cNvPr id="341" name="TextBox 61">
                <a:extLst>
                  <a:ext uri="{FF2B5EF4-FFF2-40B4-BE49-F238E27FC236}">
                    <a16:creationId xmlns:a16="http://schemas.microsoft.com/office/drawing/2014/main" id="{B945E375-0F85-FE9D-EF68-915F9B7CB657}"/>
                  </a:ext>
                </a:extLst>
              </p:cNvPr>
              <p:cNvSpPr txBox="1"/>
              <p:nvPr/>
            </p:nvSpPr>
            <p:spPr>
              <a:xfrm>
                <a:off x="7107335" y="4289678"/>
                <a:ext cx="246222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2" name="TextBox 51">
                <a:extLst>
                  <a:ext uri="{FF2B5EF4-FFF2-40B4-BE49-F238E27FC236}">
                    <a16:creationId xmlns:a16="http://schemas.microsoft.com/office/drawing/2014/main" id="{7C20E14A-8371-4714-96AC-9831772E13F3}"/>
                  </a:ext>
                </a:extLst>
              </p:cNvPr>
              <p:cNvSpPr txBox="1"/>
              <p:nvPr/>
            </p:nvSpPr>
            <p:spPr>
              <a:xfrm>
                <a:off x="7095004" y="4510569"/>
                <a:ext cx="258553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3" name="TextBox 51">
                <a:extLst>
                  <a:ext uri="{FF2B5EF4-FFF2-40B4-BE49-F238E27FC236}">
                    <a16:creationId xmlns:a16="http://schemas.microsoft.com/office/drawing/2014/main" id="{3EC0D275-ED64-95F2-97C4-09DA319F2EFC}"/>
                  </a:ext>
                </a:extLst>
              </p:cNvPr>
              <p:cNvSpPr txBox="1"/>
              <p:nvPr/>
            </p:nvSpPr>
            <p:spPr>
              <a:xfrm>
                <a:off x="7107339" y="4621016"/>
                <a:ext cx="246218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4" name="TextBox 61">
                <a:extLst>
                  <a:ext uri="{FF2B5EF4-FFF2-40B4-BE49-F238E27FC236}">
                    <a16:creationId xmlns:a16="http://schemas.microsoft.com/office/drawing/2014/main" id="{6F40B47D-12EF-856B-5FD6-560DDAF44162}"/>
                  </a:ext>
                </a:extLst>
              </p:cNvPr>
              <p:cNvSpPr txBox="1"/>
              <p:nvPr/>
            </p:nvSpPr>
            <p:spPr>
              <a:xfrm>
                <a:off x="7107335" y="4400124"/>
                <a:ext cx="246222" cy="173373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.0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5" name="TextBox 51">
                <a:extLst>
                  <a:ext uri="{FF2B5EF4-FFF2-40B4-BE49-F238E27FC236}">
                    <a16:creationId xmlns:a16="http://schemas.microsoft.com/office/drawing/2014/main" id="{85199762-7A5A-8A84-663B-9661E4495E1F}"/>
                  </a:ext>
                </a:extLst>
              </p:cNvPr>
              <p:cNvSpPr txBox="1"/>
              <p:nvPr/>
            </p:nvSpPr>
            <p:spPr>
              <a:xfrm>
                <a:off x="7159391" y="4068789"/>
                <a:ext cx="194166" cy="17337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</a:p>
            </p:txBody>
          </p:sp>
        </p:grpSp>
        <p:grpSp>
          <p:nvGrpSpPr>
            <p:cNvPr id="346" name="Group 345">
              <a:extLst>
                <a:ext uri="{FF2B5EF4-FFF2-40B4-BE49-F238E27FC236}">
                  <a16:creationId xmlns:a16="http://schemas.microsoft.com/office/drawing/2014/main" id="{B62C61AA-E3B1-1EF3-665E-1FA209A852A3}"/>
                </a:ext>
              </a:extLst>
            </p:cNvPr>
            <p:cNvGrpSpPr/>
            <p:nvPr/>
          </p:nvGrpSpPr>
          <p:grpSpPr>
            <a:xfrm>
              <a:off x="427267" y="4420737"/>
              <a:ext cx="1293985" cy="727833"/>
              <a:chOff x="5001304" y="7434189"/>
              <a:chExt cx="1293985" cy="727833"/>
            </a:xfrm>
          </p:grpSpPr>
          <p:sp>
            <p:nvSpPr>
              <p:cNvPr id="347" name="TextBox 51">
                <a:extLst>
                  <a:ext uri="{FF2B5EF4-FFF2-40B4-BE49-F238E27FC236}">
                    <a16:creationId xmlns:a16="http://schemas.microsoft.com/office/drawing/2014/main" id="{7E39A75D-38B4-D5AD-98A4-4AE965473059}"/>
                  </a:ext>
                </a:extLst>
              </p:cNvPr>
              <p:cNvSpPr txBox="1"/>
              <p:nvPr/>
            </p:nvSpPr>
            <p:spPr>
              <a:xfrm rot="16200000">
                <a:off x="4760930" y="7674563"/>
                <a:ext cx="634635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  <a:endParaRPr lang="en-US" sz="1000" b="1" dirty="0"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8" name="TextBox 61">
                <a:extLst>
                  <a:ext uri="{FF2B5EF4-FFF2-40B4-BE49-F238E27FC236}">
                    <a16:creationId xmlns:a16="http://schemas.microsoft.com/office/drawing/2014/main" id="{8D8BAAD6-406B-5155-F68B-121ED6B363E5}"/>
                  </a:ext>
                </a:extLst>
              </p:cNvPr>
              <p:cNvSpPr txBox="1"/>
              <p:nvPr/>
            </p:nvSpPr>
            <p:spPr>
              <a:xfrm rot="16200000">
                <a:off x="4969437" y="7580066"/>
                <a:ext cx="445642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SO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9" name="TextBox 51">
                <a:extLst>
                  <a:ext uri="{FF2B5EF4-FFF2-40B4-BE49-F238E27FC236}">
                    <a16:creationId xmlns:a16="http://schemas.microsoft.com/office/drawing/2014/main" id="{84A9F52A-ACCB-CA4C-7A6C-959C84D9BE94}"/>
                  </a:ext>
                </a:extLst>
              </p:cNvPr>
              <p:cNvSpPr txBox="1"/>
              <p:nvPr/>
            </p:nvSpPr>
            <p:spPr>
              <a:xfrm rot="16200000">
                <a:off x="5091999" y="7571514"/>
                <a:ext cx="42853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S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0" name="TextBox 51">
                <a:extLst>
                  <a:ext uri="{FF2B5EF4-FFF2-40B4-BE49-F238E27FC236}">
                    <a16:creationId xmlns:a16="http://schemas.microsoft.com/office/drawing/2014/main" id="{99A2C24C-B95A-C69C-FA9D-6BBBF1042A72}"/>
                  </a:ext>
                </a:extLst>
              </p:cNvPr>
              <p:cNvSpPr txBox="1"/>
              <p:nvPr/>
            </p:nvSpPr>
            <p:spPr>
              <a:xfrm rot="16200000">
                <a:off x="5181072" y="7596451"/>
                <a:ext cx="47841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SO2</a:t>
                </a:r>
              </a:p>
            </p:txBody>
          </p:sp>
          <p:sp>
            <p:nvSpPr>
              <p:cNvPr id="351" name="TextBox 51">
                <a:extLst>
                  <a:ext uri="{FF2B5EF4-FFF2-40B4-BE49-F238E27FC236}">
                    <a16:creationId xmlns:a16="http://schemas.microsoft.com/office/drawing/2014/main" id="{9ED4E98E-8A10-3BC7-EBD8-17AAE7A4AD25}"/>
                  </a:ext>
                </a:extLst>
              </p:cNvPr>
              <p:cNvSpPr txBox="1"/>
              <p:nvPr/>
            </p:nvSpPr>
            <p:spPr>
              <a:xfrm rot="16200000">
                <a:off x="5314959" y="7576574"/>
                <a:ext cx="43865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F</a:t>
                </a:r>
              </a:p>
            </p:txBody>
          </p:sp>
          <p:sp>
            <p:nvSpPr>
              <p:cNvPr id="352" name="TextBox 51">
                <a:extLst>
                  <a:ext uri="{FF2B5EF4-FFF2-40B4-BE49-F238E27FC236}">
                    <a16:creationId xmlns:a16="http://schemas.microsoft.com/office/drawing/2014/main" id="{DB30B7AD-58B3-EBDE-62E0-741353747098}"/>
                  </a:ext>
                </a:extLst>
              </p:cNvPr>
              <p:cNvSpPr txBox="1"/>
              <p:nvPr/>
            </p:nvSpPr>
            <p:spPr>
              <a:xfrm rot="16200000">
                <a:off x="5409092" y="7596451"/>
                <a:ext cx="47841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A</a:t>
                </a:r>
              </a:p>
            </p:txBody>
          </p:sp>
          <p:sp>
            <p:nvSpPr>
              <p:cNvPr id="353" name="TextBox 51">
                <a:extLst>
                  <a:ext uri="{FF2B5EF4-FFF2-40B4-BE49-F238E27FC236}">
                    <a16:creationId xmlns:a16="http://schemas.microsoft.com/office/drawing/2014/main" id="{E98D0309-42B1-93AD-B8E4-062C5A5CE404}"/>
                  </a:ext>
                </a:extLst>
              </p:cNvPr>
              <p:cNvSpPr txBox="1"/>
              <p:nvPr/>
            </p:nvSpPr>
            <p:spPr>
              <a:xfrm rot="16200000">
                <a:off x="5542979" y="7576574"/>
                <a:ext cx="43865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BA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4" name="TextBox 51">
                <a:extLst>
                  <a:ext uri="{FF2B5EF4-FFF2-40B4-BE49-F238E27FC236}">
                    <a16:creationId xmlns:a16="http://schemas.microsoft.com/office/drawing/2014/main" id="{D95E204E-9361-549E-C439-6E5836E3C5E0}"/>
                  </a:ext>
                </a:extLst>
              </p:cNvPr>
              <p:cNvSpPr txBox="1"/>
              <p:nvPr/>
            </p:nvSpPr>
            <p:spPr>
              <a:xfrm rot="16200000">
                <a:off x="5637112" y="7596451"/>
                <a:ext cx="47841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AC</a:t>
                </a:r>
              </a:p>
            </p:txBody>
          </p:sp>
          <p:sp>
            <p:nvSpPr>
              <p:cNvPr id="355" name="TextBox 51">
                <a:extLst>
                  <a:ext uri="{FF2B5EF4-FFF2-40B4-BE49-F238E27FC236}">
                    <a16:creationId xmlns:a16="http://schemas.microsoft.com/office/drawing/2014/main" id="{57A1D64F-6A7B-50B8-602B-24ACB6E746A9}"/>
                  </a:ext>
                </a:extLst>
              </p:cNvPr>
              <p:cNvSpPr txBox="1"/>
              <p:nvPr/>
            </p:nvSpPr>
            <p:spPr>
              <a:xfrm rot="16200000">
                <a:off x="5668051" y="7679522"/>
                <a:ext cx="64455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itamin C</a:t>
                </a:r>
              </a:p>
            </p:txBody>
          </p:sp>
          <p:sp>
            <p:nvSpPr>
              <p:cNvPr id="356" name="TextBox 51">
                <a:extLst>
                  <a:ext uri="{FF2B5EF4-FFF2-40B4-BE49-F238E27FC236}">
                    <a16:creationId xmlns:a16="http://schemas.microsoft.com/office/drawing/2014/main" id="{550FDFA1-F7DE-00BB-6734-A7A3BE83E08C}"/>
                  </a:ext>
                </a:extLst>
              </p:cNvPr>
              <p:cNvSpPr txBox="1"/>
              <p:nvPr/>
            </p:nvSpPr>
            <p:spPr>
              <a:xfrm rot="16200000">
                <a:off x="5786062" y="7675521"/>
                <a:ext cx="63655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itamin E</a:t>
                </a:r>
              </a:p>
            </p:txBody>
          </p:sp>
          <p:sp>
            <p:nvSpPr>
              <p:cNvPr id="357" name="TextBox 51">
                <a:extLst>
                  <a:ext uri="{FF2B5EF4-FFF2-40B4-BE49-F238E27FC236}">
                    <a16:creationId xmlns:a16="http://schemas.microsoft.com/office/drawing/2014/main" id="{E6659820-7796-F887-925E-3D01712454C7}"/>
                  </a:ext>
                </a:extLst>
              </p:cNvPr>
              <p:cNvSpPr txBox="1"/>
              <p:nvPr/>
            </p:nvSpPr>
            <p:spPr>
              <a:xfrm rot="16200000">
                <a:off x="5854428" y="7721162"/>
                <a:ext cx="727833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pplement</a:t>
                </a:r>
              </a:p>
            </p:txBody>
          </p:sp>
        </p:grpSp>
        <p:grpSp>
          <p:nvGrpSpPr>
            <p:cNvPr id="358" name="Group 357">
              <a:extLst>
                <a:ext uri="{FF2B5EF4-FFF2-40B4-BE49-F238E27FC236}">
                  <a16:creationId xmlns:a16="http://schemas.microsoft.com/office/drawing/2014/main" id="{2377882F-410F-3245-ED85-207E3B49AC78}"/>
                </a:ext>
              </a:extLst>
            </p:cNvPr>
            <p:cNvGrpSpPr/>
            <p:nvPr/>
          </p:nvGrpSpPr>
          <p:grpSpPr>
            <a:xfrm>
              <a:off x="1956032" y="4420737"/>
              <a:ext cx="1293985" cy="727833"/>
              <a:chOff x="5001304" y="7434189"/>
              <a:chExt cx="1293985" cy="727833"/>
            </a:xfrm>
          </p:grpSpPr>
          <p:sp>
            <p:nvSpPr>
              <p:cNvPr id="359" name="TextBox 51">
                <a:extLst>
                  <a:ext uri="{FF2B5EF4-FFF2-40B4-BE49-F238E27FC236}">
                    <a16:creationId xmlns:a16="http://schemas.microsoft.com/office/drawing/2014/main" id="{C8E420D2-28A1-5437-B38E-6D212B142507}"/>
                  </a:ext>
                </a:extLst>
              </p:cNvPr>
              <p:cNvSpPr txBox="1"/>
              <p:nvPr/>
            </p:nvSpPr>
            <p:spPr>
              <a:xfrm rot="16200000">
                <a:off x="4760930" y="7674563"/>
                <a:ext cx="634635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  <a:endParaRPr lang="en-US" sz="1000" b="1" dirty="0"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0" name="TextBox 61">
                <a:extLst>
                  <a:ext uri="{FF2B5EF4-FFF2-40B4-BE49-F238E27FC236}">
                    <a16:creationId xmlns:a16="http://schemas.microsoft.com/office/drawing/2014/main" id="{3F2C6A9A-EA54-D66D-8278-783D620A5653}"/>
                  </a:ext>
                </a:extLst>
              </p:cNvPr>
              <p:cNvSpPr txBox="1"/>
              <p:nvPr/>
            </p:nvSpPr>
            <p:spPr>
              <a:xfrm rot="16200000">
                <a:off x="4969437" y="7580066"/>
                <a:ext cx="445642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SO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1" name="TextBox 51">
                <a:extLst>
                  <a:ext uri="{FF2B5EF4-FFF2-40B4-BE49-F238E27FC236}">
                    <a16:creationId xmlns:a16="http://schemas.microsoft.com/office/drawing/2014/main" id="{D56F92B1-462D-FE0E-5DB4-49D3BCA4B5F4}"/>
                  </a:ext>
                </a:extLst>
              </p:cNvPr>
              <p:cNvSpPr txBox="1"/>
              <p:nvPr/>
            </p:nvSpPr>
            <p:spPr>
              <a:xfrm rot="16200000">
                <a:off x="5091999" y="7571514"/>
                <a:ext cx="42853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S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2" name="TextBox 51">
                <a:extLst>
                  <a:ext uri="{FF2B5EF4-FFF2-40B4-BE49-F238E27FC236}">
                    <a16:creationId xmlns:a16="http://schemas.microsoft.com/office/drawing/2014/main" id="{E030F3A4-9CAB-859C-CA75-6D4F277BD382}"/>
                  </a:ext>
                </a:extLst>
              </p:cNvPr>
              <p:cNvSpPr txBox="1"/>
              <p:nvPr/>
            </p:nvSpPr>
            <p:spPr>
              <a:xfrm rot="16200000">
                <a:off x="5181072" y="7596451"/>
                <a:ext cx="47841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SO2</a:t>
                </a:r>
              </a:p>
            </p:txBody>
          </p:sp>
          <p:sp>
            <p:nvSpPr>
              <p:cNvPr id="363" name="TextBox 51">
                <a:extLst>
                  <a:ext uri="{FF2B5EF4-FFF2-40B4-BE49-F238E27FC236}">
                    <a16:creationId xmlns:a16="http://schemas.microsoft.com/office/drawing/2014/main" id="{E805BB72-1522-E067-F0F2-2DE92BF584EF}"/>
                  </a:ext>
                </a:extLst>
              </p:cNvPr>
              <p:cNvSpPr txBox="1"/>
              <p:nvPr/>
            </p:nvSpPr>
            <p:spPr>
              <a:xfrm rot="16200000">
                <a:off x="5314959" y="7576574"/>
                <a:ext cx="43865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F</a:t>
                </a:r>
              </a:p>
            </p:txBody>
          </p:sp>
          <p:sp>
            <p:nvSpPr>
              <p:cNvPr id="364" name="TextBox 51">
                <a:extLst>
                  <a:ext uri="{FF2B5EF4-FFF2-40B4-BE49-F238E27FC236}">
                    <a16:creationId xmlns:a16="http://schemas.microsoft.com/office/drawing/2014/main" id="{418A7198-89ED-D6AB-694C-BE3EB1D42BAF}"/>
                  </a:ext>
                </a:extLst>
              </p:cNvPr>
              <p:cNvSpPr txBox="1"/>
              <p:nvPr/>
            </p:nvSpPr>
            <p:spPr>
              <a:xfrm rot="16200000">
                <a:off x="5409092" y="7596451"/>
                <a:ext cx="47841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A</a:t>
                </a:r>
              </a:p>
            </p:txBody>
          </p:sp>
          <p:sp>
            <p:nvSpPr>
              <p:cNvPr id="365" name="TextBox 51">
                <a:extLst>
                  <a:ext uri="{FF2B5EF4-FFF2-40B4-BE49-F238E27FC236}">
                    <a16:creationId xmlns:a16="http://schemas.microsoft.com/office/drawing/2014/main" id="{24186D72-D15E-D24B-9B04-D83A652FD5CE}"/>
                  </a:ext>
                </a:extLst>
              </p:cNvPr>
              <p:cNvSpPr txBox="1"/>
              <p:nvPr/>
            </p:nvSpPr>
            <p:spPr>
              <a:xfrm rot="16200000">
                <a:off x="5542979" y="7576574"/>
                <a:ext cx="43865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BA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6" name="TextBox 51">
                <a:extLst>
                  <a:ext uri="{FF2B5EF4-FFF2-40B4-BE49-F238E27FC236}">
                    <a16:creationId xmlns:a16="http://schemas.microsoft.com/office/drawing/2014/main" id="{03D55BFB-4431-BFFE-353C-EADCD5975DEB}"/>
                  </a:ext>
                </a:extLst>
              </p:cNvPr>
              <p:cNvSpPr txBox="1"/>
              <p:nvPr/>
            </p:nvSpPr>
            <p:spPr>
              <a:xfrm rot="16200000">
                <a:off x="5637112" y="7596451"/>
                <a:ext cx="47841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AC</a:t>
                </a:r>
              </a:p>
            </p:txBody>
          </p:sp>
          <p:sp>
            <p:nvSpPr>
              <p:cNvPr id="367" name="TextBox 51">
                <a:extLst>
                  <a:ext uri="{FF2B5EF4-FFF2-40B4-BE49-F238E27FC236}">
                    <a16:creationId xmlns:a16="http://schemas.microsoft.com/office/drawing/2014/main" id="{4152EA9E-3F98-031F-D200-831D1D1A773A}"/>
                  </a:ext>
                </a:extLst>
              </p:cNvPr>
              <p:cNvSpPr txBox="1"/>
              <p:nvPr/>
            </p:nvSpPr>
            <p:spPr>
              <a:xfrm rot="16200000">
                <a:off x="5668051" y="7679522"/>
                <a:ext cx="64455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itamin C</a:t>
                </a:r>
              </a:p>
            </p:txBody>
          </p:sp>
          <p:sp>
            <p:nvSpPr>
              <p:cNvPr id="368" name="TextBox 51">
                <a:extLst>
                  <a:ext uri="{FF2B5EF4-FFF2-40B4-BE49-F238E27FC236}">
                    <a16:creationId xmlns:a16="http://schemas.microsoft.com/office/drawing/2014/main" id="{79556CB5-2537-C9E0-3E06-CE6A37D1A9D2}"/>
                  </a:ext>
                </a:extLst>
              </p:cNvPr>
              <p:cNvSpPr txBox="1"/>
              <p:nvPr/>
            </p:nvSpPr>
            <p:spPr>
              <a:xfrm rot="16200000">
                <a:off x="5786062" y="7675521"/>
                <a:ext cx="63655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itamin E</a:t>
                </a:r>
              </a:p>
            </p:txBody>
          </p:sp>
          <p:sp>
            <p:nvSpPr>
              <p:cNvPr id="369" name="TextBox 51">
                <a:extLst>
                  <a:ext uri="{FF2B5EF4-FFF2-40B4-BE49-F238E27FC236}">
                    <a16:creationId xmlns:a16="http://schemas.microsoft.com/office/drawing/2014/main" id="{870AEFB4-9E8C-FD42-D39E-D7FA91FB8891}"/>
                  </a:ext>
                </a:extLst>
              </p:cNvPr>
              <p:cNvSpPr txBox="1"/>
              <p:nvPr/>
            </p:nvSpPr>
            <p:spPr>
              <a:xfrm rot="16200000">
                <a:off x="5854428" y="7721162"/>
                <a:ext cx="727833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pplement</a:t>
                </a:r>
              </a:p>
            </p:txBody>
          </p:sp>
        </p:grpSp>
        <p:grpSp>
          <p:nvGrpSpPr>
            <p:cNvPr id="370" name="Group 369">
              <a:extLst>
                <a:ext uri="{FF2B5EF4-FFF2-40B4-BE49-F238E27FC236}">
                  <a16:creationId xmlns:a16="http://schemas.microsoft.com/office/drawing/2014/main" id="{439390F7-0635-5C35-59EA-7E84C6FF881D}"/>
                </a:ext>
              </a:extLst>
            </p:cNvPr>
            <p:cNvGrpSpPr/>
            <p:nvPr/>
          </p:nvGrpSpPr>
          <p:grpSpPr>
            <a:xfrm>
              <a:off x="3484797" y="4420737"/>
              <a:ext cx="1293985" cy="727833"/>
              <a:chOff x="5001304" y="7434189"/>
              <a:chExt cx="1293985" cy="727833"/>
            </a:xfrm>
          </p:grpSpPr>
          <p:sp>
            <p:nvSpPr>
              <p:cNvPr id="371" name="TextBox 51">
                <a:extLst>
                  <a:ext uri="{FF2B5EF4-FFF2-40B4-BE49-F238E27FC236}">
                    <a16:creationId xmlns:a16="http://schemas.microsoft.com/office/drawing/2014/main" id="{38316EC8-82FB-7105-7E65-4D366D5DC41F}"/>
                  </a:ext>
                </a:extLst>
              </p:cNvPr>
              <p:cNvSpPr txBox="1"/>
              <p:nvPr/>
            </p:nvSpPr>
            <p:spPr>
              <a:xfrm rot="16200000">
                <a:off x="4760930" y="7674563"/>
                <a:ext cx="634635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BS</a:t>
                </a:r>
                <a:endParaRPr lang="en-US" sz="1000" b="1" dirty="0"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2" name="TextBox 61">
                <a:extLst>
                  <a:ext uri="{FF2B5EF4-FFF2-40B4-BE49-F238E27FC236}">
                    <a16:creationId xmlns:a16="http://schemas.microsoft.com/office/drawing/2014/main" id="{BCAC4E11-D522-B7AE-55E3-92719538DA0A}"/>
                  </a:ext>
                </a:extLst>
              </p:cNvPr>
              <p:cNvSpPr txBox="1"/>
              <p:nvPr/>
            </p:nvSpPr>
            <p:spPr>
              <a:xfrm rot="16200000">
                <a:off x="4969437" y="7580066"/>
                <a:ext cx="445642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SO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3" name="TextBox 51">
                <a:extLst>
                  <a:ext uri="{FF2B5EF4-FFF2-40B4-BE49-F238E27FC236}">
                    <a16:creationId xmlns:a16="http://schemas.microsoft.com/office/drawing/2014/main" id="{1210AF12-10D5-B2FE-5ACB-7F668A965428}"/>
                  </a:ext>
                </a:extLst>
              </p:cNvPr>
              <p:cNvSpPr txBox="1"/>
              <p:nvPr/>
            </p:nvSpPr>
            <p:spPr>
              <a:xfrm rot="16200000">
                <a:off x="5091999" y="7571514"/>
                <a:ext cx="42853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S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4" name="TextBox 51">
                <a:extLst>
                  <a:ext uri="{FF2B5EF4-FFF2-40B4-BE49-F238E27FC236}">
                    <a16:creationId xmlns:a16="http://schemas.microsoft.com/office/drawing/2014/main" id="{94D8C6B4-C1ED-87BC-7285-BE4032B8311A}"/>
                  </a:ext>
                </a:extLst>
              </p:cNvPr>
              <p:cNvSpPr txBox="1"/>
              <p:nvPr/>
            </p:nvSpPr>
            <p:spPr>
              <a:xfrm rot="16200000">
                <a:off x="5181072" y="7596451"/>
                <a:ext cx="47841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SO2</a:t>
                </a:r>
              </a:p>
            </p:txBody>
          </p:sp>
          <p:sp>
            <p:nvSpPr>
              <p:cNvPr id="375" name="TextBox 51">
                <a:extLst>
                  <a:ext uri="{FF2B5EF4-FFF2-40B4-BE49-F238E27FC236}">
                    <a16:creationId xmlns:a16="http://schemas.microsoft.com/office/drawing/2014/main" id="{5056BE3C-7F80-FFD4-F794-F8B6ACCDD6CD}"/>
                  </a:ext>
                </a:extLst>
              </p:cNvPr>
              <p:cNvSpPr txBox="1"/>
              <p:nvPr/>
            </p:nvSpPr>
            <p:spPr>
              <a:xfrm rot="16200000">
                <a:off x="5314959" y="7576574"/>
                <a:ext cx="43865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F</a:t>
                </a:r>
              </a:p>
            </p:txBody>
          </p:sp>
          <p:sp>
            <p:nvSpPr>
              <p:cNvPr id="376" name="TextBox 51">
                <a:extLst>
                  <a:ext uri="{FF2B5EF4-FFF2-40B4-BE49-F238E27FC236}">
                    <a16:creationId xmlns:a16="http://schemas.microsoft.com/office/drawing/2014/main" id="{A5D8ADBF-B29B-8938-F4C9-3D3A6913FA24}"/>
                  </a:ext>
                </a:extLst>
              </p:cNvPr>
              <p:cNvSpPr txBox="1"/>
              <p:nvPr/>
            </p:nvSpPr>
            <p:spPr>
              <a:xfrm rot="16200000">
                <a:off x="5409092" y="7596451"/>
                <a:ext cx="47841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MA</a:t>
                </a:r>
              </a:p>
            </p:txBody>
          </p:sp>
          <p:sp>
            <p:nvSpPr>
              <p:cNvPr id="377" name="TextBox 51">
                <a:extLst>
                  <a:ext uri="{FF2B5EF4-FFF2-40B4-BE49-F238E27FC236}">
                    <a16:creationId xmlns:a16="http://schemas.microsoft.com/office/drawing/2014/main" id="{1DE4A1FD-A476-5672-2DE1-9B902CF97FFC}"/>
                  </a:ext>
                </a:extLst>
              </p:cNvPr>
              <p:cNvSpPr txBox="1"/>
              <p:nvPr/>
            </p:nvSpPr>
            <p:spPr>
              <a:xfrm rot="16200000">
                <a:off x="5542979" y="7576574"/>
                <a:ext cx="43865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BA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8" name="TextBox 51">
                <a:extLst>
                  <a:ext uri="{FF2B5EF4-FFF2-40B4-BE49-F238E27FC236}">
                    <a16:creationId xmlns:a16="http://schemas.microsoft.com/office/drawing/2014/main" id="{BD842479-82FC-4515-E522-D283457EF1AF}"/>
                  </a:ext>
                </a:extLst>
              </p:cNvPr>
              <p:cNvSpPr txBox="1"/>
              <p:nvPr/>
            </p:nvSpPr>
            <p:spPr>
              <a:xfrm rot="16200000">
                <a:off x="5637112" y="7596451"/>
                <a:ext cx="47841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AC</a:t>
                </a:r>
              </a:p>
            </p:txBody>
          </p:sp>
          <p:sp>
            <p:nvSpPr>
              <p:cNvPr id="379" name="TextBox 51">
                <a:extLst>
                  <a:ext uri="{FF2B5EF4-FFF2-40B4-BE49-F238E27FC236}">
                    <a16:creationId xmlns:a16="http://schemas.microsoft.com/office/drawing/2014/main" id="{23659B43-81CF-C942-060B-33908C62312F}"/>
                  </a:ext>
                </a:extLst>
              </p:cNvPr>
              <p:cNvSpPr txBox="1"/>
              <p:nvPr/>
            </p:nvSpPr>
            <p:spPr>
              <a:xfrm rot="16200000">
                <a:off x="5668051" y="7679522"/>
                <a:ext cx="644554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itamin C</a:t>
                </a:r>
              </a:p>
            </p:txBody>
          </p:sp>
          <p:sp>
            <p:nvSpPr>
              <p:cNvPr id="380" name="TextBox 51">
                <a:extLst>
                  <a:ext uri="{FF2B5EF4-FFF2-40B4-BE49-F238E27FC236}">
                    <a16:creationId xmlns:a16="http://schemas.microsoft.com/office/drawing/2014/main" id="{19857D9E-E6C5-7D40-EB52-12ED2E6D352D}"/>
                  </a:ext>
                </a:extLst>
              </p:cNvPr>
              <p:cNvSpPr txBox="1"/>
              <p:nvPr/>
            </p:nvSpPr>
            <p:spPr>
              <a:xfrm rot="16200000">
                <a:off x="5786062" y="7675521"/>
                <a:ext cx="63655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itamin E</a:t>
                </a:r>
              </a:p>
            </p:txBody>
          </p:sp>
          <p:sp>
            <p:nvSpPr>
              <p:cNvPr id="381" name="TextBox 51">
                <a:extLst>
                  <a:ext uri="{FF2B5EF4-FFF2-40B4-BE49-F238E27FC236}">
                    <a16:creationId xmlns:a16="http://schemas.microsoft.com/office/drawing/2014/main" id="{3677F7C8-36CA-299B-0FC1-7DC1BF17DF35}"/>
                  </a:ext>
                </a:extLst>
              </p:cNvPr>
              <p:cNvSpPr txBox="1"/>
              <p:nvPr/>
            </p:nvSpPr>
            <p:spPr>
              <a:xfrm rot="16200000">
                <a:off x="5854428" y="7721162"/>
                <a:ext cx="727833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>
                <a:spAutoFit/>
              </a:bodyPr>
              <a:lstStyle/>
              <a:p>
                <a:pPr algn="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pplement</a:t>
                </a:r>
              </a:p>
            </p:txBody>
          </p:sp>
        </p:grpSp>
        <p:grpSp>
          <p:nvGrpSpPr>
            <p:cNvPr id="23" name="グループ化 22">
              <a:extLst>
                <a:ext uri="{FF2B5EF4-FFF2-40B4-BE49-F238E27FC236}">
                  <a16:creationId xmlns:a16="http://schemas.microsoft.com/office/drawing/2014/main" id="{6D46610C-08C8-99D6-9E43-42CF0E04F1AF}"/>
                </a:ext>
              </a:extLst>
            </p:cNvPr>
            <p:cNvGrpSpPr/>
            <p:nvPr/>
          </p:nvGrpSpPr>
          <p:grpSpPr>
            <a:xfrm>
              <a:off x="4991417" y="3067868"/>
              <a:ext cx="1340024" cy="549588"/>
              <a:chOff x="4991417" y="3094062"/>
              <a:chExt cx="1340024" cy="549588"/>
            </a:xfrm>
          </p:grpSpPr>
          <p:sp>
            <p:nvSpPr>
              <p:cNvPr id="256" name="TextBox 51">
                <a:extLst>
                  <a:ext uri="{FF2B5EF4-FFF2-40B4-BE49-F238E27FC236}">
                    <a16:creationId xmlns:a16="http://schemas.microsoft.com/office/drawing/2014/main" id="{E21557D7-03AC-173C-4F10-4CBDD95F025E}"/>
                  </a:ext>
                </a:extLst>
              </p:cNvPr>
              <p:cNvSpPr txBox="1"/>
              <p:nvPr/>
            </p:nvSpPr>
            <p:spPr>
              <a:xfrm>
                <a:off x="5564831" y="3520539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57" name="TextBox 51">
                <a:extLst>
                  <a:ext uri="{FF2B5EF4-FFF2-40B4-BE49-F238E27FC236}">
                    <a16:creationId xmlns:a16="http://schemas.microsoft.com/office/drawing/2014/main" id="{447C182D-E461-F6DF-90B1-819D444A9D85}"/>
                  </a:ext>
                </a:extLst>
              </p:cNvPr>
              <p:cNvSpPr txBox="1"/>
              <p:nvPr/>
            </p:nvSpPr>
            <p:spPr>
              <a:xfrm>
                <a:off x="5449890" y="3515374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58" name="TextBox 51">
                <a:extLst>
                  <a:ext uri="{FF2B5EF4-FFF2-40B4-BE49-F238E27FC236}">
                    <a16:creationId xmlns:a16="http://schemas.microsoft.com/office/drawing/2014/main" id="{DAB0A671-AB42-479C-E903-2E21D167E84C}"/>
                  </a:ext>
                </a:extLst>
              </p:cNvPr>
              <p:cNvSpPr txBox="1"/>
              <p:nvPr/>
            </p:nvSpPr>
            <p:spPr>
              <a:xfrm>
                <a:off x="5334081" y="3094062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59" name="TextBox 51">
                <a:extLst>
                  <a:ext uri="{FF2B5EF4-FFF2-40B4-BE49-F238E27FC236}">
                    <a16:creationId xmlns:a16="http://schemas.microsoft.com/office/drawing/2014/main" id="{32D5582F-D5EE-7B7B-7374-F92043FFC1A2}"/>
                  </a:ext>
                </a:extLst>
              </p:cNvPr>
              <p:cNvSpPr txBox="1"/>
              <p:nvPr/>
            </p:nvSpPr>
            <p:spPr>
              <a:xfrm>
                <a:off x="4991417" y="3433676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260" name="TextBox 51">
                <a:extLst>
                  <a:ext uri="{FF2B5EF4-FFF2-40B4-BE49-F238E27FC236}">
                    <a16:creationId xmlns:a16="http://schemas.microsoft.com/office/drawing/2014/main" id="{2C684EAE-9EC3-A8CF-67E5-3D6121907542}"/>
                  </a:ext>
                </a:extLst>
              </p:cNvPr>
              <p:cNvSpPr txBox="1"/>
              <p:nvPr/>
            </p:nvSpPr>
            <p:spPr>
              <a:xfrm>
                <a:off x="5792537" y="3370590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61" name="TextBox 51">
                <a:extLst>
                  <a:ext uri="{FF2B5EF4-FFF2-40B4-BE49-F238E27FC236}">
                    <a16:creationId xmlns:a16="http://schemas.microsoft.com/office/drawing/2014/main" id="{57A391DB-CCBE-7744-C53A-8A026601DAFB}"/>
                  </a:ext>
                </a:extLst>
              </p:cNvPr>
              <p:cNvSpPr txBox="1"/>
              <p:nvPr/>
            </p:nvSpPr>
            <p:spPr>
              <a:xfrm>
                <a:off x="5218984" y="3488716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62" name="TextBox 51">
                <a:extLst>
                  <a:ext uri="{FF2B5EF4-FFF2-40B4-BE49-F238E27FC236}">
                    <a16:creationId xmlns:a16="http://schemas.microsoft.com/office/drawing/2014/main" id="{C1A32A60-6B5B-4827-363F-717931D3E65F}"/>
                  </a:ext>
                </a:extLst>
              </p:cNvPr>
              <p:cNvSpPr txBox="1"/>
              <p:nvPr/>
            </p:nvSpPr>
            <p:spPr>
              <a:xfrm>
                <a:off x="6021891" y="3494161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63" name="TextBox 51">
                <a:extLst>
                  <a:ext uri="{FF2B5EF4-FFF2-40B4-BE49-F238E27FC236}">
                    <a16:creationId xmlns:a16="http://schemas.microsoft.com/office/drawing/2014/main" id="{F1EDC08F-F8E1-6E34-8ADC-8FD80B27B1E1}"/>
                  </a:ext>
                </a:extLst>
              </p:cNvPr>
              <p:cNvSpPr txBox="1"/>
              <p:nvPr/>
            </p:nvSpPr>
            <p:spPr>
              <a:xfrm>
                <a:off x="6137275" y="3467870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64" name="TextBox 51">
                <a:extLst>
                  <a:ext uri="{FF2B5EF4-FFF2-40B4-BE49-F238E27FC236}">
                    <a16:creationId xmlns:a16="http://schemas.microsoft.com/office/drawing/2014/main" id="{613DA09F-2135-294C-5172-2FFABB1787FE}"/>
                  </a:ext>
                </a:extLst>
              </p:cNvPr>
              <p:cNvSpPr txBox="1"/>
              <p:nvPr/>
            </p:nvSpPr>
            <p:spPr>
              <a:xfrm>
                <a:off x="5907884" y="3438795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24" name="グループ化 23">
              <a:extLst>
                <a:ext uri="{FF2B5EF4-FFF2-40B4-BE49-F238E27FC236}">
                  <a16:creationId xmlns:a16="http://schemas.microsoft.com/office/drawing/2014/main" id="{E26EEFC4-3B52-497E-CA17-EECF7039C721}"/>
                </a:ext>
              </a:extLst>
            </p:cNvPr>
            <p:cNvGrpSpPr/>
            <p:nvPr/>
          </p:nvGrpSpPr>
          <p:grpSpPr>
            <a:xfrm>
              <a:off x="4991417" y="3894852"/>
              <a:ext cx="1340024" cy="513628"/>
              <a:chOff x="4991417" y="3921046"/>
              <a:chExt cx="1340024" cy="513628"/>
            </a:xfrm>
          </p:grpSpPr>
          <p:sp>
            <p:nvSpPr>
              <p:cNvPr id="266" name="TextBox 51">
                <a:extLst>
                  <a:ext uri="{FF2B5EF4-FFF2-40B4-BE49-F238E27FC236}">
                    <a16:creationId xmlns:a16="http://schemas.microsoft.com/office/drawing/2014/main" id="{61673BA4-4B2F-9AF6-1E92-BDE5C3698A77}"/>
                  </a:ext>
                </a:extLst>
              </p:cNvPr>
              <p:cNvSpPr txBox="1"/>
              <p:nvPr/>
            </p:nvSpPr>
            <p:spPr>
              <a:xfrm>
                <a:off x="5564831" y="4311563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67" name="TextBox 51">
                <a:extLst>
                  <a:ext uri="{FF2B5EF4-FFF2-40B4-BE49-F238E27FC236}">
                    <a16:creationId xmlns:a16="http://schemas.microsoft.com/office/drawing/2014/main" id="{33AF93D7-69FB-7FC1-60F1-363E22B5D17A}"/>
                  </a:ext>
                </a:extLst>
              </p:cNvPr>
              <p:cNvSpPr txBox="1"/>
              <p:nvPr/>
            </p:nvSpPr>
            <p:spPr>
              <a:xfrm>
                <a:off x="5449890" y="4292514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68" name="TextBox 51">
                <a:extLst>
                  <a:ext uri="{FF2B5EF4-FFF2-40B4-BE49-F238E27FC236}">
                    <a16:creationId xmlns:a16="http://schemas.microsoft.com/office/drawing/2014/main" id="{17D59D0F-A6C3-AE60-AB81-FBD2AEDC41BB}"/>
                  </a:ext>
                </a:extLst>
              </p:cNvPr>
              <p:cNvSpPr txBox="1"/>
              <p:nvPr/>
            </p:nvSpPr>
            <p:spPr>
              <a:xfrm>
                <a:off x="5334081" y="3921046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69" name="TextBox 51">
                <a:extLst>
                  <a:ext uri="{FF2B5EF4-FFF2-40B4-BE49-F238E27FC236}">
                    <a16:creationId xmlns:a16="http://schemas.microsoft.com/office/drawing/2014/main" id="{B266D18B-C22C-3000-9973-0EDA71BB66D1}"/>
                  </a:ext>
                </a:extLst>
              </p:cNvPr>
              <p:cNvSpPr txBox="1"/>
              <p:nvPr/>
            </p:nvSpPr>
            <p:spPr>
              <a:xfrm>
                <a:off x="4991417" y="4290133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70" name="TextBox 51">
                <a:extLst>
                  <a:ext uri="{FF2B5EF4-FFF2-40B4-BE49-F238E27FC236}">
                    <a16:creationId xmlns:a16="http://schemas.microsoft.com/office/drawing/2014/main" id="{F445348F-5A2D-5978-2974-95DF7610AFA3}"/>
                  </a:ext>
                </a:extLst>
              </p:cNvPr>
              <p:cNvSpPr txBox="1"/>
              <p:nvPr/>
            </p:nvSpPr>
            <p:spPr>
              <a:xfrm>
                <a:off x="5792537" y="4149711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71" name="TextBox 51">
                <a:extLst>
                  <a:ext uri="{FF2B5EF4-FFF2-40B4-BE49-F238E27FC236}">
                    <a16:creationId xmlns:a16="http://schemas.microsoft.com/office/drawing/2014/main" id="{BE0AC8CB-6A94-EA47-4243-FAC9FA5AF6A3}"/>
                  </a:ext>
                </a:extLst>
              </p:cNvPr>
              <p:cNvSpPr txBox="1"/>
              <p:nvPr/>
            </p:nvSpPr>
            <p:spPr>
              <a:xfrm>
                <a:off x="5218984" y="4294895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72" name="TextBox 51">
                <a:extLst>
                  <a:ext uri="{FF2B5EF4-FFF2-40B4-BE49-F238E27FC236}">
                    <a16:creationId xmlns:a16="http://schemas.microsoft.com/office/drawing/2014/main" id="{191C7303-E70B-CCF5-4F10-7595A7B30DEA}"/>
                  </a:ext>
                </a:extLst>
              </p:cNvPr>
              <p:cNvSpPr txBox="1"/>
              <p:nvPr/>
            </p:nvSpPr>
            <p:spPr>
              <a:xfrm>
                <a:off x="6021891" y="4302038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73" name="TextBox 51">
                <a:extLst>
                  <a:ext uri="{FF2B5EF4-FFF2-40B4-BE49-F238E27FC236}">
                    <a16:creationId xmlns:a16="http://schemas.microsoft.com/office/drawing/2014/main" id="{C5A8BF37-F200-B59D-B419-E5C20FEE9715}"/>
                  </a:ext>
                </a:extLst>
              </p:cNvPr>
              <p:cNvSpPr txBox="1"/>
              <p:nvPr/>
            </p:nvSpPr>
            <p:spPr>
              <a:xfrm>
                <a:off x="6137275" y="4280609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74" name="TextBox 51">
                <a:extLst>
                  <a:ext uri="{FF2B5EF4-FFF2-40B4-BE49-F238E27FC236}">
                    <a16:creationId xmlns:a16="http://schemas.microsoft.com/office/drawing/2014/main" id="{04E6916F-F440-964C-82E1-A6FAD38BBA77}"/>
                  </a:ext>
                </a:extLst>
              </p:cNvPr>
              <p:cNvSpPr txBox="1"/>
              <p:nvPr/>
            </p:nvSpPr>
            <p:spPr>
              <a:xfrm>
                <a:off x="5907884" y="4287752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75" name="TextBox 51">
                <a:extLst>
                  <a:ext uri="{FF2B5EF4-FFF2-40B4-BE49-F238E27FC236}">
                    <a16:creationId xmlns:a16="http://schemas.microsoft.com/office/drawing/2014/main" id="{02264343-7E6B-617F-61F4-2FD4D735A99C}"/>
                  </a:ext>
                </a:extLst>
              </p:cNvPr>
              <p:cNvSpPr txBox="1"/>
              <p:nvPr/>
            </p:nvSpPr>
            <p:spPr>
              <a:xfrm>
                <a:off x="5675790" y="4254456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25" name="グループ化 24">
              <a:extLst>
                <a:ext uri="{FF2B5EF4-FFF2-40B4-BE49-F238E27FC236}">
                  <a16:creationId xmlns:a16="http://schemas.microsoft.com/office/drawing/2014/main" id="{1A409F51-3E85-ED94-A542-C33CB0189EE5}"/>
                </a:ext>
              </a:extLst>
            </p:cNvPr>
            <p:cNvGrpSpPr/>
            <p:nvPr/>
          </p:nvGrpSpPr>
          <p:grpSpPr>
            <a:xfrm>
              <a:off x="3464625" y="2263696"/>
              <a:ext cx="1337643" cy="563642"/>
              <a:chOff x="3464625" y="2282744"/>
              <a:chExt cx="1337643" cy="563642"/>
            </a:xfrm>
          </p:grpSpPr>
          <p:grpSp>
            <p:nvGrpSpPr>
              <p:cNvPr id="276" name="グループ化 275">
                <a:extLst>
                  <a:ext uri="{FF2B5EF4-FFF2-40B4-BE49-F238E27FC236}">
                    <a16:creationId xmlns:a16="http://schemas.microsoft.com/office/drawing/2014/main" id="{FA6BD8D1-B0D9-D655-70DD-5051FB1186F2}"/>
                  </a:ext>
                </a:extLst>
              </p:cNvPr>
              <p:cNvGrpSpPr/>
              <p:nvPr/>
            </p:nvGrpSpPr>
            <p:grpSpPr>
              <a:xfrm>
                <a:off x="3464625" y="2282744"/>
                <a:ext cx="1337643" cy="563642"/>
                <a:chOff x="4991417" y="3168376"/>
                <a:chExt cx="1337643" cy="563642"/>
              </a:xfrm>
            </p:grpSpPr>
            <p:sp>
              <p:nvSpPr>
                <p:cNvPr id="277" name="TextBox 51">
                  <a:extLst>
                    <a:ext uri="{FF2B5EF4-FFF2-40B4-BE49-F238E27FC236}">
                      <a16:creationId xmlns:a16="http://schemas.microsoft.com/office/drawing/2014/main" id="{E7792CFF-67F3-6138-E746-FA802B89ADF3}"/>
                    </a:ext>
                  </a:extLst>
                </p:cNvPr>
                <p:cNvSpPr txBox="1"/>
                <p:nvPr/>
              </p:nvSpPr>
              <p:spPr>
                <a:xfrm>
                  <a:off x="5564831" y="3608907"/>
                  <a:ext cx="194166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  <p:sp>
              <p:nvSpPr>
                <p:cNvPr id="278" name="TextBox 51">
                  <a:extLst>
                    <a:ext uri="{FF2B5EF4-FFF2-40B4-BE49-F238E27FC236}">
                      <a16:creationId xmlns:a16="http://schemas.microsoft.com/office/drawing/2014/main" id="{7E47A997-380E-2981-B292-D7E8D9EB399A}"/>
                    </a:ext>
                  </a:extLst>
                </p:cNvPr>
                <p:cNvSpPr txBox="1"/>
                <p:nvPr/>
              </p:nvSpPr>
              <p:spPr>
                <a:xfrm>
                  <a:off x="5449890" y="3529660"/>
                  <a:ext cx="194166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  <p:sp>
              <p:nvSpPr>
                <p:cNvPr id="279" name="TextBox 51">
                  <a:extLst>
                    <a:ext uri="{FF2B5EF4-FFF2-40B4-BE49-F238E27FC236}">
                      <a16:creationId xmlns:a16="http://schemas.microsoft.com/office/drawing/2014/main" id="{283F6AFD-6C2C-1B6C-A5ED-313DC01D18B8}"/>
                    </a:ext>
                  </a:extLst>
                </p:cNvPr>
                <p:cNvSpPr txBox="1"/>
                <p:nvPr/>
              </p:nvSpPr>
              <p:spPr>
                <a:xfrm>
                  <a:off x="5334081" y="3168376"/>
                  <a:ext cx="194166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  <p:sp>
              <p:nvSpPr>
                <p:cNvPr id="280" name="TextBox 51">
                  <a:extLst>
                    <a:ext uri="{FF2B5EF4-FFF2-40B4-BE49-F238E27FC236}">
                      <a16:creationId xmlns:a16="http://schemas.microsoft.com/office/drawing/2014/main" id="{C3ECEB77-D423-C063-3A7F-4C3138D9C888}"/>
                    </a:ext>
                  </a:extLst>
                </p:cNvPr>
                <p:cNvSpPr txBox="1"/>
                <p:nvPr/>
              </p:nvSpPr>
              <p:spPr>
                <a:xfrm>
                  <a:off x="4991417" y="3433676"/>
                  <a:ext cx="194166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281" name="TextBox 51">
                  <a:extLst>
                    <a:ext uri="{FF2B5EF4-FFF2-40B4-BE49-F238E27FC236}">
                      <a16:creationId xmlns:a16="http://schemas.microsoft.com/office/drawing/2014/main" id="{947D8716-9EFA-CCA1-030F-1047B2FF0355}"/>
                    </a:ext>
                  </a:extLst>
                </p:cNvPr>
                <p:cNvSpPr txBox="1"/>
                <p:nvPr/>
              </p:nvSpPr>
              <p:spPr>
                <a:xfrm>
                  <a:off x="5790156" y="3382495"/>
                  <a:ext cx="194166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  <p:sp>
              <p:nvSpPr>
                <p:cNvPr id="283" name="TextBox 51">
                  <a:extLst>
                    <a:ext uri="{FF2B5EF4-FFF2-40B4-BE49-F238E27FC236}">
                      <a16:creationId xmlns:a16="http://schemas.microsoft.com/office/drawing/2014/main" id="{B1FEEAE5-4F8B-20DA-93E6-D3645C29BE06}"/>
                    </a:ext>
                  </a:extLst>
                </p:cNvPr>
                <p:cNvSpPr txBox="1"/>
                <p:nvPr/>
              </p:nvSpPr>
              <p:spPr>
                <a:xfrm>
                  <a:off x="6019510" y="3522733"/>
                  <a:ext cx="194166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  <p:sp>
              <p:nvSpPr>
                <p:cNvPr id="284" name="TextBox 51">
                  <a:extLst>
                    <a:ext uri="{FF2B5EF4-FFF2-40B4-BE49-F238E27FC236}">
                      <a16:creationId xmlns:a16="http://schemas.microsoft.com/office/drawing/2014/main" id="{8C3C3ABD-B214-FA6D-C2F4-EBE10407E695}"/>
                    </a:ext>
                  </a:extLst>
                </p:cNvPr>
                <p:cNvSpPr txBox="1"/>
                <p:nvPr/>
              </p:nvSpPr>
              <p:spPr>
                <a:xfrm>
                  <a:off x="6134894" y="3534547"/>
                  <a:ext cx="194166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*</a:t>
                  </a:r>
                </a:p>
              </p:txBody>
            </p:sp>
            <p:sp>
              <p:nvSpPr>
                <p:cNvPr id="285" name="TextBox 51">
                  <a:extLst>
                    <a:ext uri="{FF2B5EF4-FFF2-40B4-BE49-F238E27FC236}">
                      <a16:creationId xmlns:a16="http://schemas.microsoft.com/office/drawing/2014/main" id="{D5DEF3D0-8DF7-D5F8-3717-422B2271AB68}"/>
                    </a:ext>
                  </a:extLst>
                </p:cNvPr>
                <p:cNvSpPr txBox="1"/>
                <p:nvPr/>
              </p:nvSpPr>
              <p:spPr>
                <a:xfrm>
                  <a:off x="5905503" y="3443557"/>
                  <a:ext cx="194166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</a:t>
                  </a:r>
                </a:p>
              </p:txBody>
            </p:sp>
          </p:grpSp>
          <p:sp>
            <p:nvSpPr>
              <p:cNvPr id="286" name="TextBox 51">
                <a:extLst>
                  <a:ext uri="{FF2B5EF4-FFF2-40B4-BE49-F238E27FC236}">
                    <a16:creationId xmlns:a16="http://schemas.microsoft.com/office/drawing/2014/main" id="{7E7A0952-D426-1A33-89A2-57DDBFC1CFD8}"/>
                  </a:ext>
                </a:extLst>
              </p:cNvPr>
              <p:cNvSpPr txBox="1"/>
              <p:nvPr/>
            </p:nvSpPr>
            <p:spPr>
              <a:xfrm>
                <a:off x="4148929" y="2560639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287" name="グループ化 286">
              <a:extLst>
                <a:ext uri="{FF2B5EF4-FFF2-40B4-BE49-F238E27FC236}">
                  <a16:creationId xmlns:a16="http://schemas.microsoft.com/office/drawing/2014/main" id="{41657C37-13C7-A1CC-5A27-DCFC7D91B636}"/>
                </a:ext>
              </a:extLst>
            </p:cNvPr>
            <p:cNvGrpSpPr/>
            <p:nvPr/>
          </p:nvGrpSpPr>
          <p:grpSpPr>
            <a:xfrm>
              <a:off x="406628" y="3842819"/>
              <a:ext cx="1337643" cy="568395"/>
              <a:chOff x="4991417" y="3940094"/>
              <a:chExt cx="1337643" cy="568395"/>
            </a:xfrm>
          </p:grpSpPr>
          <p:sp>
            <p:nvSpPr>
              <p:cNvPr id="288" name="TextBox 51">
                <a:extLst>
                  <a:ext uri="{FF2B5EF4-FFF2-40B4-BE49-F238E27FC236}">
                    <a16:creationId xmlns:a16="http://schemas.microsoft.com/office/drawing/2014/main" id="{5366AA63-4576-A35C-AD5E-C2C3D0315BE8}"/>
                  </a:ext>
                </a:extLst>
              </p:cNvPr>
              <p:cNvSpPr txBox="1"/>
              <p:nvPr/>
            </p:nvSpPr>
            <p:spPr>
              <a:xfrm>
                <a:off x="5564831" y="4385378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89" name="TextBox 51">
                <a:extLst>
                  <a:ext uri="{FF2B5EF4-FFF2-40B4-BE49-F238E27FC236}">
                    <a16:creationId xmlns:a16="http://schemas.microsoft.com/office/drawing/2014/main" id="{CC0F7B88-6CB3-AB9C-DA89-8BE4E709A705}"/>
                  </a:ext>
                </a:extLst>
              </p:cNvPr>
              <p:cNvSpPr txBox="1"/>
              <p:nvPr/>
            </p:nvSpPr>
            <p:spPr>
              <a:xfrm>
                <a:off x="5449890" y="4178216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90" name="TextBox 51">
                <a:extLst>
                  <a:ext uri="{FF2B5EF4-FFF2-40B4-BE49-F238E27FC236}">
                    <a16:creationId xmlns:a16="http://schemas.microsoft.com/office/drawing/2014/main" id="{9ADA909B-5F1C-E265-5E51-DE3770FD2B66}"/>
                  </a:ext>
                </a:extLst>
              </p:cNvPr>
              <p:cNvSpPr txBox="1"/>
              <p:nvPr/>
            </p:nvSpPr>
            <p:spPr>
              <a:xfrm>
                <a:off x="5334081" y="3940094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91" name="TextBox 51">
                <a:extLst>
                  <a:ext uri="{FF2B5EF4-FFF2-40B4-BE49-F238E27FC236}">
                    <a16:creationId xmlns:a16="http://schemas.microsoft.com/office/drawing/2014/main" id="{8A512DC7-F010-D39B-7927-5B1D4445AC58}"/>
                  </a:ext>
                </a:extLst>
              </p:cNvPr>
              <p:cNvSpPr txBox="1"/>
              <p:nvPr/>
            </p:nvSpPr>
            <p:spPr>
              <a:xfrm>
                <a:off x="4991417" y="4290133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92" name="TextBox 51">
                <a:extLst>
                  <a:ext uri="{FF2B5EF4-FFF2-40B4-BE49-F238E27FC236}">
                    <a16:creationId xmlns:a16="http://schemas.microsoft.com/office/drawing/2014/main" id="{8ADB72E3-0BDB-ACB2-A753-4F1287A2DACA}"/>
                  </a:ext>
                </a:extLst>
              </p:cNvPr>
              <p:cNvSpPr txBox="1"/>
              <p:nvPr/>
            </p:nvSpPr>
            <p:spPr>
              <a:xfrm>
                <a:off x="5790156" y="4255734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93" name="TextBox 51">
                <a:extLst>
                  <a:ext uri="{FF2B5EF4-FFF2-40B4-BE49-F238E27FC236}">
                    <a16:creationId xmlns:a16="http://schemas.microsoft.com/office/drawing/2014/main" id="{BA1A4066-F679-50E2-ABAC-6E50EF2F2D23}"/>
                  </a:ext>
                </a:extLst>
              </p:cNvPr>
              <p:cNvSpPr txBox="1"/>
              <p:nvPr/>
            </p:nvSpPr>
            <p:spPr>
              <a:xfrm>
                <a:off x="5218984" y="4285371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94" name="TextBox 51">
                <a:extLst>
                  <a:ext uri="{FF2B5EF4-FFF2-40B4-BE49-F238E27FC236}">
                    <a16:creationId xmlns:a16="http://schemas.microsoft.com/office/drawing/2014/main" id="{6609645F-FF7C-E678-3545-4A7C49E7ED88}"/>
                  </a:ext>
                </a:extLst>
              </p:cNvPr>
              <p:cNvSpPr txBox="1"/>
              <p:nvPr/>
            </p:nvSpPr>
            <p:spPr>
              <a:xfrm>
                <a:off x="6021891" y="4313943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95" name="TextBox 51">
                <a:extLst>
                  <a:ext uri="{FF2B5EF4-FFF2-40B4-BE49-F238E27FC236}">
                    <a16:creationId xmlns:a16="http://schemas.microsoft.com/office/drawing/2014/main" id="{B9E9447C-79AC-1211-1849-EE5E54CE6F0D}"/>
                  </a:ext>
                </a:extLst>
              </p:cNvPr>
              <p:cNvSpPr txBox="1"/>
              <p:nvPr/>
            </p:nvSpPr>
            <p:spPr>
              <a:xfrm>
                <a:off x="6134894" y="4275847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96" name="TextBox 51">
                <a:extLst>
                  <a:ext uri="{FF2B5EF4-FFF2-40B4-BE49-F238E27FC236}">
                    <a16:creationId xmlns:a16="http://schemas.microsoft.com/office/drawing/2014/main" id="{5E0BC24D-1321-EFF4-4EC4-E07829E22F62}"/>
                  </a:ext>
                </a:extLst>
              </p:cNvPr>
              <p:cNvSpPr txBox="1"/>
              <p:nvPr/>
            </p:nvSpPr>
            <p:spPr>
              <a:xfrm>
                <a:off x="5907884" y="4287752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297" name="TextBox 51">
                <a:extLst>
                  <a:ext uri="{FF2B5EF4-FFF2-40B4-BE49-F238E27FC236}">
                    <a16:creationId xmlns:a16="http://schemas.microsoft.com/office/drawing/2014/main" id="{EFEBD819-7510-0F3E-A897-9BC7F35E0189}"/>
                  </a:ext>
                </a:extLst>
              </p:cNvPr>
              <p:cNvSpPr txBox="1"/>
              <p:nvPr/>
            </p:nvSpPr>
            <p:spPr>
              <a:xfrm>
                <a:off x="5675790" y="4223503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298" name="グループ化 297">
              <a:extLst>
                <a:ext uri="{FF2B5EF4-FFF2-40B4-BE49-F238E27FC236}">
                  <a16:creationId xmlns:a16="http://schemas.microsoft.com/office/drawing/2014/main" id="{399D661E-C812-5B7B-DB10-1028CB7840B2}"/>
                </a:ext>
              </a:extLst>
            </p:cNvPr>
            <p:cNvGrpSpPr/>
            <p:nvPr/>
          </p:nvGrpSpPr>
          <p:grpSpPr>
            <a:xfrm>
              <a:off x="1937389" y="2275384"/>
              <a:ext cx="1332881" cy="549347"/>
              <a:chOff x="4991417" y="3940094"/>
              <a:chExt cx="1332881" cy="549347"/>
            </a:xfrm>
          </p:grpSpPr>
          <p:sp>
            <p:nvSpPr>
              <p:cNvPr id="306" name="TextBox 51">
                <a:extLst>
                  <a:ext uri="{FF2B5EF4-FFF2-40B4-BE49-F238E27FC236}">
                    <a16:creationId xmlns:a16="http://schemas.microsoft.com/office/drawing/2014/main" id="{24D22F9E-29CF-156E-AD67-5E8D31CFC186}"/>
                  </a:ext>
                </a:extLst>
              </p:cNvPr>
              <p:cNvSpPr txBox="1"/>
              <p:nvPr/>
            </p:nvSpPr>
            <p:spPr>
              <a:xfrm>
                <a:off x="5562450" y="4366330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09" name="TextBox 51">
                <a:extLst>
                  <a:ext uri="{FF2B5EF4-FFF2-40B4-BE49-F238E27FC236}">
                    <a16:creationId xmlns:a16="http://schemas.microsoft.com/office/drawing/2014/main" id="{D08E8FE9-D045-DA32-A14F-D53C26893EAF}"/>
                  </a:ext>
                </a:extLst>
              </p:cNvPr>
              <p:cNvSpPr txBox="1"/>
              <p:nvPr/>
            </p:nvSpPr>
            <p:spPr>
              <a:xfrm>
                <a:off x="5334081" y="3940094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10" name="TextBox 51">
                <a:extLst>
                  <a:ext uri="{FF2B5EF4-FFF2-40B4-BE49-F238E27FC236}">
                    <a16:creationId xmlns:a16="http://schemas.microsoft.com/office/drawing/2014/main" id="{B1199A91-DC9D-D781-2136-3DA7F0676102}"/>
                  </a:ext>
                </a:extLst>
              </p:cNvPr>
              <p:cNvSpPr txBox="1"/>
              <p:nvPr/>
            </p:nvSpPr>
            <p:spPr>
              <a:xfrm>
                <a:off x="4991417" y="4290133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12" name="TextBox 51">
                <a:extLst>
                  <a:ext uri="{FF2B5EF4-FFF2-40B4-BE49-F238E27FC236}">
                    <a16:creationId xmlns:a16="http://schemas.microsoft.com/office/drawing/2014/main" id="{760E04BC-5A17-3B79-6A46-7A7A93239EF7}"/>
                  </a:ext>
                </a:extLst>
              </p:cNvPr>
              <p:cNvSpPr txBox="1"/>
              <p:nvPr/>
            </p:nvSpPr>
            <p:spPr>
              <a:xfrm>
                <a:off x="5218984" y="4304419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13" name="TextBox 51">
                <a:extLst>
                  <a:ext uri="{FF2B5EF4-FFF2-40B4-BE49-F238E27FC236}">
                    <a16:creationId xmlns:a16="http://schemas.microsoft.com/office/drawing/2014/main" id="{2BED1243-0BAA-8035-98F6-F0C7451C89B6}"/>
                  </a:ext>
                </a:extLst>
              </p:cNvPr>
              <p:cNvSpPr txBox="1"/>
              <p:nvPr/>
            </p:nvSpPr>
            <p:spPr>
              <a:xfrm>
                <a:off x="6019510" y="4311562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15" name="TextBox 51">
                <a:extLst>
                  <a:ext uri="{FF2B5EF4-FFF2-40B4-BE49-F238E27FC236}">
                    <a16:creationId xmlns:a16="http://schemas.microsoft.com/office/drawing/2014/main" id="{B74970A8-90A3-C558-8AE6-E0E0A64E3074}"/>
                  </a:ext>
                </a:extLst>
              </p:cNvPr>
              <p:cNvSpPr txBox="1"/>
              <p:nvPr/>
            </p:nvSpPr>
            <p:spPr>
              <a:xfrm>
                <a:off x="6130132" y="4325362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16" name="TextBox 51">
                <a:extLst>
                  <a:ext uri="{FF2B5EF4-FFF2-40B4-BE49-F238E27FC236}">
                    <a16:creationId xmlns:a16="http://schemas.microsoft.com/office/drawing/2014/main" id="{CD7D8CA0-EAF6-FC63-E769-5E4BF555B65C}"/>
                  </a:ext>
                </a:extLst>
              </p:cNvPr>
              <p:cNvSpPr txBox="1"/>
              <p:nvPr/>
            </p:nvSpPr>
            <p:spPr>
              <a:xfrm>
                <a:off x="5903122" y="4280609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17" name="TextBox 51">
                <a:extLst>
                  <a:ext uri="{FF2B5EF4-FFF2-40B4-BE49-F238E27FC236}">
                    <a16:creationId xmlns:a16="http://schemas.microsoft.com/office/drawing/2014/main" id="{B2624805-8A26-D742-E349-096A7EB010F2}"/>
                  </a:ext>
                </a:extLst>
              </p:cNvPr>
              <p:cNvSpPr txBox="1"/>
              <p:nvPr/>
            </p:nvSpPr>
            <p:spPr>
              <a:xfrm>
                <a:off x="5673409" y="4280832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318" name="グループ化 317">
              <a:extLst>
                <a:ext uri="{FF2B5EF4-FFF2-40B4-BE49-F238E27FC236}">
                  <a16:creationId xmlns:a16="http://schemas.microsoft.com/office/drawing/2014/main" id="{83CA6D07-2123-CE37-5B58-1308551D3280}"/>
                </a:ext>
              </a:extLst>
            </p:cNvPr>
            <p:cNvGrpSpPr/>
            <p:nvPr/>
          </p:nvGrpSpPr>
          <p:grpSpPr>
            <a:xfrm>
              <a:off x="406628" y="3251203"/>
              <a:ext cx="1335262" cy="350048"/>
              <a:chOff x="4991417" y="4075101"/>
              <a:chExt cx="1335262" cy="350048"/>
            </a:xfrm>
          </p:grpSpPr>
          <p:sp>
            <p:nvSpPr>
              <p:cNvPr id="319" name="TextBox 51">
                <a:extLst>
                  <a:ext uri="{FF2B5EF4-FFF2-40B4-BE49-F238E27FC236}">
                    <a16:creationId xmlns:a16="http://schemas.microsoft.com/office/drawing/2014/main" id="{AE88598C-4DDE-9B73-D7F7-AA8319A35B29}"/>
                  </a:ext>
                </a:extLst>
              </p:cNvPr>
              <p:cNvSpPr txBox="1"/>
              <p:nvPr/>
            </p:nvSpPr>
            <p:spPr>
              <a:xfrm>
                <a:off x="5564831" y="4282267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20" name="TextBox 51">
                <a:extLst>
                  <a:ext uri="{FF2B5EF4-FFF2-40B4-BE49-F238E27FC236}">
                    <a16:creationId xmlns:a16="http://schemas.microsoft.com/office/drawing/2014/main" id="{F4240090-10B6-C856-5382-26BADA0E0233}"/>
                  </a:ext>
                </a:extLst>
              </p:cNvPr>
              <p:cNvSpPr txBox="1"/>
              <p:nvPr/>
            </p:nvSpPr>
            <p:spPr>
              <a:xfrm>
                <a:off x="5449890" y="4075101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22" name="TextBox 51">
                <a:extLst>
                  <a:ext uri="{FF2B5EF4-FFF2-40B4-BE49-F238E27FC236}">
                    <a16:creationId xmlns:a16="http://schemas.microsoft.com/office/drawing/2014/main" id="{79E40089-5120-FFE0-32BC-02501388020B}"/>
                  </a:ext>
                </a:extLst>
              </p:cNvPr>
              <p:cNvSpPr txBox="1"/>
              <p:nvPr/>
            </p:nvSpPr>
            <p:spPr>
              <a:xfrm>
                <a:off x="4991417" y="4290133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23" name="TextBox 51">
                <a:extLst>
                  <a:ext uri="{FF2B5EF4-FFF2-40B4-BE49-F238E27FC236}">
                    <a16:creationId xmlns:a16="http://schemas.microsoft.com/office/drawing/2014/main" id="{B3210C71-BC6A-F8CE-77C7-8AFF67BD46E1}"/>
                  </a:ext>
                </a:extLst>
              </p:cNvPr>
              <p:cNvSpPr txBox="1"/>
              <p:nvPr/>
            </p:nvSpPr>
            <p:spPr>
              <a:xfrm>
                <a:off x="5790156" y="4194160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24" name="TextBox 51">
                <a:extLst>
                  <a:ext uri="{FF2B5EF4-FFF2-40B4-BE49-F238E27FC236}">
                    <a16:creationId xmlns:a16="http://schemas.microsoft.com/office/drawing/2014/main" id="{4418CBF6-477F-348A-BDE0-0E8CF6D3336E}"/>
                  </a:ext>
                </a:extLst>
              </p:cNvPr>
              <p:cNvSpPr txBox="1"/>
              <p:nvPr/>
            </p:nvSpPr>
            <p:spPr>
              <a:xfrm>
                <a:off x="5218984" y="4302038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32" name="TextBox 51">
                <a:extLst>
                  <a:ext uri="{FF2B5EF4-FFF2-40B4-BE49-F238E27FC236}">
                    <a16:creationId xmlns:a16="http://schemas.microsoft.com/office/drawing/2014/main" id="{C50CE394-238D-4F33-91E8-CE05AC27C30B}"/>
                  </a:ext>
                </a:extLst>
              </p:cNvPr>
              <p:cNvSpPr txBox="1"/>
              <p:nvPr/>
            </p:nvSpPr>
            <p:spPr>
              <a:xfrm>
                <a:off x="6021891" y="4297276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33" name="TextBox 51">
                <a:extLst>
                  <a:ext uri="{FF2B5EF4-FFF2-40B4-BE49-F238E27FC236}">
                    <a16:creationId xmlns:a16="http://schemas.microsoft.com/office/drawing/2014/main" id="{F12A19C2-5E31-E2EA-D136-7155C9EBD573}"/>
                  </a:ext>
                </a:extLst>
              </p:cNvPr>
              <p:cNvSpPr txBox="1"/>
              <p:nvPr/>
            </p:nvSpPr>
            <p:spPr>
              <a:xfrm>
                <a:off x="6132513" y="4302038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34" name="TextBox 51">
                <a:extLst>
                  <a:ext uri="{FF2B5EF4-FFF2-40B4-BE49-F238E27FC236}">
                    <a16:creationId xmlns:a16="http://schemas.microsoft.com/office/drawing/2014/main" id="{3BDF15CB-37C6-4AF8-0F7A-9BB3C258321B}"/>
                  </a:ext>
                </a:extLst>
              </p:cNvPr>
              <p:cNvSpPr txBox="1"/>
              <p:nvPr/>
            </p:nvSpPr>
            <p:spPr>
              <a:xfrm>
                <a:off x="5905503" y="4287752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35" name="TextBox 51">
                <a:extLst>
                  <a:ext uri="{FF2B5EF4-FFF2-40B4-BE49-F238E27FC236}">
                    <a16:creationId xmlns:a16="http://schemas.microsoft.com/office/drawing/2014/main" id="{EFE08795-31ED-C66F-E753-C725D932B197}"/>
                  </a:ext>
                </a:extLst>
              </p:cNvPr>
              <p:cNvSpPr txBox="1"/>
              <p:nvPr/>
            </p:nvSpPr>
            <p:spPr>
              <a:xfrm>
                <a:off x="5675790" y="4292557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336" name="グループ化 335">
              <a:extLst>
                <a:ext uri="{FF2B5EF4-FFF2-40B4-BE49-F238E27FC236}">
                  <a16:creationId xmlns:a16="http://schemas.microsoft.com/office/drawing/2014/main" id="{2285B3A9-F727-1932-7DCF-1E7A3750584A}"/>
                </a:ext>
              </a:extLst>
            </p:cNvPr>
            <p:cNvGrpSpPr/>
            <p:nvPr/>
          </p:nvGrpSpPr>
          <p:grpSpPr>
            <a:xfrm>
              <a:off x="4991417" y="2244646"/>
              <a:ext cx="1340024" cy="584909"/>
              <a:chOff x="4991417" y="3830754"/>
              <a:chExt cx="1340024" cy="584909"/>
            </a:xfrm>
          </p:grpSpPr>
          <p:sp>
            <p:nvSpPr>
              <p:cNvPr id="337" name="TextBox 51">
                <a:extLst>
                  <a:ext uri="{FF2B5EF4-FFF2-40B4-BE49-F238E27FC236}">
                    <a16:creationId xmlns:a16="http://schemas.microsoft.com/office/drawing/2014/main" id="{A8380619-5940-D941-8D4E-9F0CBAA9D23D}"/>
                  </a:ext>
                </a:extLst>
              </p:cNvPr>
              <p:cNvSpPr txBox="1"/>
              <p:nvPr/>
            </p:nvSpPr>
            <p:spPr>
              <a:xfrm>
                <a:off x="5564831" y="4292552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38" name="TextBox 51">
                <a:extLst>
                  <a:ext uri="{FF2B5EF4-FFF2-40B4-BE49-F238E27FC236}">
                    <a16:creationId xmlns:a16="http://schemas.microsoft.com/office/drawing/2014/main" id="{49C166EA-045A-76A8-CD94-B8911FFC3B75}"/>
                  </a:ext>
                </a:extLst>
              </p:cNvPr>
              <p:cNvSpPr txBox="1"/>
              <p:nvPr/>
            </p:nvSpPr>
            <p:spPr>
              <a:xfrm>
                <a:off x="5449890" y="4290171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82" name="TextBox 51">
                <a:extLst>
                  <a:ext uri="{FF2B5EF4-FFF2-40B4-BE49-F238E27FC236}">
                    <a16:creationId xmlns:a16="http://schemas.microsoft.com/office/drawing/2014/main" id="{11E70D84-1315-8268-30FC-E6A78DC522A3}"/>
                  </a:ext>
                </a:extLst>
              </p:cNvPr>
              <p:cNvSpPr txBox="1"/>
              <p:nvPr/>
            </p:nvSpPr>
            <p:spPr>
              <a:xfrm>
                <a:off x="5334081" y="3830754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83" name="TextBox 51">
                <a:extLst>
                  <a:ext uri="{FF2B5EF4-FFF2-40B4-BE49-F238E27FC236}">
                    <a16:creationId xmlns:a16="http://schemas.microsoft.com/office/drawing/2014/main" id="{CFBE7AEA-50F1-798F-B28B-B56B25A7A518}"/>
                  </a:ext>
                </a:extLst>
              </p:cNvPr>
              <p:cNvSpPr txBox="1"/>
              <p:nvPr/>
            </p:nvSpPr>
            <p:spPr>
              <a:xfrm>
                <a:off x="4991417" y="4290171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84" name="TextBox 51">
                <a:extLst>
                  <a:ext uri="{FF2B5EF4-FFF2-40B4-BE49-F238E27FC236}">
                    <a16:creationId xmlns:a16="http://schemas.microsoft.com/office/drawing/2014/main" id="{3842DE32-4699-A3D1-AB6F-71EE42190B99}"/>
                  </a:ext>
                </a:extLst>
              </p:cNvPr>
              <p:cNvSpPr txBox="1"/>
              <p:nvPr/>
            </p:nvSpPr>
            <p:spPr>
              <a:xfrm>
                <a:off x="5792537" y="3975295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85" name="TextBox 51">
                <a:extLst>
                  <a:ext uri="{FF2B5EF4-FFF2-40B4-BE49-F238E27FC236}">
                    <a16:creationId xmlns:a16="http://schemas.microsoft.com/office/drawing/2014/main" id="{1B6A0682-62BA-FDE0-F53C-5DF1546C40C3}"/>
                  </a:ext>
                </a:extLst>
              </p:cNvPr>
              <p:cNvSpPr txBox="1"/>
              <p:nvPr/>
            </p:nvSpPr>
            <p:spPr>
              <a:xfrm>
                <a:off x="5218984" y="4290171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86" name="TextBox 51">
                <a:extLst>
                  <a:ext uri="{FF2B5EF4-FFF2-40B4-BE49-F238E27FC236}">
                    <a16:creationId xmlns:a16="http://schemas.microsoft.com/office/drawing/2014/main" id="{472EE064-2151-B03B-A2B7-BCB65EEDB957}"/>
                  </a:ext>
                </a:extLst>
              </p:cNvPr>
              <p:cNvSpPr txBox="1"/>
              <p:nvPr/>
            </p:nvSpPr>
            <p:spPr>
              <a:xfrm>
                <a:off x="6021891" y="4290171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87" name="TextBox 51">
                <a:extLst>
                  <a:ext uri="{FF2B5EF4-FFF2-40B4-BE49-F238E27FC236}">
                    <a16:creationId xmlns:a16="http://schemas.microsoft.com/office/drawing/2014/main" id="{BA0C90F8-F5FE-A1CB-A9CC-EB87FB95A014}"/>
                  </a:ext>
                </a:extLst>
              </p:cNvPr>
              <p:cNvSpPr txBox="1"/>
              <p:nvPr/>
            </p:nvSpPr>
            <p:spPr>
              <a:xfrm>
                <a:off x="6137275" y="4290171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88" name="TextBox 51">
                <a:extLst>
                  <a:ext uri="{FF2B5EF4-FFF2-40B4-BE49-F238E27FC236}">
                    <a16:creationId xmlns:a16="http://schemas.microsoft.com/office/drawing/2014/main" id="{B7593C6A-61D3-79E8-352F-AA4BA65228AC}"/>
                  </a:ext>
                </a:extLst>
              </p:cNvPr>
              <p:cNvSpPr txBox="1"/>
              <p:nvPr/>
            </p:nvSpPr>
            <p:spPr>
              <a:xfrm>
                <a:off x="5905503" y="4290171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391" name="TextBox 51">
                <a:extLst>
                  <a:ext uri="{FF2B5EF4-FFF2-40B4-BE49-F238E27FC236}">
                    <a16:creationId xmlns:a16="http://schemas.microsoft.com/office/drawing/2014/main" id="{8E5BE44B-AD6E-CB48-8556-55F1809F9F6F}"/>
                  </a:ext>
                </a:extLst>
              </p:cNvPr>
              <p:cNvSpPr txBox="1"/>
              <p:nvPr/>
            </p:nvSpPr>
            <p:spPr>
              <a:xfrm>
                <a:off x="5675790" y="4275885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414" name="グループ化 413">
              <a:extLst>
                <a:ext uri="{FF2B5EF4-FFF2-40B4-BE49-F238E27FC236}">
                  <a16:creationId xmlns:a16="http://schemas.microsoft.com/office/drawing/2014/main" id="{E0488100-1AAD-F575-B721-92A866C878F7}"/>
                </a:ext>
              </a:extLst>
            </p:cNvPr>
            <p:cNvGrpSpPr/>
            <p:nvPr/>
          </p:nvGrpSpPr>
          <p:grpSpPr>
            <a:xfrm>
              <a:off x="406628" y="2306560"/>
              <a:ext cx="1330500" cy="513627"/>
              <a:chOff x="4991417" y="3994858"/>
              <a:chExt cx="1330500" cy="513627"/>
            </a:xfrm>
          </p:grpSpPr>
          <p:sp>
            <p:nvSpPr>
              <p:cNvPr id="415" name="TextBox 51">
                <a:extLst>
                  <a:ext uri="{FF2B5EF4-FFF2-40B4-BE49-F238E27FC236}">
                    <a16:creationId xmlns:a16="http://schemas.microsoft.com/office/drawing/2014/main" id="{AC8A9836-C40B-833D-B3F4-7DAFE4B65961}"/>
                  </a:ext>
                </a:extLst>
              </p:cNvPr>
              <p:cNvSpPr txBox="1"/>
              <p:nvPr/>
            </p:nvSpPr>
            <p:spPr>
              <a:xfrm>
                <a:off x="5562450" y="4385374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17" name="TextBox 51">
                <a:extLst>
                  <a:ext uri="{FF2B5EF4-FFF2-40B4-BE49-F238E27FC236}">
                    <a16:creationId xmlns:a16="http://schemas.microsoft.com/office/drawing/2014/main" id="{83965A28-791D-485D-326B-28DED3822110}"/>
                  </a:ext>
                </a:extLst>
              </p:cNvPr>
              <p:cNvSpPr txBox="1"/>
              <p:nvPr/>
            </p:nvSpPr>
            <p:spPr>
              <a:xfrm>
                <a:off x="5442747" y="4371096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33" name="TextBox 51">
                <a:extLst>
                  <a:ext uri="{FF2B5EF4-FFF2-40B4-BE49-F238E27FC236}">
                    <a16:creationId xmlns:a16="http://schemas.microsoft.com/office/drawing/2014/main" id="{5EE128D0-C9CC-CFDF-31FF-8C9405028C51}"/>
                  </a:ext>
                </a:extLst>
              </p:cNvPr>
              <p:cNvSpPr txBox="1"/>
              <p:nvPr/>
            </p:nvSpPr>
            <p:spPr>
              <a:xfrm>
                <a:off x="5334081" y="3994858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34" name="TextBox 51">
                <a:extLst>
                  <a:ext uri="{FF2B5EF4-FFF2-40B4-BE49-F238E27FC236}">
                    <a16:creationId xmlns:a16="http://schemas.microsoft.com/office/drawing/2014/main" id="{E73B82FD-5B12-B9D9-382A-EA26D51284A2}"/>
                  </a:ext>
                </a:extLst>
              </p:cNvPr>
              <p:cNvSpPr txBox="1"/>
              <p:nvPr/>
            </p:nvSpPr>
            <p:spPr>
              <a:xfrm>
                <a:off x="4991417" y="4290133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35" name="TextBox 51">
                <a:extLst>
                  <a:ext uri="{FF2B5EF4-FFF2-40B4-BE49-F238E27FC236}">
                    <a16:creationId xmlns:a16="http://schemas.microsoft.com/office/drawing/2014/main" id="{ADE458BD-2C3A-1972-AF05-ACB28EE6CEF5}"/>
                  </a:ext>
                </a:extLst>
              </p:cNvPr>
              <p:cNvSpPr txBox="1"/>
              <p:nvPr/>
            </p:nvSpPr>
            <p:spPr>
              <a:xfrm>
                <a:off x="5787775" y="4268698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36" name="TextBox 51">
                <a:extLst>
                  <a:ext uri="{FF2B5EF4-FFF2-40B4-BE49-F238E27FC236}">
                    <a16:creationId xmlns:a16="http://schemas.microsoft.com/office/drawing/2014/main" id="{5D39A9B0-66DB-A202-6D15-176B7D1D08FC}"/>
                  </a:ext>
                </a:extLst>
              </p:cNvPr>
              <p:cNvSpPr txBox="1"/>
              <p:nvPr/>
            </p:nvSpPr>
            <p:spPr>
              <a:xfrm>
                <a:off x="5218984" y="4347285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37" name="TextBox 51">
                <a:extLst>
                  <a:ext uri="{FF2B5EF4-FFF2-40B4-BE49-F238E27FC236}">
                    <a16:creationId xmlns:a16="http://schemas.microsoft.com/office/drawing/2014/main" id="{AB3DD081-88CD-8ED9-A50F-24922ED38FD2}"/>
                  </a:ext>
                </a:extLst>
              </p:cNvPr>
              <p:cNvSpPr txBox="1"/>
              <p:nvPr/>
            </p:nvSpPr>
            <p:spPr>
              <a:xfrm>
                <a:off x="6014748" y="4340134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38" name="TextBox 51">
                <a:extLst>
                  <a:ext uri="{FF2B5EF4-FFF2-40B4-BE49-F238E27FC236}">
                    <a16:creationId xmlns:a16="http://schemas.microsoft.com/office/drawing/2014/main" id="{DC5BCBA8-39B7-8AC3-9171-9EF477CE4950}"/>
                  </a:ext>
                </a:extLst>
              </p:cNvPr>
              <p:cNvSpPr txBox="1"/>
              <p:nvPr/>
            </p:nvSpPr>
            <p:spPr>
              <a:xfrm>
                <a:off x="6127751" y="4294895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39" name="TextBox 51">
                <a:extLst>
                  <a:ext uri="{FF2B5EF4-FFF2-40B4-BE49-F238E27FC236}">
                    <a16:creationId xmlns:a16="http://schemas.microsoft.com/office/drawing/2014/main" id="{C6150C55-ECBF-8C3D-03FD-A6805388DA13}"/>
                  </a:ext>
                </a:extLst>
              </p:cNvPr>
              <p:cNvSpPr txBox="1"/>
              <p:nvPr/>
            </p:nvSpPr>
            <p:spPr>
              <a:xfrm>
                <a:off x="5903122" y="4282990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40" name="TextBox 51">
                <a:extLst>
                  <a:ext uri="{FF2B5EF4-FFF2-40B4-BE49-F238E27FC236}">
                    <a16:creationId xmlns:a16="http://schemas.microsoft.com/office/drawing/2014/main" id="{18AD280D-5D3C-6B95-3520-919CC16518E6}"/>
                  </a:ext>
                </a:extLst>
              </p:cNvPr>
              <p:cNvSpPr txBox="1"/>
              <p:nvPr/>
            </p:nvSpPr>
            <p:spPr>
              <a:xfrm>
                <a:off x="5673409" y="4294933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463" name="グループ化 462">
              <a:extLst>
                <a:ext uri="{FF2B5EF4-FFF2-40B4-BE49-F238E27FC236}">
                  <a16:creationId xmlns:a16="http://schemas.microsoft.com/office/drawing/2014/main" id="{3BDB0739-175D-E835-047E-C67BBDCDE216}"/>
                </a:ext>
              </a:extLst>
            </p:cNvPr>
            <p:cNvGrpSpPr/>
            <p:nvPr/>
          </p:nvGrpSpPr>
          <p:grpSpPr>
            <a:xfrm>
              <a:off x="1935180" y="3470568"/>
              <a:ext cx="1330500" cy="151683"/>
              <a:chOff x="4986655" y="4406803"/>
              <a:chExt cx="1330500" cy="151683"/>
            </a:xfrm>
          </p:grpSpPr>
          <p:sp>
            <p:nvSpPr>
              <p:cNvPr id="478" name="TextBox 51">
                <a:extLst>
                  <a:ext uri="{FF2B5EF4-FFF2-40B4-BE49-F238E27FC236}">
                    <a16:creationId xmlns:a16="http://schemas.microsoft.com/office/drawing/2014/main" id="{F36AB9A4-C1BB-F6A0-3783-0163863CCAFF}"/>
                  </a:ext>
                </a:extLst>
              </p:cNvPr>
              <p:cNvSpPr txBox="1"/>
              <p:nvPr/>
            </p:nvSpPr>
            <p:spPr>
              <a:xfrm>
                <a:off x="5329319" y="4406803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79" name="TextBox 51">
                <a:extLst>
                  <a:ext uri="{FF2B5EF4-FFF2-40B4-BE49-F238E27FC236}">
                    <a16:creationId xmlns:a16="http://schemas.microsoft.com/office/drawing/2014/main" id="{A022E029-301B-3765-7FFC-9C057A47673C}"/>
                  </a:ext>
                </a:extLst>
              </p:cNvPr>
              <p:cNvSpPr txBox="1"/>
              <p:nvPr/>
            </p:nvSpPr>
            <p:spPr>
              <a:xfrm>
                <a:off x="4986655" y="4435375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80" name="TextBox 51">
                <a:extLst>
                  <a:ext uri="{FF2B5EF4-FFF2-40B4-BE49-F238E27FC236}">
                    <a16:creationId xmlns:a16="http://schemas.microsoft.com/office/drawing/2014/main" id="{C2F468BB-79B7-7479-F27D-8989E86BC254}"/>
                  </a:ext>
                </a:extLst>
              </p:cNvPr>
              <p:cNvSpPr txBox="1"/>
              <p:nvPr/>
            </p:nvSpPr>
            <p:spPr>
              <a:xfrm>
                <a:off x="5783013" y="4435375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81" name="TextBox 51">
                <a:extLst>
                  <a:ext uri="{FF2B5EF4-FFF2-40B4-BE49-F238E27FC236}">
                    <a16:creationId xmlns:a16="http://schemas.microsoft.com/office/drawing/2014/main" id="{FBABC308-F275-3BA1-0CBA-6A05D36F4335}"/>
                  </a:ext>
                </a:extLst>
              </p:cNvPr>
              <p:cNvSpPr txBox="1"/>
              <p:nvPr/>
            </p:nvSpPr>
            <p:spPr>
              <a:xfrm>
                <a:off x="5214222" y="4435375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82" name="TextBox 51">
                <a:extLst>
                  <a:ext uri="{FF2B5EF4-FFF2-40B4-BE49-F238E27FC236}">
                    <a16:creationId xmlns:a16="http://schemas.microsoft.com/office/drawing/2014/main" id="{EAAD07ED-98C0-5FA8-86BB-1480C5B150C0}"/>
                  </a:ext>
                </a:extLst>
              </p:cNvPr>
              <p:cNvSpPr txBox="1"/>
              <p:nvPr/>
            </p:nvSpPr>
            <p:spPr>
              <a:xfrm>
                <a:off x="6009986" y="4435375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87" name="TextBox 51">
                <a:extLst>
                  <a:ext uri="{FF2B5EF4-FFF2-40B4-BE49-F238E27FC236}">
                    <a16:creationId xmlns:a16="http://schemas.microsoft.com/office/drawing/2014/main" id="{8F63E73D-C7EA-35CB-6AA5-F809F2B78FD9}"/>
                  </a:ext>
                </a:extLst>
              </p:cNvPr>
              <p:cNvSpPr txBox="1"/>
              <p:nvPr/>
            </p:nvSpPr>
            <p:spPr>
              <a:xfrm>
                <a:off x="6122989" y="4435375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88" name="TextBox 51">
                <a:extLst>
                  <a:ext uri="{FF2B5EF4-FFF2-40B4-BE49-F238E27FC236}">
                    <a16:creationId xmlns:a16="http://schemas.microsoft.com/office/drawing/2014/main" id="{68AC6A28-47CF-EE5A-ABF3-37441FDC37B7}"/>
                  </a:ext>
                </a:extLst>
              </p:cNvPr>
              <p:cNvSpPr txBox="1"/>
              <p:nvPr/>
            </p:nvSpPr>
            <p:spPr>
              <a:xfrm>
                <a:off x="5898360" y="4435375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89" name="TextBox 51">
                <a:extLst>
                  <a:ext uri="{FF2B5EF4-FFF2-40B4-BE49-F238E27FC236}">
                    <a16:creationId xmlns:a16="http://schemas.microsoft.com/office/drawing/2014/main" id="{17546136-BE43-D1C7-22AB-F3401F0EA10C}"/>
                  </a:ext>
                </a:extLst>
              </p:cNvPr>
              <p:cNvSpPr txBox="1"/>
              <p:nvPr/>
            </p:nvSpPr>
            <p:spPr>
              <a:xfrm>
                <a:off x="5668647" y="4435375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490" name="グループ化 489">
              <a:extLst>
                <a:ext uri="{FF2B5EF4-FFF2-40B4-BE49-F238E27FC236}">
                  <a16:creationId xmlns:a16="http://schemas.microsoft.com/office/drawing/2014/main" id="{F805F8DB-D2FC-099B-5C7C-CF6FC8D0B026}"/>
                </a:ext>
              </a:extLst>
            </p:cNvPr>
            <p:cNvGrpSpPr/>
            <p:nvPr/>
          </p:nvGrpSpPr>
          <p:grpSpPr>
            <a:xfrm>
              <a:off x="3464625" y="3278104"/>
              <a:ext cx="1340024" cy="339557"/>
              <a:chOff x="4991417" y="4095154"/>
              <a:chExt cx="1340024" cy="339557"/>
            </a:xfrm>
          </p:grpSpPr>
          <p:sp>
            <p:nvSpPr>
              <p:cNvPr id="491" name="TextBox 51">
                <a:extLst>
                  <a:ext uri="{FF2B5EF4-FFF2-40B4-BE49-F238E27FC236}">
                    <a16:creationId xmlns:a16="http://schemas.microsoft.com/office/drawing/2014/main" id="{E8CB4D79-D610-B590-FE47-38906F8A13A6}"/>
                  </a:ext>
                </a:extLst>
              </p:cNvPr>
              <p:cNvSpPr txBox="1"/>
              <p:nvPr/>
            </p:nvSpPr>
            <p:spPr>
              <a:xfrm>
                <a:off x="5564831" y="4306838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92" name="TextBox 51">
                <a:extLst>
                  <a:ext uri="{FF2B5EF4-FFF2-40B4-BE49-F238E27FC236}">
                    <a16:creationId xmlns:a16="http://schemas.microsoft.com/office/drawing/2014/main" id="{138E4EA7-DC24-E9FD-C2FA-93D6599CFF77}"/>
                  </a:ext>
                </a:extLst>
              </p:cNvPr>
              <p:cNvSpPr txBox="1"/>
              <p:nvPr/>
            </p:nvSpPr>
            <p:spPr>
              <a:xfrm>
                <a:off x="5449890" y="4290171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93" name="TextBox 51">
                <a:extLst>
                  <a:ext uri="{FF2B5EF4-FFF2-40B4-BE49-F238E27FC236}">
                    <a16:creationId xmlns:a16="http://schemas.microsoft.com/office/drawing/2014/main" id="{C3A13B87-B7E6-42CA-64C1-6F85B9592F94}"/>
                  </a:ext>
                </a:extLst>
              </p:cNvPr>
              <p:cNvSpPr txBox="1"/>
              <p:nvPr/>
            </p:nvSpPr>
            <p:spPr>
              <a:xfrm>
                <a:off x="5334081" y="4095154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494" name="TextBox 51">
                <a:extLst>
                  <a:ext uri="{FF2B5EF4-FFF2-40B4-BE49-F238E27FC236}">
                    <a16:creationId xmlns:a16="http://schemas.microsoft.com/office/drawing/2014/main" id="{674F6B11-BC63-052C-C192-FBEF2B25507E}"/>
                  </a:ext>
                </a:extLst>
              </p:cNvPr>
              <p:cNvSpPr txBox="1"/>
              <p:nvPr/>
            </p:nvSpPr>
            <p:spPr>
              <a:xfrm>
                <a:off x="4991417" y="4311600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05" name="TextBox 51">
                <a:extLst>
                  <a:ext uri="{FF2B5EF4-FFF2-40B4-BE49-F238E27FC236}">
                    <a16:creationId xmlns:a16="http://schemas.microsoft.com/office/drawing/2014/main" id="{08636B23-D3A7-367C-368B-3EEC5F287610}"/>
                  </a:ext>
                </a:extLst>
              </p:cNvPr>
              <p:cNvSpPr txBox="1"/>
              <p:nvPr/>
            </p:nvSpPr>
            <p:spPr>
              <a:xfrm>
                <a:off x="5790156" y="4299944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06" name="TextBox 51">
                <a:extLst>
                  <a:ext uri="{FF2B5EF4-FFF2-40B4-BE49-F238E27FC236}">
                    <a16:creationId xmlns:a16="http://schemas.microsoft.com/office/drawing/2014/main" id="{2EDE9983-9CFC-4A39-7389-681EA91A59D9}"/>
                  </a:ext>
                </a:extLst>
              </p:cNvPr>
              <p:cNvSpPr txBox="1"/>
              <p:nvPr/>
            </p:nvSpPr>
            <p:spPr>
              <a:xfrm>
                <a:off x="5216603" y="4311600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07" name="TextBox 51">
                <a:extLst>
                  <a:ext uri="{FF2B5EF4-FFF2-40B4-BE49-F238E27FC236}">
                    <a16:creationId xmlns:a16="http://schemas.microsoft.com/office/drawing/2014/main" id="{FB9E7053-7F1D-72B0-B07A-541E7F318E6B}"/>
                  </a:ext>
                </a:extLst>
              </p:cNvPr>
              <p:cNvSpPr txBox="1"/>
              <p:nvPr/>
            </p:nvSpPr>
            <p:spPr>
              <a:xfrm>
                <a:off x="6021891" y="4311600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08" name="TextBox 51">
                <a:extLst>
                  <a:ext uri="{FF2B5EF4-FFF2-40B4-BE49-F238E27FC236}">
                    <a16:creationId xmlns:a16="http://schemas.microsoft.com/office/drawing/2014/main" id="{A4A4BCF8-0DE5-7603-ED85-474DC4CAB085}"/>
                  </a:ext>
                </a:extLst>
              </p:cNvPr>
              <p:cNvSpPr txBox="1"/>
              <p:nvPr/>
            </p:nvSpPr>
            <p:spPr>
              <a:xfrm>
                <a:off x="6137275" y="4311600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09" name="TextBox 51">
                <a:extLst>
                  <a:ext uri="{FF2B5EF4-FFF2-40B4-BE49-F238E27FC236}">
                    <a16:creationId xmlns:a16="http://schemas.microsoft.com/office/drawing/2014/main" id="{374918CD-0FAC-4BA4-2731-5E483D77F647}"/>
                  </a:ext>
                </a:extLst>
              </p:cNvPr>
              <p:cNvSpPr txBox="1"/>
              <p:nvPr/>
            </p:nvSpPr>
            <p:spPr>
              <a:xfrm>
                <a:off x="5905503" y="4311600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10" name="TextBox 51">
                <a:extLst>
                  <a:ext uri="{FF2B5EF4-FFF2-40B4-BE49-F238E27FC236}">
                    <a16:creationId xmlns:a16="http://schemas.microsoft.com/office/drawing/2014/main" id="{61A4EC72-B834-209C-F8AE-1A749EFCCF2E}"/>
                  </a:ext>
                </a:extLst>
              </p:cNvPr>
              <p:cNvSpPr txBox="1"/>
              <p:nvPr/>
            </p:nvSpPr>
            <p:spPr>
              <a:xfrm>
                <a:off x="5675790" y="4294933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522" name="グループ化 521">
              <a:extLst>
                <a:ext uri="{FF2B5EF4-FFF2-40B4-BE49-F238E27FC236}">
                  <a16:creationId xmlns:a16="http://schemas.microsoft.com/office/drawing/2014/main" id="{07EA5BA7-6D1B-3C93-2A0E-CFE571E2AC64}"/>
                </a:ext>
              </a:extLst>
            </p:cNvPr>
            <p:cNvGrpSpPr/>
            <p:nvPr/>
          </p:nvGrpSpPr>
          <p:grpSpPr>
            <a:xfrm>
              <a:off x="1935180" y="3860804"/>
              <a:ext cx="1335262" cy="545305"/>
              <a:chOff x="4986655" y="3963599"/>
              <a:chExt cx="1335262" cy="545305"/>
            </a:xfrm>
          </p:grpSpPr>
          <p:sp>
            <p:nvSpPr>
              <p:cNvPr id="523" name="TextBox 51">
                <a:extLst>
                  <a:ext uri="{FF2B5EF4-FFF2-40B4-BE49-F238E27FC236}">
                    <a16:creationId xmlns:a16="http://schemas.microsoft.com/office/drawing/2014/main" id="{6AA17F1D-8900-0E9F-805B-48E04940B129}"/>
                  </a:ext>
                </a:extLst>
              </p:cNvPr>
              <p:cNvSpPr txBox="1"/>
              <p:nvPr/>
            </p:nvSpPr>
            <p:spPr>
              <a:xfrm>
                <a:off x="5562450" y="4385374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24" name="TextBox 51">
                <a:extLst>
                  <a:ext uri="{FF2B5EF4-FFF2-40B4-BE49-F238E27FC236}">
                    <a16:creationId xmlns:a16="http://schemas.microsoft.com/office/drawing/2014/main" id="{334546D1-71B3-5CFC-1B0D-6292EC918AEC}"/>
                  </a:ext>
                </a:extLst>
              </p:cNvPr>
              <p:cNvSpPr txBox="1"/>
              <p:nvPr/>
            </p:nvSpPr>
            <p:spPr>
              <a:xfrm>
                <a:off x="5442747" y="4371096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525" name="TextBox 51">
                <a:extLst>
                  <a:ext uri="{FF2B5EF4-FFF2-40B4-BE49-F238E27FC236}">
                    <a16:creationId xmlns:a16="http://schemas.microsoft.com/office/drawing/2014/main" id="{8EDDE059-958F-199B-EB18-42B711FDF139}"/>
                  </a:ext>
                </a:extLst>
              </p:cNvPr>
              <p:cNvSpPr txBox="1"/>
              <p:nvPr/>
            </p:nvSpPr>
            <p:spPr>
              <a:xfrm>
                <a:off x="5331700" y="3963599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26" name="TextBox 51">
                <a:extLst>
                  <a:ext uri="{FF2B5EF4-FFF2-40B4-BE49-F238E27FC236}">
                    <a16:creationId xmlns:a16="http://schemas.microsoft.com/office/drawing/2014/main" id="{ED927DA5-6284-547F-3CF9-AAD2C15B9C3E}"/>
                  </a:ext>
                </a:extLst>
              </p:cNvPr>
              <p:cNvSpPr txBox="1"/>
              <p:nvPr/>
            </p:nvSpPr>
            <p:spPr>
              <a:xfrm>
                <a:off x="4986655" y="4385076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527" name="TextBox 51">
                <a:extLst>
                  <a:ext uri="{FF2B5EF4-FFF2-40B4-BE49-F238E27FC236}">
                    <a16:creationId xmlns:a16="http://schemas.microsoft.com/office/drawing/2014/main" id="{9984181A-D97C-C647-8CC5-C3C93B1861DE}"/>
                  </a:ext>
                </a:extLst>
              </p:cNvPr>
              <p:cNvSpPr txBox="1"/>
              <p:nvPr/>
            </p:nvSpPr>
            <p:spPr>
              <a:xfrm>
                <a:off x="5787775" y="4054802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28" name="TextBox 51">
                <a:extLst>
                  <a:ext uri="{FF2B5EF4-FFF2-40B4-BE49-F238E27FC236}">
                    <a16:creationId xmlns:a16="http://schemas.microsoft.com/office/drawing/2014/main" id="{A2347B0C-9EBD-603C-46EF-90408D5BC1C9}"/>
                  </a:ext>
                </a:extLst>
              </p:cNvPr>
              <p:cNvSpPr txBox="1"/>
              <p:nvPr/>
            </p:nvSpPr>
            <p:spPr>
              <a:xfrm>
                <a:off x="5214222" y="4385793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29" name="TextBox 51">
                <a:extLst>
                  <a:ext uri="{FF2B5EF4-FFF2-40B4-BE49-F238E27FC236}">
                    <a16:creationId xmlns:a16="http://schemas.microsoft.com/office/drawing/2014/main" id="{758C57A5-8CCD-8A29-CED9-6CE0F4302BDC}"/>
                  </a:ext>
                </a:extLst>
              </p:cNvPr>
              <p:cNvSpPr txBox="1"/>
              <p:nvPr/>
            </p:nvSpPr>
            <p:spPr>
              <a:xfrm>
                <a:off x="6014748" y="4385793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30" name="TextBox 51">
                <a:extLst>
                  <a:ext uri="{FF2B5EF4-FFF2-40B4-BE49-F238E27FC236}">
                    <a16:creationId xmlns:a16="http://schemas.microsoft.com/office/drawing/2014/main" id="{499AD077-150A-B5AC-616B-3AF21069957D}"/>
                  </a:ext>
                </a:extLst>
              </p:cNvPr>
              <p:cNvSpPr txBox="1"/>
              <p:nvPr/>
            </p:nvSpPr>
            <p:spPr>
              <a:xfrm>
                <a:off x="6127751" y="4383412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531" name="TextBox 51">
                <a:extLst>
                  <a:ext uri="{FF2B5EF4-FFF2-40B4-BE49-F238E27FC236}">
                    <a16:creationId xmlns:a16="http://schemas.microsoft.com/office/drawing/2014/main" id="{F9B5D357-0452-096D-86A6-FA96916A6D4D}"/>
                  </a:ext>
                </a:extLst>
              </p:cNvPr>
              <p:cNvSpPr txBox="1"/>
              <p:nvPr/>
            </p:nvSpPr>
            <p:spPr>
              <a:xfrm>
                <a:off x="5898360" y="4385076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  <p:grpSp>
          <p:nvGrpSpPr>
            <p:cNvPr id="533" name="グループ化 532">
              <a:extLst>
                <a:ext uri="{FF2B5EF4-FFF2-40B4-BE49-F238E27FC236}">
                  <a16:creationId xmlns:a16="http://schemas.microsoft.com/office/drawing/2014/main" id="{DCC12391-232F-C801-743A-F49F389B83EC}"/>
                </a:ext>
              </a:extLst>
            </p:cNvPr>
            <p:cNvGrpSpPr/>
            <p:nvPr/>
          </p:nvGrpSpPr>
          <p:grpSpPr>
            <a:xfrm>
              <a:off x="3464625" y="3894138"/>
              <a:ext cx="1340024" cy="523397"/>
              <a:chOff x="4991417" y="3916076"/>
              <a:chExt cx="1340024" cy="523397"/>
            </a:xfrm>
          </p:grpSpPr>
          <p:sp>
            <p:nvSpPr>
              <p:cNvPr id="534" name="TextBox 51">
                <a:extLst>
                  <a:ext uri="{FF2B5EF4-FFF2-40B4-BE49-F238E27FC236}">
                    <a16:creationId xmlns:a16="http://schemas.microsoft.com/office/drawing/2014/main" id="{068C6654-E3FA-E386-4991-5BB268B675DB}"/>
                  </a:ext>
                </a:extLst>
              </p:cNvPr>
              <p:cNvSpPr txBox="1"/>
              <p:nvPr/>
            </p:nvSpPr>
            <p:spPr>
              <a:xfrm>
                <a:off x="5564831" y="4316362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35" name="TextBox 51">
                <a:extLst>
                  <a:ext uri="{FF2B5EF4-FFF2-40B4-BE49-F238E27FC236}">
                    <a16:creationId xmlns:a16="http://schemas.microsoft.com/office/drawing/2014/main" id="{560E4BC0-4FAB-BB40-DA00-0C7B024355D4}"/>
                  </a:ext>
                </a:extLst>
              </p:cNvPr>
              <p:cNvSpPr txBox="1"/>
              <p:nvPr/>
            </p:nvSpPr>
            <p:spPr>
              <a:xfrm>
                <a:off x="5447509" y="4254454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36" name="TextBox 51">
                <a:extLst>
                  <a:ext uri="{FF2B5EF4-FFF2-40B4-BE49-F238E27FC236}">
                    <a16:creationId xmlns:a16="http://schemas.microsoft.com/office/drawing/2014/main" id="{43F6B058-E42F-B349-ED68-D89524E72D79}"/>
                  </a:ext>
                </a:extLst>
              </p:cNvPr>
              <p:cNvSpPr txBox="1"/>
              <p:nvPr/>
            </p:nvSpPr>
            <p:spPr>
              <a:xfrm>
                <a:off x="5334081" y="3916076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37" name="TextBox 51">
                <a:extLst>
                  <a:ext uri="{FF2B5EF4-FFF2-40B4-BE49-F238E27FC236}">
                    <a16:creationId xmlns:a16="http://schemas.microsoft.com/office/drawing/2014/main" id="{CFBEB7C9-35C0-9A33-DCF6-6E7F84627595}"/>
                  </a:ext>
                </a:extLst>
              </p:cNvPr>
              <p:cNvSpPr txBox="1"/>
              <p:nvPr/>
            </p:nvSpPr>
            <p:spPr>
              <a:xfrm>
                <a:off x="4991417" y="4311600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38" name="TextBox 51">
                <a:extLst>
                  <a:ext uri="{FF2B5EF4-FFF2-40B4-BE49-F238E27FC236}">
                    <a16:creationId xmlns:a16="http://schemas.microsoft.com/office/drawing/2014/main" id="{6206D7C9-F81E-1FDA-73FD-53CECE079F16}"/>
                  </a:ext>
                </a:extLst>
              </p:cNvPr>
              <p:cNvSpPr txBox="1"/>
              <p:nvPr/>
            </p:nvSpPr>
            <p:spPr>
              <a:xfrm>
                <a:off x="5790156" y="4252546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39" name="TextBox 51">
                <a:extLst>
                  <a:ext uri="{FF2B5EF4-FFF2-40B4-BE49-F238E27FC236}">
                    <a16:creationId xmlns:a16="http://schemas.microsoft.com/office/drawing/2014/main" id="{047361C1-F8B5-72BC-B647-F901293DB551}"/>
                  </a:ext>
                </a:extLst>
              </p:cNvPr>
              <p:cNvSpPr txBox="1"/>
              <p:nvPr/>
            </p:nvSpPr>
            <p:spPr>
              <a:xfrm>
                <a:off x="5216603" y="4313981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40" name="TextBox 51">
                <a:extLst>
                  <a:ext uri="{FF2B5EF4-FFF2-40B4-BE49-F238E27FC236}">
                    <a16:creationId xmlns:a16="http://schemas.microsoft.com/office/drawing/2014/main" id="{C9AE5D58-F51C-E15A-73AB-FECE52138240}"/>
                  </a:ext>
                </a:extLst>
              </p:cNvPr>
              <p:cNvSpPr txBox="1"/>
              <p:nvPr/>
            </p:nvSpPr>
            <p:spPr>
              <a:xfrm>
                <a:off x="6021891" y="4316362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41" name="TextBox 51">
                <a:extLst>
                  <a:ext uri="{FF2B5EF4-FFF2-40B4-BE49-F238E27FC236}">
                    <a16:creationId xmlns:a16="http://schemas.microsoft.com/office/drawing/2014/main" id="{C5590726-852B-3241-2B48-E66FE07D8B4D}"/>
                  </a:ext>
                </a:extLst>
              </p:cNvPr>
              <p:cNvSpPr txBox="1"/>
              <p:nvPr/>
            </p:nvSpPr>
            <p:spPr>
              <a:xfrm>
                <a:off x="6137275" y="4311600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42" name="TextBox 51">
                <a:extLst>
                  <a:ext uri="{FF2B5EF4-FFF2-40B4-BE49-F238E27FC236}">
                    <a16:creationId xmlns:a16="http://schemas.microsoft.com/office/drawing/2014/main" id="{28F32DEF-B051-1B96-CA94-F6A406482E77}"/>
                  </a:ext>
                </a:extLst>
              </p:cNvPr>
              <p:cNvSpPr txBox="1"/>
              <p:nvPr/>
            </p:nvSpPr>
            <p:spPr>
              <a:xfrm>
                <a:off x="5905503" y="4311600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43" name="TextBox 51">
                <a:extLst>
                  <a:ext uri="{FF2B5EF4-FFF2-40B4-BE49-F238E27FC236}">
                    <a16:creationId xmlns:a16="http://schemas.microsoft.com/office/drawing/2014/main" id="{71726B9D-8245-0C16-057B-026E753439C7}"/>
                  </a:ext>
                </a:extLst>
              </p:cNvPr>
              <p:cNvSpPr txBox="1"/>
              <p:nvPr/>
            </p:nvSpPr>
            <p:spPr>
              <a:xfrm>
                <a:off x="5675790" y="4294933"/>
                <a:ext cx="194166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B1FA2912-794F-298E-EF57-BF9648D9E4A9}"/>
              </a:ext>
            </a:extLst>
          </p:cNvPr>
          <p:cNvGrpSpPr/>
          <p:nvPr/>
        </p:nvGrpSpPr>
        <p:grpSpPr>
          <a:xfrm>
            <a:off x="-27941" y="3444081"/>
            <a:ext cx="5703928" cy="1610752"/>
            <a:chOff x="-27941" y="291453"/>
            <a:chExt cx="5703928" cy="1610752"/>
          </a:xfrm>
        </p:grpSpPr>
        <p:graphicFrame>
          <p:nvGraphicFramePr>
            <p:cNvPr id="307" name="オブジェクト 7">
              <a:extLst>
                <a:ext uri="{FF2B5EF4-FFF2-40B4-BE49-F238E27FC236}">
                  <a16:creationId xmlns:a16="http://schemas.microsoft.com/office/drawing/2014/main" id="{C503BBAF-7EDE-6B59-CFD9-8FBAC765002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43559891"/>
                </p:ext>
              </p:extLst>
            </p:nvPr>
          </p:nvGraphicFramePr>
          <p:xfrm>
            <a:off x="565150" y="291453"/>
            <a:ext cx="3590925" cy="15922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5" r:id="rId4" imgW="4742640" imgH="2109240" progId="Prism5.Document">
                    <p:embed/>
                  </p:oleObj>
                </mc:Choice>
                <mc:Fallback>
                  <p:oleObj name="Prism 5" r:id="rId4" imgW="4742640" imgH="2109240" progId="Prism5.Document">
                    <p:embed/>
                    <p:pic>
                      <p:nvPicPr>
                        <p:cNvPr id="307" name="オブジェクト 7">
                          <a:extLst>
                            <a:ext uri="{FF2B5EF4-FFF2-40B4-BE49-F238E27FC236}">
                              <a16:creationId xmlns:a16="http://schemas.microsoft.com/office/drawing/2014/main" id="{C503BBAF-7EDE-6B59-CFD9-8FBAC765002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565150" y="291453"/>
                          <a:ext cx="3590925" cy="15922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" name="TextBox 5">
              <a:extLst>
                <a:ext uri="{FF2B5EF4-FFF2-40B4-BE49-F238E27FC236}">
                  <a16:creationId xmlns:a16="http://schemas.microsoft.com/office/drawing/2014/main" id="{F387FBCD-2B6F-40EC-A353-B2F78D970D48}"/>
                </a:ext>
              </a:extLst>
            </p:cNvPr>
            <p:cNvSpPr txBox="1"/>
            <p:nvPr/>
          </p:nvSpPr>
          <p:spPr>
            <a:xfrm>
              <a:off x="-27941" y="296002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itchFamily="34" charset="0"/>
                  <a:cs typeface="Arial" pitchFamily="34" charset="0"/>
                </a:rPr>
                <a:t>B</a:t>
              </a:r>
            </a:p>
          </p:txBody>
        </p:sp>
        <p:sp>
          <p:nvSpPr>
            <p:cNvPr id="16" name="テキスト ボックス 586">
              <a:extLst>
                <a:ext uri="{FF2B5EF4-FFF2-40B4-BE49-F238E27FC236}">
                  <a16:creationId xmlns:a16="http://schemas.microsoft.com/office/drawing/2014/main" id="{D452671A-367E-AB7A-5A6D-2F2AF52886BD}"/>
                </a:ext>
              </a:extLst>
            </p:cNvPr>
            <p:cNvSpPr txBox="1"/>
            <p:nvPr/>
          </p:nvSpPr>
          <p:spPr>
            <a:xfrm rot="16200000">
              <a:off x="-324890" y="973614"/>
              <a:ext cx="135238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itchFamily="34" charset="0"/>
                  <a:cs typeface="Arial" pitchFamily="34" charset="0"/>
                </a:rPr>
                <a:t>Relative DMSO2 concentration (%)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7" name="グループ化 16">
              <a:extLst>
                <a:ext uri="{FF2B5EF4-FFF2-40B4-BE49-F238E27FC236}">
                  <a16:creationId xmlns:a16="http://schemas.microsoft.com/office/drawing/2014/main" id="{3C5CBD92-D0DE-53A6-E20C-6C0700145DB8}"/>
                </a:ext>
              </a:extLst>
            </p:cNvPr>
            <p:cNvGrpSpPr/>
            <p:nvPr/>
          </p:nvGrpSpPr>
          <p:grpSpPr>
            <a:xfrm>
              <a:off x="517568" y="497479"/>
              <a:ext cx="366670" cy="1238537"/>
              <a:chOff x="429445" y="654943"/>
              <a:chExt cx="366670" cy="1238537"/>
            </a:xfrm>
          </p:grpSpPr>
          <p:sp>
            <p:nvSpPr>
              <p:cNvPr id="37" name="TextBox 51">
                <a:extLst>
                  <a:ext uri="{FF2B5EF4-FFF2-40B4-BE49-F238E27FC236}">
                    <a16:creationId xmlns:a16="http://schemas.microsoft.com/office/drawing/2014/main" id="{DEF446A4-0401-574B-CEED-B6ED1ED7585C}"/>
                  </a:ext>
                </a:extLst>
              </p:cNvPr>
              <p:cNvSpPr txBox="1"/>
              <p:nvPr/>
            </p:nvSpPr>
            <p:spPr>
              <a:xfrm>
                <a:off x="429445" y="1088803"/>
                <a:ext cx="36667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38" name="TextBox 51">
                <a:extLst>
                  <a:ext uri="{FF2B5EF4-FFF2-40B4-BE49-F238E27FC236}">
                    <a16:creationId xmlns:a16="http://schemas.microsoft.com/office/drawing/2014/main" id="{8F85CA61-371C-CD68-9AA0-6DBCBD6A6D12}"/>
                  </a:ext>
                </a:extLst>
              </p:cNvPr>
              <p:cNvSpPr txBox="1"/>
              <p:nvPr/>
            </p:nvSpPr>
            <p:spPr>
              <a:xfrm>
                <a:off x="429445" y="1522663"/>
                <a:ext cx="31110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</a:p>
            </p:txBody>
          </p:sp>
          <p:sp>
            <p:nvSpPr>
              <p:cNvPr id="39" name="TextBox 61">
                <a:extLst>
                  <a:ext uri="{FF2B5EF4-FFF2-40B4-BE49-F238E27FC236}">
                    <a16:creationId xmlns:a16="http://schemas.microsoft.com/office/drawing/2014/main" id="{6ACC11E5-343C-2D93-9107-56A74C9D1B94}"/>
                  </a:ext>
                </a:extLst>
              </p:cNvPr>
              <p:cNvSpPr txBox="1"/>
              <p:nvPr/>
            </p:nvSpPr>
            <p:spPr>
              <a:xfrm>
                <a:off x="429445" y="1305733"/>
                <a:ext cx="311112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Box 51">
                <a:extLst>
                  <a:ext uri="{FF2B5EF4-FFF2-40B4-BE49-F238E27FC236}">
                    <a16:creationId xmlns:a16="http://schemas.microsoft.com/office/drawing/2014/main" id="{C13E3DF2-F7BB-3E2F-7380-30C8BE42030C}"/>
                  </a:ext>
                </a:extLst>
              </p:cNvPr>
              <p:cNvSpPr txBox="1"/>
              <p:nvPr/>
            </p:nvSpPr>
            <p:spPr>
              <a:xfrm>
                <a:off x="429445" y="871873"/>
                <a:ext cx="36667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41" name="TextBox 51">
                <a:extLst>
                  <a:ext uri="{FF2B5EF4-FFF2-40B4-BE49-F238E27FC236}">
                    <a16:creationId xmlns:a16="http://schemas.microsoft.com/office/drawing/2014/main" id="{6BE4265D-2297-68B5-1F48-2BBFD9626769}"/>
                  </a:ext>
                </a:extLst>
              </p:cNvPr>
              <p:cNvSpPr txBox="1"/>
              <p:nvPr/>
            </p:nvSpPr>
            <p:spPr>
              <a:xfrm>
                <a:off x="429445" y="654943"/>
                <a:ext cx="36667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42" name="TextBox 51">
                <a:extLst>
                  <a:ext uri="{FF2B5EF4-FFF2-40B4-BE49-F238E27FC236}">
                    <a16:creationId xmlns:a16="http://schemas.microsoft.com/office/drawing/2014/main" id="{55AF8DF8-9AC2-C5DB-E22C-21935EF4F2BD}"/>
                  </a:ext>
                </a:extLst>
              </p:cNvPr>
              <p:cNvSpPr txBox="1"/>
              <p:nvPr/>
            </p:nvSpPr>
            <p:spPr>
              <a:xfrm>
                <a:off x="429445" y="1739592"/>
                <a:ext cx="31110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endParaRPr lang="en-US" sz="10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6" name="TextBox 83">
              <a:extLst>
                <a:ext uri="{FF2B5EF4-FFF2-40B4-BE49-F238E27FC236}">
                  <a16:creationId xmlns:a16="http://schemas.microsoft.com/office/drawing/2014/main" id="{12B07397-AE35-EACD-FFAC-DF88CDD5B2D2}"/>
                </a:ext>
              </a:extLst>
            </p:cNvPr>
            <p:cNvSpPr txBox="1"/>
            <p:nvPr/>
          </p:nvSpPr>
          <p:spPr>
            <a:xfrm>
              <a:off x="1840671" y="1655984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days)</a:t>
              </a:r>
            </a:p>
          </p:txBody>
        </p:sp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77197F54-D058-B9C1-ADB9-1447F9EBBB35}"/>
                </a:ext>
              </a:extLst>
            </p:cNvPr>
            <p:cNvGrpSpPr/>
            <p:nvPr/>
          </p:nvGrpSpPr>
          <p:grpSpPr>
            <a:xfrm>
              <a:off x="710286" y="1702150"/>
              <a:ext cx="1190744" cy="153888"/>
              <a:chOff x="654628" y="1869613"/>
              <a:chExt cx="1190744" cy="153888"/>
            </a:xfrm>
          </p:grpSpPr>
          <p:sp>
            <p:nvSpPr>
              <p:cNvPr id="71" name="TextBox 51">
                <a:extLst>
                  <a:ext uri="{FF2B5EF4-FFF2-40B4-BE49-F238E27FC236}">
                    <a16:creationId xmlns:a16="http://schemas.microsoft.com/office/drawing/2014/main" id="{BB15B069-8170-2F82-68F1-2CB7A8FA5EF5}"/>
                  </a:ext>
                </a:extLst>
              </p:cNvPr>
              <p:cNvSpPr txBox="1"/>
              <p:nvPr/>
            </p:nvSpPr>
            <p:spPr>
              <a:xfrm>
                <a:off x="925390" y="1869613"/>
                <a:ext cx="10769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n-US" sz="1000" b="1" dirty="0"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TextBox 61">
                <a:extLst>
                  <a:ext uri="{FF2B5EF4-FFF2-40B4-BE49-F238E27FC236}">
                    <a16:creationId xmlns:a16="http://schemas.microsoft.com/office/drawing/2014/main" id="{8E0AB115-19AD-2E69-D456-C4A65ADFBADA}"/>
                  </a:ext>
                </a:extLst>
              </p:cNvPr>
              <p:cNvSpPr txBox="1"/>
              <p:nvPr/>
            </p:nvSpPr>
            <p:spPr>
              <a:xfrm>
                <a:off x="1196152" y="1869613"/>
                <a:ext cx="10769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Box 51">
                <a:extLst>
                  <a:ext uri="{FF2B5EF4-FFF2-40B4-BE49-F238E27FC236}">
                    <a16:creationId xmlns:a16="http://schemas.microsoft.com/office/drawing/2014/main" id="{36BF2A1F-9CFA-731B-E7C0-2D686096B6F5}"/>
                  </a:ext>
                </a:extLst>
              </p:cNvPr>
              <p:cNvSpPr txBox="1"/>
              <p:nvPr/>
            </p:nvSpPr>
            <p:spPr>
              <a:xfrm>
                <a:off x="1466914" y="1869613"/>
                <a:ext cx="10769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TextBox 51">
                <a:extLst>
                  <a:ext uri="{FF2B5EF4-FFF2-40B4-BE49-F238E27FC236}">
                    <a16:creationId xmlns:a16="http://schemas.microsoft.com/office/drawing/2014/main" id="{5EBA4F53-F9E0-45C1-5B23-A85D1F16816B}"/>
                  </a:ext>
                </a:extLst>
              </p:cNvPr>
              <p:cNvSpPr txBox="1"/>
              <p:nvPr/>
            </p:nvSpPr>
            <p:spPr>
              <a:xfrm>
                <a:off x="1737675" y="1869613"/>
                <a:ext cx="10769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50" name="TextBox 51">
                <a:extLst>
                  <a:ext uri="{FF2B5EF4-FFF2-40B4-BE49-F238E27FC236}">
                    <a16:creationId xmlns:a16="http://schemas.microsoft.com/office/drawing/2014/main" id="{F9F99A9D-21D3-6358-9495-6DB0B21FE37F}"/>
                  </a:ext>
                </a:extLst>
              </p:cNvPr>
              <p:cNvSpPr txBox="1"/>
              <p:nvPr/>
            </p:nvSpPr>
            <p:spPr>
              <a:xfrm>
                <a:off x="654628" y="1869613"/>
                <a:ext cx="10769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1000" b="1" dirty="0"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1" name="テキスト ボックス 586">
              <a:extLst>
                <a:ext uri="{FF2B5EF4-FFF2-40B4-BE49-F238E27FC236}">
                  <a16:creationId xmlns:a16="http://schemas.microsoft.com/office/drawing/2014/main" id="{E58DFC3E-79E5-5537-3484-E93B22DDBAC7}"/>
                </a:ext>
              </a:extLst>
            </p:cNvPr>
            <p:cNvSpPr txBox="1"/>
            <p:nvPr/>
          </p:nvSpPr>
          <p:spPr>
            <a:xfrm rot="16200000">
              <a:off x="1834424" y="973614"/>
              <a:ext cx="127139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b="1" dirty="0">
                  <a:latin typeface="Arial" pitchFamily="34" charset="0"/>
                  <a:cs typeface="Arial" pitchFamily="34" charset="0"/>
                </a:rPr>
                <a:t>Relative DMSO concentration (%)</a:t>
              </a:r>
              <a:endParaRPr kumimoji="1" lang="ja-JP" alt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C9E6CDF4-8527-82BC-3A03-B7CB89639AEF}"/>
                </a:ext>
              </a:extLst>
            </p:cNvPr>
            <p:cNvSpPr txBox="1"/>
            <p:nvPr/>
          </p:nvSpPr>
          <p:spPr>
            <a:xfrm>
              <a:off x="3955065" y="1655984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days)</a:t>
              </a:r>
            </a:p>
          </p:txBody>
        </p:sp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654D3678-81C0-02ED-F7F6-8F0C9F5016B8}"/>
                </a:ext>
              </a:extLst>
            </p:cNvPr>
            <p:cNvGrpSpPr/>
            <p:nvPr/>
          </p:nvGrpSpPr>
          <p:grpSpPr>
            <a:xfrm>
              <a:off x="2838569" y="1702150"/>
              <a:ext cx="1192333" cy="153888"/>
              <a:chOff x="2607501" y="1869613"/>
              <a:chExt cx="1192333" cy="153888"/>
            </a:xfrm>
          </p:grpSpPr>
          <p:sp>
            <p:nvSpPr>
              <p:cNvPr id="86" name="TextBox 51">
                <a:extLst>
                  <a:ext uri="{FF2B5EF4-FFF2-40B4-BE49-F238E27FC236}">
                    <a16:creationId xmlns:a16="http://schemas.microsoft.com/office/drawing/2014/main" id="{5ACD79C7-991E-FE7C-A26F-B0935DA42F53}"/>
                  </a:ext>
                </a:extLst>
              </p:cNvPr>
              <p:cNvSpPr txBox="1"/>
              <p:nvPr/>
            </p:nvSpPr>
            <p:spPr>
              <a:xfrm>
                <a:off x="2878660" y="1869613"/>
                <a:ext cx="10769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en-US" sz="1000" b="1" dirty="0"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TextBox 61">
                <a:extLst>
                  <a:ext uri="{FF2B5EF4-FFF2-40B4-BE49-F238E27FC236}">
                    <a16:creationId xmlns:a16="http://schemas.microsoft.com/office/drawing/2014/main" id="{A59ABE13-44B1-E7FB-55E3-0E5ABC5AB707}"/>
                  </a:ext>
                </a:extLst>
              </p:cNvPr>
              <p:cNvSpPr txBox="1"/>
              <p:nvPr/>
            </p:nvSpPr>
            <p:spPr>
              <a:xfrm>
                <a:off x="3149819" y="1869613"/>
                <a:ext cx="10769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2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TextBox 51">
                <a:extLst>
                  <a:ext uri="{FF2B5EF4-FFF2-40B4-BE49-F238E27FC236}">
                    <a16:creationId xmlns:a16="http://schemas.microsoft.com/office/drawing/2014/main" id="{7A94EBA3-C194-B4EE-980A-FE09D16FE861}"/>
                  </a:ext>
                </a:extLst>
              </p:cNvPr>
              <p:cNvSpPr txBox="1"/>
              <p:nvPr/>
            </p:nvSpPr>
            <p:spPr>
              <a:xfrm>
                <a:off x="3420978" y="1869613"/>
                <a:ext cx="10769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TextBox 51">
                <a:extLst>
                  <a:ext uri="{FF2B5EF4-FFF2-40B4-BE49-F238E27FC236}">
                    <a16:creationId xmlns:a16="http://schemas.microsoft.com/office/drawing/2014/main" id="{11F57E60-0758-4E88-DD2D-A07645FDD071}"/>
                  </a:ext>
                </a:extLst>
              </p:cNvPr>
              <p:cNvSpPr txBox="1"/>
              <p:nvPr/>
            </p:nvSpPr>
            <p:spPr>
              <a:xfrm>
                <a:off x="3692137" y="1869613"/>
                <a:ext cx="10769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</a:p>
            </p:txBody>
          </p:sp>
          <p:sp>
            <p:nvSpPr>
              <p:cNvPr id="90" name="TextBox 51">
                <a:extLst>
                  <a:ext uri="{FF2B5EF4-FFF2-40B4-BE49-F238E27FC236}">
                    <a16:creationId xmlns:a16="http://schemas.microsoft.com/office/drawing/2014/main" id="{31393EC7-9D5A-B72A-67DF-183BC05CBF80}"/>
                  </a:ext>
                </a:extLst>
              </p:cNvPr>
              <p:cNvSpPr txBox="1"/>
              <p:nvPr/>
            </p:nvSpPr>
            <p:spPr>
              <a:xfrm>
                <a:off x="2607501" y="1869613"/>
                <a:ext cx="10769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1000" b="1" dirty="0"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9" name="グループ化 16">
              <a:extLst>
                <a:ext uri="{FF2B5EF4-FFF2-40B4-BE49-F238E27FC236}">
                  <a16:creationId xmlns:a16="http://schemas.microsoft.com/office/drawing/2014/main" id="{0A92202C-A5E4-0AE6-DE3E-4D54A300576D}"/>
                </a:ext>
              </a:extLst>
            </p:cNvPr>
            <p:cNvGrpSpPr/>
            <p:nvPr/>
          </p:nvGrpSpPr>
          <p:grpSpPr>
            <a:xfrm>
              <a:off x="2638970" y="497479"/>
              <a:ext cx="366670" cy="1238537"/>
              <a:chOff x="429445" y="654943"/>
              <a:chExt cx="366670" cy="1238537"/>
            </a:xfrm>
          </p:grpSpPr>
          <p:sp>
            <p:nvSpPr>
              <p:cNvPr id="300" name="TextBox 51">
                <a:extLst>
                  <a:ext uri="{FF2B5EF4-FFF2-40B4-BE49-F238E27FC236}">
                    <a16:creationId xmlns:a16="http://schemas.microsoft.com/office/drawing/2014/main" id="{53700882-8B08-4C27-D394-4B2380961249}"/>
                  </a:ext>
                </a:extLst>
              </p:cNvPr>
              <p:cNvSpPr txBox="1"/>
              <p:nvPr/>
            </p:nvSpPr>
            <p:spPr>
              <a:xfrm>
                <a:off x="429445" y="1088803"/>
                <a:ext cx="36667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301" name="TextBox 51">
                <a:extLst>
                  <a:ext uri="{FF2B5EF4-FFF2-40B4-BE49-F238E27FC236}">
                    <a16:creationId xmlns:a16="http://schemas.microsoft.com/office/drawing/2014/main" id="{7FCC4DBF-9C84-AB6F-1604-A3F776F05056}"/>
                  </a:ext>
                </a:extLst>
              </p:cNvPr>
              <p:cNvSpPr txBox="1"/>
              <p:nvPr/>
            </p:nvSpPr>
            <p:spPr>
              <a:xfrm>
                <a:off x="429445" y="1522663"/>
                <a:ext cx="31110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</a:p>
            </p:txBody>
          </p:sp>
          <p:sp>
            <p:nvSpPr>
              <p:cNvPr id="302" name="TextBox 61">
                <a:extLst>
                  <a:ext uri="{FF2B5EF4-FFF2-40B4-BE49-F238E27FC236}">
                    <a16:creationId xmlns:a16="http://schemas.microsoft.com/office/drawing/2014/main" id="{FEDD4EBF-29D4-843F-D9E3-D6AF711FA2AA}"/>
                  </a:ext>
                </a:extLst>
              </p:cNvPr>
              <p:cNvSpPr txBox="1"/>
              <p:nvPr/>
            </p:nvSpPr>
            <p:spPr>
              <a:xfrm>
                <a:off x="429445" y="1305733"/>
                <a:ext cx="311112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3" name="TextBox 51">
                <a:extLst>
                  <a:ext uri="{FF2B5EF4-FFF2-40B4-BE49-F238E27FC236}">
                    <a16:creationId xmlns:a16="http://schemas.microsoft.com/office/drawing/2014/main" id="{D873F4BE-27B8-C8E0-F514-80DDB2E5ECDA}"/>
                  </a:ext>
                </a:extLst>
              </p:cNvPr>
              <p:cNvSpPr txBox="1"/>
              <p:nvPr/>
            </p:nvSpPr>
            <p:spPr>
              <a:xfrm>
                <a:off x="429445" y="871873"/>
                <a:ext cx="36667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304" name="TextBox 51">
                <a:extLst>
                  <a:ext uri="{FF2B5EF4-FFF2-40B4-BE49-F238E27FC236}">
                    <a16:creationId xmlns:a16="http://schemas.microsoft.com/office/drawing/2014/main" id="{C6473C9E-A990-0FA0-1D81-D6D11BA992CE}"/>
                  </a:ext>
                </a:extLst>
              </p:cNvPr>
              <p:cNvSpPr txBox="1"/>
              <p:nvPr/>
            </p:nvSpPr>
            <p:spPr>
              <a:xfrm>
                <a:off x="429445" y="654943"/>
                <a:ext cx="36667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305" name="TextBox 51">
                <a:extLst>
                  <a:ext uri="{FF2B5EF4-FFF2-40B4-BE49-F238E27FC236}">
                    <a16:creationId xmlns:a16="http://schemas.microsoft.com/office/drawing/2014/main" id="{965633EA-A29E-C9F4-9DC5-CBCD87215CF9}"/>
                  </a:ext>
                </a:extLst>
              </p:cNvPr>
              <p:cNvSpPr txBox="1"/>
              <p:nvPr/>
            </p:nvSpPr>
            <p:spPr>
              <a:xfrm>
                <a:off x="429445" y="1739592"/>
                <a:ext cx="311107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ja-JP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2</a:t>
                </a:r>
                <a:endParaRPr lang="en-US" sz="10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9450EA22-13C3-C3F2-11AF-24A692E0FCAA}"/>
                </a:ext>
              </a:extLst>
            </p:cNvPr>
            <p:cNvGrpSpPr/>
            <p:nvPr/>
          </p:nvGrpSpPr>
          <p:grpSpPr>
            <a:xfrm>
              <a:off x="4154417" y="591449"/>
              <a:ext cx="1521570" cy="967681"/>
              <a:chOff x="4154417" y="591449"/>
              <a:chExt cx="1521570" cy="967681"/>
            </a:xfrm>
          </p:grpSpPr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59377BCA-3415-40CA-3C8D-1558F40677CE}"/>
                  </a:ext>
                </a:extLst>
              </p:cNvPr>
              <p:cNvGrpSpPr/>
              <p:nvPr/>
            </p:nvGrpSpPr>
            <p:grpSpPr>
              <a:xfrm>
                <a:off x="4154417" y="591449"/>
                <a:ext cx="1521570" cy="967681"/>
                <a:chOff x="3792950" y="397755"/>
                <a:chExt cx="1521570" cy="967681"/>
              </a:xfrm>
            </p:grpSpPr>
            <p:sp>
              <p:nvSpPr>
                <p:cNvPr id="113" name="テキスト ボックス 250">
                  <a:extLst>
                    <a:ext uri="{FF2B5EF4-FFF2-40B4-BE49-F238E27FC236}">
                      <a16:creationId xmlns:a16="http://schemas.microsoft.com/office/drawing/2014/main" id="{F9837DB3-A1DA-5939-B4A1-BF9C5F7C0B66}"/>
                    </a:ext>
                  </a:extLst>
                </p:cNvPr>
                <p:cNvSpPr txBox="1"/>
                <p:nvPr/>
              </p:nvSpPr>
              <p:spPr>
                <a:xfrm>
                  <a:off x="3792950" y="892302"/>
                  <a:ext cx="152157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latin typeface="Arial" pitchFamily="34" charset="0"/>
                      <a:cs typeface="Arial" pitchFamily="34" charset="0"/>
                    </a:rPr>
                    <a:t>DMSO2 containing medium</a:t>
                  </a:r>
                </a:p>
              </p:txBody>
            </p:sp>
            <p:sp>
              <p:nvSpPr>
                <p:cNvPr id="115" name="テキスト ボックス 250">
                  <a:extLst>
                    <a:ext uri="{FF2B5EF4-FFF2-40B4-BE49-F238E27FC236}">
                      <a16:creationId xmlns:a16="http://schemas.microsoft.com/office/drawing/2014/main" id="{EF4CC085-0253-DE8B-2CFA-219D7FE8278F}"/>
                    </a:ext>
                  </a:extLst>
                </p:cNvPr>
                <p:cNvSpPr txBox="1"/>
                <p:nvPr/>
              </p:nvSpPr>
              <p:spPr>
                <a:xfrm>
                  <a:off x="4186927" y="1149992"/>
                  <a:ext cx="75052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latin typeface="Arial" pitchFamily="34" charset="0"/>
                      <a:cs typeface="Arial" pitchFamily="34" charset="0"/>
                    </a:rPr>
                    <a:t>without cell</a:t>
                  </a:r>
                </a:p>
              </p:txBody>
            </p:sp>
            <p:sp>
              <p:nvSpPr>
                <p:cNvPr id="114" name="テキスト ボックス 250">
                  <a:extLst>
                    <a:ext uri="{FF2B5EF4-FFF2-40B4-BE49-F238E27FC236}">
                      <a16:creationId xmlns:a16="http://schemas.microsoft.com/office/drawing/2014/main" id="{01E4E6EB-6866-8269-F393-AEB0BCC4E311}"/>
                    </a:ext>
                  </a:extLst>
                </p:cNvPr>
                <p:cNvSpPr txBox="1"/>
                <p:nvPr/>
              </p:nvSpPr>
              <p:spPr>
                <a:xfrm>
                  <a:off x="4186927" y="1018194"/>
                  <a:ext cx="59182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latin typeface="Arial" pitchFamily="34" charset="0"/>
                      <a:cs typeface="Arial" pitchFamily="34" charset="0"/>
                    </a:rPr>
                    <a:t>with cell</a:t>
                  </a:r>
                </a:p>
              </p:txBody>
            </p:sp>
            <p:sp>
              <p:nvSpPr>
                <p:cNvPr id="65" name="テキスト ボックス 250">
                  <a:extLst>
                    <a:ext uri="{FF2B5EF4-FFF2-40B4-BE49-F238E27FC236}">
                      <a16:creationId xmlns:a16="http://schemas.microsoft.com/office/drawing/2014/main" id="{FECBDCB3-8ACF-9B9F-7380-34332B3D59FD}"/>
                    </a:ext>
                  </a:extLst>
                </p:cNvPr>
                <p:cNvSpPr txBox="1"/>
                <p:nvPr/>
              </p:nvSpPr>
              <p:spPr>
                <a:xfrm>
                  <a:off x="3792950" y="397755"/>
                  <a:ext cx="152157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latin typeface="Arial" pitchFamily="34" charset="0"/>
                      <a:cs typeface="Arial" pitchFamily="34" charset="0"/>
                    </a:rPr>
                    <a:t>DMSO containing medium</a:t>
                  </a:r>
                </a:p>
              </p:txBody>
            </p:sp>
            <p:sp>
              <p:nvSpPr>
                <p:cNvPr id="75" name="テキスト ボックス 250">
                  <a:extLst>
                    <a:ext uri="{FF2B5EF4-FFF2-40B4-BE49-F238E27FC236}">
                      <a16:creationId xmlns:a16="http://schemas.microsoft.com/office/drawing/2014/main" id="{D496759D-7DCE-B7AC-3F50-DD833E1BC6F6}"/>
                    </a:ext>
                  </a:extLst>
                </p:cNvPr>
                <p:cNvSpPr txBox="1"/>
                <p:nvPr/>
              </p:nvSpPr>
              <p:spPr>
                <a:xfrm>
                  <a:off x="4186927" y="523939"/>
                  <a:ext cx="59182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latin typeface="Arial" pitchFamily="34" charset="0"/>
                      <a:cs typeface="Arial" pitchFamily="34" charset="0"/>
                    </a:rPr>
                    <a:t>with cell</a:t>
                  </a:r>
                </a:p>
              </p:txBody>
            </p:sp>
            <p:sp>
              <p:nvSpPr>
                <p:cNvPr id="78" name="テキスト ボックス 250">
                  <a:extLst>
                    <a:ext uri="{FF2B5EF4-FFF2-40B4-BE49-F238E27FC236}">
                      <a16:creationId xmlns:a16="http://schemas.microsoft.com/office/drawing/2014/main" id="{77E604BB-A983-6044-D3F6-DFE50E92505C}"/>
                    </a:ext>
                  </a:extLst>
                </p:cNvPr>
                <p:cNvSpPr txBox="1"/>
                <p:nvPr/>
              </p:nvSpPr>
              <p:spPr>
                <a:xfrm>
                  <a:off x="4186927" y="655736"/>
                  <a:ext cx="75052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b="1" dirty="0">
                      <a:latin typeface="Arial" pitchFamily="34" charset="0"/>
                      <a:cs typeface="Arial" pitchFamily="34" charset="0"/>
                    </a:rPr>
                    <a:t>without cell</a:t>
                  </a:r>
                </a:p>
              </p:txBody>
            </p:sp>
          </p:grpSp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1C3A6520-26C0-824A-2D67-D236638A229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63830" t="39183" r="26543" b="52884"/>
              <a:stretch/>
            </p:blipFill>
            <p:spPr>
              <a:xfrm>
                <a:off x="4373170" y="1387677"/>
                <a:ext cx="243225" cy="138041"/>
              </a:xfrm>
              <a:prstGeom prst="rect">
                <a:avLst/>
              </a:prstGeom>
            </p:spPr>
          </p:pic>
          <p:pic>
            <p:nvPicPr>
              <p:cNvPr id="511" name="Picture 510">
                <a:extLst>
                  <a:ext uri="{FF2B5EF4-FFF2-40B4-BE49-F238E27FC236}">
                    <a16:creationId xmlns:a16="http://schemas.microsoft.com/office/drawing/2014/main" id="{51D807A3-B583-7547-DD5B-9FEA9E81D19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63830" t="16211" r="26543" b="75652"/>
              <a:stretch/>
            </p:blipFill>
            <p:spPr>
              <a:xfrm>
                <a:off x="4373170" y="884253"/>
                <a:ext cx="243225" cy="141592"/>
              </a:xfrm>
              <a:prstGeom prst="rect">
                <a:avLst/>
              </a:prstGeom>
            </p:spPr>
          </p:pic>
          <p:pic>
            <p:nvPicPr>
              <p:cNvPr id="512" name="Picture 511">
                <a:extLst>
                  <a:ext uri="{FF2B5EF4-FFF2-40B4-BE49-F238E27FC236}">
                    <a16:creationId xmlns:a16="http://schemas.microsoft.com/office/drawing/2014/main" id="{428E7D6E-581E-5670-367D-6BCA181BF74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63830" t="28287" r="26543" b="64213"/>
              <a:stretch/>
            </p:blipFill>
            <p:spPr>
              <a:xfrm>
                <a:off x="4373170" y="762231"/>
                <a:ext cx="243225" cy="130506"/>
              </a:xfrm>
              <a:prstGeom prst="rect">
                <a:avLst/>
              </a:prstGeom>
            </p:spPr>
          </p:pic>
          <p:pic>
            <p:nvPicPr>
              <p:cNvPr id="513" name="Picture 512">
                <a:extLst>
                  <a:ext uri="{FF2B5EF4-FFF2-40B4-BE49-F238E27FC236}">
                    <a16:creationId xmlns:a16="http://schemas.microsoft.com/office/drawing/2014/main" id="{2CA5CB29-21C4-96F9-20CE-1612674DBC3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63830" t="50213" r="26543" b="41749"/>
              <a:stretch/>
            </p:blipFill>
            <p:spPr>
              <a:xfrm>
                <a:off x="4373170" y="1234946"/>
                <a:ext cx="243225" cy="139864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1094954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solidFill>
          <a:srgbClr val="868686"/>
        </a:solidFill>
        <a:ln w="12700" cap="flat">
          <a:solidFill>
            <a:schemeClr val="tx1"/>
          </a:solidFill>
          <a:prstDash val="solid"/>
          <a:bevel/>
          <a:headEnd/>
          <a:tailEnd/>
        </a:ln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>
          <a:defRPr sz="800">
            <a:latin typeface="Arial" pitchFamily="34" charset="0"/>
            <a:cs typeface="Arial" pitchFamily="34" charset="0"/>
          </a:defRPr>
        </a:defPPr>
      </a:lstStyle>
    </a:spDef>
    <a:lnDef>
      <a:spPr>
        <a:ln w="127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rtlCol="0">
        <a:spAutoFit/>
      </a:bodyPr>
      <a:lstStyle>
        <a:defPPr>
          <a:defRPr sz="1200" dirty="0">
            <a:latin typeface="Arial" pitchFamily="34" charset="0"/>
            <a:cs typeface="Arial" pitchFamily="34" charset="0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45</TotalTime>
  <Words>295</Words>
  <Application>Microsoft Office PowerPoint</Application>
  <PresentationFormat>Custom</PresentationFormat>
  <Paragraphs>26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Office Theme</vt:lpstr>
      <vt:lpstr>Prism 5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Takeshi Saito</dc:creator>
  <cp:lastModifiedBy>Sugahara Go</cp:lastModifiedBy>
  <cp:revision>135</cp:revision>
  <cp:lastPrinted>2013-07-30T20:19:09Z</cp:lastPrinted>
  <dcterms:created xsi:type="dcterms:W3CDTF">2013-05-03T19:48:35Z</dcterms:created>
  <dcterms:modified xsi:type="dcterms:W3CDTF">2022-10-15T03:33:05Z</dcterms:modified>
</cp:coreProperties>
</file>